
<file path=[Content_Types].xml><?xml version="1.0" encoding="utf-8"?>
<Types xmlns="http://schemas.openxmlformats.org/package/2006/content-types">
  <Default Extension="bin" ContentType="application/vnd.openxmlformats-officedocument.oleObject"/>
  <Default Extension="png" ContentType="image/png"/>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 id="257" r:id="rId3"/>
    <p:sldId id="273" r:id="rId4"/>
    <p:sldId id="275" r:id="rId5"/>
    <p:sldId id="282" r:id="rId6"/>
    <p:sldId id="276" r:id="rId7"/>
    <p:sldId id="285" r:id="rId8"/>
    <p:sldId id="283" r:id="rId9"/>
    <p:sldId id="284" r:id="rId10"/>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53ACB7"/>
    <a:srgbClr val="FFA040"/>
    <a:srgbClr val="57AEB9"/>
    <a:srgbClr val="87CCD9"/>
    <a:srgbClr val="EBA845"/>
    <a:srgbClr val="FFFFFF"/>
    <a:srgbClr val="FFC080"/>
    <a:srgbClr val="FDFCDF"/>
    <a:srgbClr val="C0C0C0"/>
    <a:srgbClr val="9EBFD1"/>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24133" autoAdjust="0"/>
    <p:restoredTop sz="94660"/>
  </p:normalViewPr>
  <p:slideViewPr>
    <p:cSldViewPr snapToGrid="0">
      <p:cViewPr varScale="1">
        <p:scale>
          <a:sx n="58" d="100"/>
          <a:sy n="58" d="100"/>
        </p:scale>
        <p:origin x="2213" y="8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5.emf"/></Relationships>
</file>

<file path=ppt/drawings/_rels/vmlDrawing3.vml.rels><?xml version="1.0" encoding="UTF-8" standalone="yes"?>
<Relationships xmlns="http://schemas.openxmlformats.org/package/2006/relationships"><Relationship Id="rId1" Type="http://schemas.openxmlformats.org/officeDocument/2006/relationships/image" Target="../media/image10.emf"/></Relationships>
</file>

<file path=ppt/drawings/_rels/vmlDrawing4.vml.rels><?xml version="1.0" encoding="UTF-8" standalone="yes"?>
<Relationships xmlns="http://schemas.openxmlformats.org/package/2006/relationships"><Relationship Id="rId1" Type="http://schemas.openxmlformats.org/officeDocument/2006/relationships/image" Target="../media/image11.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5D691F60-EFAB-4134-B448-BE21C06D53FE}" type="datetimeFigureOut">
              <a:rPr lang="en-GB" smtClean="0"/>
              <a:t>17/01/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0379152-E8A8-474D-AB85-DCE93D00DF2B}" type="slidenum">
              <a:rPr lang="en-GB" smtClean="0"/>
              <a:t>‹#›</a:t>
            </a:fld>
            <a:endParaRPr lang="en-GB"/>
          </a:p>
        </p:txBody>
      </p:sp>
    </p:spTree>
    <p:extLst>
      <p:ext uri="{BB962C8B-B14F-4D97-AF65-F5344CB8AC3E}">
        <p14:creationId xmlns:p14="http://schemas.microsoft.com/office/powerpoint/2010/main" val="122012180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5D691F60-EFAB-4134-B448-BE21C06D53FE}" type="datetimeFigureOut">
              <a:rPr lang="en-GB" smtClean="0"/>
              <a:t>17/01/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0379152-E8A8-474D-AB85-DCE93D00DF2B}" type="slidenum">
              <a:rPr lang="en-GB" smtClean="0"/>
              <a:t>‹#›</a:t>
            </a:fld>
            <a:endParaRPr lang="en-GB"/>
          </a:p>
        </p:txBody>
      </p:sp>
    </p:spTree>
    <p:extLst>
      <p:ext uri="{BB962C8B-B14F-4D97-AF65-F5344CB8AC3E}">
        <p14:creationId xmlns:p14="http://schemas.microsoft.com/office/powerpoint/2010/main" val="374235709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5D691F60-EFAB-4134-B448-BE21C06D53FE}" type="datetimeFigureOut">
              <a:rPr lang="en-GB" smtClean="0"/>
              <a:t>17/01/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0379152-E8A8-474D-AB85-DCE93D00DF2B}" type="slidenum">
              <a:rPr lang="en-GB" smtClean="0"/>
              <a:t>‹#›</a:t>
            </a:fld>
            <a:endParaRPr lang="en-GB"/>
          </a:p>
        </p:txBody>
      </p:sp>
    </p:spTree>
    <p:extLst>
      <p:ext uri="{BB962C8B-B14F-4D97-AF65-F5344CB8AC3E}">
        <p14:creationId xmlns:p14="http://schemas.microsoft.com/office/powerpoint/2010/main" val="131270076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5D691F60-EFAB-4134-B448-BE21C06D53FE}" type="datetimeFigureOut">
              <a:rPr lang="en-GB" smtClean="0"/>
              <a:t>17/01/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0379152-E8A8-474D-AB85-DCE93D00DF2B}" type="slidenum">
              <a:rPr lang="en-GB" smtClean="0"/>
              <a:t>‹#›</a:t>
            </a:fld>
            <a:endParaRPr lang="en-GB"/>
          </a:p>
        </p:txBody>
      </p:sp>
    </p:spTree>
    <p:extLst>
      <p:ext uri="{BB962C8B-B14F-4D97-AF65-F5344CB8AC3E}">
        <p14:creationId xmlns:p14="http://schemas.microsoft.com/office/powerpoint/2010/main" val="51745011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5D691F60-EFAB-4134-B448-BE21C06D53FE}" type="datetimeFigureOut">
              <a:rPr lang="en-GB" smtClean="0"/>
              <a:t>17/01/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0379152-E8A8-474D-AB85-DCE93D00DF2B}" type="slidenum">
              <a:rPr lang="en-GB" smtClean="0"/>
              <a:t>‹#›</a:t>
            </a:fld>
            <a:endParaRPr lang="en-GB"/>
          </a:p>
        </p:txBody>
      </p:sp>
    </p:spTree>
    <p:extLst>
      <p:ext uri="{BB962C8B-B14F-4D97-AF65-F5344CB8AC3E}">
        <p14:creationId xmlns:p14="http://schemas.microsoft.com/office/powerpoint/2010/main" val="184746529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5D691F60-EFAB-4134-B448-BE21C06D53FE}" type="datetimeFigureOut">
              <a:rPr lang="en-GB" smtClean="0"/>
              <a:t>17/01/202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60379152-E8A8-474D-AB85-DCE93D00DF2B}" type="slidenum">
              <a:rPr lang="en-GB" smtClean="0"/>
              <a:t>‹#›</a:t>
            </a:fld>
            <a:endParaRPr lang="en-GB"/>
          </a:p>
        </p:txBody>
      </p:sp>
    </p:spTree>
    <p:extLst>
      <p:ext uri="{BB962C8B-B14F-4D97-AF65-F5344CB8AC3E}">
        <p14:creationId xmlns:p14="http://schemas.microsoft.com/office/powerpoint/2010/main" val="378142891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5D691F60-EFAB-4134-B448-BE21C06D53FE}" type="datetimeFigureOut">
              <a:rPr lang="en-GB" smtClean="0"/>
              <a:t>17/01/2025</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60379152-E8A8-474D-AB85-DCE93D00DF2B}" type="slidenum">
              <a:rPr lang="en-GB" smtClean="0"/>
              <a:t>‹#›</a:t>
            </a:fld>
            <a:endParaRPr lang="en-GB"/>
          </a:p>
        </p:txBody>
      </p:sp>
    </p:spTree>
    <p:extLst>
      <p:ext uri="{BB962C8B-B14F-4D97-AF65-F5344CB8AC3E}">
        <p14:creationId xmlns:p14="http://schemas.microsoft.com/office/powerpoint/2010/main" val="236449354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5D691F60-EFAB-4134-B448-BE21C06D53FE}" type="datetimeFigureOut">
              <a:rPr lang="en-GB" smtClean="0"/>
              <a:t>17/01/2025</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60379152-E8A8-474D-AB85-DCE93D00DF2B}" type="slidenum">
              <a:rPr lang="en-GB" smtClean="0"/>
              <a:t>‹#›</a:t>
            </a:fld>
            <a:endParaRPr lang="en-GB"/>
          </a:p>
        </p:txBody>
      </p:sp>
    </p:spTree>
    <p:extLst>
      <p:ext uri="{BB962C8B-B14F-4D97-AF65-F5344CB8AC3E}">
        <p14:creationId xmlns:p14="http://schemas.microsoft.com/office/powerpoint/2010/main" val="119664273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D691F60-EFAB-4134-B448-BE21C06D53FE}" type="datetimeFigureOut">
              <a:rPr lang="en-GB" smtClean="0"/>
              <a:t>17/01/2025</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60379152-E8A8-474D-AB85-DCE93D00DF2B}" type="slidenum">
              <a:rPr lang="en-GB" smtClean="0"/>
              <a:t>‹#›</a:t>
            </a:fld>
            <a:endParaRPr lang="en-GB"/>
          </a:p>
        </p:txBody>
      </p:sp>
    </p:spTree>
    <p:extLst>
      <p:ext uri="{BB962C8B-B14F-4D97-AF65-F5344CB8AC3E}">
        <p14:creationId xmlns:p14="http://schemas.microsoft.com/office/powerpoint/2010/main" val="145384385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5D691F60-EFAB-4134-B448-BE21C06D53FE}" type="datetimeFigureOut">
              <a:rPr lang="en-GB" smtClean="0"/>
              <a:t>17/01/202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60379152-E8A8-474D-AB85-DCE93D00DF2B}" type="slidenum">
              <a:rPr lang="en-GB" smtClean="0"/>
              <a:t>‹#›</a:t>
            </a:fld>
            <a:endParaRPr lang="en-GB"/>
          </a:p>
        </p:txBody>
      </p:sp>
    </p:spTree>
    <p:extLst>
      <p:ext uri="{BB962C8B-B14F-4D97-AF65-F5344CB8AC3E}">
        <p14:creationId xmlns:p14="http://schemas.microsoft.com/office/powerpoint/2010/main" val="358603073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5D691F60-EFAB-4134-B448-BE21C06D53FE}" type="datetimeFigureOut">
              <a:rPr lang="en-GB" smtClean="0"/>
              <a:t>17/01/202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60379152-E8A8-474D-AB85-DCE93D00DF2B}" type="slidenum">
              <a:rPr lang="en-GB" smtClean="0"/>
              <a:t>‹#›</a:t>
            </a:fld>
            <a:endParaRPr lang="en-GB"/>
          </a:p>
        </p:txBody>
      </p:sp>
    </p:spTree>
    <p:extLst>
      <p:ext uri="{BB962C8B-B14F-4D97-AF65-F5344CB8AC3E}">
        <p14:creationId xmlns:p14="http://schemas.microsoft.com/office/powerpoint/2010/main" val="354597710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5D691F60-EFAB-4134-B448-BE21C06D53FE}" type="datetimeFigureOut">
              <a:rPr lang="en-GB" smtClean="0"/>
              <a:t>17/01/2025</a:t>
            </a:fld>
            <a:endParaRPr lang="en-GB"/>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60379152-E8A8-474D-AB85-DCE93D00DF2B}" type="slidenum">
              <a:rPr lang="en-GB" smtClean="0"/>
              <a:t>‹#›</a:t>
            </a:fld>
            <a:endParaRPr lang="en-GB"/>
          </a:p>
        </p:txBody>
      </p:sp>
    </p:spTree>
    <p:extLst>
      <p:ext uri="{BB962C8B-B14F-4D97-AF65-F5344CB8AC3E}">
        <p14:creationId xmlns:p14="http://schemas.microsoft.com/office/powerpoint/2010/main" val="6214575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7.xml"/><Relationship Id="rId1" Type="http://schemas.openxmlformats.org/officeDocument/2006/relationships/vmlDrawing" Target="../drawings/vmlDrawing1.vml"/><Relationship Id="rId4" Type="http://schemas.openxmlformats.org/officeDocument/2006/relationships/image" Target="../media/image1.emf"/></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7.xml"/><Relationship Id="rId4" Type="http://schemas.openxmlformats.org/officeDocument/2006/relationships/image" Target="../media/image4.png"/></Relationships>
</file>

<file path=ppt/slides/_rels/slide4.xml.rels><?xml version="1.0" encoding="UTF-8" standalone="yes"?>
<Relationships xmlns="http://schemas.openxmlformats.org/package/2006/relationships"><Relationship Id="rId8" Type="http://schemas.openxmlformats.org/officeDocument/2006/relationships/image" Target="../media/image9.jpeg"/><Relationship Id="rId3" Type="http://schemas.openxmlformats.org/officeDocument/2006/relationships/oleObject" Target="../embeddings/oleObject2.bin"/><Relationship Id="rId7" Type="http://schemas.openxmlformats.org/officeDocument/2006/relationships/image" Target="../media/image8.jpeg"/><Relationship Id="rId2" Type="http://schemas.openxmlformats.org/officeDocument/2006/relationships/slideLayout" Target="../slideLayouts/slideLayout7.xml"/><Relationship Id="rId1" Type="http://schemas.openxmlformats.org/officeDocument/2006/relationships/vmlDrawing" Target="../drawings/vmlDrawing2.vml"/><Relationship Id="rId6" Type="http://schemas.openxmlformats.org/officeDocument/2006/relationships/image" Target="../media/image7.jpeg"/><Relationship Id="rId5" Type="http://schemas.openxmlformats.org/officeDocument/2006/relationships/image" Target="../media/image6.jpeg"/><Relationship Id="rId4" Type="http://schemas.openxmlformats.org/officeDocument/2006/relationships/image" Target="../media/image5.emf"/></Relationships>
</file>

<file path=ppt/slides/_rels/slide5.xml.rels><?xml version="1.0" encoding="UTF-8" standalone="yes"?>
<Relationships xmlns="http://schemas.openxmlformats.org/package/2006/relationships"><Relationship Id="rId3" Type="http://schemas.openxmlformats.org/officeDocument/2006/relationships/oleObject" Target="../embeddings/oleObject3.bin"/><Relationship Id="rId2" Type="http://schemas.openxmlformats.org/officeDocument/2006/relationships/slideLayout" Target="../slideLayouts/slideLayout7.xml"/><Relationship Id="rId1" Type="http://schemas.openxmlformats.org/officeDocument/2006/relationships/vmlDrawing" Target="../drawings/vmlDrawing3.vml"/><Relationship Id="rId4" Type="http://schemas.openxmlformats.org/officeDocument/2006/relationships/image" Target="../media/image10.emf"/></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oleObject" Target="../embeddings/oleObject4.bin"/><Relationship Id="rId2" Type="http://schemas.openxmlformats.org/officeDocument/2006/relationships/slideLayout" Target="../slideLayouts/slideLayout7.xml"/><Relationship Id="rId1" Type="http://schemas.openxmlformats.org/officeDocument/2006/relationships/vmlDrawing" Target="../drawings/vmlDrawing4.vml"/><Relationship Id="rId4" Type="http://schemas.openxmlformats.org/officeDocument/2006/relationships/image" Target="../media/image11.emf"/></Relationships>
</file>

<file path=ppt/slides/_rels/slide8.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544749" y="515566"/>
            <a:ext cx="5982511" cy="2092881"/>
          </a:xfrm>
          <a:prstGeom prst="rect">
            <a:avLst/>
          </a:prstGeom>
          <a:noFill/>
        </p:spPr>
        <p:txBody>
          <a:bodyPr wrap="square" rtlCol="0">
            <a:spAutoFit/>
          </a:bodyPr>
          <a:lstStyle/>
          <a:p>
            <a:r>
              <a:rPr lang="en-US" b="1" dirty="0" smtClean="0">
                <a:latin typeface="Cambria" panose="02040503050406030204" pitchFamily="18" charset="0"/>
                <a:ea typeface="Cambria" panose="02040503050406030204" pitchFamily="18" charset="0"/>
              </a:rPr>
              <a:t>Figure S1</a:t>
            </a:r>
          </a:p>
          <a:p>
            <a:pPr algn="just"/>
            <a:r>
              <a:rPr lang="en-US" sz="1400" b="1" dirty="0" smtClean="0">
                <a:latin typeface="Cambria" panose="02040503050406030204" pitchFamily="18" charset="0"/>
                <a:ea typeface="Cambria" panose="02040503050406030204" pitchFamily="18" charset="0"/>
              </a:rPr>
              <a:t>Graph of the cumulative percentage of the molecular weight (MW) of the individual proteins within the human proteome (n = 20,421). </a:t>
            </a:r>
            <a:r>
              <a:rPr lang="en-US" sz="1400" dirty="0" smtClean="0">
                <a:latin typeface="Cambria" panose="02040503050406030204" pitchFamily="18" charset="0"/>
                <a:ea typeface="Cambria" panose="02040503050406030204" pitchFamily="18" charset="0"/>
              </a:rPr>
              <a:t>Although 87% of the globular proteins theoretically passes the 100 </a:t>
            </a:r>
            <a:r>
              <a:rPr lang="en-US" sz="1400" dirty="0" err="1" smtClean="0">
                <a:latin typeface="Cambria" panose="02040503050406030204" pitchFamily="18" charset="0"/>
                <a:ea typeface="Cambria" panose="02040503050406030204" pitchFamily="18" charset="0"/>
              </a:rPr>
              <a:t>kDa</a:t>
            </a:r>
            <a:r>
              <a:rPr lang="en-US" sz="1400" dirty="0" smtClean="0">
                <a:latin typeface="Cambria" panose="02040503050406030204" pitchFamily="18" charset="0"/>
                <a:ea typeface="Cambria" panose="02040503050406030204" pitchFamily="18" charset="0"/>
              </a:rPr>
              <a:t> membrane (blue line), the remaining 13% will potentially accumulate on the filter and will not be efficiently removed during consecutive washing steps. In addition, 99% of the proteins have a MW below 300 </a:t>
            </a:r>
            <a:r>
              <a:rPr lang="en-US" sz="1400" dirty="0" err="1" smtClean="0">
                <a:latin typeface="Cambria" panose="02040503050406030204" pitchFamily="18" charset="0"/>
                <a:ea typeface="Cambria" panose="02040503050406030204" pitchFamily="18" charset="0"/>
              </a:rPr>
              <a:t>kDa</a:t>
            </a:r>
            <a:r>
              <a:rPr lang="en-US" sz="1400" dirty="0" smtClean="0">
                <a:latin typeface="Cambria" panose="02040503050406030204" pitchFamily="18" charset="0"/>
                <a:ea typeface="Cambria" panose="02040503050406030204" pitchFamily="18" charset="0"/>
              </a:rPr>
              <a:t>. As a result, the bulk of potentially contaminating non-EV proteins will theoretically removed from the 300 </a:t>
            </a:r>
            <a:r>
              <a:rPr lang="en-US" sz="1400" dirty="0" err="1" smtClean="0">
                <a:latin typeface="Cambria" panose="02040503050406030204" pitchFamily="18" charset="0"/>
                <a:ea typeface="Cambria" panose="02040503050406030204" pitchFamily="18" charset="0"/>
              </a:rPr>
              <a:t>kDa</a:t>
            </a:r>
            <a:r>
              <a:rPr lang="en-US" sz="1400" dirty="0" smtClean="0">
                <a:latin typeface="Cambria" panose="02040503050406030204" pitchFamily="18" charset="0"/>
                <a:ea typeface="Cambria" panose="02040503050406030204" pitchFamily="18" charset="0"/>
              </a:rPr>
              <a:t> MWCO filter membrane.</a:t>
            </a:r>
            <a:endParaRPr lang="en-GB" sz="1400" dirty="0">
              <a:latin typeface="Cambria" panose="02040503050406030204" pitchFamily="18" charset="0"/>
              <a:ea typeface="Cambria" panose="02040503050406030204" pitchFamily="18" charset="0"/>
            </a:endParaRPr>
          </a:p>
        </p:txBody>
      </p:sp>
      <p:graphicFrame>
        <p:nvGraphicFramePr>
          <p:cNvPr id="5" name="Object 4"/>
          <p:cNvGraphicFramePr>
            <a:graphicFrameLocks noChangeAspect="1"/>
          </p:cNvGraphicFramePr>
          <p:nvPr>
            <p:extLst>
              <p:ext uri="{D42A27DB-BD31-4B8C-83A1-F6EECF244321}">
                <p14:modId xmlns:p14="http://schemas.microsoft.com/office/powerpoint/2010/main" val="2849727457"/>
              </p:ext>
            </p:extLst>
          </p:nvPr>
        </p:nvGraphicFramePr>
        <p:xfrm>
          <a:off x="1179690" y="2919876"/>
          <a:ext cx="4712627" cy="4489036"/>
        </p:xfrm>
        <a:graphic>
          <a:graphicData uri="http://schemas.openxmlformats.org/presentationml/2006/ole">
            <mc:AlternateContent xmlns:mc="http://schemas.openxmlformats.org/markup-compatibility/2006">
              <mc:Choice xmlns:v="urn:schemas-microsoft-com:vml" Requires="v">
                <p:oleObj spid="_x0000_s1078" name="Prism 10" r:id="rId3" imgW="3044493" imgH="2899851" progId="Prism10.Document">
                  <p:embed/>
                </p:oleObj>
              </mc:Choice>
              <mc:Fallback>
                <p:oleObj name="Prism 10" r:id="rId3" imgW="3044493" imgH="2899851" progId="Prism10.Document">
                  <p:embed/>
                  <p:pic>
                    <p:nvPicPr>
                      <p:cNvPr id="2" name="Object 1"/>
                      <p:cNvPicPr/>
                      <p:nvPr/>
                    </p:nvPicPr>
                    <p:blipFill>
                      <a:blip r:embed="rId4"/>
                      <a:stretch>
                        <a:fillRect/>
                      </a:stretch>
                    </p:blipFill>
                    <p:spPr>
                      <a:xfrm>
                        <a:off x="1179690" y="2919876"/>
                        <a:ext cx="4712627" cy="4489036"/>
                      </a:xfrm>
                      <a:prstGeom prst="rect">
                        <a:avLst/>
                      </a:prstGeom>
                    </p:spPr>
                  </p:pic>
                </p:oleObj>
              </mc:Fallback>
            </mc:AlternateContent>
          </a:graphicData>
        </a:graphic>
      </p:graphicFrame>
    </p:spTree>
    <p:extLst>
      <p:ext uri="{BB962C8B-B14F-4D97-AF65-F5344CB8AC3E}">
        <p14:creationId xmlns:p14="http://schemas.microsoft.com/office/powerpoint/2010/main" val="268276709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1" name="Group 10"/>
          <p:cNvGrpSpPr/>
          <p:nvPr/>
        </p:nvGrpSpPr>
        <p:grpSpPr>
          <a:xfrm>
            <a:off x="2044185" y="2772200"/>
            <a:ext cx="2983637" cy="2615920"/>
            <a:chOff x="864707" y="455614"/>
            <a:chExt cx="5304244" cy="4650525"/>
          </a:xfrm>
        </p:grpSpPr>
        <p:sp>
          <p:nvSpPr>
            <p:cNvPr id="12" name="Rounded Rectangle 11"/>
            <p:cNvSpPr>
              <a:spLocks noChangeAspect="1"/>
            </p:cNvSpPr>
            <p:nvPr/>
          </p:nvSpPr>
          <p:spPr>
            <a:xfrm rot="2700000">
              <a:off x="1655122" y="1632307"/>
              <a:ext cx="3743281" cy="2086783"/>
            </a:xfrm>
            <a:prstGeom prst="roundRect">
              <a:avLst>
                <a:gd name="adj" fmla="val 50000"/>
              </a:avLst>
            </a:prstGeom>
            <a:solidFill>
              <a:schemeClr val="accent5">
                <a:lumMod val="60000"/>
                <a:lumOff val="40000"/>
                <a:alpha val="25098"/>
              </a:schemeClr>
            </a:solidFill>
            <a:ln>
              <a:solidFill>
                <a:schemeClr val="tx2"/>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51435" tIns="25718" rIns="51435" bIns="25718" numCol="1" spcCol="0" rtlCol="0" fromWordArt="0" anchor="ctr" anchorCtr="0" forceAA="0" compatLnSpc="1">
              <a:prstTxWarp prst="textNoShape">
                <a:avLst/>
              </a:prstTxWarp>
              <a:noAutofit/>
            </a:bodyPr>
            <a:lstStyle/>
            <a:p>
              <a:pPr algn="ctr"/>
              <a:endParaRPr lang="en-GB" sz="1013">
                <a:latin typeface="Cambria" panose="02040503050406030204" pitchFamily="18" charset="0"/>
                <a:ea typeface="Cambria" panose="02040503050406030204" pitchFamily="18" charset="0"/>
              </a:endParaRPr>
            </a:p>
          </p:txBody>
        </p:sp>
        <p:sp>
          <p:nvSpPr>
            <p:cNvPr id="13" name="Rounded Rectangle 12"/>
            <p:cNvSpPr>
              <a:spLocks noChangeAspect="1"/>
            </p:cNvSpPr>
            <p:nvPr/>
          </p:nvSpPr>
          <p:spPr>
            <a:xfrm rot="2700000">
              <a:off x="1086161" y="2191106"/>
              <a:ext cx="3743282" cy="2086783"/>
            </a:xfrm>
            <a:prstGeom prst="roundRect">
              <a:avLst>
                <a:gd name="adj" fmla="val 50000"/>
              </a:avLst>
            </a:prstGeom>
            <a:solidFill>
              <a:schemeClr val="accent6">
                <a:lumMod val="20000"/>
                <a:lumOff val="80000"/>
                <a:alpha val="25098"/>
              </a:schemeClr>
            </a:solidFill>
            <a:ln>
              <a:solidFill>
                <a:schemeClr val="tx2"/>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51435" tIns="25718" rIns="51435" bIns="25718" numCol="1" spcCol="0" rtlCol="0" fromWordArt="0" anchor="ctr" anchorCtr="0" forceAA="0" compatLnSpc="1">
              <a:prstTxWarp prst="textNoShape">
                <a:avLst/>
              </a:prstTxWarp>
              <a:noAutofit/>
            </a:bodyPr>
            <a:lstStyle/>
            <a:p>
              <a:pPr algn="ctr"/>
              <a:endParaRPr lang="en-GB" sz="1013" dirty="0">
                <a:latin typeface="Cambria" panose="02040503050406030204" pitchFamily="18" charset="0"/>
                <a:ea typeface="Cambria" panose="02040503050406030204" pitchFamily="18" charset="0"/>
              </a:endParaRPr>
            </a:p>
          </p:txBody>
        </p:sp>
        <p:sp>
          <p:nvSpPr>
            <p:cNvPr id="14" name="Rounded Rectangle 13"/>
            <p:cNvSpPr/>
            <p:nvPr/>
          </p:nvSpPr>
          <p:spPr>
            <a:xfrm rot="8100000">
              <a:off x="2239910" y="2148908"/>
              <a:ext cx="3848271" cy="2086783"/>
            </a:xfrm>
            <a:prstGeom prst="roundRect">
              <a:avLst>
                <a:gd name="adj" fmla="val 50000"/>
              </a:avLst>
            </a:prstGeom>
            <a:solidFill>
              <a:srgbClr val="C00000">
                <a:alpha val="25098"/>
              </a:srgbClr>
            </a:solidFill>
            <a:ln>
              <a:solidFill>
                <a:schemeClr val="tx2"/>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51435" tIns="25718" rIns="51435" bIns="25718" numCol="1" spcCol="0" rtlCol="0" fromWordArt="0" anchor="ctr" anchorCtr="0" forceAA="0" compatLnSpc="1">
              <a:prstTxWarp prst="textNoShape">
                <a:avLst/>
              </a:prstTxWarp>
              <a:noAutofit/>
            </a:bodyPr>
            <a:lstStyle/>
            <a:p>
              <a:pPr algn="ctr"/>
              <a:endParaRPr lang="en-GB" sz="1013">
                <a:latin typeface="Cambria" panose="02040503050406030204" pitchFamily="18" charset="0"/>
                <a:ea typeface="Cambria" panose="02040503050406030204" pitchFamily="18" charset="0"/>
              </a:endParaRPr>
            </a:p>
          </p:txBody>
        </p:sp>
        <p:sp>
          <p:nvSpPr>
            <p:cNvPr id="15" name="Rounded Rectangle 14"/>
            <p:cNvSpPr/>
            <p:nvPr/>
          </p:nvSpPr>
          <p:spPr>
            <a:xfrm rot="8100000">
              <a:off x="1660790" y="1579948"/>
              <a:ext cx="3848271" cy="2086783"/>
            </a:xfrm>
            <a:prstGeom prst="roundRect">
              <a:avLst>
                <a:gd name="adj" fmla="val 50000"/>
              </a:avLst>
            </a:prstGeom>
            <a:solidFill>
              <a:schemeClr val="accent4">
                <a:lumMod val="60000"/>
                <a:lumOff val="40000"/>
                <a:alpha val="25098"/>
              </a:schemeClr>
            </a:solidFill>
            <a:ln>
              <a:solidFill>
                <a:schemeClr val="tx2"/>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51435" tIns="25718" rIns="51435" bIns="25718" numCol="1" spcCol="0" rtlCol="0" fromWordArt="0" anchor="ctr" anchorCtr="0" forceAA="0" compatLnSpc="1">
              <a:prstTxWarp prst="textNoShape">
                <a:avLst/>
              </a:prstTxWarp>
              <a:noAutofit/>
            </a:bodyPr>
            <a:lstStyle/>
            <a:p>
              <a:pPr algn="ctr"/>
              <a:endParaRPr lang="en-GB" sz="1013">
                <a:latin typeface="Cambria" panose="02040503050406030204" pitchFamily="18" charset="0"/>
                <a:ea typeface="Cambria" panose="02040503050406030204" pitchFamily="18" charset="0"/>
              </a:endParaRPr>
            </a:p>
          </p:txBody>
        </p:sp>
        <p:sp>
          <p:nvSpPr>
            <p:cNvPr id="16" name="TextBox 15"/>
            <p:cNvSpPr txBox="1"/>
            <p:nvPr/>
          </p:nvSpPr>
          <p:spPr>
            <a:xfrm>
              <a:off x="3831603" y="455614"/>
              <a:ext cx="864053" cy="441260"/>
            </a:xfrm>
            <a:prstGeom prst="rect">
              <a:avLst/>
            </a:prstGeom>
            <a:noFill/>
          </p:spPr>
          <p:txBody>
            <a:bodyPr wrap="none" rtlCol="0">
              <a:spAutoFit/>
            </a:bodyPr>
            <a:lstStyle/>
            <a:p>
              <a:r>
                <a:rPr lang="en-US" sz="1013" dirty="0">
                  <a:latin typeface="Cambria" panose="02040503050406030204" pitchFamily="18" charset="0"/>
                  <a:ea typeface="Cambria" panose="02040503050406030204" pitchFamily="18" charset="0"/>
                </a:rPr>
                <a:t>Input</a:t>
              </a:r>
              <a:endParaRPr lang="en-GB" sz="1013" dirty="0">
                <a:latin typeface="Cambria" panose="02040503050406030204" pitchFamily="18" charset="0"/>
                <a:ea typeface="Cambria" panose="02040503050406030204" pitchFamily="18" charset="0"/>
              </a:endParaRPr>
            </a:p>
          </p:txBody>
        </p:sp>
        <p:sp>
          <p:nvSpPr>
            <p:cNvPr id="17" name="TextBox 16"/>
            <p:cNvSpPr txBox="1"/>
            <p:nvPr/>
          </p:nvSpPr>
          <p:spPr>
            <a:xfrm>
              <a:off x="864707" y="1332627"/>
              <a:ext cx="1123385" cy="441260"/>
            </a:xfrm>
            <a:prstGeom prst="rect">
              <a:avLst/>
            </a:prstGeom>
            <a:noFill/>
          </p:spPr>
          <p:txBody>
            <a:bodyPr wrap="none" rtlCol="0">
              <a:spAutoFit/>
            </a:bodyPr>
            <a:lstStyle/>
            <a:p>
              <a:r>
                <a:rPr lang="en-US" sz="1013" dirty="0">
                  <a:latin typeface="Cambria" panose="02040503050406030204" pitchFamily="18" charset="0"/>
                  <a:ea typeface="Cambria" panose="02040503050406030204" pitchFamily="18" charset="0"/>
                </a:rPr>
                <a:t>Loading</a:t>
              </a:r>
              <a:endParaRPr lang="en-GB" sz="1013" dirty="0">
                <a:latin typeface="Cambria" panose="02040503050406030204" pitchFamily="18" charset="0"/>
                <a:ea typeface="Cambria" panose="02040503050406030204" pitchFamily="18" charset="0"/>
              </a:endParaRPr>
            </a:p>
          </p:txBody>
        </p:sp>
        <p:sp>
          <p:nvSpPr>
            <p:cNvPr id="18" name="TextBox 17"/>
            <p:cNvSpPr txBox="1"/>
            <p:nvPr/>
          </p:nvSpPr>
          <p:spPr>
            <a:xfrm>
              <a:off x="2512202" y="455614"/>
              <a:ext cx="884004" cy="441260"/>
            </a:xfrm>
            <a:prstGeom prst="rect">
              <a:avLst/>
            </a:prstGeom>
            <a:noFill/>
          </p:spPr>
          <p:txBody>
            <a:bodyPr wrap="none" rtlCol="0">
              <a:spAutoFit/>
            </a:bodyPr>
            <a:lstStyle/>
            <a:p>
              <a:r>
                <a:rPr lang="en-US" sz="1013" dirty="0">
                  <a:latin typeface="Cambria" panose="02040503050406030204" pitchFamily="18" charset="0"/>
                  <a:ea typeface="Cambria" panose="02040503050406030204" pitchFamily="18" charset="0"/>
                </a:rPr>
                <a:t>Wash</a:t>
              </a:r>
              <a:endParaRPr lang="en-GB" sz="1013" dirty="0">
                <a:latin typeface="Cambria" panose="02040503050406030204" pitchFamily="18" charset="0"/>
                <a:ea typeface="Cambria" panose="02040503050406030204" pitchFamily="18" charset="0"/>
              </a:endParaRPr>
            </a:p>
          </p:txBody>
        </p:sp>
        <p:sp>
          <p:nvSpPr>
            <p:cNvPr id="19" name="TextBox 18"/>
            <p:cNvSpPr txBox="1"/>
            <p:nvPr/>
          </p:nvSpPr>
          <p:spPr>
            <a:xfrm>
              <a:off x="5196604" y="1332627"/>
              <a:ext cx="972347" cy="441260"/>
            </a:xfrm>
            <a:prstGeom prst="rect">
              <a:avLst/>
            </a:prstGeom>
            <a:noFill/>
          </p:spPr>
          <p:txBody>
            <a:bodyPr wrap="none" rtlCol="0">
              <a:spAutoFit/>
            </a:bodyPr>
            <a:lstStyle/>
            <a:p>
              <a:r>
                <a:rPr lang="en-US" sz="1013" dirty="0">
                  <a:latin typeface="Cambria" panose="02040503050406030204" pitchFamily="18" charset="0"/>
                  <a:ea typeface="Cambria" panose="02040503050406030204" pitchFamily="18" charset="0"/>
                </a:rPr>
                <a:t>Lysate</a:t>
              </a:r>
              <a:endParaRPr lang="en-GB" sz="1013" dirty="0">
                <a:latin typeface="Cambria" panose="02040503050406030204" pitchFamily="18" charset="0"/>
                <a:ea typeface="Cambria" panose="02040503050406030204" pitchFamily="18" charset="0"/>
              </a:endParaRPr>
            </a:p>
          </p:txBody>
        </p:sp>
        <p:sp>
          <p:nvSpPr>
            <p:cNvPr id="20" name="TextBox 19"/>
            <p:cNvSpPr txBox="1"/>
            <p:nvPr/>
          </p:nvSpPr>
          <p:spPr>
            <a:xfrm>
              <a:off x="4934074" y="2392160"/>
              <a:ext cx="1054990" cy="656590"/>
            </a:xfrm>
            <a:prstGeom prst="rect">
              <a:avLst/>
            </a:prstGeom>
            <a:noFill/>
          </p:spPr>
          <p:txBody>
            <a:bodyPr wrap="none" rtlCol="0">
              <a:spAutoFit/>
            </a:bodyPr>
            <a:lstStyle/>
            <a:p>
              <a:r>
                <a:rPr lang="en-US" b="1" dirty="0">
                  <a:latin typeface="Cambria" panose="02040503050406030204" pitchFamily="18" charset="0"/>
                  <a:ea typeface="Cambria" panose="02040503050406030204" pitchFamily="18" charset="0"/>
                </a:rPr>
                <a:t>756</a:t>
              </a:r>
              <a:endParaRPr lang="en-GB" b="1" dirty="0">
                <a:latin typeface="Cambria" panose="02040503050406030204" pitchFamily="18" charset="0"/>
                <a:ea typeface="Cambria" panose="02040503050406030204" pitchFamily="18" charset="0"/>
              </a:endParaRPr>
            </a:p>
          </p:txBody>
        </p:sp>
        <p:sp>
          <p:nvSpPr>
            <p:cNvPr id="21" name="TextBox 20"/>
            <p:cNvSpPr txBox="1"/>
            <p:nvPr/>
          </p:nvSpPr>
          <p:spPr>
            <a:xfrm>
              <a:off x="4577897" y="1788338"/>
              <a:ext cx="584775" cy="441260"/>
            </a:xfrm>
            <a:prstGeom prst="rect">
              <a:avLst/>
            </a:prstGeom>
            <a:noFill/>
          </p:spPr>
          <p:txBody>
            <a:bodyPr wrap="none" rtlCol="0">
              <a:spAutoFit/>
            </a:bodyPr>
            <a:lstStyle/>
            <a:p>
              <a:r>
                <a:rPr lang="en-US" sz="1013" dirty="0">
                  <a:latin typeface="Cambria" panose="02040503050406030204" pitchFamily="18" charset="0"/>
                  <a:ea typeface="Cambria" panose="02040503050406030204" pitchFamily="18" charset="0"/>
                </a:rPr>
                <a:t>64</a:t>
              </a:r>
              <a:endParaRPr lang="en-GB" sz="1013" dirty="0">
                <a:latin typeface="Cambria" panose="02040503050406030204" pitchFamily="18" charset="0"/>
                <a:ea typeface="Cambria" panose="02040503050406030204" pitchFamily="18" charset="0"/>
              </a:endParaRPr>
            </a:p>
          </p:txBody>
        </p:sp>
        <p:sp>
          <p:nvSpPr>
            <p:cNvPr id="22" name="TextBox 21"/>
            <p:cNvSpPr txBox="1"/>
            <p:nvPr/>
          </p:nvSpPr>
          <p:spPr>
            <a:xfrm>
              <a:off x="3972666" y="1119762"/>
              <a:ext cx="584775" cy="441260"/>
            </a:xfrm>
            <a:prstGeom prst="rect">
              <a:avLst/>
            </a:prstGeom>
            <a:noFill/>
          </p:spPr>
          <p:txBody>
            <a:bodyPr wrap="none" rtlCol="0">
              <a:spAutoFit/>
            </a:bodyPr>
            <a:lstStyle/>
            <a:p>
              <a:r>
                <a:rPr lang="en-US" sz="1013" dirty="0">
                  <a:latin typeface="Cambria" panose="02040503050406030204" pitchFamily="18" charset="0"/>
                  <a:ea typeface="Cambria" panose="02040503050406030204" pitchFamily="18" charset="0"/>
                </a:rPr>
                <a:t>47</a:t>
              </a:r>
              <a:endParaRPr lang="en-GB" sz="1013" dirty="0">
                <a:latin typeface="Cambria" panose="02040503050406030204" pitchFamily="18" charset="0"/>
                <a:ea typeface="Cambria" panose="02040503050406030204" pitchFamily="18" charset="0"/>
              </a:endParaRPr>
            </a:p>
          </p:txBody>
        </p:sp>
        <p:sp>
          <p:nvSpPr>
            <p:cNvPr id="23" name="TextBox 22"/>
            <p:cNvSpPr txBox="1"/>
            <p:nvPr/>
          </p:nvSpPr>
          <p:spPr>
            <a:xfrm>
              <a:off x="2653214" y="1162498"/>
              <a:ext cx="584775" cy="441260"/>
            </a:xfrm>
            <a:prstGeom prst="rect">
              <a:avLst/>
            </a:prstGeom>
            <a:noFill/>
          </p:spPr>
          <p:txBody>
            <a:bodyPr wrap="none" rtlCol="0">
              <a:spAutoFit/>
            </a:bodyPr>
            <a:lstStyle/>
            <a:p>
              <a:r>
                <a:rPr lang="en-US" sz="1013" dirty="0">
                  <a:latin typeface="Cambria" panose="02040503050406030204" pitchFamily="18" charset="0"/>
                  <a:ea typeface="Cambria" panose="02040503050406030204" pitchFamily="18" charset="0"/>
                </a:rPr>
                <a:t>61</a:t>
              </a:r>
              <a:endParaRPr lang="en-GB" sz="1013" dirty="0">
                <a:latin typeface="Cambria" panose="02040503050406030204" pitchFamily="18" charset="0"/>
                <a:ea typeface="Cambria" panose="02040503050406030204" pitchFamily="18" charset="0"/>
              </a:endParaRPr>
            </a:p>
          </p:txBody>
        </p:sp>
        <p:sp>
          <p:nvSpPr>
            <p:cNvPr id="24" name="TextBox 23"/>
            <p:cNvSpPr txBox="1"/>
            <p:nvPr/>
          </p:nvSpPr>
          <p:spPr>
            <a:xfrm>
              <a:off x="2070951" y="1788338"/>
              <a:ext cx="584775" cy="441260"/>
            </a:xfrm>
            <a:prstGeom prst="rect">
              <a:avLst/>
            </a:prstGeom>
            <a:noFill/>
          </p:spPr>
          <p:txBody>
            <a:bodyPr wrap="none" rtlCol="0">
              <a:spAutoFit/>
            </a:bodyPr>
            <a:lstStyle/>
            <a:p>
              <a:r>
                <a:rPr lang="en-US" sz="1013" dirty="0">
                  <a:latin typeface="Cambria" panose="02040503050406030204" pitchFamily="18" charset="0"/>
                  <a:ea typeface="Cambria" panose="02040503050406030204" pitchFamily="18" charset="0"/>
                </a:rPr>
                <a:t>34</a:t>
              </a:r>
              <a:endParaRPr lang="en-GB" sz="1013" dirty="0">
                <a:latin typeface="Cambria" panose="02040503050406030204" pitchFamily="18" charset="0"/>
                <a:ea typeface="Cambria" panose="02040503050406030204" pitchFamily="18" charset="0"/>
              </a:endParaRPr>
            </a:p>
          </p:txBody>
        </p:sp>
        <p:sp>
          <p:nvSpPr>
            <p:cNvPr id="25" name="TextBox 24"/>
            <p:cNvSpPr txBox="1"/>
            <p:nvPr/>
          </p:nvSpPr>
          <p:spPr>
            <a:xfrm>
              <a:off x="1387278" y="2492864"/>
              <a:ext cx="584775" cy="441260"/>
            </a:xfrm>
            <a:prstGeom prst="rect">
              <a:avLst/>
            </a:prstGeom>
            <a:noFill/>
          </p:spPr>
          <p:txBody>
            <a:bodyPr wrap="none" rtlCol="0">
              <a:spAutoFit/>
            </a:bodyPr>
            <a:lstStyle/>
            <a:p>
              <a:r>
                <a:rPr lang="en-US" sz="1013" dirty="0">
                  <a:latin typeface="Cambria" panose="02040503050406030204" pitchFamily="18" charset="0"/>
                  <a:ea typeface="Cambria" panose="02040503050406030204" pitchFamily="18" charset="0"/>
                </a:rPr>
                <a:t>16</a:t>
              </a:r>
              <a:endParaRPr lang="en-GB" sz="1013" dirty="0">
                <a:latin typeface="Cambria" panose="02040503050406030204" pitchFamily="18" charset="0"/>
                <a:ea typeface="Cambria" panose="02040503050406030204" pitchFamily="18" charset="0"/>
              </a:endParaRPr>
            </a:p>
          </p:txBody>
        </p:sp>
        <p:sp>
          <p:nvSpPr>
            <p:cNvPr id="26" name="TextBox 25"/>
            <p:cNvSpPr txBox="1"/>
            <p:nvPr/>
          </p:nvSpPr>
          <p:spPr>
            <a:xfrm>
              <a:off x="3242497" y="1606610"/>
              <a:ext cx="584775" cy="441260"/>
            </a:xfrm>
            <a:prstGeom prst="rect">
              <a:avLst/>
            </a:prstGeom>
            <a:noFill/>
          </p:spPr>
          <p:txBody>
            <a:bodyPr wrap="none" rtlCol="0">
              <a:spAutoFit/>
            </a:bodyPr>
            <a:lstStyle/>
            <a:p>
              <a:pPr algn="ctr"/>
              <a:r>
                <a:rPr lang="en-US" sz="1013" dirty="0">
                  <a:latin typeface="Cambria" panose="02040503050406030204" pitchFamily="18" charset="0"/>
                  <a:ea typeface="Cambria" panose="02040503050406030204" pitchFamily="18" charset="0"/>
                </a:rPr>
                <a:t>49</a:t>
              </a:r>
              <a:endParaRPr lang="en-GB" sz="1013" dirty="0">
                <a:latin typeface="Cambria" panose="02040503050406030204" pitchFamily="18" charset="0"/>
                <a:ea typeface="Cambria" panose="02040503050406030204" pitchFamily="18" charset="0"/>
              </a:endParaRPr>
            </a:p>
          </p:txBody>
        </p:sp>
        <p:sp>
          <p:nvSpPr>
            <p:cNvPr id="27" name="TextBox 26"/>
            <p:cNvSpPr txBox="1"/>
            <p:nvPr/>
          </p:nvSpPr>
          <p:spPr>
            <a:xfrm>
              <a:off x="2600321" y="2254007"/>
              <a:ext cx="713017" cy="441260"/>
            </a:xfrm>
            <a:prstGeom prst="rect">
              <a:avLst/>
            </a:prstGeom>
            <a:noFill/>
          </p:spPr>
          <p:txBody>
            <a:bodyPr wrap="none" rtlCol="0">
              <a:spAutoFit/>
            </a:bodyPr>
            <a:lstStyle/>
            <a:p>
              <a:r>
                <a:rPr lang="en-US" sz="1013" dirty="0">
                  <a:latin typeface="Cambria" panose="02040503050406030204" pitchFamily="18" charset="0"/>
                  <a:ea typeface="Cambria" panose="02040503050406030204" pitchFamily="18" charset="0"/>
                </a:rPr>
                <a:t>216</a:t>
              </a:r>
              <a:endParaRPr lang="en-GB" sz="1013" dirty="0">
                <a:latin typeface="Cambria" panose="02040503050406030204" pitchFamily="18" charset="0"/>
                <a:ea typeface="Cambria" panose="02040503050406030204" pitchFamily="18" charset="0"/>
              </a:endParaRPr>
            </a:p>
          </p:txBody>
        </p:sp>
        <p:sp>
          <p:nvSpPr>
            <p:cNvPr id="28" name="TextBox 27"/>
            <p:cNvSpPr txBox="1"/>
            <p:nvPr/>
          </p:nvSpPr>
          <p:spPr>
            <a:xfrm>
              <a:off x="2079770" y="3267556"/>
              <a:ext cx="584775" cy="441260"/>
            </a:xfrm>
            <a:prstGeom prst="rect">
              <a:avLst/>
            </a:prstGeom>
            <a:noFill/>
          </p:spPr>
          <p:txBody>
            <a:bodyPr wrap="none" rtlCol="0">
              <a:spAutoFit/>
            </a:bodyPr>
            <a:lstStyle/>
            <a:p>
              <a:r>
                <a:rPr lang="en-US" sz="1013" dirty="0">
                  <a:latin typeface="Cambria" panose="02040503050406030204" pitchFamily="18" charset="0"/>
                  <a:ea typeface="Cambria" panose="02040503050406030204" pitchFamily="18" charset="0"/>
                </a:rPr>
                <a:t>1</a:t>
              </a:r>
              <a:r>
                <a:rPr lang="en-GB" sz="1013" dirty="0">
                  <a:latin typeface="Cambria" panose="02040503050406030204" pitchFamily="18" charset="0"/>
                  <a:ea typeface="Cambria" panose="02040503050406030204" pitchFamily="18" charset="0"/>
                </a:rPr>
                <a:t>3</a:t>
              </a:r>
              <a:endParaRPr lang="en-US" sz="1013" dirty="0">
                <a:latin typeface="Cambria" panose="02040503050406030204" pitchFamily="18" charset="0"/>
                <a:ea typeface="Cambria" panose="02040503050406030204" pitchFamily="18" charset="0"/>
              </a:endParaRPr>
            </a:p>
          </p:txBody>
        </p:sp>
        <p:sp>
          <p:nvSpPr>
            <p:cNvPr id="29" name="TextBox 28"/>
            <p:cNvSpPr txBox="1"/>
            <p:nvPr/>
          </p:nvSpPr>
          <p:spPr>
            <a:xfrm>
              <a:off x="2643692" y="3788994"/>
              <a:ext cx="584775" cy="441260"/>
            </a:xfrm>
            <a:prstGeom prst="rect">
              <a:avLst/>
            </a:prstGeom>
            <a:noFill/>
          </p:spPr>
          <p:txBody>
            <a:bodyPr wrap="none" rtlCol="0">
              <a:spAutoFit/>
            </a:bodyPr>
            <a:lstStyle/>
            <a:p>
              <a:r>
                <a:rPr lang="en-US" sz="1013" dirty="0">
                  <a:latin typeface="Cambria" panose="02040503050406030204" pitchFamily="18" charset="0"/>
                  <a:ea typeface="Cambria" panose="02040503050406030204" pitchFamily="18" charset="0"/>
                </a:rPr>
                <a:t>10</a:t>
              </a:r>
              <a:endParaRPr lang="en-GB" sz="1013" dirty="0">
                <a:latin typeface="Cambria" panose="02040503050406030204" pitchFamily="18" charset="0"/>
                <a:ea typeface="Cambria" panose="02040503050406030204" pitchFamily="18" charset="0"/>
              </a:endParaRPr>
            </a:p>
          </p:txBody>
        </p:sp>
        <p:sp>
          <p:nvSpPr>
            <p:cNvPr id="30" name="TextBox 29"/>
            <p:cNvSpPr txBox="1"/>
            <p:nvPr/>
          </p:nvSpPr>
          <p:spPr>
            <a:xfrm>
              <a:off x="3021913" y="3049831"/>
              <a:ext cx="1054990" cy="656590"/>
            </a:xfrm>
            <a:prstGeom prst="rect">
              <a:avLst/>
            </a:prstGeom>
            <a:noFill/>
          </p:spPr>
          <p:txBody>
            <a:bodyPr wrap="none" rtlCol="0">
              <a:spAutoFit/>
            </a:bodyPr>
            <a:lstStyle/>
            <a:p>
              <a:pPr algn="ctr"/>
              <a:r>
                <a:rPr lang="en-US" b="1" dirty="0">
                  <a:latin typeface="Cambria" panose="02040503050406030204" pitchFamily="18" charset="0"/>
                  <a:ea typeface="Cambria" panose="02040503050406030204" pitchFamily="18" charset="0"/>
                </a:rPr>
                <a:t>533</a:t>
              </a:r>
              <a:endParaRPr lang="en-GB" sz="1013" b="1" dirty="0">
                <a:latin typeface="Cambria" panose="02040503050406030204" pitchFamily="18" charset="0"/>
                <a:ea typeface="Cambria" panose="02040503050406030204" pitchFamily="18" charset="0"/>
              </a:endParaRPr>
            </a:p>
          </p:txBody>
        </p:sp>
        <p:sp>
          <p:nvSpPr>
            <p:cNvPr id="31" name="TextBox 30"/>
            <p:cNvSpPr txBox="1"/>
            <p:nvPr/>
          </p:nvSpPr>
          <p:spPr>
            <a:xfrm>
              <a:off x="3972666" y="2254007"/>
              <a:ext cx="584775" cy="441260"/>
            </a:xfrm>
            <a:prstGeom prst="rect">
              <a:avLst/>
            </a:prstGeom>
            <a:noFill/>
          </p:spPr>
          <p:txBody>
            <a:bodyPr wrap="none" rtlCol="0">
              <a:spAutoFit/>
            </a:bodyPr>
            <a:lstStyle/>
            <a:p>
              <a:r>
                <a:rPr lang="en-US" sz="1013" dirty="0">
                  <a:latin typeface="Cambria" panose="02040503050406030204" pitchFamily="18" charset="0"/>
                  <a:ea typeface="Cambria" panose="02040503050406030204" pitchFamily="18" charset="0"/>
                </a:rPr>
                <a:t>65</a:t>
              </a:r>
              <a:endParaRPr lang="en-GB" sz="1013" dirty="0">
                <a:latin typeface="Cambria" panose="02040503050406030204" pitchFamily="18" charset="0"/>
                <a:ea typeface="Cambria" panose="02040503050406030204" pitchFamily="18" charset="0"/>
              </a:endParaRPr>
            </a:p>
          </p:txBody>
        </p:sp>
        <p:sp>
          <p:nvSpPr>
            <p:cNvPr id="32" name="TextBox 31"/>
            <p:cNvSpPr txBox="1"/>
            <p:nvPr/>
          </p:nvSpPr>
          <p:spPr>
            <a:xfrm>
              <a:off x="4577897" y="3258635"/>
              <a:ext cx="584775" cy="441260"/>
            </a:xfrm>
            <a:prstGeom prst="rect">
              <a:avLst/>
            </a:prstGeom>
            <a:noFill/>
          </p:spPr>
          <p:txBody>
            <a:bodyPr wrap="none" rtlCol="0">
              <a:spAutoFit/>
            </a:bodyPr>
            <a:lstStyle/>
            <a:p>
              <a:r>
                <a:rPr lang="en-US" sz="1013" dirty="0">
                  <a:latin typeface="Cambria" panose="02040503050406030204" pitchFamily="18" charset="0"/>
                  <a:ea typeface="Cambria" panose="02040503050406030204" pitchFamily="18" charset="0"/>
                </a:rPr>
                <a:t>32</a:t>
              </a:r>
              <a:endParaRPr lang="en-GB" sz="1013" dirty="0">
                <a:latin typeface="Cambria" panose="02040503050406030204" pitchFamily="18" charset="0"/>
                <a:ea typeface="Cambria" panose="02040503050406030204" pitchFamily="18" charset="0"/>
              </a:endParaRPr>
            </a:p>
          </p:txBody>
        </p:sp>
        <p:sp>
          <p:nvSpPr>
            <p:cNvPr id="33" name="TextBox 32"/>
            <p:cNvSpPr txBox="1"/>
            <p:nvPr/>
          </p:nvSpPr>
          <p:spPr>
            <a:xfrm>
              <a:off x="3972666" y="3785540"/>
              <a:ext cx="584775" cy="441260"/>
            </a:xfrm>
            <a:prstGeom prst="rect">
              <a:avLst/>
            </a:prstGeom>
            <a:noFill/>
          </p:spPr>
          <p:txBody>
            <a:bodyPr wrap="none" rtlCol="0">
              <a:spAutoFit/>
            </a:bodyPr>
            <a:lstStyle/>
            <a:p>
              <a:r>
                <a:rPr lang="en-US" sz="1013" dirty="0">
                  <a:latin typeface="Cambria" panose="02040503050406030204" pitchFamily="18" charset="0"/>
                  <a:ea typeface="Cambria" panose="02040503050406030204" pitchFamily="18" charset="0"/>
                </a:rPr>
                <a:t>18</a:t>
              </a:r>
              <a:endParaRPr lang="en-GB" sz="1013" dirty="0">
                <a:latin typeface="Cambria" panose="02040503050406030204" pitchFamily="18" charset="0"/>
                <a:ea typeface="Cambria" panose="02040503050406030204" pitchFamily="18" charset="0"/>
              </a:endParaRPr>
            </a:p>
          </p:txBody>
        </p:sp>
        <p:sp>
          <p:nvSpPr>
            <p:cNvPr id="34" name="TextBox 33"/>
            <p:cNvSpPr txBox="1"/>
            <p:nvPr/>
          </p:nvSpPr>
          <p:spPr>
            <a:xfrm>
              <a:off x="3169361" y="4310973"/>
              <a:ext cx="731051" cy="441260"/>
            </a:xfrm>
            <a:prstGeom prst="rect">
              <a:avLst/>
            </a:prstGeom>
            <a:noFill/>
          </p:spPr>
          <p:txBody>
            <a:bodyPr wrap="square" rtlCol="0">
              <a:spAutoFit/>
            </a:bodyPr>
            <a:lstStyle/>
            <a:p>
              <a:pPr algn="ctr"/>
              <a:r>
                <a:rPr lang="en-US" sz="1013" dirty="0">
                  <a:latin typeface="Cambria" panose="02040503050406030204" pitchFamily="18" charset="0"/>
                  <a:ea typeface="Cambria" panose="02040503050406030204" pitchFamily="18" charset="0"/>
                </a:rPr>
                <a:t>8</a:t>
              </a:r>
              <a:endParaRPr lang="en-GB" sz="1013" dirty="0">
                <a:latin typeface="Cambria" panose="02040503050406030204" pitchFamily="18" charset="0"/>
                <a:ea typeface="Cambria" panose="02040503050406030204" pitchFamily="18" charset="0"/>
              </a:endParaRPr>
            </a:p>
          </p:txBody>
        </p:sp>
      </p:grpSp>
      <p:sp>
        <p:nvSpPr>
          <p:cNvPr id="43" name="TextBox 42"/>
          <p:cNvSpPr txBox="1"/>
          <p:nvPr/>
        </p:nvSpPr>
        <p:spPr>
          <a:xfrm>
            <a:off x="222069" y="515566"/>
            <a:ext cx="6305191" cy="1231106"/>
          </a:xfrm>
          <a:prstGeom prst="rect">
            <a:avLst/>
          </a:prstGeom>
          <a:noFill/>
        </p:spPr>
        <p:txBody>
          <a:bodyPr wrap="square" rtlCol="0">
            <a:spAutoFit/>
          </a:bodyPr>
          <a:lstStyle/>
          <a:p>
            <a:r>
              <a:rPr lang="en-US" b="1" dirty="0" smtClean="0">
                <a:latin typeface="Cambria" panose="02040503050406030204" pitchFamily="18" charset="0"/>
                <a:ea typeface="Cambria" panose="02040503050406030204" pitchFamily="18" charset="0"/>
              </a:rPr>
              <a:t>Figure S2</a:t>
            </a:r>
          </a:p>
          <a:p>
            <a:pPr algn="just"/>
            <a:r>
              <a:rPr lang="en-US" sz="1400" dirty="0" smtClean="0">
                <a:latin typeface="Cambria" panose="02040503050406030204" pitchFamily="18" charset="0"/>
                <a:ea typeface="Cambria" panose="02040503050406030204" pitchFamily="18" charset="0"/>
              </a:rPr>
              <a:t>Venn diagram depicting the overlap of protein identifications between the individual fractions collected during the enrichment of </a:t>
            </a:r>
            <a:r>
              <a:rPr lang="en-US" sz="1400" dirty="0" err="1" smtClean="0">
                <a:latin typeface="Cambria" panose="02040503050406030204" pitchFamily="18" charset="0"/>
                <a:ea typeface="Cambria" panose="02040503050406030204" pitchFamily="18" charset="0"/>
              </a:rPr>
              <a:t>rEVs</a:t>
            </a:r>
            <a:r>
              <a:rPr lang="en-US" sz="1400" dirty="0" smtClean="0">
                <a:latin typeface="Cambria" panose="02040503050406030204" pitchFamily="18" charset="0"/>
                <a:ea typeface="Cambria" panose="02040503050406030204" pitchFamily="18" charset="0"/>
              </a:rPr>
              <a:t> from conditioned medium containing 10% EV-depleted FBS using 0.1% TWEEN-20 in the wash buffer. 756 proteins were uniquely identified in the lysate fraction.</a:t>
            </a:r>
            <a:endParaRPr lang="en-GB" sz="1400" dirty="0">
              <a:latin typeface="Cambria" panose="02040503050406030204" pitchFamily="18" charset="0"/>
              <a:ea typeface="Cambria" panose="02040503050406030204" pitchFamily="18" charset="0"/>
            </a:endParaRPr>
          </a:p>
        </p:txBody>
      </p:sp>
    </p:spTree>
    <p:extLst>
      <p:ext uri="{BB962C8B-B14F-4D97-AF65-F5344CB8AC3E}">
        <p14:creationId xmlns:p14="http://schemas.microsoft.com/office/powerpoint/2010/main" val="375359138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23734" y="1383144"/>
            <a:ext cx="6196519" cy="2840952"/>
          </a:xfrm>
          <a:prstGeom prst="rect">
            <a:avLst/>
          </a:prstGeom>
        </p:spPr>
      </p:pic>
      <p:pic>
        <p:nvPicPr>
          <p:cNvPr id="3" name="Picture 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223735" y="4224096"/>
            <a:ext cx="6196519" cy="2840952"/>
          </a:xfrm>
          <a:prstGeom prst="rect">
            <a:avLst/>
          </a:prstGeom>
        </p:spPr>
      </p:pic>
      <p:pic>
        <p:nvPicPr>
          <p:cNvPr id="4" name="Picture 3"/>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223736" y="7065048"/>
            <a:ext cx="6196519" cy="2840952"/>
          </a:xfrm>
          <a:prstGeom prst="rect">
            <a:avLst/>
          </a:prstGeom>
        </p:spPr>
      </p:pic>
      <p:sp>
        <p:nvSpPr>
          <p:cNvPr id="5" name="TextBox 4"/>
          <p:cNvSpPr txBox="1"/>
          <p:nvPr/>
        </p:nvSpPr>
        <p:spPr>
          <a:xfrm>
            <a:off x="223736" y="126460"/>
            <a:ext cx="6556443" cy="1015663"/>
          </a:xfrm>
          <a:prstGeom prst="rect">
            <a:avLst/>
          </a:prstGeom>
          <a:noFill/>
        </p:spPr>
        <p:txBody>
          <a:bodyPr wrap="square" rtlCol="0">
            <a:spAutoFit/>
          </a:bodyPr>
          <a:lstStyle/>
          <a:p>
            <a:r>
              <a:rPr lang="en-US" b="1" dirty="0" smtClean="0">
                <a:latin typeface="Cambria" panose="02040503050406030204" pitchFamily="18" charset="0"/>
                <a:ea typeface="Cambria" panose="02040503050406030204" pitchFamily="18" charset="0"/>
              </a:rPr>
              <a:t>Figure S3</a:t>
            </a:r>
          </a:p>
          <a:p>
            <a:r>
              <a:rPr lang="en-US" sz="1400" dirty="0">
                <a:latin typeface="Cambria" panose="02040503050406030204" pitchFamily="18" charset="0"/>
                <a:ea typeface="Cambria" panose="02040503050406030204" pitchFamily="18" charset="0"/>
              </a:rPr>
              <a:t>Top 5 Gene ontology </a:t>
            </a:r>
            <a:r>
              <a:rPr lang="en-US" sz="1400" dirty="0" smtClean="0">
                <a:latin typeface="Cambria" panose="02040503050406030204" pitchFamily="18" charset="0"/>
                <a:ea typeface="Cambria" panose="02040503050406030204" pitchFamily="18" charset="0"/>
              </a:rPr>
              <a:t>terms (String DB) </a:t>
            </a:r>
            <a:r>
              <a:rPr lang="en-US" sz="1400" dirty="0">
                <a:latin typeface="Cambria" panose="02040503050406030204" pitchFamily="18" charset="0"/>
                <a:ea typeface="Cambria" panose="02040503050406030204" pitchFamily="18" charset="0"/>
              </a:rPr>
              <a:t>associated with proteins uniquely identified in the lysate fractions (n = </a:t>
            </a:r>
            <a:r>
              <a:rPr lang="en-US" sz="1400" dirty="0" smtClean="0">
                <a:latin typeface="Cambria" panose="02040503050406030204" pitchFamily="18" charset="0"/>
                <a:ea typeface="Cambria" panose="02040503050406030204" pitchFamily="18" charset="0"/>
              </a:rPr>
              <a:t>550) </a:t>
            </a:r>
            <a:r>
              <a:rPr lang="en-US" sz="1400" dirty="0">
                <a:latin typeface="Cambria" panose="02040503050406030204" pitchFamily="18" charset="0"/>
                <a:ea typeface="Cambria" panose="02040503050406030204" pitchFamily="18" charset="0"/>
              </a:rPr>
              <a:t>in comparison to the input, loading and wash fractions.</a:t>
            </a:r>
            <a:endParaRPr lang="en-GB" sz="1400" dirty="0">
              <a:latin typeface="Cambria" panose="02040503050406030204" pitchFamily="18" charset="0"/>
              <a:ea typeface="Cambria" panose="02040503050406030204" pitchFamily="18" charset="0"/>
            </a:endParaRPr>
          </a:p>
        </p:txBody>
      </p:sp>
    </p:spTree>
    <p:extLst>
      <p:ext uri="{BB962C8B-B14F-4D97-AF65-F5344CB8AC3E}">
        <p14:creationId xmlns:p14="http://schemas.microsoft.com/office/powerpoint/2010/main" val="359390205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521426" y="235131"/>
            <a:ext cx="6282146" cy="923330"/>
          </a:xfrm>
          <a:prstGeom prst="rect">
            <a:avLst/>
          </a:prstGeom>
          <a:noFill/>
        </p:spPr>
        <p:txBody>
          <a:bodyPr wrap="square" rtlCol="0">
            <a:spAutoFit/>
          </a:bodyPr>
          <a:lstStyle/>
          <a:p>
            <a:r>
              <a:rPr lang="en-US" b="1" dirty="0">
                <a:latin typeface="Cambria" panose="02040503050406030204" pitchFamily="18" charset="0"/>
                <a:ea typeface="Cambria" panose="02040503050406030204" pitchFamily="18" charset="0"/>
              </a:rPr>
              <a:t>Figure S4: </a:t>
            </a:r>
          </a:p>
          <a:p>
            <a:r>
              <a:rPr lang="en-US" sz="1200" dirty="0" smtClean="0">
                <a:latin typeface="Cambria" panose="02040503050406030204" pitchFamily="18" charset="0"/>
                <a:ea typeface="Cambria" panose="02040503050406030204" pitchFamily="18" charset="0"/>
              </a:rPr>
              <a:t>NTA characterization and TEM visualization of the retained rEV particles using FAEVEr 96well with different percentages of TWEEN-20 in the wash buffer and ultracentrifugation as a reference. The average size is visualized by the dotted line and indicated at the x-axis.</a:t>
            </a:r>
            <a:endParaRPr lang="en-GB" sz="1200" dirty="0">
              <a:latin typeface="Cambria" panose="02040503050406030204" pitchFamily="18" charset="0"/>
              <a:ea typeface="Cambria" panose="02040503050406030204" pitchFamily="18" charset="0"/>
            </a:endParaRPr>
          </a:p>
        </p:txBody>
      </p:sp>
      <p:grpSp>
        <p:nvGrpSpPr>
          <p:cNvPr id="4" name="Group 3"/>
          <p:cNvGrpSpPr/>
          <p:nvPr/>
        </p:nvGrpSpPr>
        <p:grpSpPr>
          <a:xfrm>
            <a:off x="521426" y="1745217"/>
            <a:ext cx="5867400" cy="7920328"/>
            <a:chOff x="521426" y="1052886"/>
            <a:chExt cx="5867400" cy="7920328"/>
          </a:xfrm>
        </p:grpSpPr>
        <p:graphicFrame>
          <p:nvGraphicFramePr>
            <p:cNvPr id="2" name="Object 1"/>
            <p:cNvGraphicFramePr>
              <a:graphicFrameLocks noChangeAspect="1"/>
            </p:cNvGraphicFramePr>
            <p:nvPr>
              <p:extLst>
                <p:ext uri="{D42A27DB-BD31-4B8C-83A1-F6EECF244321}">
                  <p14:modId xmlns:p14="http://schemas.microsoft.com/office/powerpoint/2010/main" val="1066946692"/>
                </p:ext>
              </p:extLst>
            </p:nvPr>
          </p:nvGraphicFramePr>
          <p:xfrm>
            <a:off x="521426" y="1052886"/>
            <a:ext cx="5867400" cy="7702550"/>
          </p:xfrm>
          <a:graphic>
            <a:graphicData uri="http://schemas.openxmlformats.org/presentationml/2006/ole">
              <mc:AlternateContent xmlns:mc="http://schemas.openxmlformats.org/markup-compatibility/2006">
                <mc:Choice xmlns:v="urn:schemas-microsoft-com:vml" Requires="v">
                  <p:oleObj spid="_x0000_s8227" name="Prism 10" r:id="rId3" imgW="7030987" imgH="9239135" progId="Prism10.Document">
                    <p:embed/>
                  </p:oleObj>
                </mc:Choice>
                <mc:Fallback>
                  <p:oleObj name="Prism 10" r:id="rId3" imgW="7030987" imgH="9239135" progId="Prism10.Document">
                    <p:embed/>
                    <p:pic>
                      <p:nvPicPr>
                        <p:cNvPr id="0" name=""/>
                        <p:cNvPicPr/>
                        <p:nvPr/>
                      </p:nvPicPr>
                      <p:blipFill>
                        <a:blip r:embed="rId4"/>
                        <a:stretch>
                          <a:fillRect/>
                        </a:stretch>
                      </p:blipFill>
                      <p:spPr>
                        <a:xfrm>
                          <a:off x="521426" y="1052886"/>
                          <a:ext cx="5867400" cy="7702550"/>
                        </a:xfrm>
                        <a:prstGeom prst="rect">
                          <a:avLst/>
                        </a:prstGeom>
                      </p:spPr>
                    </p:pic>
                  </p:oleObj>
                </mc:Fallback>
              </mc:AlternateContent>
            </a:graphicData>
          </a:graphic>
        </p:graphicFrame>
        <p:grpSp>
          <p:nvGrpSpPr>
            <p:cNvPr id="35" name="Group 34"/>
            <p:cNvGrpSpPr/>
            <p:nvPr/>
          </p:nvGrpSpPr>
          <p:grpSpPr>
            <a:xfrm>
              <a:off x="2779842" y="5962801"/>
              <a:ext cx="3044791" cy="3010413"/>
              <a:chOff x="2964668" y="6293541"/>
              <a:chExt cx="3044791" cy="3010413"/>
            </a:xfrm>
          </p:grpSpPr>
          <p:grpSp>
            <p:nvGrpSpPr>
              <p:cNvPr id="12" name="Group 11"/>
              <p:cNvGrpSpPr/>
              <p:nvPr/>
            </p:nvGrpSpPr>
            <p:grpSpPr>
              <a:xfrm>
                <a:off x="4569459" y="6293541"/>
                <a:ext cx="1440000" cy="1440000"/>
                <a:chOff x="7410028" y="3165997"/>
                <a:chExt cx="1440000" cy="1440000"/>
              </a:xfrm>
            </p:grpSpPr>
            <p:pic>
              <p:nvPicPr>
                <p:cNvPr id="13" name="Picture 12"/>
                <p:cNvPicPr>
                  <a:picLocks noChangeAspect="1"/>
                </p:cNvPicPr>
                <p:nvPr/>
              </p:nvPicPr>
              <p:blipFill>
                <a:blip r:embed="rId5" cstate="print">
                  <a:extLst>
                    <a:ext uri="{28A0092B-C50C-407E-A947-70E740481C1C}">
                      <a14:useLocalDpi xmlns:a14="http://schemas.microsoft.com/office/drawing/2010/main" val="0"/>
                    </a:ext>
                  </a:extLst>
                </a:blip>
                <a:srcRect l="30947" t="40097" r="42458" b="24442"/>
                <a:stretch>
                  <a:fillRect/>
                </a:stretch>
              </p:blipFill>
              <p:spPr>
                <a:xfrm>
                  <a:off x="7410028" y="3165997"/>
                  <a:ext cx="1440000" cy="1440000"/>
                </a:xfrm>
                <a:custGeom>
                  <a:avLst/>
                  <a:gdLst>
                    <a:gd name="connsiteX0" fmla="*/ 0 w 2160000"/>
                    <a:gd name="connsiteY0" fmla="*/ 0 h 2160000"/>
                    <a:gd name="connsiteX1" fmla="*/ 2160000 w 2160000"/>
                    <a:gd name="connsiteY1" fmla="*/ 0 h 2160000"/>
                    <a:gd name="connsiteX2" fmla="*/ 2160000 w 2160000"/>
                    <a:gd name="connsiteY2" fmla="*/ 2160000 h 2160000"/>
                    <a:gd name="connsiteX3" fmla="*/ 0 w 2160000"/>
                    <a:gd name="connsiteY3" fmla="*/ 2160000 h 2160000"/>
                  </a:gdLst>
                  <a:ahLst/>
                  <a:cxnLst>
                    <a:cxn ang="0">
                      <a:pos x="connsiteX0" y="connsiteY0"/>
                    </a:cxn>
                    <a:cxn ang="0">
                      <a:pos x="connsiteX1" y="connsiteY1"/>
                    </a:cxn>
                    <a:cxn ang="0">
                      <a:pos x="connsiteX2" y="connsiteY2"/>
                    </a:cxn>
                    <a:cxn ang="0">
                      <a:pos x="connsiteX3" y="connsiteY3"/>
                    </a:cxn>
                  </a:cxnLst>
                  <a:rect l="l" t="t" r="r" b="b"/>
                  <a:pathLst>
                    <a:path w="2160000" h="2160000">
                      <a:moveTo>
                        <a:pt x="0" y="0"/>
                      </a:moveTo>
                      <a:lnTo>
                        <a:pt x="2160000" y="0"/>
                      </a:lnTo>
                      <a:lnTo>
                        <a:pt x="2160000" y="2160000"/>
                      </a:lnTo>
                      <a:lnTo>
                        <a:pt x="0" y="2160000"/>
                      </a:lnTo>
                      <a:close/>
                    </a:path>
                  </a:pathLst>
                </a:custGeom>
                <a:ln w="28575">
                  <a:solidFill>
                    <a:srgbClr val="53ACB7"/>
                  </a:solidFill>
                </a:ln>
              </p:spPr>
            </p:pic>
            <p:pic>
              <p:nvPicPr>
                <p:cNvPr id="14" name="Picture 13"/>
                <p:cNvPicPr>
                  <a:picLocks noChangeAspect="1"/>
                </p:cNvPicPr>
                <p:nvPr/>
              </p:nvPicPr>
              <p:blipFill>
                <a:blip r:embed="rId5" cstate="print">
                  <a:extLst>
                    <a:ext uri="{28A0092B-C50C-407E-A947-70E740481C1C}">
                      <a14:useLocalDpi xmlns:a14="http://schemas.microsoft.com/office/drawing/2010/main" val="0"/>
                    </a:ext>
                  </a:extLst>
                </a:blip>
                <a:srcRect l="71180" t="96878" r="6658" b="167"/>
                <a:stretch>
                  <a:fillRect/>
                </a:stretch>
              </p:blipFill>
              <p:spPr>
                <a:xfrm>
                  <a:off x="7650028" y="4485997"/>
                  <a:ext cx="1200000" cy="120000"/>
                </a:xfrm>
                <a:custGeom>
                  <a:avLst/>
                  <a:gdLst>
                    <a:gd name="connsiteX0" fmla="*/ 0 w 1800000"/>
                    <a:gd name="connsiteY0" fmla="*/ 0 h 180000"/>
                    <a:gd name="connsiteX1" fmla="*/ 1800000 w 1800000"/>
                    <a:gd name="connsiteY1" fmla="*/ 0 h 180000"/>
                    <a:gd name="connsiteX2" fmla="*/ 1800000 w 1800000"/>
                    <a:gd name="connsiteY2" fmla="*/ 180000 h 180000"/>
                    <a:gd name="connsiteX3" fmla="*/ 0 w 1800000"/>
                    <a:gd name="connsiteY3" fmla="*/ 180000 h 180000"/>
                  </a:gdLst>
                  <a:ahLst/>
                  <a:cxnLst>
                    <a:cxn ang="0">
                      <a:pos x="connsiteX0" y="connsiteY0"/>
                    </a:cxn>
                    <a:cxn ang="0">
                      <a:pos x="connsiteX1" y="connsiteY1"/>
                    </a:cxn>
                    <a:cxn ang="0">
                      <a:pos x="connsiteX2" y="connsiteY2"/>
                    </a:cxn>
                    <a:cxn ang="0">
                      <a:pos x="connsiteX3" y="connsiteY3"/>
                    </a:cxn>
                  </a:cxnLst>
                  <a:rect l="l" t="t" r="r" b="b"/>
                  <a:pathLst>
                    <a:path w="1800000" h="180000">
                      <a:moveTo>
                        <a:pt x="0" y="0"/>
                      </a:moveTo>
                      <a:lnTo>
                        <a:pt x="1800000" y="0"/>
                      </a:lnTo>
                      <a:lnTo>
                        <a:pt x="1800000" y="180000"/>
                      </a:lnTo>
                      <a:lnTo>
                        <a:pt x="0" y="180000"/>
                      </a:lnTo>
                      <a:close/>
                    </a:path>
                  </a:pathLst>
                </a:custGeom>
              </p:spPr>
            </p:pic>
            <p:sp>
              <p:nvSpPr>
                <p:cNvPr id="15" name="TextBox 14"/>
                <p:cNvSpPr txBox="1"/>
                <p:nvPr/>
              </p:nvSpPr>
              <p:spPr>
                <a:xfrm>
                  <a:off x="8051933" y="4335595"/>
                  <a:ext cx="655949" cy="261610"/>
                </a:xfrm>
                <a:prstGeom prst="rect">
                  <a:avLst/>
                </a:prstGeom>
                <a:noFill/>
              </p:spPr>
              <p:txBody>
                <a:bodyPr wrap="none" rtlCol="0">
                  <a:spAutoFit/>
                </a:bodyPr>
                <a:lstStyle/>
                <a:p>
                  <a:r>
                    <a:rPr lang="en-US" sz="1100" dirty="0">
                      <a:solidFill>
                        <a:schemeClr val="bg1"/>
                      </a:solidFill>
                      <a:latin typeface="Bahnschrift" panose="020B0502040204020203" pitchFamily="34" charset="0"/>
                    </a:rPr>
                    <a:t>5</a:t>
                  </a:r>
                  <a:r>
                    <a:rPr lang="en-US" sz="1100" dirty="0" smtClean="0">
                      <a:solidFill>
                        <a:schemeClr val="bg1"/>
                      </a:solidFill>
                      <a:latin typeface="Bahnschrift" panose="020B0502040204020203" pitchFamily="34" charset="0"/>
                    </a:rPr>
                    <a:t>00 nm</a:t>
                  </a:r>
                  <a:endParaRPr lang="en-GB" sz="1100" dirty="0">
                    <a:solidFill>
                      <a:schemeClr val="bg1"/>
                    </a:solidFill>
                    <a:latin typeface="Bahnschrift" panose="020B0502040204020203" pitchFamily="34" charset="0"/>
                  </a:endParaRPr>
                </a:p>
              </p:txBody>
            </p:sp>
          </p:grpSp>
          <p:grpSp>
            <p:nvGrpSpPr>
              <p:cNvPr id="16" name="Group 15"/>
              <p:cNvGrpSpPr/>
              <p:nvPr/>
            </p:nvGrpSpPr>
            <p:grpSpPr>
              <a:xfrm>
                <a:off x="2964668" y="7863954"/>
                <a:ext cx="1440000" cy="1440000"/>
                <a:chOff x="7410028" y="4629696"/>
                <a:chExt cx="1440000" cy="1440000"/>
              </a:xfrm>
            </p:grpSpPr>
            <p:pic>
              <p:nvPicPr>
                <p:cNvPr id="17" name="Picture 16"/>
                <p:cNvPicPr>
                  <a:picLocks noChangeAspect="1"/>
                </p:cNvPicPr>
                <p:nvPr/>
              </p:nvPicPr>
              <p:blipFill rotWithShape="1">
                <a:blip r:embed="rId6" cstate="print">
                  <a:extLst>
                    <a:ext uri="{28A0092B-C50C-407E-A947-70E740481C1C}">
                      <a14:useLocalDpi xmlns:a14="http://schemas.microsoft.com/office/drawing/2010/main" val="0"/>
                    </a:ext>
                  </a:extLst>
                </a:blip>
                <a:srcRect l="18882" t="6858" r="36118" b="33142"/>
                <a:stretch/>
              </p:blipFill>
              <p:spPr>
                <a:xfrm>
                  <a:off x="7410028" y="4629696"/>
                  <a:ext cx="1440000" cy="1440000"/>
                </a:xfrm>
                <a:custGeom>
                  <a:avLst/>
                  <a:gdLst>
                    <a:gd name="connsiteX0" fmla="*/ 0 w 2160000"/>
                    <a:gd name="connsiteY0" fmla="*/ 0 h 2160000"/>
                    <a:gd name="connsiteX1" fmla="*/ 2160000 w 2160000"/>
                    <a:gd name="connsiteY1" fmla="*/ 0 h 2160000"/>
                    <a:gd name="connsiteX2" fmla="*/ 2160000 w 2160000"/>
                    <a:gd name="connsiteY2" fmla="*/ 2160000 h 2160000"/>
                    <a:gd name="connsiteX3" fmla="*/ 0 w 2160000"/>
                    <a:gd name="connsiteY3" fmla="*/ 2160000 h 2160000"/>
                  </a:gdLst>
                  <a:ahLst/>
                  <a:cxnLst>
                    <a:cxn ang="0">
                      <a:pos x="connsiteX0" y="connsiteY0"/>
                    </a:cxn>
                    <a:cxn ang="0">
                      <a:pos x="connsiteX1" y="connsiteY1"/>
                    </a:cxn>
                    <a:cxn ang="0">
                      <a:pos x="connsiteX2" y="connsiteY2"/>
                    </a:cxn>
                    <a:cxn ang="0">
                      <a:pos x="connsiteX3" y="connsiteY3"/>
                    </a:cxn>
                  </a:cxnLst>
                  <a:rect l="l" t="t" r="r" b="b"/>
                  <a:pathLst>
                    <a:path w="2160000" h="2160000">
                      <a:moveTo>
                        <a:pt x="0" y="0"/>
                      </a:moveTo>
                      <a:lnTo>
                        <a:pt x="2160000" y="0"/>
                      </a:lnTo>
                      <a:lnTo>
                        <a:pt x="2160000" y="2160000"/>
                      </a:lnTo>
                      <a:lnTo>
                        <a:pt x="0" y="2160000"/>
                      </a:lnTo>
                      <a:close/>
                    </a:path>
                  </a:pathLst>
                </a:custGeom>
                <a:ln w="28575">
                  <a:solidFill>
                    <a:srgbClr val="53ACB7"/>
                  </a:solidFill>
                </a:ln>
              </p:spPr>
            </p:pic>
            <p:pic>
              <p:nvPicPr>
                <p:cNvPr id="18" name="Picture 17"/>
                <p:cNvPicPr>
                  <a:picLocks noChangeAspect="1"/>
                </p:cNvPicPr>
                <p:nvPr/>
              </p:nvPicPr>
              <p:blipFill rotWithShape="1">
                <a:blip r:embed="rId6" cstate="print">
                  <a:extLst>
                    <a:ext uri="{28A0092B-C50C-407E-A947-70E740481C1C}">
                      <a14:useLocalDpi xmlns:a14="http://schemas.microsoft.com/office/drawing/2010/main" val="0"/>
                    </a:ext>
                  </a:extLst>
                </a:blip>
                <a:srcRect l="62450" t="91774" r="49" b="3226"/>
                <a:stretch/>
              </p:blipFill>
              <p:spPr>
                <a:xfrm>
                  <a:off x="7650028" y="5949696"/>
                  <a:ext cx="1200000" cy="120000"/>
                </a:xfrm>
                <a:custGeom>
                  <a:avLst/>
                  <a:gdLst>
                    <a:gd name="connsiteX0" fmla="*/ 0 w 1800000"/>
                    <a:gd name="connsiteY0" fmla="*/ 0 h 180000"/>
                    <a:gd name="connsiteX1" fmla="*/ 1800000 w 1800000"/>
                    <a:gd name="connsiteY1" fmla="*/ 0 h 180000"/>
                    <a:gd name="connsiteX2" fmla="*/ 1800000 w 1800000"/>
                    <a:gd name="connsiteY2" fmla="*/ 180000 h 180000"/>
                    <a:gd name="connsiteX3" fmla="*/ 0 w 1800000"/>
                    <a:gd name="connsiteY3" fmla="*/ 180000 h 180000"/>
                  </a:gdLst>
                  <a:ahLst/>
                  <a:cxnLst>
                    <a:cxn ang="0">
                      <a:pos x="connsiteX0" y="connsiteY0"/>
                    </a:cxn>
                    <a:cxn ang="0">
                      <a:pos x="connsiteX1" y="connsiteY1"/>
                    </a:cxn>
                    <a:cxn ang="0">
                      <a:pos x="connsiteX2" y="connsiteY2"/>
                    </a:cxn>
                    <a:cxn ang="0">
                      <a:pos x="connsiteX3" y="connsiteY3"/>
                    </a:cxn>
                  </a:cxnLst>
                  <a:rect l="l" t="t" r="r" b="b"/>
                  <a:pathLst>
                    <a:path w="1800000" h="180000">
                      <a:moveTo>
                        <a:pt x="0" y="0"/>
                      </a:moveTo>
                      <a:lnTo>
                        <a:pt x="1800000" y="0"/>
                      </a:lnTo>
                      <a:lnTo>
                        <a:pt x="1800000" y="180000"/>
                      </a:lnTo>
                      <a:lnTo>
                        <a:pt x="0" y="180000"/>
                      </a:lnTo>
                      <a:close/>
                    </a:path>
                  </a:pathLst>
                </a:custGeom>
              </p:spPr>
            </p:pic>
            <p:sp>
              <p:nvSpPr>
                <p:cNvPr id="19" name="TextBox 18"/>
                <p:cNvSpPr txBox="1"/>
                <p:nvPr/>
              </p:nvSpPr>
              <p:spPr>
                <a:xfrm>
                  <a:off x="8007353" y="5754140"/>
                  <a:ext cx="651140" cy="261610"/>
                </a:xfrm>
                <a:prstGeom prst="rect">
                  <a:avLst/>
                </a:prstGeom>
                <a:noFill/>
              </p:spPr>
              <p:txBody>
                <a:bodyPr wrap="none" rtlCol="0">
                  <a:spAutoFit/>
                </a:bodyPr>
                <a:lstStyle/>
                <a:p>
                  <a:r>
                    <a:rPr lang="en-US" sz="1100" dirty="0" smtClean="0">
                      <a:solidFill>
                        <a:schemeClr val="bg1"/>
                      </a:solidFill>
                      <a:latin typeface="Bahnschrift" panose="020B0502040204020203" pitchFamily="34" charset="0"/>
                    </a:rPr>
                    <a:t>200 nm</a:t>
                  </a:r>
                  <a:endParaRPr lang="en-GB" sz="1100" dirty="0">
                    <a:solidFill>
                      <a:schemeClr val="bg1"/>
                    </a:solidFill>
                    <a:latin typeface="Bahnschrift" panose="020B0502040204020203" pitchFamily="34" charset="0"/>
                  </a:endParaRPr>
                </a:p>
              </p:txBody>
            </p:sp>
          </p:grpSp>
          <p:grpSp>
            <p:nvGrpSpPr>
              <p:cNvPr id="34" name="Group 33"/>
              <p:cNvGrpSpPr/>
              <p:nvPr/>
            </p:nvGrpSpPr>
            <p:grpSpPr>
              <a:xfrm>
                <a:off x="2964668" y="6293541"/>
                <a:ext cx="1441512" cy="1440000"/>
                <a:chOff x="4598992" y="6120858"/>
                <a:chExt cx="1441512" cy="1440000"/>
              </a:xfrm>
            </p:grpSpPr>
            <p:grpSp>
              <p:nvGrpSpPr>
                <p:cNvPr id="8" name="Group 7"/>
                <p:cNvGrpSpPr/>
                <p:nvPr/>
              </p:nvGrpSpPr>
              <p:grpSpPr>
                <a:xfrm>
                  <a:off x="4598992" y="6120858"/>
                  <a:ext cx="1440000" cy="1440000"/>
                  <a:chOff x="7410028" y="1695997"/>
                  <a:chExt cx="1440000" cy="1440000"/>
                </a:xfrm>
              </p:grpSpPr>
              <p:pic>
                <p:nvPicPr>
                  <p:cNvPr id="9" name="Picture 8"/>
                  <p:cNvPicPr>
                    <a:picLocks noChangeAspect="1"/>
                  </p:cNvPicPr>
                  <p:nvPr/>
                </p:nvPicPr>
                <p:blipFill>
                  <a:blip r:embed="rId7" cstate="print">
                    <a:extLst>
                      <a:ext uri="{28A0092B-C50C-407E-A947-70E740481C1C}">
                        <a14:useLocalDpi xmlns:a14="http://schemas.microsoft.com/office/drawing/2010/main" val="0"/>
                      </a:ext>
                    </a:extLst>
                  </a:blip>
                  <a:srcRect l="6814" t="3997" r="50000" b="38422"/>
                  <a:stretch>
                    <a:fillRect/>
                  </a:stretch>
                </p:blipFill>
                <p:spPr>
                  <a:xfrm>
                    <a:off x="7410028" y="1695997"/>
                    <a:ext cx="1440000" cy="1440000"/>
                  </a:xfrm>
                  <a:custGeom>
                    <a:avLst/>
                    <a:gdLst>
                      <a:gd name="connsiteX0" fmla="*/ 0 w 2160000"/>
                      <a:gd name="connsiteY0" fmla="*/ 0 h 2160000"/>
                      <a:gd name="connsiteX1" fmla="*/ 2160000 w 2160000"/>
                      <a:gd name="connsiteY1" fmla="*/ 0 h 2160000"/>
                      <a:gd name="connsiteX2" fmla="*/ 2160000 w 2160000"/>
                      <a:gd name="connsiteY2" fmla="*/ 2160000 h 2160000"/>
                      <a:gd name="connsiteX3" fmla="*/ 0 w 2160000"/>
                      <a:gd name="connsiteY3" fmla="*/ 2160000 h 2160000"/>
                    </a:gdLst>
                    <a:ahLst/>
                    <a:cxnLst>
                      <a:cxn ang="0">
                        <a:pos x="connsiteX0" y="connsiteY0"/>
                      </a:cxn>
                      <a:cxn ang="0">
                        <a:pos x="connsiteX1" y="connsiteY1"/>
                      </a:cxn>
                      <a:cxn ang="0">
                        <a:pos x="connsiteX2" y="connsiteY2"/>
                      </a:cxn>
                      <a:cxn ang="0">
                        <a:pos x="connsiteX3" y="connsiteY3"/>
                      </a:cxn>
                    </a:cxnLst>
                    <a:rect l="l" t="t" r="r" b="b"/>
                    <a:pathLst>
                      <a:path w="2160000" h="2160000">
                        <a:moveTo>
                          <a:pt x="0" y="0"/>
                        </a:moveTo>
                        <a:lnTo>
                          <a:pt x="2160000" y="0"/>
                        </a:lnTo>
                        <a:lnTo>
                          <a:pt x="2160000" y="2160000"/>
                        </a:lnTo>
                        <a:lnTo>
                          <a:pt x="0" y="2160000"/>
                        </a:lnTo>
                        <a:close/>
                      </a:path>
                    </a:pathLst>
                  </a:custGeom>
                  <a:ln w="28575">
                    <a:solidFill>
                      <a:srgbClr val="53ACB7"/>
                    </a:solidFill>
                  </a:ln>
                </p:spPr>
              </p:pic>
              <p:pic>
                <p:nvPicPr>
                  <p:cNvPr id="10" name="Picture 9"/>
                  <p:cNvPicPr>
                    <a:picLocks noChangeAspect="1"/>
                  </p:cNvPicPr>
                  <p:nvPr/>
                </p:nvPicPr>
                <p:blipFill rotWithShape="1">
                  <a:blip r:embed="rId7" cstate="print">
                    <a:extLst>
                      <a:ext uri="{28A0092B-C50C-407E-A947-70E740481C1C}">
                        <a14:useLocalDpi xmlns:a14="http://schemas.microsoft.com/office/drawing/2010/main" val="0"/>
                      </a:ext>
                    </a:extLst>
                  </a:blip>
                  <a:srcRect l="73060" t="97034" r="6233" b="-145"/>
                  <a:stretch/>
                </p:blipFill>
                <p:spPr>
                  <a:xfrm>
                    <a:off x="7410028" y="3055677"/>
                    <a:ext cx="690467" cy="77795"/>
                  </a:xfrm>
                  <a:custGeom>
                    <a:avLst/>
                    <a:gdLst>
                      <a:gd name="connsiteX0" fmla="*/ 0 w 1347458"/>
                      <a:gd name="connsiteY0" fmla="*/ 0 h 180000"/>
                      <a:gd name="connsiteX1" fmla="*/ 1347458 w 1347458"/>
                      <a:gd name="connsiteY1" fmla="*/ 0 h 180000"/>
                      <a:gd name="connsiteX2" fmla="*/ 1347458 w 1347458"/>
                      <a:gd name="connsiteY2" fmla="*/ 180000 h 180000"/>
                      <a:gd name="connsiteX3" fmla="*/ 0 w 1347458"/>
                      <a:gd name="connsiteY3" fmla="*/ 180000 h 180000"/>
                    </a:gdLst>
                    <a:ahLst/>
                    <a:cxnLst>
                      <a:cxn ang="0">
                        <a:pos x="connsiteX0" y="connsiteY0"/>
                      </a:cxn>
                      <a:cxn ang="0">
                        <a:pos x="connsiteX1" y="connsiteY1"/>
                      </a:cxn>
                      <a:cxn ang="0">
                        <a:pos x="connsiteX2" y="connsiteY2"/>
                      </a:cxn>
                      <a:cxn ang="0">
                        <a:pos x="connsiteX3" y="connsiteY3"/>
                      </a:cxn>
                    </a:cxnLst>
                    <a:rect l="l" t="t" r="r" b="b"/>
                    <a:pathLst>
                      <a:path w="1347458" h="180000">
                        <a:moveTo>
                          <a:pt x="0" y="0"/>
                        </a:moveTo>
                        <a:lnTo>
                          <a:pt x="1347458" y="0"/>
                        </a:lnTo>
                        <a:lnTo>
                          <a:pt x="1347458" y="180000"/>
                        </a:lnTo>
                        <a:lnTo>
                          <a:pt x="0" y="180000"/>
                        </a:lnTo>
                        <a:close/>
                      </a:path>
                    </a:pathLst>
                  </a:custGeom>
                </p:spPr>
              </p:pic>
              <p:sp>
                <p:nvSpPr>
                  <p:cNvPr id="11" name="TextBox 10"/>
                  <p:cNvSpPr txBox="1"/>
                  <p:nvPr/>
                </p:nvSpPr>
                <p:spPr>
                  <a:xfrm>
                    <a:off x="7415304" y="2820441"/>
                    <a:ext cx="651140" cy="261610"/>
                  </a:xfrm>
                  <a:prstGeom prst="rect">
                    <a:avLst/>
                  </a:prstGeom>
                  <a:noFill/>
                </p:spPr>
                <p:txBody>
                  <a:bodyPr wrap="none" rtlCol="0">
                    <a:spAutoFit/>
                  </a:bodyPr>
                  <a:lstStyle/>
                  <a:p>
                    <a:r>
                      <a:rPr lang="en-US" sz="1100" dirty="0" smtClean="0">
                        <a:solidFill>
                          <a:schemeClr val="bg1"/>
                        </a:solidFill>
                        <a:latin typeface="Bahnschrift" panose="020B0502040204020203" pitchFamily="34" charset="0"/>
                      </a:rPr>
                      <a:t>200 nm</a:t>
                    </a:r>
                    <a:endParaRPr lang="en-GB" sz="1100" dirty="0">
                      <a:solidFill>
                        <a:schemeClr val="bg1"/>
                      </a:solidFill>
                      <a:latin typeface="Bahnschrift" panose="020B0502040204020203" pitchFamily="34" charset="0"/>
                    </a:endParaRPr>
                  </a:p>
                </p:txBody>
              </p:sp>
            </p:grpSp>
            <p:sp>
              <p:nvSpPr>
                <p:cNvPr id="21" name="TextBox 20"/>
                <p:cNvSpPr txBox="1"/>
                <p:nvPr/>
              </p:nvSpPr>
              <p:spPr>
                <a:xfrm>
                  <a:off x="4672821" y="6123821"/>
                  <a:ext cx="1367683" cy="261610"/>
                </a:xfrm>
                <a:prstGeom prst="rect">
                  <a:avLst/>
                </a:prstGeom>
                <a:noFill/>
              </p:spPr>
              <p:txBody>
                <a:bodyPr wrap="none" rtlCol="0">
                  <a:spAutoFit/>
                </a:bodyPr>
                <a:lstStyle/>
                <a:p>
                  <a:pPr algn="ctr"/>
                  <a:r>
                    <a:rPr lang="en-US" sz="1100" b="1" dirty="0" smtClean="0">
                      <a:solidFill>
                        <a:schemeClr val="bg1"/>
                      </a:solidFill>
                      <a:latin typeface="Bahnschrift" panose="020B0502040204020203" pitchFamily="34" charset="0"/>
                    </a:rPr>
                    <a:t>FAEVEr 0.5% TW20</a:t>
                  </a:r>
                  <a:endParaRPr lang="en-GB" sz="1100" b="1" dirty="0">
                    <a:solidFill>
                      <a:schemeClr val="bg1"/>
                    </a:solidFill>
                    <a:latin typeface="Bahnschrift" panose="020B0502040204020203" pitchFamily="34" charset="0"/>
                  </a:endParaRPr>
                </a:p>
              </p:txBody>
            </p:sp>
          </p:grpSp>
          <p:sp>
            <p:nvSpPr>
              <p:cNvPr id="22" name="TextBox 21"/>
              <p:cNvSpPr txBox="1"/>
              <p:nvPr/>
            </p:nvSpPr>
            <p:spPr>
              <a:xfrm>
                <a:off x="4530730" y="6293541"/>
                <a:ext cx="1361270" cy="261610"/>
              </a:xfrm>
              <a:prstGeom prst="rect">
                <a:avLst/>
              </a:prstGeom>
              <a:noFill/>
            </p:spPr>
            <p:txBody>
              <a:bodyPr wrap="none" rtlCol="0">
                <a:spAutoFit/>
              </a:bodyPr>
              <a:lstStyle/>
              <a:p>
                <a:pPr algn="ctr"/>
                <a:r>
                  <a:rPr lang="en-US" sz="1100" b="1" dirty="0" smtClean="0">
                    <a:solidFill>
                      <a:schemeClr val="bg1"/>
                    </a:solidFill>
                    <a:latin typeface="Bahnschrift" panose="020B0502040204020203" pitchFamily="34" charset="0"/>
                  </a:rPr>
                  <a:t>FAEVEr 2.5% TW20</a:t>
                </a:r>
                <a:endParaRPr lang="en-GB" sz="1100" b="1" dirty="0">
                  <a:solidFill>
                    <a:schemeClr val="bg1"/>
                  </a:solidFill>
                  <a:latin typeface="Bahnschrift" panose="020B0502040204020203" pitchFamily="34" charset="0"/>
                </a:endParaRPr>
              </a:p>
            </p:txBody>
          </p:sp>
          <p:sp>
            <p:nvSpPr>
              <p:cNvPr id="23" name="TextBox 22"/>
              <p:cNvSpPr txBox="1"/>
              <p:nvPr/>
            </p:nvSpPr>
            <p:spPr>
              <a:xfrm>
                <a:off x="3000826" y="7863954"/>
                <a:ext cx="1367683" cy="261610"/>
              </a:xfrm>
              <a:prstGeom prst="rect">
                <a:avLst/>
              </a:prstGeom>
              <a:noFill/>
            </p:spPr>
            <p:txBody>
              <a:bodyPr wrap="none" rtlCol="0">
                <a:spAutoFit/>
              </a:bodyPr>
              <a:lstStyle/>
              <a:p>
                <a:pPr algn="ctr"/>
                <a:r>
                  <a:rPr lang="en-US" sz="1100" b="1" dirty="0" smtClean="0">
                    <a:solidFill>
                      <a:schemeClr val="bg1"/>
                    </a:solidFill>
                    <a:latin typeface="Bahnschrift" panose="020B0502040204020203" pitchFamily="34" charset="0"/>
                  </a:rPr>
                  <a:t>FAEVEr 5.0% TW20</a:t>
                </a:r>
                <a:endParaRPr lang="en-GB" sz="1100" b="1" dirty="0">
                  <a:solidFill>
                    <a:schemeClr val="bg1"/>
                  </a:solidFill>
                  <a:latin typeface="Bahnschrift" panose="020B0502040204020203" pitchFamily="34" charset="0"/>
                </a:endParaRPr>
              </a:p>
            </p:txBody>
          </p:sp>
          <p:grpSp>
            <p:nvGrpSpPr>
              <p:cNvPr id="33" name="Group 32"/>
              <p:cNvGrpSpPr/>
              <p:nvPr/>
            </p:nvGrpSpPr>
            <p:grpSpPr>
              <a:xfrm>
                <a:off x="4569459" y="7863954"/>
                <a:ext cx="1440000" cy="1440000"/>
                <a:chOff x="4569459" y="7863954"/>
                <a:chExt cx="1440000" cy="1440000"/>
              </a:xfrm>
            </p:grpSpPr>
            <p:grpSp>
              <p:nvGrpSpPr>
                <p:cNvPr id="28" name="Group 27"/>
                <p:cNvGrpSpPr/>
                <p:nvPr/>
              </p:nvGrpSpPr>
              <p:grpSpPr>
                <a:xfrm>
                  <a:off x="4569459" y="7863954"/>
                  <a:ext cx="1440000" cy="1440000"/>
                  <a:chOff x="7410028" y="225997"/>
                  <a:chExt cx="1440000" cy="1440000"/>
                </a:xfrm>
              </p:grpSpPr>
              <p:pic>
                <p:nvPicPr>
                  <p:cNvPr id="29" name="Picture 28"/>
                  <p:cNvPicPr>
                    <a:picLocks noChangeAspect="1"/>
                  </p:cNvPicPr>
                  <p:nvPr/>
                </p:nvPicPr>
                <p:blipFill rotWithShape="1">
                  <a:blip r:embed="rId8" cstate="print">
                    <a:extLst>
                      <a:ext uri="{28A0092B-C50C-407E-A947-70E740481C1C}">
                        <a14:useLocalDpi xmlns:a14="http://schemas.microsoft.com/office/drawing/2010/main" val="0"/>
                      </a:ext>
                    </a:extLst>
                  </a:blip>
                  <a:srcRect l="69187" t="39367" r="2040" b="22269"/>
                  <a:stretch/>
                </p:blipFill>
                <p:spPr>
                  <a:xfrm>
                    <a:off x="7410028" y="225997"/>
                    <a:ext cx="1440000" cy="1440000"/>
                  </a:xfrm>
                  <a:custGeom>
                    <a:avLst/>
                    <a:gdLst>
                      <a:gd name="connsiteX0" fmla="*/ 0 w 2160000"/>
                      <a:gd name="connsiteY0" fmla="*/ 0 h 2160000"/>
                      <a:gd name="connsiteX1" fmla="*/ 2160000 w 2160000"/>
                      <a:gd name="connsiteY1" fmla="*/ 0 h 2160000"/>
                      <a:gd name="connsiteX2" fmla="*/ 2160000 w 2160000"/>
                      <a:gd name="connsiteY2" fmla="*/ 2160000 h 2160000"/>
                      <a:gd name="connsiteX3" fmla="*/ 0 w 2160000"/>
                      <a:gd name="connsiteY3" fmla="*/ 2160000 h 2160000"/>
                    </a:gdLst>
                    <a:ahLst/>
                    <a:cxnLst>
                      <a:cxn ang="0">
                        <a:pos x="connsiteX0" y="connsiteY0"/>
                      </a:cxn>
                      <a:cxn ang="0">
                        <a:pos x="connsiteX1" y="connsiteY1"/>
                      </a:cxn>
                      <a:cxn ang="0">
                        <a:pos x="connsiteX2" y="connsiteY2"/>
                      </a:cxn>
                      <a:cxn ang="0">
                        <a:pos x="connsiteX3" y="connsiteY3"/>
                      </a:cxn>
                    </a:cxnLst>
                    <a:rect l="l" t="t" r="r" b="b"/>
                    <a:pathLst>
                      <a:path w="2160000" h="2160000">
                        <a:moveTo>
                          <a:pt x="0" y="0"/>
                        </a:moveTo>
                        <a:lnTo>
                          <a:pt x="2160000" y="0"/>
                        </a:lnTo>
                        <a:lnTo>
                          <a:pt x="2160000" y="2160000"/>
                        </a:lnTo>
                        <a:lnTo>
                          <a:pt x="0" y="2160000"/>
                        </a:lnTo>
                        <a:close/>
                      </a:path>
                    </a:pathLst>
                  </a:custGeom>
                  <a:ln w="28575">
                    <a:solidFill>
                      <a:srgbClr val="FFA040"/>
                    </a:solidFill>
                  </a:ln>
                </p:spPr>
              </p:pic>
              <p:pic>
                <p:nvPicPr>
                  <p:cNvPr id="30" name="Picture 29"/>
                  <p:cNvPicPr>
                    <a:picLocks noChangeAspect="1"/>
                  </p:cNvPicPr>
                  <p:nvPr/>
                </p:nvPicPr>
                <p:blipFill rotWithShape="1">
                  <a:blip r:embed="rId8" cstate="print">
                    <a:extLst>
                      <a:ext uri="{28A0092B-C50C-407E-A947-70E740481C1C}">
                        <a14:useLocalDpi xmlns:a14="http://schemas.microsoft.com/office/drawing/2010/main" val="0"/>
                      </a:ext>
                    </a:extLst>
                  </a:blip>
                  <a:srcRect l="70931" t="96417" r="296" b="386"/>
                  <a:stretch/>
                </p:blipFill>
                <p:spPr>
                  <a:xfrm>
                    <a:off x="7410028" y="1545997"/>
                    <a:ext cx="1440000" cy="120000"/>
                  </a:xfrm>
                  <a:custGeom>
                    <a:avLst/>
                    <a:gdLst>
                      <a:gd name="connsiteX0" fmla="*/ 0 w 2160000"/>
                      <a:gd name="connsiteY0" fmla="*/ 0 h 180000"/>
                      <a:gd name="connsiteX1" fmla="*/ 2160000 w 2160000"/>
                      <a:gd name="connsiteY1" fmla="*/ 0 h 180000"/>
                      <a:gd name="connsiteX2" fmla="*/ 2160000 w 2160000"/>
                      <a:gd name="connsiteY2" fmla="*/ 180000 h 180000"/>
                      <a:gd name="connsiteX3" fmla="*/ 0 w 2160000"/>
                      <a:gd name="connsiteY3" fmla="*/ 180000 h 180000"/>
                    </a:gdLst>
                    <a:ahLst/>
                    <a:cxnLst>
                      <a:cxn ang="0">
                        <a:pos x="connsiteX0" y="connsiteY0"/>
                      </a:cxn>
                      <a:cxn ang="0">
                        <a:pos x="connsiteX1" y="connsiteY1"/>
                      </a:cxn>
                      <a:cxn ang="0">
                        <a:pos x="connsiteX2" y="connsiteY2"/>
                      </a:cxn>
                      <a:cxn ang="0">
                        <a:pos x="connsiteX3" y="connsiteY3"/>
                      </a:cxn>
                    </a:cxnLst>
                    <a:rect l="l" t="t" r="r" b="b"/>
                    <a:pathLst>
                      <a:path w="2160000" h="180000">
                        <a:moveTo>
                          <a:pt x="0" y="0"/>
                        </a:moveTo>
                        <a:lnTo>
                          <a:pt x="2160000" y="0"/>
                        </a:lnTo>
                        <a:lnTo>
                          <a:pt x="2160000" y="180000"/>
                        </a:lnTo>
                        <a:lnTo>
                          <a:pt x="0" y="180000"/>
                        </a:lnTo>
                        <a:close/>
                      </a:path>
                    </a:pathLst>
                  </a:custGeom>
                </p:spPr>
              </p:pic>
              <p:sp>
                <p:nvSpPr>
                  <p:cNvPr id="31" name="TextBox 30"/>
                  <p:cNvSpPr txBox="1"/>
                  <p:nvPr/>
                </p:nvSpPr>
                <p:spPr>
                  <a:xfrm>
                    <a:off x="7939949" y="1369093"/>
                    <a:ext cx="651140" cy="261610"/>
                  </a:xfrm>
                  <a:prstGeom prst="rect">
                    <a:avLst/>
                  </a:prstGeom>
                  <a:noFill/>
                </p:spPr>
                <p:txBody>
                  <a:bodyPr wrap="none" rtlCol="0">
                    <a:spAutoFit/>
                  </a:bodyPr>
                  <a:lstStyle/>
                  <a:p>
                    <a:r>
                      <a:rPr lang="en-US" sz="1100" dirty="0" smtClean="0">
                        <a:solidFill>
                          <a:schemeClr val="bg1"/>
                        </a:solidFill>
                        <a:latin typeface="Bahnschrift" panose="020B0502040204020203" pitchFamily="34" charset="0"/>
                      </a:rPr>
                      <a:t>200 nm</a:t>
                    </a:r>
                    <a:endParaRPr lang="en-GB" sz="1100" dirty="0">
                      <a:solidFill>
                        <a:schemeClr val="bg1"/>
                      </a:solidFill>
                      <a:latin typeface="Bahnschrift" panose="020B0502040204020203" pitchFamily="34" charset="0"/>
                    </a:endParaRPr>
                  </a:p>
                </p:txBody>
              </p:sp>
            </p:grpSp>
            <p:sp>
              <p:nvSpPr>
                <p:cNvPr id="32" name="TextBox 31"/>
                <p:cNvSpPr txBox="1"/>
                <p:nvPr/>
              </p:nvSpPr>
              <p:spPr>
                <a:xfrm>
                  <a:off x="4833281" y="7863954"/>
                  <a:ext cx="1064715" cy="261610"/>
                </a:xfrm>
                <a:prstGeom prst="rect">
                  <a:avLst/>
                </a:prstGeom>
                <a:noFill/>
              </p:spPr>
              <p:txBody>
                <a:bodyPr wrap="none" rtlCol="0">
                  <a:spAutoFit/>
                </a:bodyPr>
                <a:lstStyle/>
                <a:p>
                  <a:r>
                    <a:rPr lang="en-US" sz="1100" b="1" dirty="0" smtClean="0">
                      <a:solidFill>
                        <a:schemeClr val="bg1"/>
                      </a:solidFill>
                      <a:latin typeface="Bahnschrift" panose="020B0502040204020203" pitchFamily="34" charset="0"/>
                    </a:rPr>
                    <a:t>UC 0.0% TW20</a:t>
                  </a:r>
                  <a:endParaRPr lang="en-GB" sz="1100" b="1" dirty="0">
                    <a:solidFill>
                      <a:schemeClr val="bg1"/>
                    </a:solidFill>
                    <a:latin typeface="Bahnschrift" panose="020B0502040204020203" pitchFamily="34" charset="0"/>
                  </a:endParaRPr>
                </a:p>
              </p:txBody>
            </p:sp>
          </p:grpSp>
        </p:grpSp>
      </p:grpSp>
    </p:spTree>
    <p:extLst>
      <p:ext uri="{BB962C8B-B14F-4D97-AF65-F5344CB8AC3E}">
        <p14:creationId xmlns:p14="http://schemas.microsoft.com/office/powerpoint/2010/main" val="240147503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0" y="209005"/>
            <a:ext cx="6858000" cy="1107996"/>
          </a:xfrm>
          <a:prstGeom prst="rect">
            <a:avLst/>
          </a:prstGeom>
          <a:noFill/>
        </p:spPr>
        <p:txBody>
          <a:bodyPr wrap="square" rtlCol="0">
            <a:spAutoFit/>
          </a:bodyPr>
          <a:lstStyle/>
          <a:p>
            <a:r>
              <a:rPr lang="en-US" b="1" dirty="0">
                <a:latin typeface="Cambria" panose="02040503050406030204" pitchFamily="18" charset="0"/>
                <a:ea typeface="Cambria" panose="02040503050406030204" pitchFamily="18" charset="0"/>
              </a:rPr>
              <a:t>Figure </a:t>
            </a:r>
            <a:r>
              <a:rPr lang="en-US" b="1" dirty="0" smtClean="0">
                <a:latin typeface="Cambria" panose="02040503050406030204" pitchFamily="18" charset="0"/>
                <a:ea typeface="Cambria" panose="02040503050406030204" pitchFamily="18" charset="0"/>
              </a:rPr>
              <a:t>S5:</a:t>
            </a:r>
            <a:endParaRPr lang="en-US" b="1" dirty="0">
              <a:latin typeface="Cambria" panose="02040503050406030204" pitchFamily="18" charset="0"/>
              <a:ea typeface="Cambria" panose="02040503050406030204" pitchFamily="18" charset="0"/>
            </a:endParaRPr>
          </a:p>
          <a:p>
            <a:r>
              <a:rPr lang="en-US" sz="1200" dirty="0" smtClean="0"/>
              <a:t>Absolute quantifications of bovine serum proteins using different percentages of TWEEN-20 in the wash buffer. A consistent decrease is observed with an increasing percentage of TWEEN-20. The corresponding </a:t>
            </a:r>
            <a:r>
              <a:rPr lang="en-US" sz="1200" dirty="0" err="1" smtClean="0"/>
              <a:t>iBAQ</a:t>
            </a:r>
            <a:r>
              <a:rPr lang="en-US" sz="1200" dirty="0" smtClean="0"/>
              <a:t> intensities using the ultracentrifugation approach is indicated by dashed lines. Note that ApoC4 was not found in the UC approach.</a:t>
            </a:r>
            <a:endParaRPr lang="en-GB" sz="1200" dirty="0"/>
          </a:p>
        </p:txBody>
      </p:sp>
      <p:graphicFrame>
        <p:nvGraphicFramePr>
          <p:cNvPr id="4" name="Object 3"/>
          <p:cNvGraphicFramePr>
            <a:graphicFrameLocks noChangeAspect="1"/>
          </p:cNvGraphicFramePr>
          <p:nvPr>
            <p:extLst>
              <p:ext uri="{D42A27DB-BD31-4B8C-83A1-F6EECF244321}">
                <p14:modId xmlns:p14="http://schemas.microsoft.com/office/powerpoint/2010/main" val="1275719180"/>
              </p:ext>
            </p:extLst>
          </p:nvPr>
        </p:nvGraphicFramePr>
        <p:xfrm>
          <a:off x="900113" y="1800225"/>
          <a:ext cx="5541962" cy="5022850"/>
        </p:xfrm>
        <a:graphic>
          <a:graphicData uri="http://schemas.openxmlformats.org/presentationml/2006/ole">
            <mc:AlternateContent xmlns:mc="http://schemas.openxmlformats.org/markup-compatibility/2006">
              <mc:Choice xmlns:v="urn:schemas-microsoft-com:vml" Requires="v">
                <p:oleObj spid="_x0000_s13338" name="Prism 10" r:id="rId3" imgW="3986134" imgH="3612935" progId="Prism10.Document">
                  <p:embed/>
                </p:oleObj>
              </mc:Choice>
              <mc:Fallback>
                <p:oleObj name="Prism 10" r:id="rId3" imgW="3986134" imgH="3612935" progId="Prism10.Document">
                  <p:embed/>
                  <p:pic>
                    <p:nvPicPr>
                      <p:cNvPr id="2" name="Object 1"/>
                      <p:cNvPicPr/>
                      <p:nvPr/>
                    </p:nvPicPr>
                    <p:blipFill>
                      <a:blip r:embed="rId4"/>
                      <a:stretch>
                        <a:fillRect/>
                      </a:stretch>
                    </p:blipFill>
                    <p:spPr>
                      <a:xfrm>
                        <a:off x="900113" y="1800225"/>
                        <a:ext cx="5541962" cy="5022850"/>
                      </a:xfrm>
                      <a:prstGeom prst="rect">
                        <a:avLst/>
                      </a:prstGeom>
                    </p:spPr>
                  </p:pic>
                </p:oleObj>
              </mc:Fallback>
            </mc:AlternateContent>
          </a:graphicData>
        </a:graphic>
      </p:graphicFrame>
    </p:spTree>
    <p:extLst>
      <p:ext uri="{BB962C8B-B14F-4D97-AF65-F5344CB8AC3E}">
        <p14:creationId xmlns:p14="http://schemas.microsoft.com/office/powerpoint/2010/main" val="50037741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287488" y="1764167"/>
            <a:ext cx="6303061" cy="7672607"/>
            <a:chOff x="287488" y="653824"/>
            <a:chExt cx="6303061" cy="7672607"/>
          </a:xfrm>
        </p:grpSpPr>
        <p:grpSp>
          <p:nvGrpSpPr>
            <p:cNvPr id="69" name="Group 68"/>
            <p:cNvGrpSpPr/>
            <p:nvPr/>
          </p:nvGrpSpPr>
          <p:grpSpPr>
            <a:xfrm>
              <a:off x="287488" y="6345230"/>
              <a:ext cx="2046516" cy="1981201"/>
              <a:chOff x="640080" y="1062445"/>
              <a:chExt cx="2046516" cy="1981201"/>
            </a:xfrm>
          </p:grpSpPr>
          <p:sp>
            <p:nvSpPr>
              <p:cNvPr id="11" name="Freeform 10"/>
              <p:cNvSpPr/>
              <p:nvPr/>
            </p:nvSpPr>
            <p:spPr>
              <a:xfrm>
                <a:off x="1266115" y="1136965"/>
                <a:ext cx="794446" cy="603969"/>
              </a:xfrm>
              <a:custGeom>
                <a:avLst/>
                <a:gdLst>
                  <a:gd name="connsiteX0" fmla="*/ 397223 w 794446"/>
                  <a:gd name="connsiteY0" fmla="*/ 0 h 603969"/>
                  <a:gd name="connsiteX1" fmla="*/ 483936 w 794446"/>
                  <a:gd name="connsiteY1" fmla="*/ 47066 h 603969"/>
                  <a:gd name="connsiteX2" fmla="*/ 783353 w 794446"/>
                  <a:gd name="connsiteY2" fmla="*/ 493928 h 603969"/>
                  <a:gd name="connsiteX3" fmla="*/ 794446 w 794446"/>
                  <a:gd name="connsiteY3" fmla="*/ 603969 h 603969"/>
                  <a:gd name="connsiteX4" fmla="*/ 674337 w 794446"/>
                  <a:gd name="connsiteY4" fmla="*/ 538776 h 603969"/>
                  <a:gd name="connsiteX5" fmla="*/ 397223 w 794446"/>
                  <a:gd name="connsiteY5" fmla="*/ 482829 h 603969"/>
                  <a:gd name="connsiteX6" fmla="*/ 120109 w 794446"/>
                  <a:gd name="connsiteY6" fmla="*/ 538776 h 603969"/>
                  <a:gd name="connsiteX7" fmla="*/ 0 w 794446"/>
                  <a:gd name="connsiteY7" fmla="*/ 603969 h 603969"/>
                  <a:gd name="connsiteX8" fmla="*/ 11093 w 794446"/>
                  <a:gd name="connsiteY8" fmla="*/ 493928 h 603969"/>
                  <a:gd name="connsiteX9" fmla="*/ 310510 w 794446"/>
                  <a:gd name="connsiteY9" fmla="*/ 47066 h 603969"/>
                  <a:gd name="connsiteX10" fmla="*/ 397223 w 794446"/>
                  <a:gd name="connsiteY10" fmla="*/ 0 h 60396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794446" h="603969">
                    <a:moveTo>
                      <a:pt x="397223" y="0"/>
                    </a:moveTo>
                    <a:lnTo>
                      <a:pt x="483936" y="47066"/>
                    </a:lnTo>
                    <a:cubicBezTo>
                      <a:pt x="635435" y="149416"/>
                      <a:pt x="745419" y="308549"/>
                      <a:pt x="783353" y="493928"/>
                    </a:cubicBezTo>
                    <a:lnTo>
                      <a:pt x="794446" y="603969"/>
                    </a:lnTo>
                    <a:lnTo>
                      <a:pt x="674337" y="538776"/>
                    </a:lnTo>
                    <a:cubicBezTo>
                      <a:pt x="589163" y="502750"/>
                      <a:pt x="495520" y="482829"/>
                      <a:pt x="397223" y="482829"/>
                    </a:cubicBezTo>
                    <a:cubicBezTo>
                      <a:pt x="298927" y="482829"/>
                      <a:pt x="205283" y="502750"/>
                      <a:pt x="120109" y="538776"/>
                    </a:cubicBezTo>
                    <a:lnTo>
                      <a:pt x="0" y="603969"/>
                    </a:lnTo>
                    <a:lnTo>
                      <a:pt x="11093" y="493928"/>
                    </a:lnTo>
                    <a:cubicBezTo>
                      <a:pt x="49027" y="308549"/>
                      <a:pt x="159012" y="149416"/>
                      <a:pt x="310510" y="47066"/>
                    </a:cubicBezTo>
                    <a:lnTo>
                      <a:pt x="397223" y="0"/>
                    </a:lnTo>
                    <a:close/>
                  </a:path>
                </a:pathLst>
              </a:custGeom>
              <a:solidFill>
                <a:srgbClr val="EBA845">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smtClean="0">
                    <a:solidFill>
                      <a:schemeClr val="tx1"/>
                    </a:solidFill>
                    <a:latin typeface="Cambria" panose="02040503050406030204" pitchFamily="18" charset="0"/>
                    <a:ea typeface="Cambria" panose="02040503050406030204" pitchFamily="18" charset="0"/>
                  </a:rPr>
                  <a:t>88</a:t>
                </a:r>
                <a:endParaRPr lang="en-GB" sz="1200" dirty="0">
                  <a:solidFill>
                    <a:schemeClr val="tx1"/>
                  </a:solidFill>
                  <a:latin typeface="Cambria" panose="02040503050406030204" pitchFamily="18" charset="0"/>
                  <a:ea typeface="Cambria" panose="02040503050406030204" pitchFamily="18" charset="0"/>
                </a:endParaRPr>
              </a:p>
            </p:txBody>
          </p:sp>
          <p:sp>
            <p:nvSpPr>
              <p:cNvPr id="10" name="Freeform 9"/>
              <p:cNvSpPr/>
              <p:nvPr/>
            </p:nvSpPr>
            <p:spPr>
              <a:xfrm>
                <a:off x="951412" y="1740934"/>
                <a:ext cx="711926" cy="745363"/>
              </a:xfrm>
              <a:custGeom>
                <a:avLst/>
                <a:gdLst>
                  <a:gd name="connsiteX0" fmla="*/ 314703 w 711926"/>
                  <a:gd name="connsiteY0" fmla="*/ 0 h 745363"/>
                  <a:gd name="connsiteX1" fmla="*/ 311332 w 711926"/>
                  <a:gd name="connsiteY1" fmla="*/ 33437 h 745363"/>
                  <a:gd name="connsiteX2" fmla="*/ 625213 w 711926"/>
                  <a:gd name="connsiteY2" fmla="*/ 623777 h 745363"/>
                  <a:gd name="connsiteX3" fmla="*/ 711926 w 711926"/>
                  <a:gd name="connsiteY3" fmla="*/ 670843 h 745363"/>
                  <a:gd name="connsiteX4" fmla="*/ 677708 w 711926"/>
                  <a:gd name="connsiteY4" fmla="*/ 689416 h 745363"/>
                  <a:gd name="connsiteX5" fmla="*/ 400594 w 711926"/>
                  <a:gd name="connsiteY5" fmla="*/ 745363 h 745363"/>
                  <a:gd name="connsiteX6" fmla="*/ 123480 w 711926"/>
                  <a:gd name="connsiteY6" fmla="*/ 689416 h 745363"/>
                  <a:gd name="connsiteX7" fmla="*/ 3371 w 711926"/>
                  <a:gd name="connsiteY7" fmla="*/ 624223 h 745363"/>
                  <a:gd name="connsiteX8" fmla="*/ 0 w 711926"/>
                  <a:gd name="connsiteY8" fmla="*/ 590786 h 745363"/>
                  <a:gd name="connsiteX9" fmla="*/ 313881 w 711926"/>
                  <a:gd name="connsiteY9" fmla="*/ 446 h 745363"/>
                  <a:gd name="connsiteX10" fmla="*/ 314703 w 711926"/>
                  <a:gd name="connsiteY10" fmla="*/ 0 h 74536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711926" h="745363">
                    <a:moveTo>
                      <a:pt x="314703" y="0"/>
                    </a:moveTo>
                    <a:lnTo>
                      <a:pt x="311332" y="33437"/>
                    </a:lnTo>
                    <a:cubicBezTo>
                      <a:pt x="311332" y="279178"/>
                      <a:pt x="435840" y="495839"/>
                      <a:pt x="625213" y="623777"/>
                    </a:cubicBezTo>
                    <a:lnTo>
                      <a:pt x="711926" y="670843"/>
                    </a:lnTo>
                    <a:lnTo>
                      <a:pt x="677708" y="689416"/>
                    </a:lnTo>
                    <a:cubicBezTo>
                      <a:pt x="592534" y="725442"/>
                      <a:pt x="498891" y="745363"/>
                      <a:pt x="400594" y="745363"/>
                    </a:cubicBezTo>
                    <a:cubicBezTo>
                      <a:pt x="302298" y="745363"/>
                      <a:pt x="208654" y="725442"/>
                      <a:pt x="123480" y="689416"/>
                    </a:cubicBezTo>
                    <a:lnTo>
                      <a:pt x="3371" y="624223"/>
                    </a:lnTo>
                    <a:lnTo>
                      <a:pt x="0" y="590786"/>
                    </a:lnTo>
                    <a:cubicBezTo>
                      <a:pt x="0" y="345045"/>
                      <a:pt x="124508" y="128384"/>
                      <a:pt x="313881" y="446"/>
                    </a:cubicBezTo>
                    <a:lnTo>
                      <a:pt x="314703" y="0"/>
                    </a:lnTo>
                    <a:close/>
                  </a:path>
                </a:pathLst>
              </a:custGeom>
              <a:solidFill>
                <a:srgbClr val="EBA845">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200" dirty="0" smtClean="0">
                    <a:solidFill>
                      <a:schemeClr val="tx1"/>
                    </a:solidFill>
                    <a:latin typeface="Cambria" panose="02040503050406030204" pitchFamily="18" charset="0"/>
                    <a:ea typeface="Cambria" panose="02040503050406030204" pitchFamily="18" charset="0"/>
                  </a:rPr>
                  <a:t>43</a:t>
                </a:r>
                <a:endParaRPr lang="en-GB" sz="1200" dirty="0">
                  <a:solidFill>
                    <a:schemeClr val="tx1"/>
                  </a:solidFill>
                  <a:latin typeface="Cambria" panose="02040503050406030204" pitchFamily="18" charset="0"/>
                  <a:ea typeface="Cambria" panose="02040503050406030204" pitchFamily="18" charset="0"/>
                </a:endParaRPr>
              </a:p>
            </p:txBody>
          </p:sp>
          <p:sp>
            <p:nvSpPr>
              <p:cNvPr id="9" name="Freeform 8"/>
              <p:cNvSpPr/>
              <p:nvPr/>
            </p:nvSpPr>
            <p:spPr>
              <a:xfrm>
                <a:off x="1663338" y="1740934"/>
                <a:ext cx="711926" cy="745363"/>
              </a:xfrm>
              <a:custGeom>
                <a:avLst/>
                <a:gdLst>
                  <a:gd name="connsiteX0" fmla="*/ 397223 w 711926"/>
                  <a:gd name="connsiteY0" fmla="*/ 0 h 745363"/>
                  <a:gd name="connsiteX1" fmla="*/ 398045 w 711926"/>
                  <a:gd name="connsiteY1" fmla="*/ 446 h 745363"/>
                  <a:gd name="connsiteX2" fmla="*/ 711926 w 711926"/>
                  <a:gd name="connsiteY2" fmla="*/ 590786 h 745363"/>
                  <a:gd name="connsiteX3" fmla="*/ 708555 w 711926"/>
                  <a:gd name="connsiteY3" fmla="*/ 624223 h 745363"/>
                  <a:gd name="connsiteX4" fmla="*/ 588446 w 711926"/>
                  <a:gd name="connsiteY4" fmla="*/ 689416 h 745363"/>
                  <a:gd name="connsiteX5" fmla="*/ 311332 w 711926"/>
                  <a:gd name="connsiteY5" fmla="*/ 745363 h 745363"/>
                  <a:gd name="connsiteX6" fmla="*/ 34218 w 711926"/>
                  <a:gd name="connsiteY6" fmla="*/ 689416 h 745363"/>
                  <a:gd name="connsiteX7" fmla="*/ 0 w 711926"/>
                  <a:gd name="connsiteY7" fmla="*/ 670843 h 745363"/>
                  <a:gd name="connsiteX8" fmla="*/ 86713 w 711926"/>
                  <a:gd name="connsiteY8" fmla="*/ 623777 h 745363"/>
                  <a:gd name="connsiteX9" fmla="*/ 400594 w 711926"/>
                  <a:gd name="connsiteY9" fmla="*/ 33437 h 745363"/>
                  <a:gd name="connsiteX10" fmla="*/ 397223 w 711926"/>
                  <a:gd name="connsiteY10" fmla="*/ 0 h 74536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711926" h="745363">
                    <a:moveTo>
                      <a:pt x="397223" y="0"/>
                    </a:moveTo>
                    <a:lnTo>
                      <a:pt x="398045" y="446"/>
                    </a:lnTo>
                    <a:cubicBezTo>
                      <a:pt x="587418" y="128384"/>
                      <a:pt x="711926" y="345045"/>
                      <a:pt x="711926" y="590786"/>
                    </a:cubicBezTo>
                    <a:lnTo>
                      <a:pt x="708555" y="624223"/>
                    </a:lnTo>
                    <a:lnTo>
                      <a:pt x="588446" y="689416"/>
                    </a:lnTo>
                    <a:cubicBezTo>
                      <a:pt x="503272" y="725442"/>
                      <a:pt x="409629" y="745363"/>
                      <a:pt x="311332" y="745363"/>
                    </a:cubicBezTo>
                    <a:cubicBezTo>
                      <a:pt x="213036" y="745363"/>
                      <a:pt x="119392" y="725442"/>
                      <a:pt x="34218" y="689416"/>
                    </a:cubicBezTo>
                    <a:lnTo>
                      <a:pt x="0" y="670843"/>
                    </a:lnTo>
                    <a:lnTo>
                      <a:pt x="86713" y="623777"/>
                    </a:lnTo>
                    <a:cubicBezTo>
                      <a:pt x="276086" y="495839"/>
                      <a:pt x="400594" y="279178"/>
                      <a:pt x="400594" y="33437"/>
                    </a:cubicBezTo>
                    <a:lnTo>
                      <a:pt x="397223" y="0"/>
                    </a:lnTo>
                    <a:close/>
                  </a:path>
                </a:pathLst>
              </a:custGeom>
              <a:solidFill>
                <a:srgbClr val="EBA845">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r"/>
                <a:r>
                  <a:rPr lang="en-US" sz="1200" dirty="0" smtClean="0">
                    <a:solidFill>
                      <a:schemeClr val="tx1"/>
                    </a:solidFill>
                    <a:latin typeface="Cambria" panose="02040503050406030204" pitchFamily="18" charset="0"/>
                    <a:ea typeface="Cambria" panose="02040503050406030204" pitchFamily="18" charset="0"/>
                  </a:rPr>
                  <a:t>545</a:t>
                </a:r>
                <a:endParaRPr lang="en-GB" sz="1200" dirty="0">
                  <a:solidFill>
                    <a:schemeClr val="tx1"/>
                  </a:solidFill>
                  <a:latin typeface="Cambria" panose="02040503050406030204" pitchFamily="18" charset="0"/>
                  <a:ea typeface="Cambria" panose="02040503050406030204" pitchFamily="18" charset="0"/>
                </a:endParaRPr>
              </a:p>
            </p:txBody>
          </p:sp>
          <p:sp>
            <p:nvSpPr>
              <p:cNvPr id="8" name="Freeform 7"/>
              <p:cNvSpPr/>
              <p:nvPr/>
            </p:nvSpPr>
            <p:spPr>
              <a:xfrm>
                <a:off x="640080" y="1062445"/>
                <a:ext cx="1023258" cy="1302712"/>
              </a:xfrm>
              <a:custGeom>
                <a:avLst/>
                <a:gdLst>
                  <a:gd name="connsiteX0" fmla="*/ 711926 w 1023258"/>
                  <a:gd name="connsiteY0" fmla="*/ 0 h 1302712"/>
                  <a:gd name="connsiteX1" fmla="*/ 989040 w 1023258"/>
                  <a:gd name="connsiteY1" fmla="*/ 55947 h 1302712"/>
                  <a:gd name="connsiteX2" fmla="*/ 1023258 w 1023258"/>
                  <a:gd name="connsiteY2" fmla="*/ 74520 h 1302712"/>
                  <a:gd name="connsiteX3" fmla="*/ 936545 w 1023258"/>
                  <a:gd name="connsiteY3" fmla="*/ 121586 h 1302712"/>
                  <a:gd name="connsiteX4" fmla="*/ 637128 w 1023258"/>
                  <a:gd name="connsiteY4" fmla="*/ 568448 h 1302712"/>
                  <a:gd name="connsiteX5" fmla="*/ 626035 w 1023258"/>
                  <a:gd name="connsiteY5" fmla="*/ 678489 h 1302712"/>
                  <a:gd name="connsiteX6" fmla="*/ 625213 w 1023258"/>
                  <a:gd name="connsiteY6" fmla="*/ 678935 h 1302712"/>
                  <a:gd name="connsiteX7" fmla="*/ 311332 w 1023258"/>
                  <a:gd name="connsiteY7" fmla="*/ 1269275 h 1302712"/>
                  <a:gd name="connsiteX8" fmla="*/ 314703 w 1023258"/>
                  <a:gd name="connsiteY8" fmla="*/ 1302712 h 1302712"/>
                  <a:gd name="connsiteX9" fmla="*/ 313881 w 1023258"/>
                  <a:gd name="connsiteY9" fmla="*/ 1302266 h 1302712"/>
                  <a:gd name="connsiteX10" fmla="*/ 0 w 1023258"/>
                  <a:gd name="connsiteY10" fmla="*/ 711926 h 1302712"/>
                  <a:gd name="connsiteX11" fmla="*/ 711926 w 1023258"/>
                  <a:gd name="connsiteY11" fmla="*/ 0 h 13027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Lst>
                <a:rect l="l" t="t" r="r" b="b"/>
                <a:pathLst>
                  <a:path w="1023258" h="1302712">
                    <a:moveTo>
                      <a:pt x="711926" y="0"/>
                    </a:moveTo>
                    <a:cubicBezTo>
                      <a:pt x="810223" y="0"/>
                      <a:pt x="903866" y="19921"/>
                      <a:pt x="989040" y="55947"/>
                    </a:cubicBezTo>
                    <a:lnTo>
                      <a:pt x="1023258" y="74520"/>
                    </a:lnTo>
                    <a:lnTo>
                      <a:pt x="936545" y="121586"/>
                    </a:lnTo>
                    <a:cubicBezTo>
                      <a:pt x="785047" y="223936"/>
                      <a:pt x="675062" y="383069"/>
                      <a:pt x="637128" y="568448"/>
                    </a:cubicBezTo>
                    <a:lnTo>
                      <a:pt x="626035" y="678489"/>
                    </a:lnTo>
                    <a:lnTo>
                      <a:pt x="625213" y="678935"/>
                    </a:lnTo>
                    <a:cubicBezTo>
                      <a:pt x="435840" y="806873"/>
                      <a:pt x="311332" y="1023534"/>
                      <a:pt x="311332" y="1269275"/>
                    </a:cubicBezTo>
                    <a:lnTo>
                      <a:pt x="314703" y="1302712"/>
                    </a:lnTo>
                    <a:lnTo>
                      <a:pt x="313881" y="1302266"/>
                    </a:lnTo>
                    <a:cubicBezTo>
                      <a:pt x="124508" y="1174328"/>
                      <a:pt x="0" y="957667"/>
                      <a:pt x="0" y="711926"/>
                    </a:cubicBezTo>
                    <a:cubicBezTo>
                      <a:pt x="0" y="318740"/>
                      <a:pt x="318740" y="0"/>
                      <a:pt x="711926" y="0"/>
                    </a:cubicBezTo>
                    <a:close/>
                  </a:path>
                </a:pathLst>
              </a:custGeom>
              <a:solidFill>
                <a:srgbClr val="EBA845">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200" dirty="0" smtClean="0">
                    <a:solidFill>
                      <a:schemeClr val="tx1"/>
                    </a:solidFill>
                    <a:latin typeface="Cambria" panose="02040503050406030204" pitchFamily="18" charset="0"/>
                    <a:ea typeface="Cambria" panose="02040503050406030204" pitchFamily="18" charset="0"/>
                  </a:rPr>
                  <a:t>59</a:t>
                </a:r>
              </a:p>
            </p:txBody>
          </p:sp>
          <p:sp>
            <p:nvSpPr>
              <p:cNvPr id="7" name="Freeform 6"/>
              <p:cNvSpPr/>
              <p:nvPr/>
            </p:nvSpPr>
            <p:spPr>
              <a:xfrm>
                <a:off x="1663338" y="1062445"/>
                <a:ext cx="1023258" cy="1302712"/>
              </a:xfrm>
              <a:custGeom>
                <a:avLst/>
                <a:gdLst>
                  <a:gd name="connsiteX0" fmla="*/ 311332 w 1023258"/>
                  <a:gd name="connsiteY0" fmla="*/ 0 h 1302712"/>
                  <a:gd name="connsiteX1" fmla="*/ 1023258 w 1023258"/>
                  <a:gd name="connsiteY1" fmla="*/ 711926 h 1302712"/>
                  <a:gd name="connsiteX2" fmla="*/ 709377 w 1023258"/>
                  <a:gd name="connsiteY2" fmla="*/ 1302266 h 1302712"/>
                  <a:gd name="connsiteX3" fmla="*/ 708555 w 1023258"/>
                  <a:gd name="connsiteY3" fmla="*/ 1302712 h 1302712"/>
                  <a:gd name="connsiteX4" fmla="*/ 711926 w 1023258"/>
                  <a:gd name="connsiteY4" fmla="*/ 1269275 h 1302712"/>
                  <a:gd name="connsiteX5" fmla="*/ 398045 w 1023258"/>
                  <a:gd name="connsiteY5" fmla="*/ 678935 h 1302712"/>
                  <a:gd name="connsiteX6" fmla="*/ 397223 w 1023258"/>
                  <a:gd name="connsiteY6" fmla="*/ 678489 h 1302712"/>
                  <a:gd name="connsiteX7" fmla="*/ 386130 w 1023258"/>
                  <a:gd name="connsiteY7" fmla="*/ 568448 h 1302712"/>
                  <a:gd name="connsiteX8" fmla="*/ 86713 w 1023258"/>
                  <a:gd name="connsiteY8" fmla="*/ 121586 h 1302712"/>
                  <a:gd name="connsiteX9" fmla="*/ 0 w 1023258"/>
                  <a:gd name="connsiteY9" fmla="*/ 74520 h 1302712"/>
                  <a:gd name="connsiteX10" fmla="*/ 34218 w 1023258"/>
                  <a:gd name="connsiteY10" fmla="*/ 55947 h 1302712"/>
                  <a:gd name="connsiteX11" fmla="*/ 311332 w 1023258"/>
                  <a:gd name="connsiteY11" fmla="*/ 0 h 13027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Lst>
                <a:rect l="l" t="t" r="r" b="b"/>
                <a:pathLst>
                  <a:path w="1023258" h="1302712">
                    <a:moveTo>
                      <a:pt x="311332" y="0"/>
                    </a:moveTo>
                    <a:cubicBezTo>
                      <a:pt x="704518" y="0"/>
                      <a:pt x="1023258" y="318740"/>
                      <a:pt x="1023258" y="711926"/>
                    </a:cubicBezTo>
                    <a:cubicBezTo>
                      <a:pt x="1023258" y="957667"/>
                      <a:pt x="898750" y="1174328"/>
                      <a:pt x="709377" y="1302266"/>
                    </a:cubicBezTo>
                    <a:lnTo>
                      <a:pt x="708555" y="1302712"/>
                    </a:lnTo>
                    <a:lnTo>
                      <a:pt x="711926" y="1269275"/>
                    </a:lnTo>
                    <a:cubicBezTo>
                      <a:pt x="711926" y="1023534"/>
                      <a:pt x="587418" y="806873"/>
                      <a:pt x="398045" y="678935"/>
                    </a:cubicBezTo>
                    <a:lnTo>
                      <a:pt x="397223" y="678489"/>
                    </a:lnTo>
                    <a:lnTo>
                      <a:pt x="386130" y="568448"/>
                    </a:lnTo>
                    <a:cubicBezTo>
                      <a:pt x="348196" y="383069"/>
                      <a:pt x="238212" y="223936"/>
                      <a:pt x="86713" y="121586"/>
                    </a:cubicBezTo>
                    <a:lnTo>
                      <a:pt x="0" y="74520"/>
                    </a:lnTo>
                    <a:lnTo>
                      <a:pt x="34218" y="55947"/>
                    </a:lnTo>
                    <a:cubicBezTo>
                      <a:pt x="119392" y="19921"/>
                      <a:pt x="213036" y="0"/>
                      <a:pt x="311332" y="0"/>
                    </a:cubicBezTo>
                    <a:close/>
                  </a:path>
                </a:pathLst>
              </a:custGeom>
              <a:solidFill>
                <a:srgbClr val="EBA845">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r"/>
                <a:r>
                  <a:rPr lang="en-US" sz="1200" dirty="0" smtClean="0">
                    <a:solidFill>
                      <a:schemeClr val="tx1"/>
                    </a:solidFill>
                    <a:latin typeface="Cambria" panose="02040503050406030204" pitchFamily="18" charset="0"/>
                    <a:ea typeface="Cambria" panose="02040503050406030204" pitchFamily="18" charset="0"/>
                  </a:rPr>
                  <a:t>245</a:t>
                </a:r>
              </a:p>
            </p:txBody>
          </p:sp>
          <p:sp>
            <p:nvSpPr>
              <p:cNvPr id="6" name="Freeform 5"/>
              <p:cNvSpPr/>
              <p:nvPr/>
            </p:nvSpPr>
            <p:spPr>
              <a:xfrm>
                <a:off x="1262744" y="1619794"/>
                <a:ext cx="801188" cy="791983"/>
              </a:xfrm>
              <a:custGeom>
                <a:avLst/>
                <a:gdLst>
                  <a:gd name="connsiteX0" fmla="*/ 400594 w 801188"/>
                  <a:gd name="connsiteY0" fmla="*/ 0 h 791983"/>
                  <a:gd name="connsiteX1" fmla="*/ 677708 w 801188"/>
                  <a:gd name="connsiteY1" fmla="*/ 55947 h 791983"/>
                  <a:gd name="connsiteX2" fmla="*/ 797817 w 801188"/>
                  <a:gd name="connsiteY2" fmla="*/ 121140 h 791983"/>
                  <a:gd name="connsiteX3" fmla="*/ 801188 w 801188"/>
                  <a:gd name="connsiteY3" fmla="*/ 154577 h 791983"/>
                  <a:gd name="connsiteX4" fmla="*/ 487307 w 801188"/>
                  <a:gd name="connsiteY4" fmla="*/ 744917 h 791983"/>
                  <a:gd name="connsiteX5" fmla="*/ 400594 w 801188"/>
                  <a:gd name="connsiteY5" fmla="*/ 791983 h 791983"/>
                  <a:gd name="connsiteX6" fmla="*/ 313881 w 801188"/>
                  <a:gd name="connsiteY6" fmla="*/ 744917 h 791983"/>
                  <a:gd name="connsiteX7" fmla="*/ 0 w 801188"/>
                  <a:gd name="connsiteY7" fmla="*/ 154577 h 791983"/>
                  <a:gd name="connsiteX8" fmla="*/ 3371 w 801188"/>
                  <a:gd name="connsiteY8" fmla="*/ 121140 h 791983"/>
                  <a:gd name="connsiteX9" fmla="*/ 123480 w 801188"/>
                  <a:gd name="connsiteY9" fmla="*/ 55947 h 791983"/>
                  <a:gd name="connsiteX10" fmla="*/ 400594 w 801188"/>
                  <a:gd name="connsiteY10" fmla="*/ 0 h 79198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801188" h="791983">
                    <a:moveTo>
                      <a:pt x="400594" y="0"/>
                    </a:moveTo>
                    <a:cubicBezTo>
                      <a:pt x="498891" y="0"/>
                      <a:pt x="592534" y="19921"/>
                      <a:pt x="677708" y="55947"/>
                    </a:cubicBezTo>
                    <a:lnTo>
                      <a:pt x="797817" y="121140"/>
                    </a:lnTo>
                    <a:lnTo>
                      <a:pt x="801188" y="154577"/>
                    </a:lnTo>
                    <a:cubicBezTo>
                      <a:pt x="801188" y="400318"/>
                      <a:pt x="676680" y="616979"/>
                      <a:pt x="487307" y="744917"/>
                    </a:cubicBezTo>
                    <a:lnTo>
                      <a:pt x="400594" y="791983"/>
                    </a:lnTo>
                    <a:lnTo>
                      <a:pt x="313881" y="744917"/>
                    </a:lnTo>
                    <a:cubicBezTo>
                      <a:pt x="124508" y="616979"/>
                      <a:pt x="0" y="400318"/>
                      <a:pt x="0" y="154577"/>
                    </a:cubicBezTo>
                    <a:lnTo>
                      <a:pt x="3371" y="121140"/>
                    </a:lnTo>
                    <a:lnTo>
                      <a:pt x="123480" y="55947"/>
                    </a:lnTo>
                    <a:cubicBezTo>
                      <a:pt x="208654" y="19921"/>
                      <a:pt x="302298" y="0"/>
                      <a:pt x="400594" y="0"/>
                    </a:cubicBezTo>
                    <a:close/>
                  </a:path>
                </a:pathLst>
              </a:custGeom>
              <a:solidFill>
                <a:srgbClr val="EBA845">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smtClean="0">
                    <a:solidFill>
                      <a:schemeClr val="tx1"/>
                    </a:solidFill>
                    <a:latin typeface="Cambria" panose="02040503050406030204" pitchFamily="18" charset="0"/>
                    <a:ea typeface="Cambria" panose="02040503050406030204" pitchFamily="18" charset="0"/>
                  </a:rPr>
                  <a:t>2,039</a:t>
                </a:r>
                <a:endParaRPr lang="en-GB" sz="1200" dirty="0">
                  <a:solidFill>
                    <a:schemeClr val="tx1"/>
                  </a:solidFill>
                  <a:latin typeface="Cambria" panose="02040503050406030204" pitchFamily="18" charset="0"/>
                  <a:ea typeface="Cambria" panose="02040503050406030204" pitchFamily="18" charset="0"/>
                </a:endParaRPr>
              </a:p>
            </p:txBody>
          </p:sp>
          <p:sp>
            <p:nvSpPr>
              <p:cNvPr id="5" name="Freeform 4"/>
              <p:cNvSpPr/>
              <p:nvPr/>
            </p:nvSpPr>
            <p:spPr>
              <a:xfrm>
                <a:off x="954783" y="2365157"/>
                <a:ext cx="1417110" cy="678489"/>
              </a:xfrm>
              <a:custGeom>
                <a:avLst/>
                <a:gdLst>
                  <a:gd name="connsiteX0" fmla="*/ 0 w 1417110"/>
                  <a:gd name="connsiteY0" fmla="*/ 0 h 678489"/>
                  <a:gd name="connsiteX1" fmla="*/ 120109 w 1417110"/>
                  <a:gd name="connsiteY1" fmla="*/ 65193 h 678489"/>
                  <a:gd name="connsiteX2" fmla="*/ 397223 w 1417110"/>
                  <a:gd name="connsiteY2" fmla="*/ 121140 h 678489"/>
                  <a:gd name="connsiteX3" fmla="*/ 674337 w 1417110"/>
                  <a:gd name="connsiteY3" fmla="*/ 65193 h 678489"/>
                  <a:gd name="connsiteX4" fmla="*/ 708555 w 1417110"/>
                  <a:gd name="connsiteY4" fmla="*/ 46620 h 678489"/>
                  <a:gd name="connsiteX5" fmla="*/ 742773 w 1417110"/>
                  <a:gd name="connsiteY5" fmla="*/ 65193 h 678489"/>
                  <a:gd name="connsiteX6" fmla="*/ 1019887 w 1417110"/>
                  <a:gd name="connsiteY6" fmla="*/ 121140 h 678489"/>
                  <a:gd name="connsiteX7" fmla="*/ 1297001 w 1417110"/>
                  <a:gd name="connsiteY7" fmla="*/ 65193 h 678489"/>
                  <a:gd name="connsiteX8" fmla="*/ 1417110 w 1417110"/>
                  <a:gd name="connsiteY8" fmla="*/ 0 h 678489"/>
                  <a:gd name="connsiteX9" fmla="*/ 1406017 w 1417110"/>
                  <a:gd name="connsiteY9" fmla="*/ 110041 h 678489"/>
                  <a:gd name="connsiteX10" fmla="*/ 708555 w 1417110"/>
                  <a:gd name="connsiteY10" fmla="*/ 678489 h 678489"/>
                  <a:gd name="connsiteX11" fmla="*/ 11093 w 1417110"/>
                  <a:gd name="connsiteY11" fmla="*/ 110041 h 678489"/>
                  <a:gd name="connsiteX12" fmla="*/ 0 w 1417110"/>
                  <a:gd name="connsiteY12" fmla="*/ 0 h 67848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Lst>
                <a:rect l="l" t="t" r="r" b="b"/>
                <a:pathLst>
                  <a:path w="1417110" h="678489">
                    <a:moveTo>
                      <a:pt x="0" y="0"/>
                    </a:moveTo>
                    <a:lnTo>
                      <a:pt x="120109" y="65193"/>
                    </a:lnTo>
                    <a:cubicBezTo>
                      <a:pt x="205283" y="101219"/>
                      <a:pt x="298927" y="121140"/>
                      <a:pt x="397223" y="121140"/>
                    </a:cubicBezTo>
                    <a:cubicBezTo>
                      <a:pt x="495520" y="121140"/>
                      <a:pt x="589163" y="101219"/>
                      <a:pt x="674337" y="65193"/>
                    </a:cubicBezTo>
                    <a:lnTo>
                      <a:pt x="708555" y="46620"/>
                    </a:lnTo>
                    <a:lnTo>
                      <a:pt x="742773" y="65193"/>
                    </a:lnTo>
                    <a:cubicBezTo>
                      <a:pt x="827947" y="101219"/>
                      <a:pt x="921591" y="121140"/>
                      <a:pt x="1019887" y="121140"/>
                    </a:cubicBezTo>
                    <a:cubicBezTo>
                      <a:pt x="1118184" y="121140"/>
                      <a:pt x="1211827" y="101219"/>
                      <a:pt x="1297001" y="65193"/>
                    </a:cubicBezTo>
                    <a:lnTo>
                      <a:pt x="1417110" y="0"/>
                    </a:lnTo>
                    <a:lnTo>
                      <a:pt x="1406017" y="110041"/>
                    </a:lnTo>
                    <a:cubicBezTo>
                      <a:pt x="1339633" y="434454"/>
                      <a:pt x="1052593" y="678489"/>
                      <a:pt x="708555" y="678489"/>
                    </a:cubicBezTo>
                    <a:cubicBezTo>
                      <a:pt x="364517" y="678489"/>
                      <a:pt x="77477" y="434454"/>
                      <a:pt x="11093" y="110041"/>
                    </a:cubicBezTo>
                    <a:lnTo>
                      <a:pt x="0" y="0"/>
                    </a:lnTo>
                    <a:close/>
                  </a:path>
                </a:pathLst>
              </a:custGeom>
              <a:solidFill>
                <a:srgbClr val="EBA845">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smtClean="0">
                    <a:solidFill>
                      <a:schemeClr val="tx1"/>
                    </a:solidFill>
                    <a:latin typeface="Cambria" panose="02040503050406030204" pitchFamily="18" charset="0"/>
                    <a:ea typeface="Cambria" panose="02040503050406030204" pitchFamily="18" charset="0"/>
                  </a:rPr>
                  <a:t>125</a:t>
                </a:r>
                <a:endParaRPr lang="en-GB" sz="1200" dirty="0">
                  <a:solidFill>
                    <a:schemeClr val="tx1"/>
                  </a:solidFill>
                  <a:latin typeface="Cambria" panose="02040503050406030204" pitchFamily="18" charset="0"/>
                  <a:ea typeface="Cambria" panose="02040503050406030204" pitchFamily="18" charset="0"/>
                </a:endParaRPr>
              </a:p>
            </p:txBody>
          </p:sp>
        </p:grpSp>
        <p:grpSp>
          <p:nvGrpSpPr>
            <p:cNvPr id="70" name="Group 69"/>
            <p:cNvGrpSpPr/>
            <p:nvPr/>
          </p:nvGrpSpPr>
          <p:grpSpPr>
            <a:xfrm>
              <a:off x="287488" y="1094308"/>
              <a:ext cx="2046516" cy="1981201"/>
              <a:chOff x="2874373" y="1062445"/>
              <a:chExt cx="2046516" cy="1981201"/>
            </a:xfrm>
          </p:grpSpPr>
          <p:sp>
            <p:nvSpPr>
              <p:cNvPr id="19" name="Freeform 18"/>
              <p:cNvSpPr/>
              <p:nvPr/>
            </p:nvSpPr>
            <p:spPr>
              <a:xfrm>
                <a:off x="3500408" y="1136965"/>
                <a:ext cx="794446" cy="603969"/>
              </a:xfrm>
              <a:custGeom>
                <a:avLst/>
                <a:gdLst>
                  <a:gd name="connsiteX0" fmla="*/ 397223 w 794446"/>
                  <a:gd name="connsiteY0" fmla="*/ 0 h 603969"/>
                  <a:gd name="connsiteX1" fmla="*/ 483936 w 794446"/>
                  <a:gd name="connsiteY1" fmla="*/ 47066 h 603969"/>
                  <a:gd name="connsiteX2" fmla="*/ 783353 w 794446"/>
                  <a:gd name="connsiteY2" fmla="*/ 493928 h 603969"/>
                  <a:gd name="connsiteX3" fmla="*/ 794446 w 794446"/>
                  <a:gd name="connsiteY3" fmla="*/ 603969 h 603969"/>
                  <a:gd name="connsiteX4" fmla="*/ 674337 w 794446"/>
                  <a:gd name="connsiteY4" fmla="*/ 538776 h 603969"/>
                  <a:gd name="connsiteX5" fmla="*/ 397223 w 794446"/>
                  <a:gd name="connsiteY5" fmla="*/ 482829 h 603969"/>
                  <a:gd name="connsiteX6" fmla="*/ 120109 w 794446"/>
                  <a:gd name="connsiteY6" fmla="*/ 538776 h 603969"/>
                  <a:gd name="connsiteX7" fmla="*/ 0 w 794446"/>
                  <a:gd name="connsiteY7" fmla="*/ 603969 h 603969"/>
                  <a:gd name="connsiteX8" fmla="*/ 11093 w 794446"/>
                  <a:gd name="connsiteY8" fmla="*/ 493928 h 603969"/>
                  <a:gd name="connsiteX9" fmla="*/ 310510 w 794446"/>
                  <a:gd name="connsiteY9" fmla="*/ 47066 h 603969"/>
                  <a:gd name="connsiteX10" fmla="*/ 397223 w 794446"/>
                  <a:gd name="connsiteY10" fmla="*/ 0 h 60396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794446" h="603969">
                    <a:moveTo>
                      <a:pt x="397223" y="0"/>
                    </a:moveTo>
                    <a:lnTo>
                      <a:pt x="483936" y="47066"/>
                    </a:lnTo>
                    <a:cubicBezTo>
                      <a:pt x="635435" y="149416"/>
                      <a:pt x="745419" y="308549"/>
                      <a:pt x="783353" y="493928"/>
                    </a:cubicBezTo>
                    <a:lnTo>
                      <a:pt x="794446" y="603969"/>
                    </a:lnTo>
                    <a:lnTo>
                      <a:pt x="674337" y="538776"/>
                    </a:lnTo>
                    <a:cubicBezTo>
                      <a:pt x="589163" y="502750"/>
                      <a:pt x="495520" y="482829"/>
                      <a:pt x="397223" y="482829"/>
                    </a:cubicBezTo>
                    <a:cubicBezTo>
                      <a:pt x="298927" y="482829"/>
                      <a:pt x="205283" y="502750"/>
                      <a:pt x="120109" y="538776"/>
                    </a:cubicBezTo>
                    <a:lnTo>
                      <a:pt x="0" y="603969"/>
                    </a:lnTo>
                    <a:lnTo>
                      <a:pt x="11093" y="493928"/>
                    </a:lnTo>
                    <a:cubicBezTo>
                      <a:pt x="49027" y="308549"/>
                      <a:pt x="159012" y="149416"/>
                      <a:pt x="310510" y="47066"/>
                    </a:cubicBezTo>
                    <a:lnTo>
                      <a:pt x="397223" y="0"/>
                    </a:lnTo>
                    <a:close/>
                  </a:path>
                </a:pathLst>
              </a:custGeom>
              <a:solidFill>
                <a:srgbClr val="87CCD9">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smtClean="0">
                    <a:solidFill>
                      <a:schemeClr val="tx1"/>
                    </a:solidFill>
                    <a:latin typeface="Cambria" panose="02040503050406030204" pitchFamily="18" charset="0"/>
                    <a:ea typeface="Cambria" panose="02040503050406030204" pitchFamily="18" charset="0"/>
                  </a:rPr>
                  <a:t>109</a:t>
                </a:r>
                <a:endParaRPr lang="en-GB" sz="1200" dirty="0">
                  <a:solidFill>
                    <a:schemeClr val="tx1"/>
                  </a:solidFill>
                  <a:latin typeface="Cambria" panose="02040503050406030204" pitchFamily="18" charset="0"/>
                  <a:ea typeface="Cambria" panose="02040503050406030204" pitchFamily="18" charset="0"/>
                </a:endParaRPr>
              </a:p>
            </p:txBody>
          </p:sp>
          <p:sp>
            <p:nvSpPr>
              <p:cNvPr id="20" name="Freeform 19"/>
              <p:cNvSpPr/>
              <p:nvPr/>
            </p:nvSpPr>
            <p:spPr>
              <a:xfrm>
                <a:off x="3185705" y="1740934"/>
                <a:ext cx="711926" cy="745363"/>
              </a:xfrm>
              <a:custGeom>
                <a:avLst/>
                <a:gdLst>
                  <a:gd name="connsiteX0" fmla="*/ 314703 w 711926"/>
                  <a:gd name="connsiteY0" fmla="*/ 0 h 745363"/>
                  <a:gd name="connsiteX1" fmla="*/ 311332 w 711926"/>
                  <a:gd name="connsiteY1" fmla="*/ 33437 h 745363"/>
                  <a:gd name="connsiteX2" fmla="*/ 625213 w 711926"/>
                  <a:gd name="connsiteY2" fmla="*/ 623777 h 745363"/>
                  <a:gd name="connsiteX3" fmla="*/ 711926 w 711926"/>
                  <a:gd name="connsiteY3" fmla="*/ 670843 h 745363"/>
                  <a:gd name="connsiteX4" fmla="*/ 677708 w 711926"/>
                  <a:gd name="connsiteY4" fmla="*/ 689416 h 745363"/>
                  <a:gd name="connsiteX5" fmla="*/ 400594 w 711926"/>
                  <a:gd name="connsiteY5" fmla="*/ 745363 h 745363"/>
                  <a:gd name="connsiteX6" fmla="*/ 123480 w 711926"/>
                  <a:gd name="connsiteY6" fmla="*/ 689416 h 745363"/>
                  <a:gd name="connsiteX7" fmla="*/ 3371 w 711926"/>
                  <a:gd name="connsiteY7" fmla="*/ 624223 h 745363"/>
                  <a:gd name="connsiteX8" fmla="*/ 0 w 711926"/>
                  <a:gd name="connsiteY8" fmla="*/ 590786 h 745363"/>
                  <a:gd name="connsiteX9" fmla="*/ 313881 w 711926"/>
                  <a:gd name="connsiteY9" fmla="*/ 446 h 745363"/>
                  <a:gd name="connsiteX10" fmla="*/ 314703 w 711926"/>
                  <a:gd name="connsiteY10" fmla="*/ 0 h 74536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711926" h="745363">
                    <a:moveTo>
                      <a:pt x="314703" y="0"/>
                    </a:moveTo>
                    <a:lnTo>
                      <a:pt x="311332" y="33437"/>
                    </a:lnTo>
                    <a:cubicBezTo>
                      <a:pt x="311332" y="279178"/>
                      <a:pt x="435840" y="495839"/>
                      <a:pt x="625213" y="623777"/>
                    </a:cubicBezTo>
                    <a:lnTo>
                      <a:pt x="711926" y="670843"/>
                    </a:lnTo>
                    <a:lnTo>
                      <a:pt x="677708" y="689416"/>
                    </a:lnTo>
                    <a:cubicBezTo>
                      <a:pt x="592534" y="725442"/>
                      <a:pt x="498891" y="745363"/>
                      <a:pt x="400594" y="745363"/>
                    </a:cubicBezTo>
                    <a:cubicBezTo>
                      <a:pt x="302298" y="745363"/>
                      <a:pt x="208654" y="725442"/>
                      <a:pt x="123480" y="689416"/>
                    </a:cubicBezTo>
                    <a:lnTo>
                      <a:pt x="3371" y="624223"/>
                    </a:lnTo>
                    <a:lnTo>
                      <a:pt x="0" y="590786"/>
                    </a:lnTo>
                    <a:cubicBezTo>
                      <a:pt x="0" y="345045"/>
                      <a:pt x="124508" y="128384"/>
                      <a:pt x="313881" y="446"/>
                    </a:cubicBezTo>
                    <a:lnTo>
                      <a:pt x="314703" y="0"/>
                    </a:lnTo>
                    <a:close/>
                  </a:path>
                </a:pathLst>
              </a:custGeom>
              <a:solidFill>
                <a:srgbClr val="87CCD9">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200" dirty="0" smtClean="0">
                    <a:solidFill>
                      <a:schemeClr val="tx1"/>
                    </a:solidFill>
                    <a:latin typeface="Cambria" panose="02040503050406030204" pitchFamily="18" charset="0"/>
                    <a:ea typeface="Cambria" panose="02040503050406030204" pitchFamily="18" charset="0"/>
                  </a:rPr>
                  <a:t>51</a:t>
                </a:r>
                <a:endParaRPr lang="en-GB" sz="1200" dirty="0">
                  <a:solidFill>
                    <a:schemeClr val="tx1"/>
                  </a:solidFill>
                  <a:latin typeface="Cambria" panose="02040503050406030204" pitchFamily="18" charset="0"/>
                  <a:ea typeface="Cambria" panose="02040503050406030204" pitchFamily="18" charset="0"/>
                </a:endParaRPr>
              </a:p>
            </p:txBody>
          </p:sp>
          <p:sp>
            <p:nvSpPr>
              <p:cNvPr id="21" name="Freeform 20"/>
              <p:cNvSpPr/>
              <p:nvPr/>
            </p:nvSpPr>
            <p:spPr>
              <a:xfrm>
                <a:off x="3897631" y="1740934"/>
                <a:ext cx="711926" cy="745363"/>
              </a:xfrm>
              <a:custGeom>
                <a:avLst/>
                <a:gdLst>
                  <a:gd name="connsiteX0" fmla="*/ 397223 w 711926"/>
                  <a:gd name="connsiteY0" fmla="*/ 0 h 745363"/>
                  <a:gd name="connsiteX1" fmla="*/ 398045 w 711926"/>
                  <a:gd name="connsiteY1" fmla="*/ 446 h 745363"/>
                  <a:gd name="connsiteX2" fmla="*/ 711926 w 711926"/>
                  <a:gd name="connsiteY2" fmla="*/ 590786 h 745363"/>
                  <a:gd name="connsiteX3" fmla="*/ 708555 w 711926"/>
                  <a:gd name="connsiteY3" fmla="*/ 624223 h 745363"/>
                  <a:gd name="connsiteX4" fmla="*/ 588446 w 711926"/>
                  <a:gd name="connsiteY4" fmla="*/ 689416 h 745363"/>
                  <a:gd name="connsiteX5" fmla="*/ 311332 w 711926"/>
                  <a:gd name="connsiteY5" fmla="*/ 745363 h 745363"/>
                  <a:gd name="connsiteX6" fmla="*/ 34218 w 711926"/>
                  <a:gd name="connsiteY6" fmla="*/ 689416 h 745363"/>
                  <a:gd name="connsiteX7" fmla="*/ 0 w 711926"/>
                  <a:gd name="connsiteY7" fmla="*/ 670843 h 745363"/>
                  <a:gd name="connsiteX8" fmla="*/ 86713 w 711926"/>
                  <a:gd name="connsiteY8" fmla="*/ 623777 h 745363"/>
                  <a:gd name="connsiteX9" fmla="*/ 400594 w 711926"/>
                  <a:gd name="connsiteY9" fmla="*/ 33437 h 745363"/>
                  <a:gd name="connsiteX10" fmla="*/ 397223 w 711926"/>
                  <a:gd name="connsiteY10" fmla="*/ 0 h 74536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711926" h="745363">
                    <a:moveTo>
                      <a:pt x="397223" y="0"/>
                    </a:moveTo>
                    <a:lnTo>
                      <a:pt x="398045" y="446"/>
                    </a:lnTo>
                    <a:cubicBezTo>
                      <a:pt x="587418" y="128384"/>
                      <a:pt x="711926" y="345045"/>
                      <a:pt x="711926" y="590786"/>
                    </a:cubicBezTo>
                    <a:lnTo>
                      <a:pt x="708555" y="624223"/>
                    </a:lnTo>
                    <a:lnTo>
                      <a:pt x="588446" y="689416"/>
                    </a:lnTo>
                    <a:cubicBezTo>
                      <a:pt x="503272" y="725442"/>
                      <a:pt x="409629" y="745363"/>
                      <a:pt x="311332" y="745363"/>
                    </a:cubicBezTo>
                    <a:cubicBezTo>
                      <a:pt x="213036" y="745363"/>
                      <a:pt x="119392" y="725442"/>
                      <a:pt x="34218" y="689416"/>
                    </a:cubicBezTo>
                    <a:lnTo>
                      <a:pt x="0" y="670843"/>
                    </a:lnTo>
                    <a:lnTo>
                      <a:pt x="86713" y="623777"/>
                    </a:lnTo>
                    <a:cubicBezTo>
                      <a:pt x="276086" y="495839"/>
                      <a:pt x="400594" y="279178"/>
                      <a:pt x="400594" y="33437"/>
                    </a:cubicBezTo>
                    <a:lnTo>
                      <a:pt x="397223" y="0"/>
                    </a:lnTo>
                    <a:close/>
                  </a:path>
                </a:pathLst>
              </a:custGeom>
              <a:solidFill>
                <a:srgbClr val="87CCD9">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r"/>
                <a:r>
                  <a:rPr lang="en-US" sz="1200" dirty="0" smtClean="0">
                    <a:solidFill>
                      <a:schemeClr val="tx1"/>
                    </a:solidFill>
                    <a:latin typeface="Cambria" panose="02040503050406030204" pitchFamily="18" charset="0"/>
                    <a:ea typeface="Cambria" panose="02040503050406030204" pitchFamily="18" charset="0"/>
                  </a:rPr>
                  <a:t>56</a:t>
                </a:r>
                <a:endParaRPr lang="en-GB" sz="1200" dirty="0">
                  <a:solidFill>
                    <a:schemeClr val="tx1"/>
                  </a:solidFill>
                  <a:latin typeface="Cambria" panose="02040503050406030204" pitchFamily="18" charset="0"/>
                  <a:ea typeface="Cambria" panose="02040503050406030204" pitchFamily="18" charset="0"/>
                </a:endParaRPr>
              </a:p>
            </p:txBody>
          </p:sp>
          <p:sp>
            <p:nvSpPr>
              <p:cNvPr id="22" name="Freeform 21"/>
              <p:cNvSpPr/>
              <p:nvPr/>
            </p:nvSpPr>
            <p:spPr>
              <a:xfrm>
                <a:off x="2874373" y="1062445"/>
                <a:ext cx="1023258" cy="1302712"/>
              </a:xfrm>
              <a:custGeom>
                <a:avLst/>
                <a:gdLst>
                  <a:gd name="connsiteX0" fmla="*/ 711926 w 1023258"/>
                  <a:gd name="connsiteY0" fmla="*/ 0 h 1302712"/>
                  <a:gd name="connsiteX1" fmla="*/ 989040 w 1023258"/>
                  <a:gd name="connsiteY1" fmla="*/ 55947 h 1302712"/>
                  <a:gd name="connsiteX2" fmla="*/ 1023258 w 1023258"/>
                  <a:gd name="connsiteY2" fmla="*/ 74520 h 1302712"/>
                  <a:gd name="connsiteX3" fmla="*/ 936545 w 1023258"/>
                  <a:gd name="connsiteY3" fmla="*/ 121586 h 1302712"/>
                  <a:gd name="connsiteX4" fmla="*/ 637128 w 1023258"/>
                  <a:gd name="connsiteY4" fmla="*/ 568448 h 1302712"/>
                  <a:gd name="connsiteX5" fmla="*/ 626035 w 1023258"/>
                  <a:gd name="connsiteY5" fmla="*/ 678489 h 1302712"/>
                  <a:gd name="connsiteX6" fmla="*/ 625213 w 1023258"/>
                  <a:gd name="connsiteY6" fmla="*/ 678935 h 1302712"/>
                  <a:gd name="connsiteX7" fmla="*/ 311332 w 1023258"/>
                  <a:gd name="connsiteY7" fmla="*/ 1269275 h 1302712"/>
                  <a:gd name="connsiteX8" fmla="*/ 314703 w 1023258"/>
                  <a:gd name="connsiteY8" fmla="*/ 1302712 h 1302712"/>
                  <a:gd name="connsiteX9" fmla="*/ 313881 w 1023258"/>
                  <a:gd name="connsiteY9" fmla="*/ 1302266 h 1302712"/>
                  <a:gd name="connsiteX10" fmla="*/ 0 w 1023258"/>
                  <a:gd name="connsiteY10" fmla="*/ 711926 h 1302712"/>
                  <a:gd name="connsiteX11" fmla="*/ 711926 w 1023258"/>
                  <a:gd name="connsiteY11" fmla="*/ 0 h 13027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Lst>
                <a:rect l="l" t="t" r="r" b="b"/>
                <a:pathLst>
                  <a:path w="1023258" h="1302712">
                    <a:moveTo>
                      <a:pt x="711926" y="0"/>
                    </a:moveTo>
                    <a:cubicBezTo>
                      <a:pt x="810223" y="0"/>
                      <a:pt x="903866" y="19921"/>
                      <a:pt x="989040" y="55947"/>
                    </a:cubicBezTo>
                    <a:lnTo>
                      <a:pt x="1023258" y="74520"/>
                    </a:lnTo>
                    <a:lnTo>
                      <a:pt x="936545" y="121586"/>
                    </a:lnTo>
                    <a:cubicBezTo>
                      <a:pt x="785047" y="223936"/>
                      <a:pt x="675062" y="383069"/>
                      <a:pt x="637128" y="568448"/>
                    </a:cubicBezTo>
                    <a:lnTo>
                      <a:pt x="626035" y="678489"/>
                    </a:lnTo>
                    <a:lnTo>
                      <a:pt x="625213" y="678935"/>
                    </a:lnTo>
                    <a:cubicBezTo>
                      <a:pt x="435840" y="806873"/>
                      <a:pt x="311332" y="1023534"/>
                      <a:pt x="311332" y="1269275"/>
                    </a:cubicBezTo>
                    <a:lnTo>
                      <a:pt x="314703" y="1302712"/>
                    </a:lnTo>
                    <a:lnTo>
                      <a:pt x="313881" y="1302266"/>
                    </a:lnTo>
                    <a:cubicBezTo>
                      <a:pt x="124508" y="1174328"/>
                      <a:pt x="0" y="957667"/>
                      <a:pt x="0" y="711926"/>
                    </a:cubicBezTo>
                    <a:cubicBezTo>
                      <a:pt x="0" y="318740"/>
                      <a:pt x="318740" y="0"/>
                      <a:pt x="711926" y="0"/>
                    </a:cubicBezTo>
                    <a:close/>
                  </a:path>
                </a:pathLst>
              </a:custGeom>
              <a:solidFill>
                <a:srgbClr val="87CCD9">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200" dirty="0" smtClean="0">
                    <a:solidFill>
                      <a:schemeClr val="tx1"/>
                    </a:solidFill>
                    <a:latin typeface="Cambria" panose="02040503050406030204" pitchFamily="18" charset="0"/>
                    <a:ea typeface="Cambria" panose="02040503050406030204" pitchFamily="18" charset="0"/>
                  </a:rPr>
                  <a:t>60</a:t>
                </a:r>
              </a:p>
            </p:txBody>
          </p:sp>
          <p:sp>
            <p:nvSpPr>
              <p:cNvPr id="23" name="Freeform 22"/>
              <p:cNvSpPr/>
              <p:nvPr/>
            </p:nvSpPr>
            <p:spPr>
              <a:xfrm>
                <a:off x="3897631" y="1062445"/>
                <a:ext cx="1023258" cy="1302712"/>
              </a:xfrm>
              <a:custGeom>
                <a:avLst/>
                <a:gdLst>
                  <a:gd name="connsiteX0" fmla="*/ 311332 w 1023258"/>
                  <a:gd name="connsiteY0" fmla="*/ 0 h 1302712"/>
                  <a:gd name="connsiteX1" fmla="*/ 1023258 w 1023258"/>
                  <a:gd name="connsiteY1" fmla="*/ 711926 h 1302712"/>
                  <a:gd name="connsiteX2" fmla="*/ 709377 w 1023258"/>
                  <a:gd name="connsiteY2" fmla="*/ 1302266 h 1302712"/>
                  <a:gd name="connsiteX3" fmla="*/ 708555 w 1023258"/>
                  <a:gd name="connsiteY3" fmla="*/ 1302712 h 1302712"/>
                  <a:gd name="connsiteX4" fmla="*/ 711926 w 1023258"/>
                  <a:gd name="connsiteY4" fmla="*/ 1269275 h 1302712"/>
                  <a:gd name="connsiteX5" fmla="*/ 398045 w 1023258"/>
                  <a:gd name="connsiteY5" fmla="*/ 678935 h 1302712"/>
                  <a:gd name="connsiteX6" fmla="*/ 397223 w 1023258"/>
                  <a:gd name="connsiteY6" fmla="*/ 678489 h 1302712"/>
                  <a:gd name="connsiteX7" fmla="*/ 386130 w 1023258"/>
                  <a:gd name="connsiteY7" fmla="*/ 568448 h 1302712"/>
                  <a:gd name="connsiteX8" fmla="*/ 86713 w 1023258"/>
                  <a:gd name="connsiteY8" fmla="*/ 121586 h 1302712"/>
                  <a:gd name="connsiteX9" fmla="*/ 0 w 1023258"/>
                  <a:gd name="connsiteY9" fmla="*/ 74520 h 1302712"/>
                  <a:gd name="connsiteX10" fmla="*/ 34218 w 1023258"/>
                  <a:gd name="connsiteY10" fmla="*/ 55947 h 1302712"/>
                  <a:gd name="connsiteX11" fmla="*/ 311332 w 1023258"/>
                  <a:gd name="connsiteY11" fmla="*/ 0 h 13027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Lst>
                <a:rect l="l" t="t" r="r" b="b"/>
                <a:pathLst>
                  <a:path w="1023258" h="1302712">
                    <a:moveTo>
                      <a:pt x="311332" y="0"/>
                    </a:moveTo>
                    <a:cubicBezTo>
                      <a:pt x="704518" y="0"/>
                      <a:pt x="1023258" y="318740"/>
                      <a:pt x="1023258" y="711926"/>
                    </a:cubicBezTo>
                    <a:cubicBezTo>
                      <a:pt x="1023258" y="957667"/>
                      <a:pt x="898750" y="1174328"/>
                      <a:pt x="709377" y="1302266"/>
                    </a:cubicBezTo>
                    <a:lnTo>
                      <a:pt x="708555" y="1302712"/>
                    </a:lnTo>
                    <a:lnTo>
                      <a:pt x="711926" y="1269275"/>
                    </a:lnTo>
                    <a:cubicBezTo>
                      <a:pt x="711926" y="1023534"/>
                      <a:pt x="587418" y="806873"/>
                      <a:pt x="398045" y="678935"/>
                    </a:cubicBezTo>
                    <a:lnTo>
                      <a:pt x="397223" y="678489"/>
                    </a:lnTo>
                    <a:lnTo>
                      <a:pt x="386130" y="568448"/>
                    </a:lnTo>
                    <a:cubicBezTo>
                      <a:pt x="348196" y="383069"/>
                      <a:pt x="238212" y="223936"/>
                      <a:pt x="86713" y="121586"/>
                    </a:cubicBezTo>
                    <a:lnTo>
                      <a:pt x="0" y="74520"/>
                    </a:lnTo>
                    <a:lnTo>
                      <a:pt x="34218" y="55947"/>
                    </a:lnTo>
                    <a:cubicBezTo>
                      <a:pt x="119392" y="19921"/>
                      <a:pt x="213036" y="0"/>
                      <a:pt x="311332" y="0"/>
                    </a:cubicBezTo>
                    <a:close/>
                  </a:path>
                </a:pathLst>
              </a:custGeom>
              <a:solidFill>
                <a:srgbClr val="87CCD9">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r"/>
                <a:r>
                  <a:rPr lang="en-US" sz="1200" dirty="0" smtClean="0">
                    <a:solidFill>
                      <a:schemeClr val="tx1"/>
                    </a:solidFill>
                    <a:latin typeface="Cambria" panose="02040503050406030204" pitchFamily="18" charset="0"/>
                    <a:ea typeface="Cambria" panose="02040503050406030204" pitchFamily="18" charset="0"/>
                  </a:rPr>
                  <a:t>45</a:t>
                </a:r>
              </a:p>
            </p:txBody>
          </p:sp>
          <p:sp>
            <p:nvSpPr>
              <p:cNvPr id="24" name="Freeform 23"/>
              <p:cNvSpPr/>
              <p:nvPr/>
            </p:nvSpPr>
            <p:spPr>
              <a:xfrm>
                <a:off x="3497037" y="1619794"/>
                <a:ext cx="801188" cy="791983"/>
              </a:xfrm>
              <a:custGeom>
                <a:avLst/>
                <a:gdLst>
                  <a:gd name="connsiteX0" fmla="*/ 400594 w 801188"/>
                  <a:gd name="connsiteY0" fmla="*/ 0 h 791983"/>
                  <a:gd name="connsiteX1" fmla="*/ 677708 w 801188"/>
                  <a:gd name="connsiteY1" fmla="*/ 55947 h 791983"/>
                  <a:gd name="connsiteX2" fmla="*/ 797817 w 801188"/>
                  <a:gd name="connsiteY2" fmla="*/ 121140 h 791983"/>
                  <a:gd name="connsiteX3" fmla="*/ 801188 w 801188"/>
                  <a:gd name="connsiteY3" fmla="*/ 154577 h 791983"/>
                  <a:gd name="connsiteX4" fmla="*/ 487307 w 801188"/>
                  <a:gd name="connsiteY4" fmla="*/ 744917 h 791983"/>
                  <a:gd name="connsiteX5" fmla="*/ 400594 w 801188"/>
                  <a:gd name="connsiteY5" fmla="*/ 791983 h 791983"/>
                  <a:gd name="connsiteX6" fmla="*/ 313881 w 801188"/>
                  <a:gd name="connsiteY6" fmla="*/ 744917 h 791983"/>
                  <a:gd name="connsiteX7" fmla="*/ 0 w 801188"/>
                  <a:gd name="connsiteY7" fmla="*/ 154577 h 791983"/>
                  <a:gd name="connsiteX8" fmla="*/ 3371 w 801188"/>
                  <a:gd name="connsiteY8" fmla="*/ 121140 h 791983"/>
                  <a:gd name="connsiteX9" fmla="*/ 123480 w 801188"/>
                  <a:gd name="connsiteY9" fmla="*/ 55947 h 791983"/>
                  <a:gd name="connsiteX10" fmla="*/ 400594 w 801188"/>
                  <a:gd name="connsiteY10" fmla="*/ 0 h 79198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801188" h="791983">
                    <a:moveTo>
                      <a:pt x="400594" y="0"/>
                    </a:moveTo>
                    <a:cubicBezTo>
                      <a:pt x="498891" y="0"/>
                      <a:pt x="592534" y="19921"/>
                      <a:pt x="677708" y="55947"/>
                    </a:cubicBezTo>
                    <a:lnTo>
                      <a:pt x="797817" y="121140"/>
                    </a:lnTo>
                    <a:lnTo>
                      <a:pt x="801188" y="154577"/>
                    </a:lnTo>
                    <a:cubicBezTo>
                      <a:pt x="801188" y="400318"/>
                      <a:pt x="676680" y="616979"/>
                      <a:pt x="487307" y="744917"/>
                    </a:cubicBezTo>
                    <a:lnTo>
                      <a:pt x="400594" y="791983"/>
                    </a:lnTo>
                    <a:lnTo>
                      <a:pt x="313881" y="744917"/>
                    </a:lnTo>
                    <a:cubicBezTo>
                      <a:pt x="124508" y="616979"/>
                      <a:pt x="0" y="400318"/>
                      <a:pt x="0" y="154577"/>
                    </a:cubicBezTo>
                    <a:lnTo>
                      <a:pt x="3371" y="121140"/>
                    </a:lnTo>
                    <a:lnTo>
                      <a:pt x="123480" y="55947"/>
                    </a:lnTo>
                    <a:cubicBezTo>
                      <a:pt x="208654" y="19921"/>
                      <a:pt x="302298" y="0"/>
                      <a:pt x="400594" y="0"/>
                    </a:cubicBezTo>
                    <a:close/>
                  </a:path>
                </a:pathLst>
              </a:custGeom>
              <a:solidFill>
                <a:srgbClr val="87CCD9">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smtClean="0">
                    <a:solidFill>
                      <a:schemeClr val="tx1"/>
                    </a:solidFill>
                    <a:latin typeface="Cambria" panose="02040503050406030204" pitchFamily="18" charset="0"/>
                    <a:ea typeface="Cambria" panose="02040503050406030204" pitchFamily="18" charset="0"/>
                  </a:rPr>
                  <a:t>2,697</a:t>
                </a:r>
                <a:endParaRPr lang="en-GB" sz="1200" dirty="0">
                  <a:solidFill>
                    <a:schemeClr val="tx1"/>
                  </a:solidFill>
                  <a:latin typeface="Cambria" panose="02040503050406030204" pitchFamily="18" charset="0"/>
                  <a:ea typeface="Cambria" panose="02040503050406030204" pitchFamily="18" charset="0"/>
                </a:endParaRPr>
              </a:p>
            </p:txBody>
          </p:sp>
          <p:sp>
            <p:nvSpPr>
              <p:cNvPr id="25" name="Freeform 24"/>
              <p:cNvSpPr/>
              <p:nvPr/>
            </p:nvSpPr>
            <p:spPr>
              <a:xfrm>
                <a:off x="3189076" y="2365157"/>
                <a:ext cx="1417110" cy="678489"/>
              </a:xfrm>
              <a:custGeom>
                <a:avLst/>
                <a:gdLst>
                  <a:gd name="connsiteX0" fmla="*/ 0 w 1417110"/>
                  <a:gd name="connsiteY0" fmla="*/ 0 h 678489"/>
                  <a:gd name="connsiteX1" fmla="*/ 120109 w 1417110"/>
                  <a:gd name="connsiteY1" fmla="*/ 65193 h 678489"/>
                  <a:gd name="connsiteX2" fmla="*/ 397223 w 1417110"/>
                  <a:gd name="connsiteY2" fmla="*/ 121140 h 678489"/>
                  <a:gd name="connsiteX3" fmla="*/ 674337 w 1417110"/>
                  <a:gd name="connsiteY3" fmla="*/ 65193 h 678489"/>
                  <a:gd name="connsiteX4" fmla="*/ 708555 w 1417110"/>
                  <a:gd name="connsiteY4" fmla="*/ 46620 h 678489"/>
                  <a:gd name="connsiteX5" fmla="*/ 742773 w 1417110"/>
                  <a:gd name="connsiteY5" fmla="*/ 65193 h 678489"/>
                  <a:gd name="connsiteX6" fmla="*/ 1019887 w 1417110"/>
                  <a:gd name="connsiteY6" fmla="*/ 121140 h 678489"/>
                  <a:gd name="connsiteX7" fmla="*/ 1297001 w 1417110"/>
                  <a:gd name="connsiteY7" fmla="*/ 65193 h 678489"/>
                  <a:gd name="connsiteX8" fmla="*/ 1417110 w 1417110"/>
                  <a:gd name="connsiteY8" fmla="*/ 0 h 678489"/>
                  <a:gd name="connsiteX9" fmla="*/ 1406017 w 1417110"/>
                  <a:gd name="connsiteY9" fmla="*/ 110041 h 678489"/>
                  <a:gd name="connsiteX10" fmla="*/ 708555 w 1417110"/>
                  <a:gd name="connsiteY10" fmla="*/ 678489 h 678489"/>
                  <a:gd name="connsiteX11" fmla="*/ 11093 w 1417110"/>
                  <a:gd name="connsiteY11" fmla="*/ 110041 h 678489"/>
                  <a:gd name="connsiteX12" fmla="*/ 0 w 1417110"/>
                  <a:gd name="connsiteY12" fmla="*/ 0 h 67848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Lst>
                <a:rect l="l" t="t" r="r" b="b"/>
                <a:pathLst>
                  <a:path w="1417110" h="678489">
                    <a:moveTo>
                      <a:pt x="0" y="0"/>
                    </a:moveTo>
                    <a:lnTo>
                      <a:pt x="120109" y="65193"/>
                    </a:lnTo>
                    <a:cubicBezTo>
                      <a:pt x="205283" y="101219"/>
                      <a:pt x="298927" y="121140"/>
                      <a:pt x="397223" y="121140"/>
                    </a:cubicBezTo>
                    <a:cubicBezTo>
                      <a:pt x="495520" y="121140"/>
                      <a:pt x="589163" y="101219"/>
                      <a:pt x="674337" y="65193"/>
                    </a:cubicBezTo>
                    <a:lnTo>
                      <a:pt x="708555" y="46620"/>
                    </a:lnTo>
                    <a:lnTo>
                      <a:pt x="742773" y="65193"/>
                    </a:lnTo>
                    <a:cubicBezTo>
                      <a:pt x="827947" y="101219"/>
                      <a:pt x="921591" y="121140"/>
                      <a:pt x="1019887" y="121140"/>
                    </a:cubicBezTo>
                    <a:cubicBezTo>
                      <a:pt x="1118184" y="121140"/>
                      <a:pt x="1211827" y="101219"/>
                      <a:pt x="1297001" y="65193"/>
                    </a:cubicBezTo>
                    <a:lnTo>
                      <a:pt x="1417110" y="0"/>
                    </a:lnTo>
                    <a:lnTo>
                      <a:pt x="1406017" y="110041"/>
                    </a:lnTo>
                    <a:cubicBezTo>
                      <a:pt x="1339633" y="434454"/>
                      <a:pt x="1052593" y="678489"/>
                      <a:pt x="708555" y="678489"/>
                    </a:cubicBezTo>
                    <a:cubicBezTo>
                      <a:pt x="364517" y="678489"/>
                      <a:pt x="77477" y="434454"/>
                      <a:pt x="11093" y="110041"/>
                    </a:cubicBezTo>
                    <a:lnTo>
                      <a:pt x="0" y="0"/>
                    </a:lnTo>
                    <a:close/>
                  </a:path>
                </a:pathLst>
              </a:custGeom>
              <a:solidFill>
                <a:srgbClr val="87CCD9">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smtClean="0">
                    <a:solidFill>
                      <a:schemeClr val="tx1"/>
                    </a:solidFill>
                    <a:latin typeface="Cambria" panose="02040503050406030204" pitchFamily="18" charset="0"/>
                    <a:ea typeface="Cambria" panose="02040503050406030204" pitchFamily="18" charset="0"/>
                  </a:rPr>
                  <a:t>45</a:t>
                </a:r>
                <a:endParaRPr lang="en-GB" sz="1200" dirty="0">
                  <a:solidFill>
                    <a:schemeClr val="tx1"/>
                  </a:solidFill>
                  <a:latin typeface="Cambria" panose="02040503050406030204" pitchFamily="18" charset="0"/>
                  <a:ea typeface="Cambria" panose="02040503050406030204" pitchFamily="18" charset="0"/>
                </a:endParaRPr>
              </a:p>
            </p:txBody>
          </p:sp>
        </p:grpSp>
        <p:grpSp>
          <p:nvGrpSpPr>
            <p:cNvPr id="71" name="Group 70"/>
            <p:cNvGrpSpPr/>
            <p:nvPr/>
          </p:nvGrpSpPr>
          <p:grpSpPr>
            <a:xfrm>
              <a:off x="2414997" y="1094308"/>
              <a:ext cx="2046516" cy="1981201"/>
              <a:chOff x="640520" y="3370217"/>
              <a:chExt cx="2046516" cy="1981201"/>
            </a:xfrm>
          </p:grpSpPr>
          <p:sp>
            <p:nvSpPr>
              <p:cNvPr id="26" name="Freeform 25"/>
              <p:cNvSpPr/>
              <p:nvPr/>
            </p:nvSpPr>
            <p:spPr>
              <a:xfrm>
                <a:off x="1266555" y="3444737"/>
                <a:ext cx="794446" cy="603969"/>
              </a:xfrm>
              <a:custGeom>
                <a:avLst/>
                <a:gdLst>
                  <a:gd name="connsiteX0" fmla="*/ 397223 w 794446"/>
                  <a:gd name="connsiteY0" fmla="*/ 0 h 603969"/>
                  <a:gd name="connsiteX1" fmla="*/ 483936 w 794446"/>
                  <a:gd name="connsiteY1" fmla="*/ 47066 h 603969"/>
                  <a:gd name="connsiteX2" fmla="*/ 783353 w 794446"/>
                  <a:gd name="connsiteY2" fmla="*/ 493928 h 603969"/>
                  <a:gd name="connsiteX3" fmla="*/ 794446 w 794446"/>
                  <a:gd name="connsiteY3" fmla="*/ 603969 h 603969"/>
                  <a:gd name="connsiteX4" fmla="*/ 674337 w 794446"/>
                  <a:gd name="connsiteY4" fmla="*/ 538776 h 603969"/>
                  <a:gd name="connsiteX5" fmla="*/ 397223 w 794446"/>
                  <a:gd name="connsiteY5" fmla="*/ 482829 h 603969"/>
                  <a:gd name="connsiteX6" fmla="*/ 120109 w 794446"/>
                  <a:gd name="connsiteY6" fmla="*/ 538776 h 603969"/>
                  <a:gd name="connsiteX7" fmla="*/ 0 w 794446"/>
                  <a:gd name="connsiteY7" fmla="*/ 603969 h 603969"/>
                  <a:gd name="connsiteX8" fmla="*/ 11093 w 794446"/>
                  <a:gd name="connsiteY8" fmla="*/ 493928 h 603969"/>
                  <a:gd name="connsiteX9" fmla="*/ 310510 w 794446"/>
                  <a:gd name="connsiteY9" fmla="*/ 47066 h 603969"/>
                  <a:gd name="connsiteX10" fmla="*/ 397223 w 794446"/>
                  <a:gd name="connsiteY10" fmla="*/ 0 h 60396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794446" h="603969">
                    <a:moveTo>
                      <a:pt x="397223" y="0"/>
                    </a:moveTo>
                    <a:lnTo>
                      <a:pt x="483936" y="47066"/>
                    </a:lnTo>
                    <a:cubicBezTo>
                      <a:pt x="635435" y="149416"/>
                      <a:pt x="745419" y="308549"/>
                      <a:pt x="783353" y="493928"/>
                    </a:cubicBezTo>
                    <a:lnTo>
                      <a:pt x="794446" y="603969"/>
                    </a:lnTo>
                    <a:lnTo>
                      <a:pt x="674337" y="538776"/>
                    </a:lnTo>
                    <a:cubicBezTo>
                      <a:pt x="589163" y="502750"/>
                      <a:pt x="495520" y="482829"/>
                      <a:pt x="397223" y="482829"/>
                    </a:cubicBezTo>
                    <a:cubicBezTo>
                      <a:pt x="298927" y="482829"/>
                      <a:pt x="205283" y="502750"/>
                      <a:pt x="120109" y="538776"/>
                    </a:cubicBezTo>
                    <a:lnTo>
                      <a:pt x="0" y="603969"/>
                    </a:lnTo>
                    <a:lnTo>
                      <a:pt x="11093" y="493928"/>
                    </a:lnTo>
                    <a:cubicBezTo>
                      <a:pt x="49027" y="308549"/>
                      <a:pt x="159012" y="149416"/>
                      <a:pt x="310510" y="47066"/>
                    </a:cubicBezTo>
                    <a:lnTo>
                      <a:pt x="397223" y="0"/>
                    </a:lnTo>
                    <a:close/>
                  </a:path>
                </a:pathLst>
              </a:custGeom>
              <a:solidFill>
                <a:srgbClr val="87CCD9">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smtClean="0">
                    <a:solidFill>
                      <a:schemeClr val="tx1"/>
                    </a:solidFill>
                    <a:latin typeface="Cambria" panose="02040503050406030204" pitchFamily="18" charset="0"/>
                    <a:ea typeface="Cambria" panose="02040503050406030204" pitchFamily="18" charset="0"/>
                  </a:rPr>
                  <a:t>83</a:t>
                </a:r>
                <a:endParaRPr lang="en-GB" sz="1200" dirty="0">
                  <a:solidFill>
                    <a:schemeClr val="tx1"/>
                  </a:solidFill>
                  <a:latin typeface="Cambria" panose="02040503050406030204" pitchFamily="18" charset="0"/>
                  <a:ea typeface="Cambria" panose="02040503050406030204" pitchFamily="18" charset="0"/>
                </a:endParaRPr>
              </a:p>
            </p:txBody>
          </p:sp>
          <p:sp>
            <p:nvSpPr>
              <p:cNvPr id="27" name="Freeform 26"/>
              <p:cNvSpPr/>
              <p:nvPr/>
            </p:nvSpPr>
            <p:spPr>
              <a:xfrm>
                <a:off x="951852" y="4048706"/>
                <a:ext cx="711926" cy="745363"/>
              </a:xfrm>
              <a:custGeom>
                <a:avLst/>
                <a:gdLst>
                  <a:gd name="connsiteX0" fmla="*/ 314703 w 711926"/>
                  <a:gd name="connsiteY0" fmla="*/ 0 h 745363"/>
                  <a:gd name="connsiteX1" fmla="*/ 311332 w 711926"/>
                  <a:gd name="connsiteY1" fmla="*/ 33437 h 745363"/>
                  <a:gd name="connsiteX2" fmla="*/ 625213 w 711926"/>
                  <a:gd name="connsiteY2" fmla="*/ 623777 h 745363"/>
                  <a:gd name="connsiteX3" fmla="*/ 711926 w 711926"/>
                  <a:gd name="connsiteY3" fmla="*/ 670843 h 745363"/>
                  <a:gd name="connsiteX4" fmla="*/ 677708 w 711926"/>
                  <a:gd name="connsiteY4" fmla="*/ 689416 h 745363"/>
                  <a:gd name="connsiteX5" fmla="*/ 400594 w 711926"/>
                  <a:gd name="connsiteY5" fmla="*/ 745363 h 745363"/>
                  <a:gd name="connsiteX6" fmla="*/ 123480 w 711926"/>
                  <a:gd name="connsiteY6" fmla="*/ 689416 h 745363"/>
                  <a:gd name="connsiteX7" fmla="*/ 3371 w 711926"/>
                  <a:gd name="connsiteY7" fmla="*/ 624223 h 745363"/>
                  <a:gd name="connsiteX8" fmla="*/ 0 w 711926"/>
                  <a:gd name="connsiteY8" fmla="*/ 590786 h 745363"/>
                  <a:gd name="connsiteX9" fmla="*/ 313881 w 711926"/>
                  <a:gd name="connsiteY9" fmla="*/ 446 h 745363"/>
                  <a:gd name="connsiteX10" fmla="*/ 314703 w 711926"/>
                  <a:gd name="connsiteY10" fmla="*/ 0 h 74536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711926" h="745363">
                    <a:moveTo>
                      <a:pt x="314703" y="0"/>
                    </a:moveTo>
                    <a:lnTo>
                      <a:pt x="311332" y="33437"/>
                    </a:lnTo>
                    <a:cubicBezTo>
                      <a:pt x="311332" y="279178"/>
                      <a:pt x="435840" y="495839"/>
                      <a:pt x="625213" y="623777"/>
                    </a:cubicBezTo>
                    <a:lnTo>
                      <a:pt x="711926" y="670843"/>
                    </a:lnTo>
                    <a:lnTo>
                      <a:pt x="677708" y="689416"/>
                    </a:lnTo>
                    <a:cubicBezTo>
                      <a:pt x="592534" y="725442"/>
                      <a:pt x="498891" y="745363"/>
                      <a:pt x="400594" y="745363"/>
                    </a:cubicBezTo>
                    <a:cubicBezTo>
                      <a:pt x="302298" y="745363"/>
                      <a:pt x="208654" y="725442"/>
                      <a:pt x="123480" y="689416"/>
                    </a:cubicBezTo>
                    <a:lnTo>
                      <a:pt x="3371" y="624223"/>
                    </a:lnTo>
                    <a:lnTo>
                      <a:pt x="0" y="590786"/>
                    </a:lnTo>
                    <a:cubicBezTo>
                      <a:pt x="0" y="345045"/>
                      <a:pt x="124508" y="128384"/>
                      <a:pt x="313881" y="446"/>
                    </a:cubicBezTo>
                    <a:lnTo>
                      <a:pt x="314703" y="0"/>
                    </a:lnTo>
                    <a:close/>
                  </a:path>
                </a:pathLst>
              </a:custGeom>
              <a:solidFill>
                <a:srgbClr val="87CCD9">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200" dirty="0" smtClean="0">
                    <a:solidFill>
                      <a:schemeClr val="tx1"/>
                    </a:solidFill>
                    <a:latin typeface="Cambria" panose="02040503050406030204" pitchFamily="18" charset="0"/>
                    <a:ea typeface="Cambria" panose="02040503050406030204" pitchFamily="18" charset="0"/>
                  </a:rPr>
                  <a:t>188</a:t>
                </a:r>
                <a:endParaRPr lang="en-GB" sz="1200" dirty="0">
                  <a:solidFill>
                    <a:schemeClr val="tx1"/>
                  </a:solidFill>
                  <a:latin typeface="Cambria" panose="02040503050406030204" pitchFamily="18" charset="0"/>
                  <a:ea typeface="Cambria" panose="02040503050406030204" pitchFamily="18" charset="0"/>
                </a:endParaRPr>
              </a:p>
            </p:txBody>
          </p:sp>
          <p:sp>
            <p:nvSpPr>
              <p:cNvPr id="28" name="Freeform 27"/>
              <p:cNvSpPr/>
              <p:nvPr/>
            </p:nvSpPr>
            <p:spPr>
              <a:xfrm>
                <a:off x="1663778" y="4048706"/>
                <a:ext cx="711926" cy="745363"/>
              </a:xfrm>
              <a:custGeom>
                <a:avLst/>
                <a:gdLst>
                  <a:gd name="connsiteX0" fmla="*/ 397223 w 711926"/>
                  <a:gd name="connsiteY0" fmla="*/ 0 h 745363"/>
                  <a:gd name="connsiteX1" fmla="*/ 398045 w 711926"/>
                  <a:gd name="connsiteY1" fmla="*/ 446 h 745363"/>
                  <a:gd name="connsiteX2" fmla="*/ 711926 w 711926"/>
                  <a:gd name="connsiteY2" fmla="*/ 590786 h 745363"/>
                  <a:gd name="connsiteX3" fmla="*/ 708555 w 711926"/>
                  <a:gd name="connsiteY3" fmla="*/ 624223 h 745363"/>
                  <a:gd name="connsiteX4" fmla="*/ 588446 w 711926"/>
                  <a:gd name="connsiteY4" fmla="*/ 689416 h 745363"/>
                  <a:gd name="connsiteX5" fmla="*/ 311332 w 711926"/>
                  <a:gd name="connsiteY5" fmla="*/ 745363 h 745363"/>
                  <a:gd name="connsiteX6" fmla="*/ 34218 w 711926"/>
                  <a:gd name="connsiteY6" fmla="*/ 689416 h 745363"/>
                  <a:gd name="connsiteX7" fmla="*/ 0 w 711926"/>
                  <a:gd name="connsiteY7" fmla="*/ 670843 h 745363"/>
                  <a:gd name="connsiteX8" fmla="*/ 86713 w 711926"/>
                  <a:gd name="connsiteY8" fmla="*/ 623777 h 745363"/>
                  <a:gd name="connsiteX9" fmla="*/ 400594 w 711926"/>
                  <a:gd name="connsiteY9" fmla="*/ 33437 h 745363"/>
                  <a:gd name="connsiteX10" fmla="*/ 397223 w 711926"/>
                  <a:gd name="connsiteY10" fmla="*/ 0 h 74536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711926" h="745363">
                    <a:moveTo>
                      <a:pt x="397223" y="0"/>
                    </a:moveTo>
                    <a:lnTo>
                      <a:pt x="398045" y="446"/>
                    </a:lnTo>
                    <a:cubicBezTo>
                      <a:pt x="587418" y="128384"/>
                      <a:pt x="711926" y="345045"/>
                      <a:pt x="711926" y="590786"/>
                    </a:cubicBezTo>
                    <a:lnTo>
                      <a:pt x="708555" y="624223"/>
                    </a:lnTo>
                    <a:lnTo>
                      <a:pt x="588446" y="689416"/>
                    </a:lnTo>
                    <a:cubicBezTo>
                      <a:pt x="503272" y="725442"/>
                      <a:pt x="409629" y="745363"/>
                      <a:pt x="311332" y="745363"/>
                    </a:cubicBezTo>
                    <a:cubicBezTo>
                      <a:pt x="213036" y="745363"/>
                      <a:pt x="119392" y="725442"/>
                      <a:pt x="34218" y="689416"/>
                    </a:cubicBezTo>
                    <a:lnTo>
                      <a:pt x="0" y="670843"/>
                    </a:lnTo>
                    <a:lnTo>
                      <a:pt x="86713" y="623777"/>
                    </a:lnTo>
                    <a:cubicBezTo>
                      <a:pt x="276086" y="495839"/>
                      <a:pt x="400594" y="279178"/>
                      <a:pt x="400594" y="33437"/>
                    </a:cubicBezTo>
                    <a:lnTo>
                      <a:pt x="397223" y="0"/>
                    </a:lnTo>
                    <a:close/>
                  </a:path>
                </a:pathLst>
              </a:custGeom>
              <a:solidFill>
                <a:srgbClr val="87CCD9">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r"/>
                <a:r>
                  <a:rPr lang="en-US" sz="1200" dirty="0" smtClean="0">
                    <a:solidFill>
                      <a:schemeClr val="tx1"/>
                    </a:solidFill>
                    <a:latin typeface="Cambria" panose="02040503050406030204" pitchFamily="18" charset="0"/>
                    <a:ea typeface="Cambria" panose="02040503050406030204" pitchFamily="18" charset="0"/>
                  </a:rPr>
                  <a:t>83</a:t>
                </a:r>
                <a:endParaRPr lang="en-GB" sz="1200" dirty="0">
                  <a:solidFill>
                    <a:schemeClr val="tx1"/>
                  </a:solidFill>
                  <a:latin typeface="Cambria" panose="02040503050406030204" pitchFamily="18" charset="0"/>
                  <a:ea typeface="Cambria" panose="02040503050406030204" pitchFamily="18" charset="0"/>
                </a:endParaRPr>
              </a:p>
            </p:txBody>
          </p:sp>
          <p:sp>
            <p:nvSpPr>
              <p:cNvPr id="29" name="Freeform 28"/>
              <p:cNvSpPr/>
              <p:nvPr/>
            </p:nvSpPr>
            <p:spPr>
              <a:xfrm>
                <a:off x="640520" y="3370217"/>
                <a:ext cx="1023258" cy="1302712"/>
              </a:xfrm>
              <a:custGeom>
                <a:avLst/>
                <a:gdLst>
                  <a:gd name="connsiteX0" fmla="*/ 711926 w 1023258"/>
                  <a:gd name="connsiteY0" fmla="*/ 0 h 1302712"/>
                  <a:gd name="connsiteX1" fmla="*/ 989040 w 1023258"/>
                  <a:gd name="connsiteY1" fmla="*/ 55947 h 1302712"/>
                  <a:gd name="connsiteX2" fmla="*/ 1023258 w 1023258"/>
                  <a:gd name="connsiteY2" fmla="*/ 74520 h 1302712"/>
                  <a:gd name="connsiteX3" fmla="*/ 936545 w 1023258"/>
                  <a:gd name="connsiteY3" fmla="*/ 121586 h 1302712"/>
                  <a:gd name="connsiteX4" fmla="*/ 637128 w 1023258"/>
                  <a:gd name="connsiteY4" fmla="*/ 568448 h 1302712"/>
                  <a:gd name="connsiteX5" fmla="*/ 626035 w 1023258"/>
                  <a:gd name="connsiteY5" fmla="*/ 678489 h 1302712"/>
                  <a:gd name="connsiteX6" fmla="*/ 625213 w 1023258"/>
                  <a:gd name="connsiteY6" fmla="*/ 678935 h 1302712"/>
                  <a:gd name="connsiteX7" fmla="*/ 311332 w 1023258"/>
                  <a:gd name="connsiteY7" fmla="*/ 1269275 h 1302712"/>
                  <a:gd name="connsiteX8" fmla="*/ 314703 w 1023258"/>
                  <a:gd name="connsiteY8" fmla="*/ 1302712 h 1302712"/>
                  <a:gd name="connsiteX9" fmla="*/ 313881 w 1023258"/>
                  <a:gd name="connsiteY9" fmla="*/ 1302266 h 1302712"/>
                  <a:gd name="connsiteX10" fmla="*/ 0 w 1023258"/>
                  <a:gd name="connsiteY10" fmla="*/ 711926 h 1302712"/>
                  <a:gd name="connsiteX11" fmla="*/ 711926 w 1023258"/>
                  <a:gd name="connsiteY11" fmla="*/ 0 h 13027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Lst>
                <a:rect l="l" t="t" r="r" b="b"/>
                <a:pathLst>
                  <a:path w="1023258" h="1302712">
                    <a:moveTo>
                      <a:pt x="711926" y="0"/>
                    </a:moveTo>
                    <a:cubicBezTo>
                      <a:pt x="810223" y="0"/>
                      <a:pt x="903866" y="19921"/>
                      <a:pt x="989040" y="55947"/>
                    </a:cubicBezTo>
                    <a:lnTo>
                      <a:pt x="1023258" y="74520"/>
                    </a:lnTo>
                    <a:lnTo>
                      <a:pt x="936545" y="121586"/>
                    </a:lnTo>
                    <a:cubicBezTo>
                      <a:pt x="785047" y="223936"/>
                      <a:pt x="675062" y="383069"/>
                      <a:pt x="637128" y="568448"/>
                    </a:cubicBezTo>
                    <a:lnTo>
                      <a:pt x="626035" y="678489"/>
                    </a:lnTo>
                    <a:lnTo>
                      <a:pt x="625213" y="678935"/>
                    </a:lnTo>
                    <a:cubicBezTo>
                      <a:pt x="435840" y="806873"/>
                      <a:pt x="311332" y="1023534"/>
                      <a:pt x="311332" y="1269275"/>
                    </a:cubicBezTo>
                    <a:lnTo>
                      <a:pt x="314703" y="1302712"/>
                    </a:lnTo>
                    <a:lnTo>
                      <a:pt x="313881" y="1302266"/>
                    </a:lnTo>
                    <a:cubicBezTo>
                      <a:pt x="124508" y="1174328"/>
                      <a:pt x="0" y="957667"/>
                      <a:pt x="0" y="711926"/>
                    </a:cubicBezTo>
                    <a:cubicBezTo>
                      <a:pt x="0" y="318740"/>
                      <a:pt x="318740" y="0"/>
                      <a:pt x="711926" y="0"/>
                    </a:cubicBezTo>
                    <a:close/>
                  </a:path>
                </a:pathLst>
              </a:custGeom>
              <a:solidFill>
                <a:srgbClr val="87CCD9">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200" dirty="0" smtClean="0">
                    <a:solidFill>
                      <a:schemeClr val="tx1"/>
                    </a:solidFill>
                    <a:latin typeface="Cambria" panose="02040503050406030204" pitchFamily="18" charset="0"/>
                    <a:ea typeface="Cambria" panose="02040503050406030204" pitchFamily="18" charset="0"/>
                  </a:rPr>
                  <a:t>131</a:t>
                </a:r>
              </a:p>
            </p:txBody>
          </p:sp>
          <p:sp>
            <p:nvSpPr>
              <p:cNvPr id="30" name="Freeform 29"/>
              <p:cNvSpPr/>
              <p:nvPr/>
            </p:nvSpPr>
            <p:spPr>
              <a:xfrm>
                <a:off x="1663778" y="3370217"/>
                <a:ext cx="1023258" cy="1302712"/>
              </a:xfrm>
              <a:custGeom>
                <a:avLst/>
                <a:gdLst>
                  <a:gd name="connsiteX0" fmla="*/ 311332 w 1023258"/>
                  <a:gd name="connsiteY0" fmla="*/ 0 h 1302712"/>
                  <a:gd name="connsiteX1" fmla="*/ 1023258 w 1023258"/>
                  <a:gd name="connsiteY1" fmla="*/ 711926 h 1302712"/>
                  <a:gd name="connsiteX2" fmla="*/ 709377 w 1023258"/>
                  <a:gd name="connsiteY2" fmla="*/ 1302266 h 1302712"/>
                  <a:gd name="connsiteX3" fmla="*/ 708555 w 1023258"/>
                  <a:gd name="connsiteY3" fmla="*/ 1302712 h 1302712"/>
                  <a:gd name="connsiteX4" fmla="*/ 711926 w 1023258"/>
                  <a:gd name="connsiteY4" fmla="*/ 1269275 h 1302712"/>
                  <a:gd name="connsiteX5" fmla="*/ 398045 w 1023258"/>
                  <a:gd name="connsiteY5" fmla="*/ 678935 h 1302712"/>
                  <a:gd name="connsiteX6" fmla="*/ 397223 w 1023258"/>
                  <a:gd name="connsiteY6" fmla="*/ 678489 h 1302712"/>
                  <a:gd name="connsiteX7" fmla="*/ 386130 w 1023258"/>
                  <a:gd name="connsiteY7" fmla="*/ 568448 h 1302712"/>
                  <a:gd name="connsiteX8" fmla="*/ 86713 w 1023258"/>
                  <a:gd name="connsiteY8" fmla="*/ 121586 h 1302712"/>
                  <a:gd name="connsiteX9" fmla="*/ 0 w 1023258"/>
                  <a:gd name="connsiteY9" fmla="*/ 74520 h 1302712"/>
                  <a:gd name="connsiteX10" fmla="*/ 34218 w 1023258"/>
                  <a:gd name="connsiteY10" fmla="*/ 55947 h 1302712"/>
                  <a:gd name="connsiteX11" fmla="*/ 311332 w 1023258"/>
                  <a:gd name="connsiteY11" fmla="*/ 0 h 13027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Lst>
                <a:rect l="l" t="t" r="r" b="b"/>
                <a:pathLst>
                  <a:path w="1023258" h="1302712">
                    <a:moveTo>
                      <a:pt x="311332" y="0"/>
                    </a:moveTo>
                    <a:cubicBezTo>
                      <a:pt x="704518" y="0"/>
                      <a:pt x="1023258" y="318740"/>
                      <a:pt x="1023258" y="711926"/>
                    </a:cubicBezTo>
                    <a:cubicBezTo>
                      <a:pt x="1023258" y="957667"/>
                      <a:pt x="898750" y="1174328"/>
                      <a:pt x="709377" y="1302266"/>
                    </a:cubicBezTo>
                    <a:lnTo>
                      <a:pt x="708555" y="1302712"/>
                    </a:lnTo>
                    <a:lnTo>
                      <a:pt x="711926" y="1269275"/>
                    </a:lnTo>
                    <a:cubicBezTo>
                      <a:pt x="711926" y="1023534"/>
                      <a:pt x="587418" y="806873"/>
                      <a:pt x="398045" y="678935"/>
                    </a:cubicBezTo>
                    <a:lnTo>
                      <a:pt x="397223" y="678489"/>
                    </a:lnTo>
                    <a:lnTo>
                      <a:pt x="386130" y="568448"/>
                    </a:lnTo>
                    <a:cubicBezTo>
                      <a:pt x="348196" y="383069"/>
                      <a:pt x="238212" y="223936"/>
                      <a:pt x="86713" y="121586"/>
                    </a:cubicBezTo>
                    <a:lnTo>
                      <a:pt x="0" y="74520"/>
                    </a:lnTo>
                    <a:lnTo>
                      <a:pt x="34218" y="55947"/>
                    </a:lnTo>
                    <a:cubicBezTo>
                      <a:pt x="119392" y="19921"/>
                      <a:pt x="213036" y="0"/>
                      <a:pt x="311332" y="0"/>
                    </a:cubicBezTo>
                    <a:close/>
                  </a:path>
                </a:pathLst>
              </a:custGeom>
              <a:solidFill>
                <a:srgbClr val="87CCD9">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r"/>
                <a:r>
                  <a:rPr lang="en-US" sz="1200" dirty="0" smtClean="0">
                    <a:solidFill>
                      <a:schemeClr val="tx1"/>
                    </a:solidFill>
                    <a:latin typeface="Cambria" panose="02040503050406030204" pitchFamily="18" charset="0"/>
                    <a:ea typeface="Cambria" panose="02040503050406030204" pitchFamily="18" charset="0"/>
                  </a:rPr>
                  <a:t>60</a:t>
                </a:r>
              </a:p>
            </p:txBody>
          </p:sp>
          <p:sp>
            <p:nvSpPr>
              <p:cNvPr id="31" name="Freeform 30"/>
              <p:cNvSpPr/>
              <p:nvPr/>
            </p:nvSpPr>
            <p:spPr>
              <a:xfrm>
                <a:off x="1263184" y="3927566"/>
                <a:ext cx="801188" cy="791983"/>
              </a:xfrm>
              <a:custGeom>
                <a:avLst/>
                <a:gdLst>
                  <a:gd name="connsiteX0" fmla="*/ 400594 w 801188"/>
                  <a:gd name="connsiteY0" fmla="*/ 0 h 791983"/>
                  <a:gd name="connsiteX1" fmla="*/ 677708 w 801188"/>
                  <a:gd name="connsiteY1" fmla="*/ 55947 h 791983"/>
                  <a:gd name="connsiteX2" fmla="*/ 797817 w 801188"/>
                  <a:gd name="connsiteY2" fmla="*/ 121140 h 791983"/>
                  <a:gd name="connsiteX3" fmla="*/ 801188 w 801188"/>
                  <a:gd name="connsiteY3" fmla="*/ 154577 h 791983"/>
                  <a:gd name="connsiteX4" fmla="*/ 487307 w 801188"/>
                  <a:gd name="connsiteY4" fmla="*/ 744917 h 791983"/>
                  <a:gd name="connsiteX5" fmla="*/ 400594 w 801188"/>
                  <a:gd name="connsiteY5" fmla="*/ 791983 h 791983"/>
                  <a:gd name="connsiteX6" fmla="*/ 313881 w 801188"/>
                  <a:gd name="connsiteY6" fmla="*/ 744917 h 791983"/>
                  <a:gd name="connsiteX7" fmla="*/ 0 w 801188"/>
                  <a:gd name="connsiteY7" fmla="*/ 154577 h 791983"/>
                  <a:gd name="connsiteX8" fmla="*/ 3371 w 801188"/>
                  <a:gd name="connsiteY8" fmla="*/ 121140 h 791983"/>
                  <a:gd name="connsiteX9" fmla="*/ 123480 w 801188"/>
                  <a:gd name="connsiteY9" fmla="*/ 55947 h 791983"/>
                  <a:gd name="connsiteX10" fmla="*/ 400594 w 801188"/>
                  <a:gd name="connsiteY10" fmla="*/ 0 h 79198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801188" h="791983">
                    <a:moveTo>
                      <a:pt x="400594" y="0"/>
                    </a:moveTo>
                    <a:cubicBezTo>
                      <a:pt x="498891" y="0"/>
                      <a:pt x="592534" y="19921"/>
                      <a:pt x="677708" y="55947"/>
                    </a:cubicBezTo>
                    <a:lnTo>
                      <a:pt x="797817" y="121140"/>
                    </a:lnTo>
                    <a:lnTo>
                      <a:pt x="801188" y="154577"/>
                    </a:lnTo>
                    <a:cubicBezTo>
                      <a:pt x="801188" y="400318"/>
                      <a:pt x="676680" y="616979"/>
                      <a:pt x="487307" y="744917"/>
                    </a:cubicBezTo>
                    <a:lnTo>
                      <a:pt x="400594" y="791983"/>
                    </a:lnTo>
                    <a:lnTo>
                      <a:pt x="313881" y="744917"/>
                    </a:lnTo>
                    <a:cubicBezTo>
                      <a:pt x="124508" y="616979"/>
                      <a:pt x="0" y="400318"/>
                      <a:pt x="0" y="154577"/>
                    </a:cubicBezTo>
                    <a:lnTo>
                      <a:pt x="3371" y="121140"/>
                    </a:lnTo>
                    <a:lnTo>
                      <a:pt x="123480" y="55947"/>
                    </a:lnTo>
                    <a:cubicBezTo>
                      <a:pt x="208654" y="19921"/>
                      <a:pt x="302298" y="0"/>
                      <a:pt x="400594" y="0"/>
                    </a:cubicBezTo>
                    <a:close/>
                  </a:path>
                </a:pathLst>
              </a:custGeom>
              <a:solidFill>
                <a:srgbClr val="87CCD9">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smtClean="0">
                    <a:solidFill>
                      <a:schemeClr val="tx1"/>
                    </a:solidFill>
                    <a:latin typeface="Cambria" panose="02040503050406030204" pitchFamily="18" charset="0"/>
                    <a:ea typeface="Cambria" panose="02040503050406030204" pitchFamily="18" charset="0"/>
                  </a:rPr>
                  <a:t>2,346</a:t>
                </a:r>
                <a:endParaRPr lang="en-GB" sz="1200" dirty="0">
                  <a:solidFill>
                    <a:schemeClr val="tx1"/>
                  </a:solidFill>
                  <a:latin typeface="Cambria" panose="02040503050406030204" pitchFamily="18" charset="0"/>
                  <a:ea typeface="Cambria" panose="02040503050406030204" pitchFamily="18" charset="0"/>
                </a:endParaRPr>
              </a:p>
            </p:txBody>
          </p:sp>
          <p:sp>
            <p:nvSpPr>
              <p:cNvPr id="32" name="Freeform 31"/>
              <p:cNvSpPr/>
              <p:nvPr/>
            </p:nvSpPr>
            <p:spPr>
              <a:xfrm>
                <a:off x="955223" y="4672929"/>
                <a:ext cx="1417110" cy="678489"/>
              </a:xfrm>
              <a:custGeom>
                <a:avLst/>
                <a:gdLst>
                  <a:gd name="connsiteX0" fmla="*/ 0 w 1417110"/>
                  <a:gd name="connsiteY0" fmla="*/ 0 h 678489"/>
                  <a:gd name="connsiteX1" fmla="*/ 120109 w 1417110"/>
                  <a:gd name="connsiteY1" fmla="*/ 65193 h 678489"/>
                  <a:gd name="connsiteX2" fmla="*/ 397223 w 1417110"/>
                  <a:gd name="connsiteY2" fmla="*/ 121140 h 678489"/>
                  <a:gd name="connsiteX3" fmla="*/ 674337 w 1417110"/>
                  <a:gd name="connsiteY3" fmla="*/ 65193 h 678489"/>
                  <a:gd name="connsiteX4" fmla="*/ 708555 w 1417110"/>
                  <a:gd name="connsiteY4" fmla="*/ 46620 h 678489"/>
                  <a:gd name="connsiteX5" fmla="*/ 742773 w 1417110"/>
                  <a:gd name="connsiteY5" fmla="*/ 65193 h 678489"/>
                  <a:gd name="connsiteX6" fmla="*/ 1019887 w 1417110"/>
                  <a:gd name="connsiteY6" fmla="*/ 121140 h 678489"/>
                  <a:gd name="connsiteX7" fmla="*/ 1297001 w 1417110"/>
                  <a:gd name="connsiteY7" fmla="*/ 65193 h 678489"/>
                  <a:gd name="connsiteX8" fmla="*/ 1417110 w 1417110"/>
                  <a:gd name="connsiteY8" fmla="*/ 0 h 678489"/>
                  <a:gd name="connsiteX9" fmla="*/ 1406017 w 1417110"/>
                  <a:gd name="connsiteY9" fmla="*/ 110041 h 678489"/>
                  <a:gd name="connsiteX10" fmla="*/ 708555 w 1417110"/>
                  <a:gd name="connsiteY10" fmla="*/ 678489 h 678489"/>
                  <a:gd name="connsiteX11" fmla="*/ 11093 w 1417110"/>
                  <a:gd name="connsiteY11" fmla="*/ 110041 h 678489"/>
                  <a:gd name="connsiteX12" fmla="*/ 0 w 1417110"/>
                  <a:gd name="connsiteY12" fmla="*/ 0 h 67848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Lst>
                <a:rect l="l" t="t" r="r" b="b"/>
                <a:pathLst>
                  <a:path w="1417110" h="678489">
                    <a:moveTo>
                      <a:pt x="0" y="0"/>
                    </a:moveTo>
                    <a:lnTo>
                      <a:pt x="120109" y="65193"/>
                    </a:lnTo>
                    <a:cubicBezTo>
                      <a:pt x="205283" y="101219"/>
                      <a:pt x="298927" y="121140"/>
                      <a:pt x="397223" y="121140"/>
                    </a:cubicBezTo>
                    <a:cubicBezTo>
                      <a:pt x="495520" y="121140"/>
                      <a:pt x="589163" y="101219"/>
                      <a:pt x="674337" y="65193"/>
                    </a:cubicBezTo>
                    <a:lnTo>
                      <a:pt x="708555" y="46620"/>
                    </a:lnTo>
                    <a:lnTo>
                      <a:pt x="742773" y="65193"/>
                    </a:lnTo>
                    <a:cubicBezTo>
                      <a:pt x="827947" y="101219"/>
                      <a:pt x="921591" y="121140"/>
                      <a:pt x="1019887" y="121140"/>
                    </a:cubicBezTo>
                    <a:cubicBezTo>
                      <a:pt x="1118184" y="121140"/>
                      <a:pt x="1211827" y="101219"/>
                      <a:pt x="1297001" y="65193"/>
                    </a:cubicBezTo>
                    <a:lnTo>
                      <a:pt x="1417110" y="0"/>
                    </a:lnTo>
                    <a:lnTo>
                      <a:pt x="1406017" y="110041"/>
                    </a:lnTo>
                    <a:cubicBezTo>
                      <a:pt x="1339633" y="434454"/>
                      <a:pt x="1052593" y="678489"/>
                      <a:pt x="708555" y="678489"/>
                    </a:cubicBezTo>
                    <a:cubicBezTo>
                      <a:pt x="364517" y="678489"/>
                      <a:pt x="77477" y="434454"/>
                      <a:pt x="11093" y="110041"/>
                    </a:cubicBezTo>
                    <a:lnTo>
                      <a:pt x="0" y="0"/>
                    </a:lnTo>
                    <a:close/>
                  </a:path>
                </a:pathLst>
              </a:custGeom>
              <a:solidFill>
                <a:srgbClr val="87CCD9">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smtClean="0">
                    <a:solidFill>
                      <a:schemeClr val="tx1"/>
                    </a:solidFill>
                    <a:latin typeface="Cambria" panose="02040503050406030204" pitchFamily="18" charset="0"/>
                    <a:ea typeface="Cambria" panose="02040503050406030204" pitchFamily="18" charset="0"/>
                  </a:rPr>
                  <a:t>81</a:t>
                </a:r>
                <a:endParaRPr lang="en-GB" sz="1200" dirty="0">
                  <a:solidFill>
                    <a:schemeClr val="tx1"/>
                  </a:solidFill>
                  <a:latin typeface="Cambria" panose="02040503050406030204" pitchFamily="18" charset="0"/>
                  <a:ea typeface="Cambria" panose="02040503050406030204" pitchFamily="18" charset="0"/>
                </a:endParaRPr>
              </a:p>
            </p:txBody>
          </p:sp>
        </p:grpSp>
        <p:grpSp>
          <p:nvGrpSpPr>
            <p:cNvPr id="72" name="Group 71"/>
            <p:cNvGrpSpPr/>
            <p:nvPr/>
          </p:nvGrpSpPr>
          <p:grpSpPr>
            <a:xfrm>
              <a:off x="4544033" y="1094308"/>
              <a:ext cx="2046516" cy="1981201"/>
              <a:chOff x="2874373" y="3370217"/>
              <a:chExt cx="2046516" cy="1981201"/>
            </a:xfrm>
          </p:grpSpPr>
          <p:sp>
            <p:nvSpPr>
              <p:cNvPr id="33" name="Freeform 32"/>
              <p:cNvSpPr/>
              <p:nvPr/>
            </p:nvSpPr>
            <p:spPr>
              <a:xfrm>
                <a:off x="3500408" y="3444737"/>
                <a:ext cx="794446" cy="603969"/>
              </a:xfrm>
              <a:custGeom>
                <a:avLst/>
                <a:gdLst>
                  <a:gd name="connsiteX0" fmla="*/ 397223 w 794446"/>
                  <a:gd name="connsiteY0" fmla="*/ 0 h 603969"/>
                  <a:gd name="connsiteX1" fmla="*/ 483936 w 794446"/>
                  <a:gd name="connsiteY1" fmla="*/ 47066 h 603969"/>
                  <a:gd name="connsiteX2" fmla="*/ 783353 w 794446"/>
                  <a:gd name="connsiteY2" fmla="*/ 493928 h 603969"/>
                  <a:gd name="connsiteX3" fmla="*/ 794446 w 794446"/>
                  <a:gd name="connsiteY3" fmla="*/ 603969 h 603969"/>
                  <a:gd name="connsiteX4" fmla="*/ 674337 w 794446"/>
                  <a:gd name="connsiteY4" fmla="*/ 538776 h 603969"/>
                  <a:gd name="connsiteX5" fmla="*/ 397223 w 794446"/>
                  <a:gd name="connsiteY5" fmla="*/ 482829 h 603969"/>
                  <a:gd name="connsiteX6" fmla="*/ 120109 w 794446"/>
                  <a:gd name="connsiteY6" fmla="*/ 538776 h 603969"/>
                  <a:gd name="connsiteX7" fmla="*/ 0 w 794446"/>
                  <a:gd name="connsiteY7" fmla="*/ 603969 h 603969"/>
                  <a:gd name="connsiteX8" fmla="*/ 11093 w 794446"/>
                  <a:gd name="connsiteY8" fmla="*/ 493928 h 603969"/>
                  <a:gd name="connsiteX9" fmla="*/ 310510 w 794446"/>
                  <a:gd name="connsiteY9" fmla="*/ 47066 h 603969"/>
                  <a:gd name="connsiteX10" fmla="*/ 397223 w 794446"/>
                  <a:gd name="connsiteY10" fmla="*/ 0 h 60396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794446" h="603969">
                    <a:moveTo>
                      <a:pt x="397223" y="0"/>
                    </a:moveTo>
                    <a:lnTo>
                      <a:pt x="483936" y="47066"/>
                    </a:lnTo>
                    <a:cubicBezTo>
                      <a:pt x="635435" y="149416"/>
                      <a:pt x="745419" y="308549"/>
                      <a:pt x="783353" y="493928"/>
                    </a:cubicBezTo>
                    <a:lnTo>
                      <a:pt x="794446" y="603969"/>
                    </a:lnTo>
                    <a:lnTo>
                      <a:pt x="674337" y="538776"/>
                    </a:lnTo>
                    <a:cubicBezTo>
                      <a:pt x="589163" y="502750"/>
                      <a:pt x="495520" y="482829"/>
                      <a:pt x="397223" y="482829"/>
                    </a:cubicBezTo>
                    <a:cubicBezTo>
                      <a:pt x="298927" y="482829"/>
                      <a:pt x="205283" y="502750"/>
                      <a:pt x="120109" y="538776"/>
                    </a:cubicBezTo>
                    <a:lnTo>
                      <a:pt x="0" y="603969"/>
                    </a:lnTo>
                    <a:lnTo>
                      <a:pt x="11093" y="493928"/>
                    </a:lnTo>
                    <a:cubicBezTo>
                      <a:pt x="49027" y="308549"/>
                      <a:pt x="159012" y="149416"/>
                      <a:pt x="310510" y="47066"/>
                    </a:cubicBezTo>
                    <a:lnTo>
                      <a:pt x="397223" y="0"/>
                    </a:lnTo>
                    <a:close/>
                  </a:path>
                </a:pathLst>
              </a:custGeom>
              <a:solidFill>
                <a:srgbClr val="87CCD9">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smtClean="0">
                    <a:solidFill>
                      <a:schemeClr val="tx1"/>
                    </a:solidFill>
                    <a:latin typeface="Cambria" panose="02040503050406030204" pitchFamily="18" charset="0"/>
                    <a:ea typeface="Cambria" panose="02040503050406030204" pitchFamily="18" charset="0"/>
                  </a:rPr>
                  <a:t>65</a:t>
                </a:r>
                <a:endParaRPr lang="en-GB" sz="1200" dirty="0">
                  <a:solidFill>
                    <a:schemeClr val="tx1"/>
                  </a:solidFill>
                  <a:latin typeface="Cambria" panose="02040503050406030204" pitchFamily="18" charset="0"/>
                  <a:ea typeface="Cambria" panose="02040503050406030204" pitchFamily="18" charset="0"/>
                </a:endParaRPr>
              </a:p>
            </p:txBody>
          </p:sp>
          <p:sp>
            <p:nvSpPr>
              <p:cNvPr id="34" name="Freeform 33"/>
              <p:cNvSpPr/>
              <p:nvPr/>
            </p:nvSpPr>
            <p:spPr>
              <a:xfrm>
                <a:off x="3185705" y="4048706"/>
                <a:ext cx="711926" cy="745363"/>
              </a:xfrm>
              <a:custGeom>
                <a:avLst/>
                <a:gdLst>
                  <a:gd name="connsiteX0" fmla="*/ 314703 w 711926"/>
                  <a:gd name="connsiteY0" fmla="*/ 0 h 745363"/>
                  <a:gd name="connsiteX1" fmla="*/ 311332 w 711926"/>
                  <a:gd name="connsiteY1" fmla="*/ 33437 h 745363"/>
                  <a:gd name="connsiteX2" fmla="*/ 625213 w 711926"/>
                  <a:gd name="connsiteY2" fmla="*/ 623777 h 745363"/>
                  <a:gd name="connsiteX3" fmla="*/ 711926 w 711926"/>
                  <a:gd name="connsiteY3" fmla="*/ 670843 h 745363"/>
                  <a:gd name="connsiteX4" fmla="*/ 677708 w 711926"/>
                  <a:gd name="connsiteY4" fmla="*/ 689416 h 745363"/>
                  <a:gd name="connsiteX5" fmla="*/ 400594 w 711926"/>
                  <a:gd name="connsiteY5" fmla="*/ 745363 h 745363"/>
                  <a:gd name="connsiteX6" fmla="*/ 123480 w 711926"/>
                  <a:gd name="connsiteY6" fmla="*/ 689416 h 745363"/>
                  <a:gd name="connsiteX7" fmla="*/ 3371 w 711926"/>
                  <a:gd name="connsiteY7" fmla="*/ 624223 h 745363"/>
                  <a:gd name="connsiteX8" fmla="*/ 0 w 711926"/>
                  <a:gd name="connsiteY8" fmla="*/ 590786 h 745363"/>
                  <a:gd name="connsiteX9" fmla="*/ 313881 w 711926"/>
                  <a:gd name="connsiteY9" fmla="*/ 446 h 745363"/>
                  <a:gd name="connsiteX10" fmla="*/ 314703 w 711926"/>
                  <a:gd name="connsiteY10" fmla="*/ 0 h 74536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711926" h="745363">
                    <a:moveTo>
                      <a:pt x="314703" y="0"/>
                    </a:moveTo>
                    <a:lnTo>
                      <a:pt x="311332" y="33437"/>
                    </a:lnTo>
                    <a:cubicBezTo>
                      <a:pt x="311332" y="279178"/>
                      <a:pt x="435840" y="495839"/>
                      <a:pt x="625213" y="623777"/>
                    </a:cubicBezTo>
                    <a:lnTo>
                      <a:pt x="711926" y="670843"/>
                    </a:lnTo>
                    <a:lnTo>
                      <a:pt x="677708" y="689416"/>
                    </a:lnTo>
                    <a:cubicBezTo>
                      <a:pt x="592534" y="725442"/>
                      <a:pt x="498891" y="745363"/>
                      <a:pt x="400594" y="745363"/>
                    </a:cubicBezTo>
                    <a:cubicBezTo>
                      <a:pt x="302298" y="745363"/>
                      <a:pt x="208654" y="725442"/>
                      <a:pt x="123480" y="689416"/>
                    </a:cubicBezTo>
                    <a:lnTo>
                      <a:pt x="3371" y="624223"/>
                    </a:lnTo>
                    <a:lnTo>
                      <a:pt x="0" y="590786"/>
                    </a:lnTo>
                    <a:cubicBezTo>
                      <a:pt x="0" y="345045"/>
                      <a:pt x="124508" y="128384"/>
                      <a:pt x="313881" y="446"/>
                    </a:cubicBezTo>
                    <a:lnTo>
                      <a:pt x="314703" y="0"/>
                    </a:lnTo>
                    <a:close/>
                  </a:path>
                </a:pathLst>
              </a:custGeom>
              <a:solidFill>
                <a:srgbClr val="87CCD9">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200" dirty="0" smtClean="0">
                    <a:solidFill>
                      <a:schemeClr val="tx1"/>
                    </a:solidFill>
                    <a:latin typeface="Cambria" panose="02040503050406030204" pitchFamily="18" charset="0"/>
                    <a:ea typeface="Cambria" panose="02040503050406030204" pitchFamily="18" charset="0"/>
                  </a:rPr>
                  <a:t>99</a:t>
                </a:r>
                <a:endParaRPr lang="en-GB" sz="1200" dirty="0">
                  <a:solidFill>
                    <a:schemeClr val="tx1"/>
                  </a:solidFill>
                  <a:latin typeface="Cambria" panose="02040503050406030204" pitchFamily="18" charset="0"/>
                  <a:ea typeface="Cambria" panose="02040503050406030204" pitchFamily="18" charset="0"/>
                </a:endParaRPr>
              </a:p>
            </p:txBody>
          </p:sp>
          <p:sp>
            <p:nvSpPr>
              <p:cNvPr id="35" name="Freeform 34"/>
              <p:cNvSpPr/>
              <p:nvPr/>
            </p:nvSpPr>
            <p:spPr>
              <a:xfrm>
                <a:off x="3897631" y="4048706"/>
                <a:ext cx="711926" cy="745363"/>
              </a:xfrm>
              <a:custGeom>
                <a:avLst/>
                <a:gdLst>
                  <a:gd name="connsiteX0" fmla="*/ 397223 w 711926"/>
                  <a:gd name="connsiteY0" fmla="*/ 0 h 745363"/>
                  <a:gd name="connsiteX1" fmla="*/ 398045 w 711926"/>
                  <a:gd name="connsiteY1" fmla="*/ 446 h 745363"/>
                  <a:gd name="connsiteX2" fmla="*/ 711926 w 711926"/>
                  <a:gd name="connsiteY2" fmla="*/ 590786 h 745363"/>
                  <a:gd name="connsiteX3" fmla="*/ 708555 w 711926"/>
                  <a:gd name="connsiteY3" fmla="*/ 624223 h 745363"/>
                  <a:gd name="connsiteX4" fmla="*/ 588446 w 711926"/>
                  <a:gd name="connsiteY4" fmla="*/ 689416 h 745363"/>
                  <a:gd name="connsiteX5" fmla="*/ 311332 w 711926"/>
                  <a:gd name="connsiteY5" fmla="*/ 745363 h 745363"/>
                  <a:gd name="connsiteX6" fmla="*/ 34218 w 711926"/>
                  <a:gd name="connsiteY6" fmla="*/ 689416 h 745363"/>
                  <a:gd name="connsiteX7" fmla="*/ 0 w 711926"/>
                  <a:gd name="connsiteY7" fmla="*/ 670843 h 745363"/>
                  <a:gd name="connsiteX8" fmla="*/ 86713 w 711926"/>
                  <a:gd name="connsiteY8" fmla="*/ 623777 h 745363"/>
                  <a:gd name="connsiteX9" fmla="*/ 400594 w 711926"/>
                  <a:gd name="connsiteY9" fmla="*/ 33437 h 745363"/>
                  <a:gd name="connsiteX10" fmla="*/ 397223 w 711926"/>
                  <a:gd name="connsiteY10" fmla="*/ 0 h 74536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711926" h="745363">
                    <a:moveTo>
                      <a:pt x="397223" y="0"/>
                    </a:moveTo>
                    <a:lnTo>
                      <a:pt x="398045" y="446"/>
                    </a:lnTo>
                    <a:cubicBezTo>
                      <a:pt x="587418" y="128384"/>
                      <a:pt x="711926" y="345045"/>
                      <a:pt x="711926" y="590786"/>
                    </a:cubicBezTo>
                    <a:lnTo>
                      <a:pt x="708555" y="624223"/>
                    </a:lnTo>
                    <a:lnTo>
                      <a:pt x="588446" y="689416"/>
                    </a:lnTo>
                    <a:cubicBezTo>
                      <a:pt x="503272" y="725442"/>
                      <a:pt x="409629" y="745363"/>
                      <a:pt x="311332" y="745363"/>
                    </a:cubicBezTo>
                    <a:cubicBezTo>
                      <a:pt x="213036" y="745363"/>
                      <a:pt x="119392" y="725442"/>
                      <a:pt x="34218" y="689416"/>
                    </a:cubicBezTo>
                    <a:lnTo>
                      <a:pt x="0" y="670843"/>
                    </a:lnTo>
                    <a:lnTo>
                      <a:pt x="86713" y="623777"/>
                    </a:lnTo>
                    <a:cubicBezTo>
                      <a:pt x="276086" y="495839"/>
                      <a:pt x="400594" y="279178"/>
                      <a:pt x="400594" y="33437"/>
                    </a:cubicBezTo>
                    <a:lnTo>
                      <a:pt x="397223" y="0"/>
                    </a:lnTo>
                    <a:close/>
                  </a:path>
                </a:pathLst>
              </a:custGeom>
              <a:solidFill>
                <a:srgbClr val="87CCD9">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r"/>
                <a:r>
                  <a:rPr lang="en-US" sz="1200" dirty="0" smtClean="0">
                    <a:solidFill>
                      <a:schemeClr val="tx1"/>
                    </a:solidFill>
                    <a:latin typeface="Cambria" panose="02040503050406030204" pitchFamily="18" charset="0"/>
                    <a:ea typeface="Cambria" panose="02040503050406030204" pitchFamily="18" charset="0"/>
                  </a:rPr>
                  <a:t>249</a:t>
                </a:r>
                <a:endParaRPr lang="en-GB" sz="1200" dirty="0">
                  <a:solidFill>
                    <a:schemeClr val="tx1"/>
                  </a:solidFill>
                  <a:latin typeface="Cambria" panose="02040503050406030204" pitchFamily="18" charset="0"/>
                  <a:ea typeface="Cambria" panose="02040503050406030204" pitchFamily="18" charset="0"/>
                </a:endParaRPr>
              </a:p>
            </p:txBody>
          </p:sp>
          <p:sp>
            <p:nvSpPr>
              <p:cNvPr id="36" name="Freeform 35"/>
              <p:cNvSpPr/>
              <p:nvPr/>
            </p:nvSpPr>
            <p:spPr>
              <a:xfrm>
                <a:off x="2874373" y="3370217"/>
                <a:ext cx="1023258" cy="1302712"/>
              </a:xfrm>
              <a:custGeom>
                <a:avLst/>
                <a:gdLst>
                  <a:gd name="connsiteX0" fmla="*/ 711926 w 1023258"/>
                  <a:gd name="connsiteY0" fmla="*/ 0 h 1302712"/>
                  <a:gd name="connsiteX1" fmla="*/ 989040 w 1023258"/>
                  <a:gd name="connsiteY1" fmla="*/ 55947 h 1302712"/>
                  <a:gd name="connsiteX2" fmla="*/ 1023258 w 1023258"/>
                  <a:gd name="connsiteY2" fmla="*/ 74520 h 1302712"/>
                  <a:gd name="connsiteX3" fmla="*/ 936545 w 1023258"/>
                  <a:gd name="connsiteY3" fmla="*/ 121586 h 1302712"/>
                  <a:gd name="connsiteX4" fmla="*/ 637128 w 1023258"/>
                  <a:gd name="connsiteY4" fmla="*/ 568448 h 1302712"/>
                  <a:gd name="connsiteX5" fmla="*/ 626035 w 1023258"/>
                  <a:gd name="connsiteY5" fmla="*/ 678489 h 1302712"/>
                  <a:gd name="connsiteX6" fmla="*/ 625213 w 1023258"/>
                  <a:gd name="connsiteY6" fmla="*/ 678935 h 1302712"/>
                  <a:gd name="connsiteX7" fmla="*/ 311332 w 1023258"/>
                  <a:gd name="connsiteY7" fmla="*/ 1269275 h 1302712"/>
                  <a:gd name="connsiteX8" fmla="*/ 314703 w 1023258"/>
                  <a:gd name="connsiteY8" fmla="*/ 1302712 h 1302712"/>
                  <a:gd name="connsiteX9" fmla="*/ 313881 w 1023258"/>
                  <a:gd name="connsiteY9" fmla="*/ 1302266 h 1302712"/>
                  <a:gd name="connsiteX10" fmla="*/ 0 w 1023258"/>
                  <a:gd name="connsiteY10" fmla="*/ 711926 h 1302712"/>
                  <a:gd name="connsiteX11" fmla="*/ 711926 w 1023258"/>
                  <a:gd name="connsiteY11" fmla="*/ 0 h 13027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Lst>
                <a:rect l="l" t="t" r="r" b="b"/>
                <a:pathLst>
                  <a:path w="1023258" h="1302712">
                    <a:moveTo>
                      <a:pt x="711926" y="0"/>
                    </a:moveTo>
                    <a:cubicBezTo>
                      <a:pt x="810223" y="0"/>
                      <a:pt x="903866" y="19921"/>
                      <a:pt x="989040" y="55947"/>
                    </a:cubicBezTo>
                    <a:lnTo>
                      <a:pt x="1023258" y="74520"/>
                    </a:lnTo>
                    <a:lnTo>
                      <a:pt x="936545" y="121586"/>
                    </a:lnTo>
                    <a:cubicBezTo>
                      <a:pt x="785047" y="223936"/>
                      <a:pt x="675062" y="383069"/>
                      <a:pt x="637128" y="568448"/>
                    </a:cubicBezTo>
                    <a:lnTo>
                      <a:pt x="626035" y="678489"/>
                    </a:lnTo>
                    <a:lnTo>
                      <a:pt x="625213" y="678935"/>
                    </a:lnTo>
                    <a:cubicBezTo>
                      <a:pt x="435840" y="806873"/>
                      <a:pt x="311332" y="1023534"/>
                      <a:pt x="311332" y="1269275"/>
                    </a:cubicBezTo>
                    <a:lnTo>
                      <a:pt x="314703" y="1302712"/>
                    </a:lnTo>
                    <a:lnTo>
                      <a:pt x="313881" y="1302266"/>
                    </a:lnTo>
                    <a:cubicBezTo>
                      <a:pt x="124508" y="1174328"/>
                      <a:pt x="0" y="957667"/>
                      <a:pt x="0" y="711926"/>
                    </a:cubicBezTo>
                    <a:cubicBezTo>
                      <a:pt x="0" y="318740"/>
                      <a:pt x="318740" y="0"/>
                      <a:pt x="711926" y="0"/>
                    </a:cubicBezTo>
                    <a:close/>
                  </a:path>
                </a:pathLst>
              </a:custGeom>
              <a:solidFill>
                <a:srgbClr val="87CCD9">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200" dirty="0" smtClean="0">
                    <a:solidFill>
                      <a:schemeClr val="tx1"/>
                    </a:solidFill>
                    <a:latin typeface="Cambria" panose="02040503050406030204" pitchFamily="18" charset="0"/>
                    <a:ea typeface="Cambria" panose="02040503050406030204" pitchFamily="18" charset="0"/>
                  </a:rPr>
                  <a:t>80</a:t>
                </a:r>
              </a:p>
            </p:txBody>
          </p:sp>
          <p:sp>
            <p:nvSpPr>
              <p:cNvPr id="37" name="Freeform 36"/>
              <p:cNvSpPr/>
              <p:nvPr/>
            </p:nvSpPr>
            <p:spPr>
              <a:xfrm>
                <a:off x="3897631" y="3370217"/>
                <a:ext cx="1023258" cy="1302712"/>
              </a:xfrm>
              <a:custGeom>
                <a:avLst/>
                <a:gdLst>
                  <a:gd name="connsiteX0" fmla="*/ 311332 w 1023258"/>
                  <a:gd name="connsiteY0" fmla="*/ 0 h 1302712"/>
                  <a:gd name="connsiteX1" fmla="*/ 1023258 w 1023258"/>
                  <a:gd name="connsiteY1" fmla="*/ 711926 h 1302712"/>
                  <a:gd name="connsiteX2" fmla="*/ 709377 w 1023258"/>
                  <a:gd name="connsiteY2" fmla="*/ 1302266 h 1302712"/>
                  <a:gd name="connsiteX3" fmla="*/ 708555 w 1023258"/>
                  <a:gd name="connsiteY3" fmla="*/ 1302712 h 1302712"/>
                  <a:gd name="connsiteX4" fmla="*/ 711926 w 1023258"/>
                  <a:gd name="connsiteY4" fmla="*/ 1269275 h 1302712"/>
                  <a:gd name="connsiteX5" fmla="*/ 398045 w 1023258"/>
                  <a:gd name="connsiteY5" fmla="*/ 678935 h 1302712"/>
                  <a:gd name="connsiteX6" fmla="*/ 397223 w 1023258"/>
                  <a:gd name="connsiteY6" fmla="*/ 678489 h 1302712"/>
                  <a:gd name="connsiteX7" fmla="*/ 386130 w 1023258"/>
                  <a:gd name="connsiteY7" fmla="*/ 568448 h 1302712"/>
                  <a:gd name="connsiteX8" fmla="*/ 86713 w 1023258"/>
                  <a:gd name="connsiteY8" fmla="*/ 121586 h 1302712"/>
                  <a:gd name="connsiteX9" fmla="*/ 0 w 1023258"/>
                  <a:gd name="connsiteY9" fmla="*/ 74520 h 1302712"/>
                  <a:gd name="connsiteX10" fmla="*/ 34218 w 1023258"/>
                  <a:gd name="connsiteY10" fmla="*/ 55947 h 1302712"/>
                  <a:gd name="connsiteX11" fmla="*/ 311332 w 1023258"/>
                  <a:gd name="connsiteY11" fmla="*/ 0 h 13027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Lst>
                <a:rect l="l" t="t" r="r" b="b"/>
                <a:pathLst>
                  <a:path w="1023258" h="1302712">
                    <a:moveTo>
                      <a:pt x="311332" y="0"/>
                    </a:moveTo>
                    <a:cubicBezTo>
                      <a:pt x="704518" y="0"/>
                      <a:pt x="1023258" y="318740"/>
                      <a:pt x="1023258" y="711926"/>
                    </a:cubicBezTo>
                    <a:cubicBezTo>
                      <a:pt x="1023258" y="957667"/>
                      <a:pt x="898750" y="1174328"/>
                      <a:pt x="709377" y="1302266"/>
                    </a:cubicBezTo>
                    <a:lnTo>
                      <a:pt x="708555" y="1302712"/>
                    </a:lnTo>
                    <a:lnTo>
                      <a:pt x="711926" y="1269275"/>
                    </a:lnTo>
                    <a:cubicBezTo>
                      <a:pt x="711926" y="1023534"/>
                      <a:pt x="587418" y="806873"/>
                      <a:pt x="398045" y="678935"/>
                    </a:cubicBezTo>
                    <a:lnTo>
                      <a:pt x="397223" y="678489"/>
                    </a:lnTo>
                    <a:lnTo>
                      <a:pt x="386130" y="568448"/>
                    </a:lnTo>
                    <a:cubicBezTo>
                      <a:pt x="348196" y="383069"/>
                      <a:pt x="238212" y="223936"/>
                      <a:pt x="86713" y="121586"/>
                    </a:cubicBezTo>
                    <a:lnTo>
                      <a:pt x="0" y="74520"/>
                    </a:lnTo>
                    <a:lnTo>
                      <a:pt x="34218" y="55947"/>
                    </a:lnTo>
                    <a:cubicBezTo>
                      <a:pt x="119392" y="19921"/>
                      <a:pt x="213036" y="0"/>
                      <a:pt x="311332" y="0"/>
                    </a:cubicBezTo>
                    <a:close/>
                  </a:path>
                </a:pathLst>
              </a:custGeom>
              <a:solidFill>
                <a:srgbClr val="87CCD9">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r"/>
                <a:r>
                  <a:rPr lang="en-US" sz="1200" dirty="0" smtClean="0">
                    <a:solidFill>
                      <a:schemeClr val="tx1"/>
                    </a:solidFill>
                    <a:latin typeface="Cambria" panose="02040503050406030204" pitchFamily="18" charset="0"/>
                    <a:ea typeface="Cambria" panose="02040503050406030204" pitchFamily="18" charset="0"/>
                  </a:rPr>
                  <a:t>100</a:t>
                </a:r>
              </a:p>
            </p:txBody>
          </p:sp>
          <p:sp>
            <p:nvSpPr>
              <p:cNvPr id="38" name="Freeform 37"/>
              <p:cNvSpPr/>
              <p:nvPr/>
            </p:nvSpPr>
            <p:spPr>
              <a:xfrm>
                <a:off x="3497037" y="3927566"/>
                <a:ext cx="801188" cy="791983"/>
              </a:xfrm>
              <a:custGeom>
                <a:avLst/>
                <a:gdLst>
                  <a:gd name="connsiteX0" fmla="*/ 400594 w 801188"/>
                  <a:gd name="connsiteY0" fmla="*/ 0 h 791983"/>
                  <a:gd name="connsiteX1" fmla="*/ 677708 w 801188"/>
                  <a:gd name="connsiteY1" fmla="*/ 55947 h 791983"/>
                  <a:gd name="connsiteX2" fmla="*/ 797817 w 801188"/>
                  <a:gd name="connsiteY2" fmla="*/ 121140 h 791983"/>
                  <a:gd name="connsiteX3" fmla="*/ 801188 w 801188"/>
                  <a:gd name="connsiteY3" fmla="*/ 154577 h 791983"/>
                  <a:gd name="connsiteX4" fmla="*/ 487307 w 801188"/>
                  <a:gd name="connsiteY4" fmla="*/ 744917 h 791983"/>
                  <a:gd name="connsiteX5" fmla="*/ 400594 w 801188"/>
                  <a:gd name="connsiteY5" fmla="*/ 791983 h 791983"/>
                  <a:gd name="connsiteX6" fmla="*/ 313881 w 801188"/>
                  <a:gd name="connsiteY6" fmla="*/ 744917 h 791983"/>
                  <a:gd name="connsiteX7" fmla="*/ 0 w 801188"/>
                  <a:gd name="connsiteY7" fmla="*/ 154577 h 791983"/>
                  <a:gd name="connsiteX8" fmla="*/ 3371 w 801188"/>
                  <a:gd name="connsiteY8" fmla="*/ 121140 h 791983"/>
                  <a:gd name="connsiteX9" fmla="*/ 123480 w 801188"/>
                  <a:gd name="connsiteY9" fmla="*/ 55947 h 791983"/>
                  <a:gd name="connsiteX10" fmla="*/ 400594 w 801188"/>
                  <a:gd name="connsiteY10" fmla="*/ 0 h 79198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801188" h="791983">
                    <a:moveTo>
                      <a:pt x="400594" y="0"/>
                    </a:moveTo>
                    <a:cubicBezTo>
                      <a:pt x="498891" y="0"/>
                      <a:pt x="592534" y="19921"/>
                      <a:pt x="677708" y="55947"/>
                    </a:cubicBezTo>
                    <a:lnTo>
                      <a:pt x="797817" y="121140"/>
                    </a:lnTo>
                    <a:lnTo>
                      <a:pt x="801188" y="154577"/>
                    </a:lnTo>
                    <a:cubicBezTo>
                      <a:pt x="801188" y="400318"/>
                      <a:pt x="676680" y="616979"/>
                      <a:pt x="487307" y="744917"/>
                    </a:cubicBezTo>
                    <a:lnTo>
                      <a:pt x="400594" y="791983"/>
                    </a:lnTo>
                    <a:lnTo>
                      <a:pt x="313881" y="744917"/>
                    </a:lnTo>
                    <a:cubicBezTo>
                      <a:pt x="124508" y="616979"/>
                      <a:pt x="0" y="400318"/>
                      <a:pt x="0" y="154577"/>
                    </a:cubicBezTo>
                    <a:lnTo>
                      <a:pt x="3371" y="121140"/>
                    </a:lnTo>
                    <a:lnTo>
                      <a:pt x="123480" y="55947"/>
                    </a:lnTo>
                    <a:cubicBezTo>
                      <a:pt x="208654" y="19921"/>
                      <a:pt x="302298" y="0"/>
                      <a:pt x="400594" y="0"/>
                    </a:cubicBezTo>
                    <a:close/>
                  </a:path>
                </a:pathLst>
              </a:custGeom>
              <a:solidFill>
                <a:srgbClr val="87CCD9">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smtClean="0">
                    <a:solidFill>
                      <a:schemeClr val="tx1"/>
                    </a:solidFill>
                    <a:latin typeface="Cambria" panose="02040503050406030204" pitchFamily="18" charset="0"/>
                    <a:ea typeface="Cambria" panose="02040503050406030204" pitchFamily="18" charset="0"/>
                  </a:rPr>
                  <a:t>2,102</a:t>
                </a:r>
                <a:endParaRPr lang="en-GB" sz="1200" dirty="0">
                  <a:solidFill>
                    <a:schemeClr val="tx1"/>
                  </a:solidFill>
                  <a:latin typeface="Cambria" panose="02040503050406030204" pitchFamily="18" charset="0"/>
                  <a:ea typeface="Cambria" panose="02040503050406030204" pitchFamily="18" charset="0"/>
                </a:endParaRPr>
              </a:p>
            </p:txBody>
          </p:sp>
          <p:sp>
            <p:nvSpPr>
              <p:cNvPr id="39" name="Freeform 38"/>
              <p:cNvSpPr/>
              <p:nvPr/>
            </p:nvSpPr>
            <p:spPr>
              <a:xfrm>
                <a:off x="3189076" y="4672929"/>
                <a:ext cx="1417110" cy="678489"/>
              </a:xfrm>
              <a:custGeom>
                <a:avLst/>
                <a:gdLst>
                  <a:gd name="connsiteX0" fmla="*/ 0 w 1417110"/>
                  <a:gd name="connsiteY0" fmla="*/ 0 h 678489"/>
                  <a:gd name="connsiteX1" fmla="*/ 120109 w 1417110"/>
                  <a:gd name="connsiteY1" fmla="*/ 65193 h 678489"/>
                  <a:gd name="connsiteX2" fmla="*/ 397223 w 1417110"/>
                  <a:gd name="connsiteY2" fmla="*/ 121140 h 678489"/>
                  <a:gd name="connsiteX3" fmla="*/ 674337 w 1417110"/>
                  <a:gd name="connsiteY3" fmla="*/ 65193 h 678489"/>
                  <a:gd name="connsiteX4" fmla="*/ 708555 w 1417110"/>
                  <a:gd name="connsiteY4" fmla="*/ 46620 h 678489"/>
                  <a:gd name="connsiteX5" fmla="*/ 742773 w 1417110"/>
                  <a:gd name="connsiteY5" fmla="*/ 65193 h 678489"/>
                  <a:gd name="connsiteX6" fmla="*/ 1019887 w 1417110"/>
                  <a:gd name="connsiteY6" fmla="*/ 121140 h 678489"/>
                  <a:gd name="connsiteX7" fmla="*/ 1297001 w 1417110"/>
                  <a:gd name="connsiteY7" fmla="*/ 65193 h 678489"/>
                  <a:gd name="connsiteX8" fmla="*/ 1417110 w 1417110"/>
                  <a:gd name="connsiteY8" fmla="*/ 0 h 678489"/>
                  <a:gd name="connsiteX9" fmla="*/ 1406017 w 1417110"/>
                  <a:gd name="connsiteY9" fmla="*/ 110041 h 678489"/>
                  <a:gd name="connsiteX10" fmla="*/ 708555 w 1417110"/>
                  <a:gd name="connsiteY10" fmla="*/ 678489 h 678489"/>
                  <a:gd name="connsiteX11" fmla="*/ 11093 w 1417110"/>
                  <a:gd name="connsiteY11" fmla="*/ 110041 h 678489"/>
                  <a:gd name="connsiteX12" fmla="*/ 0 w 1417110"/>
                  <a:gd name="connsiteY12" fmla="*/ 0 h 67848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Lst>
                <a:rect l="l" t="t" r="r" b="b"/>
                <a:pathLst>
                  <a:path w="1417110" h="678489">
                    <a:moveTo>
                      <a:pt x="0" y="0"/>
                    </a:moveTo>
                    <a:lnTo>
                      <a:pt x="120109" y="65193"/>
                    </a:lnTo>
                    <a:cubicBezTo>
                      <a:pt x="205283" y="101219"/>
                      <a:pt x="298927" y="121140"/>
                      <a:pt x="397223" y="121140"/>
                    </a:cubicBezTo>
                    <a:cubicBezTo>
                      <a:pt x="495520" y="121140"/>
                      <a:pt x="589163" y="101219"/>
                      <a:pt x="674337" y="65193"/>
                    </a:cubicBezTo>
                    <a:lnTo>
                      <a:pt x="708555" y="46620"/>
                    </a:lnTo>
                    <a:lnTo>
                      <a:pt x="742773" y="65193"/>
                    </a:lnTo>
                    <a:cubicBezTo>
                      <a:pt x="827947" y="101219"/>
                      <a:pt x="921591" y="121140"/>
                      <a:pt x="1019887" y="121140"/>
                    </a:cubicBezTo>
                    <a:cubicBezTo>
                      <a:pt x="1118184" y="121140"/>
                      <a:pt x="1211827" y="101219"/>
                      <a:pt x="1297001" y="65193"/>
                    </a:cubicBezTo>
                    <a:lnTo>
                      <a:pt x="1417110" y="0"/>
                    </a:lnTo>
                    <a:lnTo>
                      <a:pt x="1406017" y="110041"/>
                    </a:lnTo>
                    <a:cubicBezTo>
                      <a:pt x="1339633" y="434454"/>
                      <a:pt x="1052593" y="678489"/>
                      <a:pt x="708555" y="678489"/>
                    </a:cubicBezTo>
                    <a:cubicBezTo>
                      <a:pt x="364517" y="678489"/>
                      <a:pt x="77477" y="434454"/>
                      <a:pt x="11093" y="110041"/>
                    </a:cubicBezTo>
                    <a:lnTo>
                      <a:pt x="0" y="0"/>
                    </a:lnTo>
                    <a:close/>
                  </a:path>
                </a:pathLst>
              </a:custGeom>
              <a:solidFill>
                <a:srgbClr val="87CCD9">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smtClean="0">
                    <a:solidFill>
                      <a:schemeClr val="tx1"/>
                    </a:solidFill>
                    <a:latin typeface="Cambria" panose="02040503050406030204" pitchFamily="18" charset="0"/>
                    <a:ea typeface="Cambria" panose="02040503050406030204" pitchFamily="18" charset="0"/>
                  </a:rPr>
                  <a:t>153</a:t>
                </a:r>
                <a:endParaRPr lang="en-GB" sz="1200" dirty="0">
                  <a:solidFill>
                    <a:schemeClr val="tx1"/>
                  </a:solidFill>
                  <a:latin typeface="Cambria" panose="02040503050406030204" pitchFamily="18" charset="0"/>
                  <a:ea typeface="Cambria" panose="02040503050406030204" pitchFamily="18" charset="0"/>
                </a:endParaRPr>
              </a:p>
            </p:txBody>
          </p:sp>
        </p:grpSp>
        <p:grpSp>
          <p:nvGrpSpPr>
            <p:cNvPr id="73" name="Group 72"/>
            <p:cNvGrpSpPr/>
            <p:nvPr/>
          </p:nvGrpSpPr>
          <p:grpSpPr>
            <a:xfrm>
              <a:off x="287488" y="3780339"/>
              <a:ext cx="2046516" cy="1981201"/>
              <a:chOff x="635182" y="5677989"/>
              <a:chExt cx="2046516" cy="1981201"/>
            </a:xfrm>
          </p:grpSpPr>
          <p:sp>
            <p:nvSpPr>
              <p:cNvPr id="41" name="Freeform 40"/>
              <p:cNvSpPr/>
              <p:nvPr/>
            </p:nvSpPr>
            <p:spPr>
              <a:xfrm>
                <a:off x="1261217" y="5752509"/>
                <a:ext cx="794446" cy="603969"/>
              </a:xfrm>
              <a:custGeom>
                <a:avLst/>
                <a:gdLst>
                  <a:gd name="connsiteX0" fmla="*/ 397223 w 794446"/>
                  <a:gd name="connsiteY0" fmla="*/ 0 h 603969"/>
                  <a:gd name="connsiteX1" fmla="*/ 483936 w 794446"/>
                  <a:gd name="connsiteY1" fmla="*/ 47066 h 603969"/>
                  <a:gd name="connsiteX2" fmla="*/ 783353 w 794446"/>
                  <a:gd name="connsiteY2" fmla="*/ 493928 h 603969"/>
                  <a:gd name="connsiteX3" fmla="*/ 794446 w 794446"/>
                  <a:gd name="connsiteY3" fmla="*/ 603969 h 603969"/>
                  <a:gd name="connsiteX4" fmla="*/ 674337 w 794446"/>
                  <a:gd name="connsiteY4" fmla="*/ 538776 h 603969"/>
                  <a:gd name="connsiteX5" fmla="*/ 397223 w 794446"/>
                  <a:gd name="connsiteY5" fmla="*/ 482829 h 603969"/>
                  <a:gd name="connsiteX6" fmla="*/ 120109 w 794446"/>
                  <a:gd name="connsiteY6" fmla="*/ 538776 h 603969"/>
                  <a:gd name="connsiteX7" fmla="*/ 0 w 794446"/>
                  <a:gd name="connsiteY7" fmla="*/ 603969 h 603969"/>
                  <a:gd name="connsiteX8" fmla="*/ 11093 w 794446"/>
                  <a:gd name="connsiteY8" fmla="*/ 493928 h 603969"/>
                  <a:gd name="connsiteX9" fmla="*/ 310510 w 794446"/>
                  <a:gd name="connsiteY9" fmla="*/ 47066 h 603969"/>
                  <a:gd name="connsiteX10" fmla="*/ 397223 w 794446"/>
                  <a:gd name="connsiteY10" fmla="*/ 0 h 60396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794446" h="603969">
                    <a:moveTo>
                      <a:pt x="397223" y="0"/>
                    </a:moveTo>
                    <a:lnTo>
                      <a:pt x="483936" y="47066"/>
                    </a:lnTo>
                    <a:cubicBezTo>
                      <a:pt x="635435" y="149416"/>
                      <a:pt x="745419" y="308549"/>
                      <a:pt x="783353" y="493928"/>
                    </a:cubicBezTo>
                    <a:lnTo>
                      <a:pt x="794446" y="603969"/>
                    </a:lnTo>
                    <a:lnTo>
                      <a:pt x="674337" y="538776"/>
                    </a:lnTo>
                    <a:cubicBezTo>
                      <a:pt x="589163" y="502750"/>
                      <a:pt x="495520" y="482829"/>
                      <a:pt x="397223" y="482829"/>
                    </a:cubicBezTo>
                    <a:cubicBezTo>
                      <a:pt x="298927" y="482829"/>
                      <a:pt x="205283" y="502750"/>
                      <a:pt x="120109" y="538776"/>
                    </a:cubicBezTo>
                    <a:lnTo>
                      <a:pt x="0" y="603969"/>
                    </a:lnTo>
                    <a:lnTo>
                      <a:pt x="11093" y="493928"/>
                    </a:lnTo>
                    <a:cubicBezTo>
                      <a:pt x="49027" y="308549"/>
                      <a:pt x="159012" y="149416"/>
                      <a:pt x="310510" y="47066"/>
                    </a:cubicBezTo>
                    <a:lnTo>
                      <a:pt x="397223" y="0"/>
                    </a:lnTo>
                    <a:close/>
                  </a:path>
                </a:pathLst>
              </a:custGeom>
              <a:solidFill>
                <a:srgbClr val="87CCD9">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smtClean="0">
                    <a:solidFill>
                      <a:schemeClr val="tx1"/>
                    </a:solidFill>
                    <a:latin typeface="Cambria" panose="02040503050406030204" pitchFamily="18" charset="0"/>
                    <a:ea typeface="Cambria" panose="02040503050406030204" pitchFamily="18" charset="0"/>
                  </a:rPr>
                  <a:t>180</a:t>
                </a:r>
                <a:endParaRPr lang="en-GB" sz="1200" dirty="0">
                  <a:solidFill>
                    <a:schemeClr val="tx1"/>
                  </a:solidFill>
                  <a:latin typeface="Cambria" panose="02040503050406030204" pitchFamily="18" charset="0"/>
                  <a:ea typeface="Cambria" panose="02040503050406030204" pitchFamily="18" charset="0"/>
                </a:endParaRPr>
              </a:p>
            </p:txBody>
          </p:sp>
          <p:sp>
            <p:nvSpPr>
              <p:cNvPr id="42" name="Freeform 41"/>
              <p:cNvSpPr/>
              <p:nvPr/>
            </p:nvSpPr>
            <p:spPr>
              <a:xfrm>
                <a:off x="946514" y="6356478"/>
                <a:ext cx="711926" cy="745363"/>
              </a:xfrm>
              <a:custGeom>
                <a:avLst/>
                <a:gdLst>
                  <a:gd name="connsiteX0" fmla="*/ 314703 w 711926"/>
                  <a:gd name="connsiteY0" fmla="*/ 0 h 745363"/>
                  <a:gd name="connsiteX1" fmla="*/ 311332 w 711926"/>
                  <a:gd name="connsiteY1" fmla="*/ 33437 h 745363"/>
                  <a:gd name="connsiteX2" fmla="*/ 625213 w 711926"/>
                  <a:gd name="connsiteY2" fmla="*/ 623777 h 745363"/>
                  <a:gd name="connsiteX3" fmla="*/ 711926 w 711926"/>
                  <a:gd name="connsiteY3" fmla="*/ 670843 h 745363"/>
                  <a:gd name="connsiteX4" fmla="*/ 677708 w 711926"/>
                  <a:gd name="connsiteY4" fmla="*/ 689416 h 745363"/>
                  <a:gd name="connsiteX5" fmla="*/ 400594 w 711926"/>
                  <a:gd name="connsiteY5" fmla="*/ 745363 h 745363"/>
                  <a:gd name="connsiteX6" fmla="*/ 123480 w 711926"/>
                  <a:gd name="connsiteY6" fmla="*/ 689416 h 745363"/>
                  <a:gd name="connsiteX7" fmla="*/ 3371 w 711926"/>
                  <a:gd name="connsiteY7" fmla="*/ 624223 h 745363"/>
                  <a:gd name="connsiteX8" fmla="*/ 0 w 711926"/>
                  <a:gd name="connsiteY8" fmla="*/ 590786 h 745363"/>
                  <a:gd name="connsiteX9" fmla="*/ 313881 w 711926"/>
                  <a:gd name="connsiteY9" fmla="*/ 446 h 745363"/>
                  <a:gd name="connsiteX10" fmla="*/ 314703 w 711926"/>
                  <a:gd name="connsiteY10" fmla="*/ 0 h 74536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711926" h="745363">
                    <a:moveTo>
                      <a:pt x="314703" y="0"/>
                    </a:moveTo>
                    <a:lnTo>
                      <a:pt x="311332" y="33437"/>
                    </a:lnTo>
                    <a:cubicBezTo>
                      <a:pt x="311332" y="279178"/>
                      <a:pt x="435840" y="495839"/>
                      <a:pt x="625213" y="623777"/>
                    </a:cubicBezTo>
                    <a:lnTo>
                      <a:pt x="711926" y="670843"/>
                    </a:lnTo>
                    <a:lnTo>
                      <a:pt x="677708" y="689416"/>
                    </a:lnTo>
                    <a:cubicBezTo>
                      <a:pt x="592534" y="725442"/>
                      <a:pt x="498891" y="745363"/>
                      <a:pt x="400594" y="745363"/>
                    </a:cubicBezTo>
                    <a:cubicBezTo>
                      <a:pt x="302298" y="745363"/>
                      <a:pt x="208654" y="725442"/>
                      <a:pt x="123480" y="689416"/>
                    </a:cubicBezTo>
                    <a:lnTo>
                      <a:pt x="3371" y="624223"/>
                    </a:lnTo>
                    <a:lnTo>
                      <a:pt x="0" y="590786"/>
                    </a:lnTo>
                    <a:cubicBezTo>
                      <a:pt x="0" y="345045"/>
                      <a:pt x="124508" y="128384"/>
                      <a:pt x="313881" y="446"/>
                    </a:cubicBezTo>
                    <a:lnTo>
                      <a:pt x="314703" y="0"/>
                    </a:lnTo>
                    <a:close/>
                  </a:path>
                </a:pathLst>
              </a:custGeom>
              <a:solidFill>
                <a:srgbClr val="87CCD9">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200" dirty="0" smtClean="0">
                    <a:solidFill>
                      <a:schemeClr val="tx1"/>
                    </a:solidFill>
                    <a:latin typeface="Cambria" panose="02040503050406030204" pitchFamily="18" charset="0"/>
                    <a:ea typeface="Cambria" panose="02040503050406030204" pitchFamily="18" charset="0"/>
                  </a:rPr>
                  <a:t>78</a:t>
                </a:r>
                <a:endParaRPr lang="en-GB" sz="1200" dirty="0">
                  <a:solidFill>
                    <a:schemeClr val="tx1"/>
                  </a:solidFill>
                  <a:latin typeface="Cambria" panose="02040503050406030204" pitchFamily="18" charset="0"/>
                  <a:ea typeface="Cambria" panose="02040503050406030204" pitchFamily="18" charset="0"/>
                </a:endParaRPr>
              </a:p>
            </p:txBody>
          </p:sp>
          <p:sp>
            <p:nvSpPr>
              <p:cNvPr id="43" name="Freeform 42"/>
              <p:cNvSpPr/>
              <p:nvPr/>
            </p:nvSpPr>
            <p:spPr>
              <a:xfrm>
                <a:off x="1658440" y="6356478"/>
                <a:ext cx="711926" cy="745363"/>
              </a:xfrm>
              <a:custGeom>
                <a:avLst/>
                <a:gdLst>
                  <a:gd name="connsiteX0" fmla="*/ 397223 w 711926"/>
                  <a:gd name="connsiteY0" fmla="*/ 0 h 745363"/>
                  <a:gd name="connsiteX1" fmla="*/ 398045 w 711926"/>
                  <a:gd name="connsiteY1" fmla="*/ 446 h 745363"/>
                  <a:gd name="connsiteX2" fmla="*/ 711926 w 711926"/>
                  <a:gd name="connsiteY2" fmla="*/ 590786 h 745363"/>
                  <a:gd name="connsiteX3" fmla="*/ 708555 w 711926"/>
                  <a:gd name="connsiteY3" fmla="*/ 624223 h 745363"/>
                  <a:gd name="connsiteX4" fmla="*/ 588446 w 711926"/>
                  <a:gd name="connsiteY4" fmla="*/ 689416 h 745363"/>
                  <a:gd name="connsiteX5" fmla="*/ 311332 w 711926"/>
                  <a:gd name="connsiteY5" fmla="*/ 745363 h 745363"/>
                  <a:gd name="connsiteX6" fmla="*/ 34218 w 711926"/>
                  <a:gd name="connsiteY6" fmla="*/ 689416 h 745363"/>
                  <a:gd name="connsiteX7" fmla="*/ 0 w 711926"/>
                  <a:gd name="connsiteY7" fmla="*/ 670843 h 745363"/>
                  <a:gd name="connsiteX8" fmla="*/ 86713 w 711926"/>
                  <a:gd name="connsiteY8" fmla="*/ 623777 h 745363"/>
                  <a:gd name="connsiteX9" fmla="*/ 400594 w 711926"/>
                  <a:gd name="connsiteY9" fmla="*/ 33437 h 745363"/>
                  <a:gd name="connsiteX10" fmla="*/ 397223 w 711926"/>
                  <a:gd name="connsiteY10" fmla="*/ 0 h 74536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711926" h="745363">
                    <a:moveTo>
                      <a:pt x="397223" y="0"/>
                    </a:moveTo>
                    <a:lnTo>
                      <a:pt x="398045" y="446"/>
                    </a:lnTo>
                    <a:cubicBezTo>
                      <a:pt x="587418" y="128384"/>
                      <a:pt x="711926" y="345045"/>
                      <a:pt x="711926" y="590786"/>
                    </a:cubicBezTo>
                    <a:lnTo>
                      <a:pt x="708555" y="624223"/>
                    </a:lnTo>
                    <a:lnTo>
                      <a:pt x="588446" y="689416"/>
                    </a:lnTo>
                    <a:cubicBezTo>
                      <a:pt x="503272" y="725442"/>
                      <a:pt x="409629" y="745363"/>
                      <a:pt x="311332" y="745363"/>
                    </a:cubicBezTo>
                    <a:cubicBezTo>
                      <a:pt x="213036" y="745363"/>
                      <a:pt x="119392" y="725442"/>
                      <a:pt x="34218" y="689416"/>
                    </a:cubicBezTo>
                    <a:lnTo>
                      <a:pt x="0" y="670843"/>
                    </a:lnTo>
                    <a:lnTo>
                      <a:pt x="86713" y="623777"/>
                    </a:lnTo>
                    <a:cubicBezTo>
                      <a:pt x="276086" y="495839"/>
                      <a:pt x="400594" y="279178"/>
                      <a:pt x="400594" y="33437"/>
                    </a:cubicBezTo>
                    <a:lnTo>
                      <a:pt x="397223" y="0"/>
                    </a:lnTo>
                    <a:close/>
                  </a:path>
                </a:pathLst>
              </a:custGeom>
              <a:solidFill>
                <a:srgbClr val="87CCD9">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r"/>
                <a:r>
                  <a:rPr lang="en-US" sz="1200" dirty="0" smtClean="0">
                    <a:solidFill>
                      <a:schemeClr val="tx1"/>
                    </a:solidFill>
                    <a:latin typeface="Cambria" panose="02040503050406030204" pitchFamily="18" charset="0"/>
                    <a:ea typeface="Cambria" panose="02040503050406030204" pitchFamily="18" charset="0"/>
                  </a:rPr>
                  <a:t>105</a:t>
                </a:r>
                <a:endParaRPr lang="en-GB" sz="1200" dirty="0">
                  <a:solidFill>
                    <a:schemeClr val="tx1"/>
                  </a:solidFill>
                  <a:latin typeface="Cambria" panose="02040503050406030204" pitchFamily="18" charset="0"/>
                  <a:ea typeface="Cambria" panose="02040503050406030204" pitchFamily="18" charset="0"/>
                </a:endParaRPr>
              </a:p>
            </p:txBody>
          </p:sp>
          <p:sp>
            <p:nvSpPr>
              <p:cNvPr id="44" name="Freeform 43"/>
              <p:cNvSpPr/>
              <p:nvPr/>
            </p:nvSpPr>
            <p:spPr>
              <a:xfrm>
                <a:off x="635182" y="5677989"/>
                <a:ext cx="1023258" cy="1302712"/>
              </a:xfrm>
              <a:custGeom>
                <a:avLst/>
                <a:gdLst>
                  <a:gd name="connsiteX0" fmla="*/ 711926 w 1023258"/>
                  <a:gd name="connsiteY0" fmla="*/ 0 h 1302712"/>
                  <a:gd name="connsiteX1" fmla="*/ 989040 w 1023258"/>
                  <a:gd name="connsiteY1" fmla="*/ 55947 h 1302712"/>
                  <a:gd name="connsiteX2" fmla="*/ 1023258 w 1023258"/>
                  <a:gd name="connsiteY2" fmla="*/ 74520 h 1302712"/>
                  <a:gd name="connsiteX3" fmla="*/ 936545 w 1023258"/>
                  <a:gd name="connsiteY3" fmla="*/ 121586 h 1302712"/>
                  <a:gd name="connsiteX4" fmla="*/ 637128 w 1023258"/>
                  <a:gd name="connsiteY4" fmla="*/ 568448 h 1302712"/>
                  <a:gd name="connsiteX5" fmla="*/ 626035 w 1023258"/>
                  <a:gd name="connsiteY5" fmla="*/ 678489 h 1302712"/>
                  <a:gd name="connsiteX6" fmla="*/ 625213 w 1023258"/>
                  <a:gd name="connsiteY6" fmla="*/ 678935 h 1302712"/>
                  <a:gd name="connsiteX7" fmla="*/ 311332 w 1023258"/>
                  <a:gd name="connsiteY7" fmla="*/ 1269275 h 1302712"/>
                  <a:gd name="connsiteX8" fmla="*/ 314703 w 1023258"/>
                  <a:gd name="connsiteY8" fmla="*/ 1302712 h 1302712"/>
                  <a:gd name="connsiteX9" fmla="*/ 313881 w 1023258"/>
                  <a:gd name="connsiteY9" fmla="*/ 1302266 h 1302712"/>
                  <a:gd name="connsiteX10" fmla="*/ 0 w 1023258"/>
                  <a:gd name="connsiteY10" fmla="*/ 711926 h 1302712"/>
                  <a:gd name="connsiteX11" fmla="*/ 711926 w 1023258"/>
                  <a:gd name="connsiteY11" fmla="*/ 0 h 13027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Lst>
                <a:rect l="l" t="t" r="r" b="b"/>
                <a:pathLst>
                  <a:path w="1023258" h="1302712">
                    <a:moveTo>
                      <a:pt x="711926" y="0"/>
                    </a:moveTo>
                    <a:cubicBezTo>
                      <a:pt x="810223" y="0"/>
                      <a:pt x="903866" y="19921"/>
                      <a:pt x="989040" y="55947"/>
                    </a:cubicBezTo>
                    <a:lnTo>
                      <a:pt x="1023258" y="74520"/>
                    </a:lnTo>
                    <a:lnTo>
                      <a:pt x="936545" y="121586"/>
                    </a:lnTo>
                    <a:cubicBezTo>
                      <a:pt x="785047" y="223936"/>
                      <a:pt x="675062" y="383069"/>
                      <a:pt x="637128" y="568448"/>
                    </a:cubicBezTo>
                    <a:lnTo>
                      <a:pt x="626035" y="678489"/>
                    </a:lnTo>
                    <a:lnTo>
                      <a:pt x="625213" y="678935"/>
                    </a:lnTo>
                    <a:cubicBezTo>
                      <a:pt x="435840" y="806873"/>
                      <a:pt x="311332" y="1023534"/>
                      <a:pt x="311332" y="1269275"/>
                    </a:cubicBezTo>
                    <a:lnTo>
                      <a:pt x="314703" y="1302712"/>
                    </a:lnTo>
                    <a:lnTo>
                      <a:pt x="313881" y="1302266"/>
                    </a:lnTo>
                    <a:cubicBezTo>
                      <a:pt x="124508" y="1174328"/>
                      <a:pt x="0" y="957667"/>
                      <a:pt x="0" y="711926"/>
                    </a:cubicBezTo>
                    <a:cubicBezTo>
                      <a:pt x="0" y="318740"/>
                      <a:pt x="318740" y="0"/>
                      <a:pt x="711926" y="0"/>
                    </a:cubicBezTo>
                    <a:close/>
                  </a:path>
                </a:pathLst>
              </a:custGeom>
              <a:solidFill>
                <a:srgbClr val="87CCD9">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200" dirty="0" smtClean="0">
                    <a:solidFill>
                      <a:schemeClr val="tx1"/>
                    </a:solidFill>
                    <a:latin typeface="Cambria" panose="02040503050406030204" pitchFamily="18" charset="0"/>
                    <a:ea typeface="Cambria" panose="02040503050406030204" pitchFamily="18" charset="0"/>
                  </a:rPr>
                  <a:t>76</a:t>
                </a:r>
              </a:p>
            </p:txBody>
          </p:sp>
          <p:sp>
            <p:nvSpPr>
              <p:cNvPr id="45" name="Freeform 44"/>
              <p:cNvSpPr/>
              <p:nvPr/>
            </p:nvSpPr>
            <p:spPr>
              <a:xfrm>
                <a:off x="1658440" y="5677989"/>
                <a:ext cx="1023258" cy="1302712"/>
              </a:xfrm>
              <a:custGeom>
                <a:avLst/>
                <a:gdLst>
                  <a:gd name="connsiteX0" fmla="*/ 311332 w 1023258"/>
                  <a:gd name="connsiteY0" fmla="*/ 0 h 1302712"/>
                  <a:gd name="connsiteX1" fmla="*/ 1023258 w 1023258"/>
                  <a:gd name="connsiteY1" fmla="*/ 711926 h 1302712"/>
                  <a:gd name="connsiteX2" fmla="*/ 709377 w 1023258"/>
                  <a:gd name="connsiteY2" fmla="*/ 1302266 h 1302712"/>
                  <a:gd name="connsiteX3" fmla="*/ 708555 w 1023258"/>
                  <a:gd name="connsiteY3" fmla="*/ 1302712 h 1302712"/>
                  <a:gd name="connsiteX4" fmla="*/ 711926 w 1023258"/>
                  <a:gd name="connsiteY4" fmla="*/ 1269275 h 1302712"/>
                  <a:gd name="connsiteX5" fmla="*/ 398045 w 1023258"/>
                  <a:gd name="connsiteY5" fmla="*/ 678935 h 1302712"/>
                  <a:gd name="connsiteX6" fmla="*/ 397223 w 1023258"/>
                  <a:gd name="connsiteY6" fmla="*/ 678489 h 1302712"/>
                  <a:gd name="connsiteX7" fmla="*/ 386130 w 1023258"/>
                  <a:gd name="connsiteY7" fmla="*/ 568448 h 1302712"/>
                  <a:gd name="connsiteX8" fmla="*/ 86713 w 1023258"/>
                  <a:gd name="connsiteY8" fmla="*/ 121586 h 1302712"/>
                  <a:gd name="connsiteX9" fmla="*/ 0 w 1023258"/>
                  <a:gd name="connsiteY9" fmla="*/ 74520 h 1302712"/>
                  <a:gd name="connsiteX10" fmla="*/ 34218 w 1023258"/>
                  <a:gd name="connsiteY10" fmla="*/ 55947 h 1302712"/>
                  <a:gd name="connsiteX11" fmla="*/ 311332 w 1023258"/>
                  <a:gd name="connsiteY11" fmla="*/ 0 h 13027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Lst>
                <a:rect l="l" t="t" r="r" b="b"/>
                <a:pathLst>
                  <a:path w="1023258" h="1302712">
                    <a:moveTo>
                      <a:pt x="311332" y="0"/>
                    </a:moveTo>
                    <a:cubicBezTo>
                      <a:pt x="704518" y="0"/>
                      <a:pt x="1023258" y="318740"/>
                      <a:pt x="1023258" y="711926"/>
                    </a:cubicBezTo>
                    <a:cubicBezTo>
                      <a:pt x="1023258" y="957667"/>
                      <a:pt x="898750" y="1174328"/>
                      <a:pt x="709377" y="1302266"/>
                    </a:cubicBezTo>
                    <a:lnTo>
                      <a:pt x="708555" y="1302712"/>
                    </a:lnTo>
                    <a:lnTo>
                      <a:pt x="711926" y="1269275"/>
                    </a:lnTo>
                    <a:cubicBezTo>
                      <a:pt x="711926" y="1023534"/>
                      <a:pt x="587418" y="806873"/>
                      <a:pt x="398045" y="678935"/>
                    </a:cubicBezTo>
                    <a:lnTo>
                      <a:pt x="397223" y="678489"/>
                    </a:lnTo>
                    <a:lnTo>
                      <a:pt x="386130" y="568448"/>
                    </a:lnTo>
                    <a:cubicBezTo>
                      <a:pt x="348196" y="383069"/>
                      <a:pt x="238212" y="223936"/>
                      <a:pt x="86713" y="121586"/>
                    </a:cubicBezTo>
                    <a:lnTo>
                      <a:pt x="0" y="74520"/>
                    </a:lnTo>
                    <a:lnTo>
                      <a:pt x="34218" y="55947"/>
                    </a:lnTo>
                    <a:cubicBezTo>
                      <a:pt x="119392" y="19921"/>
                      <a:pt x="213036" y="0"/>
                      <a:pt x="311332" y="0"/>
                    </a:cubicBezTo>
                    <a:close/>
                  </a:path>
                </a:pathLst>
              </a:custGeom>
              <a:solidFill>
                <a:srgbClr val="87CCD9">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r"/>
                <a:r>
                  <a:rPr lang="en-US" sz="1200" dirty="0" smtClean="0">
                    <a:solidFill>
                      <a:schemeClr val="tx1"/>
                    </a:solidFill>
                    <a:latin typeface="Cambria" panose="02040503050406030204" pitchFamily="18" charset="0"/>
                    <a:ea typeface="Cambria" panose="02040503050406030204" pitchFamily="18" charset="0"/>
                  </a:rPr>
                  <a:t>109</a:t>
                </a:r>
              </a:p>
            </p:txBody>
          </p:sp>
          <p:sp>
            <p:nvSpPr>
              <p:cNvPr id="46" name="Freeform 45"/>
              <p:cNvSpPr/>
              <p:nvPr/>
            </p:nvSpPr>
            <p:spPr>
              <a:xfrm>
                <a:off x="1257846" y="6235338"/>
                <a:ext cx="801188" cy="791983"/>
              </a:xfrm>
              <a:custGeom>
                <a:avLst/>
                <a:gdLst>
                  <a:gd name="connsiteX0" fmla="*/ 400594 w 801188"/>
                  <a:gd name="connsiteY0" fmla="*/ 0 h 791983"/>
                  <a:gd name="connsiteX1" fmla="*/ 677708 w 801188"/>
                  <a:gd name="connsiteY1" fmla="*/ 55947 h 791983"/>
                  <a:gd name="connsiteX2" fmla="*/ 797817 w 801188"/>
                  <a:gd name="connsiteY2" fmla="*/ 121140 h 791983"/>
                  <a:gd name="connsiteX3" fmla="*/ 801188 w 801188"/>
                  <a:gd name="connsiteY3" fmla="*/ 154577 h 791983"/>
                  <a:gd name="connsiteX4" fmla="*/ 487307 w 801188"/>
                  <a:gd name="connsiteY4" fmla="*/ 744917 h 791983"/>
                  <a:gd name="connsiteX5" fmla="*/ 400594 w 801188"/>
                  <a:gd name="connsiteY5" fmla="*/ 791983 h 791983"/>
                  <a:gd name="connsiteX6" fmla="*/ 313881 w 801188"/>
                  <a:gd name="connsiteY6" fmla="*/ 744917 h 791983"/>
                  <a:gd name="connsiteX7" fmla="*/ 0 w 801188"/>
                  <a:gd name="connsiteY7" fmla="*/ 154577 h 791983"/>
                  <a:gd name="connsiteX8" fmla="*/ 3371 w 801188"/>
                  <a:gd name="connsiteY8" fmla="*/ 121140 h 791983"/>
                  <a:gd name="connsiteX9" fmla="*/ 123480 w 801188"/>
                  <a:gd name="connsiteY9" fmla="*/ 55947 h 791983"/>
                  <a:gd name="connsiteX10" fmla="*/ 400594 w 801188"/>
                  <a:gd name="connsiteY10" fmla="*/ 0 h 79198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801188" h="791983">
                    <a:moveTo>
                      <a:pt x="400594" y="0"/>
                    </a:moveTo>
                    <a:cubicBezTo>
                      <a:pt x="498891" y="0"/>
                      <a:pt x="592534" y="19921"/>
                      <a:pt x="677708" y="55947"/>
                    </a:cubicBezTo>
                    <a:lnTo>
                      <a:pt x="797817" y="121140"/>
                    </a:lnTo>
                    <a:lnTo>
                      <a:pt x="801188" y="154577"/>
                    </a:lnTo>
                    <a:cubicBezTo>
                      <a:pt x="801188" y="400318"/>
                      <a:pt x="676680" y="616979"/>
                      <a:pt x="487307" y="744917"/>
                    </a:cubicBezTo>
                    <a:lnTo>
                      <a:pt x="400594" y="791983"/>
                    </a:lnTo>
                    <a:lnTo>
                      <a:pt x="313881" y="744917"/>
                    </a:lnTo>
                    <a:cubicBezTo>
                      <a:pt x="124508" y="616979"/>
                      <a:pt x="0" y="400318"/>
                      <a:pt x="0" y="154577"/>
                    </a:cubicBezTo>
                    <a:lnTo>
                      <a:pt x="3371" y="121140"/>
                    </a:lnTo>
                    <a:lnTo>
                      <a:pt x="123480" y="55947"/>
                    </a:lnTo>
                    <a:cubicBezTo>
                      <a:pt x="208654" y="19921"/>
                      <a:pt x="302298" y="0"/>
                      <a:pt x="400594" y="0"/>
                    </a:cubicBezTo>
                    <a:close/>
                  </a:path>
                </a:pathLst>
              </a:custGeom>
              <a:solidFill>
                <a:srgbClr val="87CCD9">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smtClean="0">
                    <a:solidFill>
                      <a:schemeClr val="tx1"/>
                    </a:solidFill>
                    <a:latin typeface="Cambria" panose="02040503050406030204" pitchFamily="18" charset="0"/>
                    <a:ea typeface="Cambria" panose="02040503050406030204" pitchFamily="18" charset="0"/>
                  </a:rPr>
                  <a:t>2,120</a:t>
                </a:r>
                <a:endParaRPr lang="en-GB" sz="1200" dirty="0">
                  <a:solidFill>
                    <a:schemeClr val="tx1"/>
                  </a:solidFill>
                  <a:latin typeface="Cambria" panose="02040503050406030204" pitchFamily="18" charset="0"/>
                  <a:ea typeface="Cambria" panose="02040503050406030204" pitchFamily="18" charset="0"/>
                </a:endParaRPr>
              </a:p>
            </p:txBody>
          </p:sp>
          <p:sp>
            <p:nvSpPr>
              <p:cNvPr id="47" name="Freeform 46"/>
              <p:cNvSpPr/>
              <p:nvPr/>
            </p:nvSpPr>
            <p:spPr>
              <a:xfrm>
                <a:off x="949885" y="6980701"/>
                <a:ext cx="1417110" cy="678489"/>
              </a:xfrm>
              <a:custGeom>
                <a:avLst/>
                <a:gdLst>
                  <a:gd name="connsiteX0" fmla="*/ 0 w 1417110"/>
                  <a:gd name="connsiteY0" fmla="*/ 0 h 678489"/>
                  <a:gd name="connsiteX1" fmla="*/ 120109 w 1417110"/>
                  <a:gd name="connsiteY1" fmla="*/ 65193 h 678489"/>
                  <a:gd name="connsiteX2" fmla="*/ 397223 w 1417110"/>
                  <a:gd name="connsiteY2" fmla="*/ 121140 h 678489"/>
                  <a:gd name="connsiteX3" fmla="*/ 674337 w 1417110"/>
                  <a:gd name="connsiteY3" fmla="*/ 65193 h 678489"/>
                  <a:gd name="connsiteX4" fmla="*/ 708555 w 1417110"/>
                  <a:gd name="connsiteY4" fmla="*/ 46620 h 678489"/>
                  <a:gd name="connsiteX5" fmla="*/ 742773 w 1417110"/>
                  <a:gd name="connsiteY5" fmla="*/ 65193 h 678489"/>
                  <a:gd name="connsiteX6" fmla="*/ 1019887 w 1417110"/>
                  <a:gd name="connsiteY6" fmla="*/ 121140 h 678489"/>
                  <a:gd name="connsiteX7" fmla="*/ 1297001 w 1417110"/>
                  <a:gd name="connsiteY7" fmla="*/ 65193 h 678489"/>
                  <a:gd name="connsiteX8" fmla="*/ 1417110 w 1417110"/>
                  <a:gd name="connsiteY8" fmla="*/ 0 h 678489"/>
                  <a:gd name="connsiteX9" fmla="*/ 1406017 w 1417110"/>
                  <a:gd name="connsiteY9" fmla="*/ 110041 h 678489"/>
                  <a:gd name="connsiteX10" fmla="*/ 708555 w 1417110"/>
                  <a:gd name="connsiteY10" fmla="*/ 678489 h 678489"/>
                  <a:gd name="connsiteX11" fmla="*/ 11093 w 1417110"/>
                  <a:gd name="connsiteY11" fmla="*/ 110041 h 678489"/>
                  <a:gd name="connsiteX12" fmla="*/ 0 w 1417110"/>
                  <a:gd name="connsiteY12" fmla="*/ 0 h 67848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Lst>
                <a:rect l="l" t="t" r="r" b="b"/>
                <a:pathLst>
                  <a:path w="1417110" h="678489">
                    <a:moveTo>
                      <a:pt x="0" y="0"/>
                    </a:moveTo>
                    <a:lnTo>
                      <a:pt x="120109" y="65193"/>
                    </a:lnTo>
                    <a:cubicBezTo>
                      <a:pt x="205283" y="101219"/>
                      <a:pt x="298927" y="121140"/>
                      <a:pt x="397223" y="121140"/>
                    </a:cubicBezTo>
                    <a:cubicBezTo>
                      <a:pt x="495520" y="121140"/>
                      <a:pt x="589163" y="101219"/>
                      <a:pt x="674337" y="65193"/>
                    </a:cubicBezTo>
                    <a:lnTo>
                      <a:pt x="708555" y="46620"/>
                    </a:lnTo>
                    <a:lnTo>
                      <a:pt x="742773" y="65193"/>
                    </a:lnTo>
                    <a:cubicBezTo>
                      <a:pt x="827947" y="101219"/>
                      <a:pt x="921591" y="121140"/>
                      <a:pt x="1019887" y="121140"/>
                    </a:cubicBezTo>
                    <a:cubicBezTo>
                      <a:pt x="1118184" y="121140"/>
                      <a:pt x="1211827" y="101219"/>
                      <a:pt x="1297001" y="65193"/>
                    </a:cubicBezTo>
                    <a:lnTo>
                      <a:pt x="1417110" y="0"/>
                    </a:lnTo>
                    <a:lnTo>
                      <a:pt x="1406017" y="110041"/>
                    </a:lnTo>
                    <a:cubicBezTo>
                      <a:pt x="1339633" y="434454"/>
                      <a:pt x="1052593" y="678489"/>
                      <a:pt x="708555" y="678489"/>
                    </a:cubicBezTo>
                    <a:cubicBezTo>
                      <a:pt x="364517" y="678489"/>
                      <a:pt x="77477" y="434454"/>
                      <a:pt x="11093" y="110041"/>
                    </a:cubicBezTo>
                    <a:lnTo>
                      <a:pt x="0" y="0"/>
                    </a:lnTo>
                    <a:close/>
                  </a:path>
                </a:pathLst>
              </a:custGeom>
              <a:solidFill>
                <a:srgbClr val="87CCD9">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smtClean="0">
                    <a:solidFill>
                      <a:schemeClr val="tx1"/>
                    </a:solidFill>
                    <a:latin typeface="Cambria" panose="02040503050406030204" pitchFamily="18" charset="0"/>
                    <a:ea typeface="Cambria" panose="02040503050406030204" pitchFamily="18" charset="0"/>
                  </a:rPr>
                  <a:t>96</a:t>
                </a:r>
                <a:endParaRPr lang="en-GB" sz="1200" dirty="0">
                  <a:solidFill>
                    <a:schemeClr val="tx1"/>
                  </a:solidFill>
                  <a:latin typeface="Cambria" panose="02040503050406030204" pitchFamily="18" charset="0"/>
                  <a:ea typeface="Cambria" panose="02040503050406030204" pitchFamily="18" charset="0"/>
                </a:endParaRPr>
              </a:p>
            </p:txBody>
          </p:sp>
        </p:grpSp>
        <p:grpSp>
          <p:nvGrpSpPr>
            <p:cNvPr id="74" name="Group 73"/>
            <p:cNvGrpSpPr/>
            <p:nvPr/>
          </p:nvGrpSpPr>
          <p:grpSpPr>
            <a:xfrm>
              <a:off x="2414997" y="3776313"/>
              <a:ext cx="2046516" cy="1981201"/>
              <a:chOff x="3082292" y="5677989"/>
              <a:chExt cx="2046516" cy="1981201"/>
            </a:xfrm>
          </p:grpSpPr>
          <p:sp>
            <p:nvSpPr>
              <p:cNvPr id="48" name="Freeform 47"/>
              <p:cNvSpPr/>
              <p:nvPr/>
            </p:nvSpPr>
            <p:spPr>
              <a:xfrm>
                <a:off x="3708327" y="5752509"/>
                <a:ext cx="794446" cy="603969"/>
              </a:xfrm>
              <a:custGeom>
                <a:avLst/>
                <a:gdLst>
                  <a:gd name="connsiteX0" fmla="*/ 397223 w 794446"/>
                  <a:gd name="connsiteY0" fmla="*/ 0 h 603969"/>
                  <a:gd name="connsiteX1" fmla="*/ 483936 w 794446"/>
                  <a:gd name="connsiteY1" fmla="*/ 47066 h 603969"/>
                  <a:gd name="connsiteX2" fmla="*/ 783353 w 794446"/>
                  <a:gd name="connsiteY2" fmla="*/ 493928 h 603969"/>
                  <a:gd name="connsiteX3" fmla="*/ 794446 w 794446"/>
                  <a:gd name="connsiteY3" fmla="*/ 603969 h 603969"/>
                  <a:gd name="connsiteX4" fmla="*/ 674337 w 794446"/>
                  <a:gd name="connsiteY4" fmla="*/ 538776 h 603969"/>
                  <a:gd name="connsiteX5" fmla="*/ 397223 w 794446"/>
                  <a:gd name="connsiteY5" fmla="*/ 482829 h 603969"/>
                  <a:gd name="connsiteX6" fmla="*/ 120109 w 794446"/>
                  <a:gd name="connsiteY6" fmla="*/ 538776 h 603969"/>
                  <a:gd name="connsiteX7" fmla="*/ 0 w 794446"/>
                  <a:gd name="connsiteY7" fmla="*/ 603969 h 603969"/>
                  <a:gd name="connsiteX8" fmla="*/ 11093 w 794446"/>
                  <a:gd name="connsiteY8" fmla="*/ 493928 h 603969"/>
                  <a:gd name="connsiteX9" fmla="*/ 310510 w 794446"/>
                  <a:gd name="connsiteY9" fmla="*/ 47066 h 603969"/>
                  <a:gd name="connsiteX10" fmla="*/ 397223 w 794446"/>
                  <a:gd name="connsiteY10" fmla="*/ 0 h 60396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794446" h="603969">
                    <a:moveTo>
                      <a:pt x="397223" y="0"/>
                    </a:moveTo>
                    <a:lnTo>
                      <a:pt x="483936" y="47066"/>
                    </a:lnTo>
                    <a:cubicBezTo>
                      <a:pt x="635435" y="149416"/>
                      <a:pt x="745419" y="308549"/>
                      <a:pt x="783353" y="493928"/>
                    </a:cubicBezTo>
                    <a:lnTo>
                      <a:pt x="794446" y="603969"/>
                    </a:lnTo>
                    <a:lnTo>
                      <a:pt x="674337" y="538776"/>
                    </a:lnTo>
                    <a:cubicBezTo>
                      <a:pt x="589163" y="502750"/>
                      <a:pt x="495520" y="482829"/>
                      <a:pt x="397223" y="482829"/>
                    </a:cubicBezTo>
                    <a:cubicBezTo>
                      <a:pt x="298927" y="482829"/>
                      <a:pt x="205283" y="502750"/>
                      <a:pt x="120109" y="538776"/>
                    </a:cubicBezTo>
                    <a:lnTo>
                      <a:pt x="0" y="603969"/>
                    </a:lnTo>
                    <a:lnTo>
                      <a:pt x="11093" y="493928"/>
                    </a:lnTo>
                    <a:cubicBezTo>
                      <a:pt x="49027" y="308549"/>
                      <a:pt x="159012" y="149416"/>
                      <a:pt x="310510" y="47066"/>
                    </a:cubicBezTo>
                    <a:lnTo>
                      <a:pt x="397223" y="0"/>
                    </a:lnTo>
                    <a:close/>
                  </a:path>
                </a:pathLst>
              </a:custGeom>
              <a:solidFill>
                <a:srgbClr val="87CCD9">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smtClean="0">
                    <a:solidFill>
                      <a:schemeClr val="tx1"/>
                    </a:solidFill>
                    <a:latin typeface="Cambria" panose="02040503050406030204" pitchFamily="18" charset="0"/>
                    <a:ea typeface="Cambria" panose="02040503050406030204" pitchFamily="18" charset="0"/>
                  </a:rPr>
                  <a:t>211</a:t>
                </a:r>
                <a:endParaRPr lang="en-GB" sz="1200" dirty="0">
                  <a:solidFill>
                    <a:schemeClr val="tx1"/>
                  </a:solidFill>
                  <a:latin typeface="Cambria" panose="02040503050406030204" pitchFamily="18" charset="0"/>
                  <a:ea typeface="Cambria" panose="02040503050406030204" pitchFamily="18" charset="0"/>
                </a:endParaRPr>
              </a:p>
            </p:txBody>
          </p:sp>
          <p:sp>
            <p:nvSpPr>
              <p:cNvPr id="49" name="Freeform 48"/>
              <p:cNvSpPr/>
              <p:nvPr/>
            </p:nvSpPr>
            <p:spPr>
              <a:xfrm>
                <a:off x="3393624" y="6356478"/>
                <a:ext cx="711926" cy="745363"/>
              </a:xfrm>
              <a:custGeom>
                <a:avLst/>
                <a:gdLst>
                  <a:gd name="connsiteX0" fmla="*/ 314703 w 711926"/>
                  <a:gd name="connsiteY0" fmla="*/ 0 h 745363"/>
                  <a:gd name="connsiteX1" fmla="*/ 311332 w 711926"/>
                  <a:gd name="connsiteY1" fmla="*/ 33437 h 745363"/>
                  <a:gd name="connsiteX2" fmla="*/ 625213 w 711926"/>
                  <a:gd name="connsiteY2" fmla="*/ 623777 h 745363"/>
                  <a:gd name="connsiteX3" fmla="*/ 711926 w 711926"/>
                  <a:gd name="connsiteY3" fmla="*/ 670843 h 745363"/>
                  <a:gd name="connsiteX4" fmla="*/ 677708 w 711926"/>
                  <a:gd name="connsiteY4" fmla="*/ 689416 h 745363"/>
                  <a:gd name="connsiteX5" fmla="*/ 400594 w 711926"/>
                  <a:gd name="connsiteY5" fmla="*/ 745363 h 745363"/>
                  <a:gd name="connsiteX6" fmla="*/ 123480 w 711926"/>
                  <a:gd name="connsiteY6" fmla="*/ 689416 h 745363"/>
                  <a:gd name="connsiteX7" fmla="*/ 3371 w 711926"/>
                  <a:gd name="connsiteY7" fmla="*/ 624223 h 745363"/>
                  <a:gd name="connsiteX8" fmla="*/ 0 w 711926"/>
                  <a:gd name="connsiteY8" fmla="*/ 590786 h 745363"/>
                  <a:gd name="connsiteX9" fmla="*/ 313881 w 711926"/>
                  <a:gd name="connsiteY9" fmla="*/ 446 h 745363"/>
                  <a:gd name="connsiteX10" fmla="*/ 314703 w 711926"/>
                  <a:gd name="connsiteY10" fmla="*/ 0 h 74536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711926" h="745363">
                    <a:moveTo>
                      <a:pt x="314703" y="0"/>
                    </a:moveTo>
                    <a:lnTo>
                      <a:pt x="311332" y="33437"/>
                    </a:lnTo>
                    <a:cubicBezTo>
                      <a:pt x="311332" y="279178"/>
                      <a:pt x="435840" y="495839"/>
                      <a:pt x="625213" y="623777"/>
                    </a:cubicBezTo>
                    <a:lnTo>
                      <a:pt x="711926" y="670843"/>
                    </a:lnTo>
                    <a:lnTo>
                      <a:pt x="677708" y="689416"/>
                    </a:lnTo>
                    <a:cubicBezTo>
                      <a:pt x="592534" y="725442"/>
                      <a:pt x="498891" y="745363"/>
                      <a:pt x="400594" y="745363"/>
                    </a:cubicBezTo>
                    <a:cubicBezTo>
                      <a:pt x="302298" y="745363"/>
                      <a:pt x="208654" y="725442"/>
                      <a:pt x="123480" y="689416"/>
                    </a:cubicBezTo>
                    <a:lnTo>
                      <a:pt x="3371" y="624223"/>
                    </a:lnTo>
                    <a:lnTo>
                      <a:pt x="0" y="590786"/>
                    </a:lnTo>
                    <a:cubicBezTo>
                      <a:pt x="0" y="345045"/>
                      <a:pt x="124508" y="128384"/>
                      <a:pt x="313881" y="446"/>
                    </a:cubicBezTo>
                    <a:lnTo>
                      <a:pt x="314703" y="0"/>
                    </a:lnTo>
                    <a:close/>
                  </a:path>
                </a:pathLst>
              </a:custGeom>
              <a:solidFill>
                <a:srgbClr val="87CCD9">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200" dirty="0" smtClean="0">
                    <a:solidFill>
                      <a:schemeClr val="tx1"/>
                    </a:solidFill>
                    <a:latin typeface="Cambria" panose="02040503050406030204" pitchFamily="18" charset="0"/>
                    <a:ea typeface="Cambria" panose="02040503050406030204" pitchFamily="18" charset="0"/>
                  </a:rPr>
                  <a:t>85</a:t>
                </a:r>
                <a:endParaRPr lang="en-GB" sz="1200" dirty="0">
                  <a:solidFill>
                    <a:schemeClr val="tx1"/>
                  </a:solidFill>
                  <a:latin typeface="Cambria" panose="02040503050406030204" pitchFamily="18" charset="0"/>
                  <a:ea typeface="Cambria" panose="02040503050406030204" pitchFamily="18" charset="0"/>
                </a:endParaRPr>
              </a:p>
            </p:txBody>
          </p:sp>
          <p:sp>
            <p:nvSpPr>
              <p:cNvPr id="50" name="Freeform 49"/>
              <p:cNvSpPr/>
              <p:nvPr/>
            </p:nvSpPr>
            <p:spPr>
              <a:xfrm>
                <a:off x="4105550" y="6356478"/>
                <a:ext cx="711926" cy="745363"/>
              </a:xfrm>
              <a:custGeom>
                <a:avLst/>
                <a:gdLst>
                  <a:gd name="connsiteX0" fmla="*/ 397223 w 711926"/>
                  <a:gd name="connsiteY0" fmla="*/ 0 h 745363"/>
                  <a:gd name="connsiteX1" fmla="*/ 398045 w 711926"/>
                  <a:gd name="connsiteY1" fmla="*/ 446 h 745363"/>
                  <a:gd name="connsiteX2" fmla="*/ 711926 w 711926"/>
                  <a:gd name="connsiteY2" fmla="*/ 590786 h 745363"/>
                  <a:gd name="connsiteX3" fmla="*/ 708555 w 711926"/>
                  <a:gd name="connsiteY3" fmla="*/ 624223 h 745363"/>
                  <a:gd name="connsiteX4" fmla="*/ 588446 w 711926"/>
                  <a:gd name="connsiteY4" fmla="*/ 689416 h 745363"/>
                  <a:gd name="connsiteX5" fmla="*/ 311332 w 711926"/>
                  <a:gd name="connsiteY5" fmla="*/ 745363 h 745363"/>
                  <a:gd name="connsiteX6" fmla="*/ 34218 w 711926"/>
                  <a:gd name="connsiteY6" fmla="*/ 689416 h 745363"/>
                  <a:gd name="connsiteX7" fmla="*/ 0 w 711926"/>
                  <a:gd name="connsiteY7" fmla="*/ 670843 h 745363"/>
                  <a:gd name="connsiteX8" fmla="*/ 86713 w 711926"/>
                  <a:gd name="connsiteY8" fmla="*/ 623777 h 745363"/>
                  <a:gd name="connsiteX9" fmla="*/ 400594 w 711926"/>
                  <a:gd name="connsiteY9" fmla="*/ 33437 h 745363"/>
                  <a:gd name="connsiteX10" fmla="*/ 397223 w 711926"/>
                  <a:gd name="connsiteY10" fmla="*/ 0 h 74536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711926" h="745363">
                    <a:moveTo>
                      <a:pt x="397223" y="0"/>
                    </a:moveTo>
                    <a:lnTo>
                      <a:pt x="398045" y="446"/>
                    </a:lnTo>
                    <a:cubicBezTo>
                      <a:pt x="587418" y="128384"/>
                      <a:pt x="711926" y="345045"/>
                      <a:pt x="711926" y="590786"/>
                    </a:cubicBezTo>
                    <a:lnTo>
                      <a:pt x="708555" y="624223"/>
                    </a:lnTo>
                    <a:lnTo>
                      <a:pt x="588446" y="689416"/>
                    </a:lnTo>
                    <a:cubicBezTo>
                      <a:pt x="503272" y="725442"/>
                      <a:pt x="409629" y="745363"/>
                      <a:pt x="311332" y="745363"/>
                    </a:cubicBezTo>
                    <a:cubicBezTo>
                      <a:pt x="213036" y="745363"/>
                      <a:pt x="119392" y="725442"/>
                      <a:pt x="34218" y="689416"/>
                    </a:cubicBezTo>
                    <a:lnTo>
                      <a:pt x="0" y="670843"/>
                    </a:lnTo>
                    <a:lnTo>
                      <a:pt x="86713" y="623777"/>
                    </a:lnTo>
                    <a:cubicBezTo>
                      <a:pt x="276086" y="495839"/>
                      <a:pt x="400594" y="279178"/>
                      <a:pt x="400594" y="33437"/>
                    </a:cubicBezTo>
                    <a:lnTo>
                      <a:pt x="397223" y="0"/>
                    </a:lnTo>
                    <a:close/>
                  </a:path>
                </a:pathLst>
              </a:custGeom>
              <a:solidFill>
                <a:srgbClr val="87CCD9">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r"/>
                <a:r>
                  <a:rPr lang="en-US" sz="1200" dirty="0" smtClean="0">
                    <a:solidFill>
                      <a:schemeClr val="tx1"/>
                    </a:solidFill>
                    <a:latin typeface="Cambria" panose="02040503050406030204" pitchFamily="18" charset="0"/>
                    <a:ea typeface="Cambria" panose="02040503050406030204" pitchFamily="18" charset="0"/>
                  </a:rPr>
                  <a:t>71</a:t>
                </a:r>
                <a:endParaRPr lang="en-GB" sz="1200" dirty="0">
                  <a:solidFill>
                    <a:schemeClr val="tx1"/>
                  </a:solidFill>
                  <a:latin typeface="Cambria" panose="02040503050406030204" pitchFamily="18" charset="0"/>
                  <a:ea typeface="Cambria" panose="02040503050406030204" pitchFamily="18" charset="0"/>
                </a:endParaRPr>
              </a:p>
            </p:txBody>
          </p:sp>
          <p:sp>
            <p:nvSpPr>
              <p:cNvPr id="51" name="Freeform 50"/>
              <p:cNvSpPr/>
              <p:nvPr/>
            </p:nvSpPr>
            <p:spPr>
              <a:xfrm>
                <a:off x="3082292" y="5677989"/>
                <a:ext cx="1023258" cy="1302712"/>
              </a:xfrm>
              <a:custGeom>
                <a:avLst/>
                <a:gdLst>
                  <a:gd name="connsiteX0" fmla="*/ 711926 w 1023258"/>
                  <a:gd name="connsiteY0" fmla="*/ 0 h 1302712"/>
                  <a:gd name="connsiteX1" fmla="*/ 989040 w 1023258"/>
                  <a:gd name="connsiteY1" fmla="*/ 55947 h 1302712"/>
                  <a:gd name="connsiteX2" fmla="*/ 1023258 w 1023258"/>
                  <a:gd name="connsiteY2" fmla="*/ 74520 h 1302712"/>
                  <a:gd name="connsiteX3" fmla="*/ 936545 w 1023258"/>
                  <a:gd name="connsiteY3" fmla="*/ 121586 h 1302712"/>
                  <a:gd name="connsiteX4" fmla="*/ 637128 w 1023258"/>
                  <a:gd name="connsiteY4" fmla="*/ 568448 h 1302712"/>
                  <a:gd name="connsiteX5" fmla="*/ 626035 w 1023258"/>
                  <a:gd name="connsiteY5" fmla="*/ 678489 h 1302712"/>
                  <a:gd name="connsiteX6" fmla="*/ 625213 w 1023258"/>
                  <a:gd name="connsiteY6" fmla="*/ 678935 h 1302712"/>
                  <a:gd name="connsiteX7" fmla="*/ 311332 w 1023258"/>
                  <a:gd name="connsiteY7" fmla="*/ 1269275 h 1302712"/>
                  <a:gd name="connsiteX8" fmla="*/ 314703 w 1023258"/>
                  <a:gd name="connsiteY8" fmla="*/ 1302712 h 1302712"/>
                  <a:gd name="connsiteX9" fmla="*/ 313881 w 1023258"/>
                  <a:gd name="connsiteY9" fmla="*/ 1302266 h 1302712"/>
                  <a:gd name="connsiteX10" fmla="*/ 0 w 1023258"/>
                  <a:gd name="connsiteY10" fmla="*/ 711926 h 1302712"/>
                  <a:gd name="connsiteX11" fmla="*/ 711926 w 1023258"/>
                  <a:gd name="connsiteY11" fmla="*/ 0 h 13027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Lst>
                <a:rect l="l" t="t" r="r" b="b"/>
                <a:pathLst>
                  <a:path w="1023258" h="1302712">
                    <a:moveTo>
                      <a:pt x="711926" y="0"/>
                    </a:moveTo>
                    <a:cubicBezTo>
                      <a:pt x="810223" y="0"/>
                      <a:pt x="903866" y="19921"/>
                      <a:pt x="989040" y="55947"/>
                    </a:cubicBezTo>
                    <a:lnTo>
                      <a:pt x="1023258" y="74520"/>
                    </a:lnTo>
                    <a:lnTo>
                      <a:pt x="936545" y="121586"/>
                    </a:lnTo>
                    <a:cubicBezTo>
                      <a:pt x="785047" y="223936"/>
                      <a:pt x="675062" y="383069"/>
                      <a:pt x="637128" y="568448"/>
                    </a:cubicBezTo>
                    <a:lnTo>
                      <a:pt x="626035" y="678489"/>
                    </a:lnTo>
                    <a:lnTo>
                      <a:pt x="625213" y="678935"/>
                    </a:lnTo>
                    <a:cubicBezTo>
                      <a:pt x="435840" y="806873"/>
                      <a:pt x="311332" y="1023534"/>
                      <a:pt x="311332" y="1269275"/>
                    </a:cubicBezTo>
                    <a:lnTo>
                      <a:pt x="314703" y="1302712"/>
                    </a:lnTo>
                    <a:lnTo>
                      <a:pt x="313881" y="1302266"/>
                    </a:lnTo>
                    <a:cubicBezTo>
                      <a:pt x="124508" y="1174328"/>
                      <a:pt x="0" y="957667"/>
                      <a:pt x="0" y="711926"/>
                    </a:cubicBezTo>
                    <a:cubicBezTo>
                      <a:pt x="0" y="318740"/>
                      <a:pt x="318740" y="0"/>
                      <a:pt x="711926" y="0"/>
                    </a:cubicBezTo>
                    <a:close/>
                  </a:path>
                </a:pathLst>
              </a:custGeom>
              <a:solidFill>
                <a:srgbClr val="87CCD9">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200" dirty="0" smtClean="0">
                    <a:solidFill>
                      <a:schemeClr val="tx1"/>
                    </a:solidFill>
                    <a:latin typeface="Cambria" panose="02040503050406030204" pitchFamily="18" charset="0"/>
                    <a:ea typeface="Cambria" panose="02040503050406030204" pitchFamily="18" charset="0"/>
                  </a:rPr>
                  <a:t>113</a:t>
                </a:r>
              </a:p>
            </p:txBody>
          </p:sp>
          <p:sp>
            <p:nvSpPr>
              <p:cNvPr id="52" name="Freeform 51"/>
              <p:cNvSpPr/>
              <p:nvPr/>
            </p:nvSpPr>
            <p:spPr>
              <a:xfrm>
                <a:off x="4105550" y="5677989"/>
                <a:ext cx="1023258" cy="1302712"/>
              </a:xfrm>
              <a:custGeom>
                <a:avLst/>
                <a:gdLst>
                  <a:gd name="connsiteX0" fmla="*/ 311332 w 1023258"/>
                  <a:gd name="connsiteY0" fmla="*/ 0 h 1302712"/>
                  <a:gd name="connsiteX1" fmla="*/ 1023258 w 1023258"/>
                  <a:gd name="connsiteY1" fmla="*/ 711926 h 1302712"/>
                  <a:gd name="connsiteX2" fmla="*/ 709377 w 1023258"/>
                  <a:gd name="connsiteY2" fmla="*/ 1302266 h 1302712"/>
                  <a:gd name="connsiteX3" fmla="*/ 708555 w 1023258"/>
                  <a:gd name="connsiteY3" fmla="*/ 1302712 h 1302712"/>
                  <a:gd name="connsiteX4" fmla="*/ 711926 w 1023258"/>
                  <a:gd name="connsiteY4" fmla="*/ 1269275 h 1302712"/>
                  <a:gd name="connsiteX5" fmla="*/ 398045 w 1023258"/>
                  <a:gd name="connsiteY5" fmla="*/ 678935 h 1302712"/>
                  <a:gd name="connsiteX6" fmla="*/ 397223 w 1023258"/>
                  <a:gd name="connsiteY6" fmla="*/ 678489 h 1302712"/>
                  <a:gd name="connsiteX7" fmla="*/ 386130 w 1023258"/>
                  <a:gd name="connsiteY7" fmla="*/ 568448 h 1302712"/>
                  <a:gd name="connsiteX8" fmla="*/ 86713 w 1023258"/>
                  <a:gd name="connsiteY8" fmla="*/ 121586 h 1302712"/>
                  <a:gd name="connsiteX9" fmla="*/ 0 w 1023258"/>
                  <a:gd name="connsiteY9" fmla="*/ 74520 h 1302712"/>
                  <a:gd name="connsiteX10" fmla="*/ 34218 w 1023258"/>
                  <a:gd name="connsiteY10" fmla="*/ 55947 h 1302712"/>
                  <a:gd name="connsiteX11" fmla="*/ 311332 w 1023258"/>
                  <a:gd name="connsiteY11" fmla="*/ 0 h 13027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Lst>
                <a:rect l="l" t="t" r="r" b="b"/>
                <a:pathLst>
                  <a:path w="1023258" h="1302712">
                    <a:moveTo>
                      <a:pt x="311332" y="0"/>
                    </a:moveTo>
                    <a:cubicBezTo>
                      <a:pt x="704518" y="0"/>
                      <a:pt x="1023258" y="318740"/>
                      <a:pt x="1023258" y="711926"/>
                    </a:cubicBezTo>
                    <a:cubicBezTo>
                      <a:pt x="1023258" y="957667"/>
                      <a:pt x="898750" y="1174328"/>
                      <a:pt x="709377" y="1302266"/>
                    </a:cubicBezTo>
                    <a:lnTo>
                      <a:pt x="708555" y="1302712"/>
                    </a:lnTo>
                    <a:lnTo>
                      <a:pt x="711926" y="1269275"/>
                    </a:lnTo>
                    <a:cubicBezTo>
                      <a:pt x="711926" y="1023534"/>
                      <a:pt x="587418" y="806873"/>
                      <a:pt x="398045" y="678935"/>
                    </a:cubicBezTo>
                    <a:lnTo>
                      <a:pt x="397223" y="678489"/>
                    </a:lnTo>
                    <a:lnTo>
                      <a:pt x="386130" y="568448"/>
                    </a:lnTo>
                    <a:cubicBezTo>
                      <a:pt x="348196" y="383069"/>
                      <a:pt x="238212" y="223936"/>
                      <a:pt x="86713" y="121586"/>
                    </a:cubicBezTo>
                    <a:lnTo>
                      <a:pt x="0" y="74520"/>
                    </a:lnTo>
                    <a:lnTo>
                      <a:pt x="34218" y="55947"/>
                    </a:lnTo>
                    <a:cubicBezTo>
                      <a:pt x="119392" y="19921"/>
                      <a:pt x="213036" y="0"/>
                      <a:pt x="311332" y="0"/>
                    </a:cubicBezTo>
                    <a:close/>
                  </a:path>
                </a:pathLst>
              </a:custGeom>
              <a:solidFill>
                <a:srgbClr val="87CCD9">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r"/>
                <a:r>
                  <a:rPr lang="en-US" sz="1200" dirty="0" smtClean="0">
                    <a:solidFill>
                      <a:schemeClr val="tx1"/>
                    </a:solidFill>
                    <a:latin typeface="Cambria" panose="02040503050406030204" pitchFamily="18" charset="0"/>
                    <a:ea typeface="Cambria" panose="02040503050406030204" pitchFamily="18" charset="0"/>
                  </a:rPr>
                  <a:t>103</a:t>
                </a:r>
              </a:p>
            </p:txBody>
          </p:sp>
          <p:sp>
            <p:nvSpPr>
              <p:cNvPr id="53" name="Freeform 52"/>
              <p:cNvSpPr/>
              <p:nvPr/>
            </p:nvSpPr>
            <p:spPr>
              <a:xfrm>
                <a:off x="3704956" y="6235338"/>
                <a:ext cx="801188" cy="791983"/>
              </a:xfrm>
              <a:custGeom>
                <a:avLst/>
                <a:gdLst>
                  <a:gd name="connsiteX0" fmla="*/ 400594 w 801188"/>
                  <a:gd name="connsiteY0" fmla="*/ 0 h 791983"/>
                  <a:gd name="connsiteX1" fmla="*/ 677708 w 801188"/>
                  <a:gd name="connsiteY1" fmla="*/ 55947 h 791983"/>
                  <a:gd name="connsiteX2" fmla="*/ 797817 w 801188"/>
                  <a:gd name="connsiteY2" fmla="*/ 121140 h 791983"/>
                  <a:gd name="connsiteX3" fmla="*/ 801188 w 801188"/>
                  <a:gd name="connsiteY3" fmla="*/ 154577 h 791983"/>
                  <a:gd name="connsiteX4" fmla="*/ 487307 w 801188"/>
                  <a:gd name="connsiteY4" fmla="*/ 744917 h 791983"/>
                  <a:gd name="connsiteX5" fmla="*/ 400594 w 801188"/>
                  <a:gd name="connsiteY5" fmla="*/ 791983 h 791983"/>
                  <a:gd name="connsiteX6" fmla="*/ 313881 w 801188"/>
                  <a:gd name="connsiteY6" fmla="*/ 744917 h 791983"/>
                  <a:gd name="connsiteX7" fmla="*/ 0 w 801188"/>
                  <a:gd name="connsiteY7" fmla="*/ 154577 h 791983"/>
                  <a:gd name="connsiteX8" fmla="*/ 3371 w 801188"/>
                  <a:gd name="connsiteY8" fmla="*/ 121140 h 791983"/>
                  <a:gd name="connsiteX9" fmla="*/ 123480 w 801188"/>
                  <a:gd name="connsiteY9" fmla="*/ 55947 h 791983"/>
                  <a:gd name="connsiteX10" fmla="*/ 400594 w 801188"/>
                  <a:gd name="connsiteY10" fmla="*/ 0 h 79198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801188" h="791983">
                    <a:moveTo>
                      <a:pt x="400594" y="0"/>
                    </a:moveTo>
                    <a:cubicBezTo>
                      <a:pt x="498891" y="0"/>
                      <a:pt x="592534" y="19921"/>
                      <a:pt x="677708" y="55947"/>
                    </a:cubicBezTo>
                    <a:lnTo>
                      <a:pt x="797817" y="121140"/>
                    </a:lnTo>
                    <a:lnTo>
                      <a:pt x="801188" y="154577"/>
                    </a:lnTo>
                    <a:cubicBezTo>
                      <a:pt x="801188" y="400318"/>
                      <a:pt x="676680" y="616979"/>
                      <a:pt x="487307" y="744917"/>
                    </a:cubicBezTo>
                    <a:lnTo>
                      <a:pt x="400594" y="791983"/>
                    </a:lnTo>
                    <a:lnTo>
                      <a:pt x="313881" y="744917"/>
                    </a:lnTo>
                    <a:cubicBezTo>
                      <a:pt x="124508" y="616979"/>
                      <a:pt x="0" y="400318"/>
                      <a:pt x="0" y="154577"/>
                    </a:cubicBezTo>
                    <a:lnTo>
                      <a:pt x="3371" y="121140"/>
                    </a:lnTo>
                    <a:lnTo>
                      <a:pt x="123480" y="55947"/>
                    </a:lnTo>
                    <a:cubicBezTo>
                      <a:pt x="208654" y="19921"/>
                      <a:pt x="302298" y="0"/>
                      <a:pt x="400594" y="0"/>
                    </a:cubicBezTo>
                    <a:close/>
                  </a:path>
                </a:pathLst>
              </a:custGeom>
              <a:solidFill>
                <a:srgbClr val="87CCD9">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smtClean="0">
                    <a:solidFill>
                      <a:schemeClr val="tx1"/>
                    </a:solidFill>
                    <a:latin typeface="Cambria" panose="02040503050406030204" pitchFamily="18" charset="0"/>
                    <a:ea typeface="Cambria" panose="02040503050406030204" pitchFamily="18" charset="0"/>
                  </a:rPr>
                  <a:t>2,191</a:t>
                </a:r>
                <a:endParaRPr lang="en-GB" sz="1200" dirty="0">
                  <a:solidFill>
                    <a:schemeClr val="tx1"/>
                  </a:solidFill>
                  <a:latin typeface="Cambria" panose="02040503050406030204" pitchFamily="18" charset="0"/>
                  <a:ea typeface="Cambria" panose="02040503050406030204" pitchFamily="18" charset="0"/>
                </a:endParaRPr>
              </a:p>
            </p:txBody>
          </p:sp>
          <p:sp>
            <p:nvSpPr>
              <p:cNvPr id="54" name="Freeform 53"/>
              <p:cNvSpPr/>
              <p:nvPr/>
            </p:nvSpPr>
            <p:spPr>
              <a:xfrm>
                <a:off x="3396995" y="6980701"/>
                <a:ext cx="1417110" cy="678489"/>
              </a:xfrm>
              <a:custGeom>
                <a:avLst/>
                <a:gdLst>
                  <a:gd name="connsiteX0" fmla="*/ 0 w 1417110"/>
                  <a:gd name="connsiteY0" fmla="*/ 0 h 678489"/>
                  <a:gd name="connsiteX1" fmla="*/ 120109 w 1417110"/>
                  <a:gd name="connsiteY1" fmla="*/ 65193 h 678489"/>
                  <a:gd name="connsiteX2" fmla="*/ 397223 w 1417110"/>
                  <a:gd name="connsiteY2" fmla="*/ 121140 h 678489"/>
                  <a:gd name="connsiteX3" fmla="*/ 674337 w 1417110"/>
                  <a:gd name="connsiteY3" fmla="*/ 65193 h 678489"/>
                  <a:gd name="connsiteX4" fmla="*/ 708555 w 1417110"/>
                  <a:gd name="connsiteY4" fmla="*/ 46620 h 678489"/>
                  <a:gd name="connsiteX5" fmla="*/ 742773 w 1417110"/>
                  <a:gd name="connsiteY5" fmla="*/ 65193 h 678489"/>
                  <a:gd name="connsiteX6" fmla="*/ 1019887 w 1417110"/>
                  <a:gd name="connsiteY6" fmla="*/ 121140 h 678489"/>
                  <a:gd name="connsiteX7" fmla="*/ 1297001 w 1417110"/>
                  <a:gd name="connsiteY7" fmla="*/ 65193 h 678489"/>
                  <a:gd name="connsiteX8" fmla="*/ 1417110 w 1417110"/>
                  <a:gd name="connsiteY8" fmla="*/ 0 h 678489"/>
                  <a:gd name="connsiteX9" fmla="*/ 1406017 w 1417110"/>
                  <a:gd name="connsiteY9" fmla="*/ 110041 h 678489"/>
                  <a:gd name="connsiteX10" fmla="*/ 708555 w 1417110"/>
                  <a:gd name="connsiteY10" fmla="*/ 678489 h 678489"/>
                  <a:gd name="connsiteX11" fmla="*/ 11093 w 1417110"/>
                  <a:gd name="connsiteY11" fmla="*/ 110041 h 678489"/>
                  <a:gd name="connsiteX12" fmla="*/ 0 w 1417110"/>
                  <a:gd name="connsiteY12" fmla="*/ 0 h 67848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Lst>
                <a:rect l="l" t="t" r="r" b="b"/>
                <a:pathLst>
                  <a:path w="1417110" h="678489">
                    <a:moveTo>
                      <a:pt x="0" y="0"/>
                    </a:moveTo>
                    <a:lnTo>
                      <a:pt x="120109" y="65193"/>
                    </a:lnTo>
                    <a:cubicBezTo>
                      <a:pt x="205283" y="101219"/>
                      <a:pt x="298927" y="121140"/>
                      <a:pt x="397223" y="121140"/>
                    </a:cubicBezTo>
                    <a:cubicBezTo>
                      <a:pt x="495520" y="121140"/>
                      <a:pt x="589163" y="101219"/>
                      <a:pt x="674337" y="65193"/>
                    </a:cubicBezTo>
                    <a:lnTo>
                      <a:pt x="708555" y="46620"/>
                    </a:lnTo>
                    <a:lnTo>
                      <a:pt x="742773" y="65193"/>
                    </a:lnTo>
                    <a:cubicBezTo>
                      <a:pt x="827947" y="101219"/>
                      <a:pt x="921591" y="121140"/>
                      <a:pt x="1019887" y="121140"/>
                    </a:cubicBezTo>
                    <a:cubicBezTo>
                      <a:pt x="1118184" y="121140"/>
                      <a:pt x="1211827" y="101219"/>
                      <a:pt x="1297001" y="65193"/>
                    </a:cubicBezTo>
                    <a:lnTo>
                      <a:pt x="1417110" y="0"/>
                    </a:lnTo>
                    <a:lnTo>
                      <a:pt x="1406017" y="110041"/>
                    </a:lnTo>
                    <a:cubicBezTo>
                      <a:pt x="1339633" y="434454"/>
                      <a:pt x="1052593" y="678489"/>
                      <a:pt x="708555" y="678489"/>
                    </a:cubicBezTo>
                    <a:cubicBezTo>
                      <a:pt x="364517" y="678489"/>
                      <a:pt x="77477" y="434454"/>
                      <a:pt x="11093" y="110041"/>
                    </a:cubicBezTo>
                    <a:lnTo>
                      <a:pt x="0" y="0"/>
                    </a:lnTo>
                    <a:close/>
                  </a:path>
                </a:pathLst>
              </a:custGeom>
              <a:solidFill>
                <a:srgbClr val="87CCD9">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smtClean="0">
                    <a:solidFill>
                      <a:schemeClr val="tx1"/>
                    </a:solidFill>
                    <a:latin typeface="Cambria" panose="02040503050406030204" pitchFamily="18" charset="0"/>
                    <a:ea typeface="Cambria" panose="02040503050406030204" pitchFamily="18" charset="0"/>
                  </a:rPr>
                  <a:t>45</a:t>
                </a:r>
                <a:endParaRPr lang="en-GB" sz="1200" dirty="0">
                  <a:solidFill>
                    <a:schemeClr val="tx1"/>
                  </a:solidFill>
                  <a:latin typeface="Cambria" panose="02040503050406030204" pitchFamily="18" charset="0"/>
                  <a:ea typeface="Cambria" panose="02040503050406030204" pitchFamily="18" charset="0"/>
                </a:endParaRPr>
              </a:p>
            </p:txBody>
          </p:sp>
        </p:grpSp>
        <p:grpSp>
          <p:nvGrpSpPr>
            <p:cNvPr id="75" name="Group 74"/>
            <p:cNvGrpSpPr/>
            <p:nvPr/>
          </p:nvGrpSpPr>
          <p:grpSpPr>
            <a:xfrm>
              <a:off x="4542506" y="3776313"/>
              <a:ext cx="2046516" cy="1981201"/>
              <a:chOff x="643451" y="7795382"/>
              <a:chExt cx="2046516" cy="1981201"/>
            </a:xfrm>
          </p:grpSpPr>
          <p:sp>
            <p:nvSpPr>
              <p:cNvPr id="62" name="Freeform 61"/>
              <p:cNvSpPr/>
              <p:nvPr/>
            </p:nvSpPr>
            <p:spPr>
              <a:xfrm>
                <a:off x="1269486" y="7869902"/>
                <a:ext cx="794446" cy="603969"/>
              </a:xfrm>
              <a:custGeom>
                <a:avLst/>
                <a:gdLst>
                  <a:gd name="connsiteX0" fmla="*/ 397223 w 794446"/>
                  <a:gd name="connsiteY0" fmla="*/ 0 h 603969"/>
                  <a:gd name="connsiteX1" fmla="*/ 483936 w 794446"/>
                  <a:gd name="connsiteY1" fmla="*/ 47066 h 603969"/>
                  <a:gd name="connsiteX2" fmla="*/ 783353 w 794446"/>
                  <a:gd name="connsiteY2" fmla="*/ 493928 h 603969"/>
                  <a:gd name="connsiteX3" fmla="*/ 794446 w 794446"/>
                  <a:gd name="connsiteY3" fmla="*/ 603969 h 603969"/>
                  <a:gd name="connsiteX4" fmla="*/ 674337 w 794446"/>
                  <a:gd name="connsiteY4" fmla="*/ 538776 h 603969"/>
                  <a:gd name="connsiteX5" fmla="*/ 397223 w 794446"/>
                  <a:gd name="connsiteY5" fmla="*/ 482829 h 603969"/>
                  <a:gd name="connsiteX6" fmla="*/ 120109 w 794446"/>
                  <a:gd name="connsiteY6" fmla="*/ 538776 h 603969"/>
                  <a:gd name="connsiteX7" fmla="*/ 0 w 794446"/>
                  <a:gd name="connsiteY7" fmla="*/ 603969 h 603969"/>
                  <a:gd name="connsiteX8" fmla="*/ 11093 w 794446"/>
                  <a:gd name="connsiteY8" fmla="*/ 493928 h 603969"/>
                  <a:gd name="connsiteX9" fmla="*/ 310510 w 794446"/>
                  <a:gd name="connsiteY9" fmla="*/ 47066 h 603969"/>
                  <a:gd name="connsiteX10" fmla="*/ 397223 w 794446"/>
                  <a:gd name="connsiteY10" fmla="*/ 0 h 60396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794446" h="603969">
                    <a:moveTo>
                      <a:pt x="397223" y="0"/>
                    </a:moveTo>
                    <a:lnTo>
                      <a:pt x="483936" y="47066"/>
                    </a:lnTo>
                    <a:cubicBezTo>
                      <a:pt x="635435" y="149416"/>
                      <a:pt x="745419" y="308549"/>
                      <a:pt x="783353" y="493928"/>
                    </a:cubicBezTo>
                    <a:lnTo>
                      <a:pt x="794446" y="603969"/>
                    </a:lnTo>
                    <a:lnTo>
                      <a:pt x="674337" y="538776"/>
                    </a:lnTo>
                    <a:cubicBezTo>
                      <a:pt x="589163" y="502750"/>
                      <a:pt x="495520" y="482829"/>
                      <a:pt x="397223" y="482829"/>
                    </a:cubicBezTo>
                    <a:cubicBezTo>
                      <a:pt x="298927" y="482829"/>
                      <a:pt x="205283" y="502750"/>
                      <a:pt x="120109" y="538776"/>
                    </a:cubicBezTo>
                    <a:lnTo>
                      <a:pt x="0" y="603969"/>
                    </a:lnTo>
                    <a:lnTo>
                      <a:pt x="11093" y="493928"/>
                    </a:lnTo>
                    <a:cubicBezTo>
                      <a:pt x="49027" y="308549"/>
                      <a:pt x="159012" y="149416"/>
                      <a:pt x="310510" y="47066"/>
                    </a:cubicBezTo>
                    <a:lnTo>
                      <a:pt x="397223" y="0"/>
                    </a:lnTo>
                    <a:close/>
                  </a:path>
                </a:pathLst>
              </a:custGeom>
              <a:solidFill>
                <a:srgbClr val="87CCD9">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smtClean="0">
                    <a:solidFill>
                      <a:schemeClr val="tx1"/>
                    </a:solidFill>
                    <a:latin typeface="Cambria" panose="02040503050406030204" pitchFamily="18" charset="0"/>
                    <a:ea typeface="Cambria" panose="02040503050406030204" pitchFamily="18" charset="0"/>
                  </a:rPr>
                  <a:t>99</a:t>
                </a:r>
                <a:endParaRPr lang="en-GB" sz="1200" dirty="0">
                  <a:solidFill>
                    <a:schemeClr val="tx1"/>
                  </a:solidFill>
                  <a:latin typeface="Cambria" panose="02040503050406030204" pitchFamily="18" charset="0"/>
                  <a:ea typeface="Cambria" panose="02040503050406030204" pitchFamily="18" charset="0"/>
                </a:endParaRPr>
              </a:p>
            </p:txBody>
          </p:sp>
          <p:sp>
            <p:nvSpPr>
              <p:cNvPr id="63" name="Freeform 62"/>
              <p:cNvSpPr/>
              <p:nvPr/>
            </p:nvSpPr>
            <p:spPr>
              <a:xfrm>
                <a:off x="954783" y="8473871"/>
                <a:ext cx="711926" cy="745363"/>
              </a:xfrm>
              <a:custGeom>
                <a:avLst/>
                <a:gdLst>
                  <a:gd name="connsiteX0" fmla="*/ 314703 w 711926"/>
                  <a:gd name="connsiteY0" fmla="*/ 0 h 745363"/>
                  <a:gd name="connsiteX1" fmla="*/ 311332 w 711926"/>
                  <a:gd name="connsiteY1" fmla="*/ 33437 h 745363"/>
                  <a:gd name="connsiteX2" fmla="*/ 625213 w 711926"/>
                  <a:gd name="connsiteY2" fmla="*/ 623777 h 745363"/>
                  <a:gd name="connsiteX3" fmla="*/ 711926 w 711926"/>
                  <a:gd name="connsiteY3" fmla="*/ 670843 h 745363"/>
                  <a:gd name="connsiteX4" fmla="*/ 677708 w 711926"/>
                  <a:gd name="connsiteY4" fmla="*/ 689416 h 745363"/>
                  <a:gd name="connsiteX5" fmla="*/ 400594 w 711926"/>
                  <a:gd name="connsiteY5" fmla="*/ 745363 h 745363"/>
                  <a:gd name="connsiteX6" fmla="*/ 123480 w 711926"/>
                  <a:gd name="connsiteY6" fmla="*/ 689416 h 745363"/>
                  <a:gd name="connsiteX7" fmla="*/ 3371 w 711926"/>
                  <a:gd name="connsiteY7" fmla="*/ 624223 h 745363"/>
                  <a:gd name="connsiteX8" fmla="*/ 0 w 711926"/>
                  <a:gd name="connsiteY8" fmla="*/ 590786 h 745363"/>
                  <a:gd name="connsiteX9" fmla="*/ 313881 w 711926"/>
                  <a:gd name="connsiteY9" fmla="*/ 446 h 745363"/>
                  <a:gd name="connsiteX10" fmla="*/ 314703 w 711926"/>
                  <a:gd name="connsiteY10" fmla="*/ 0 h 74536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711926" h="745363">
                    <a:moveTo>
                      <a:pt x="314703" y="0"/>
                    </a:moveTo>
                    <a:lnTo>
                      <a:pt x="311332" y="33437"/>
                    </a:lnTo>
                    <a:cubicBezTo>
                      <a:pt x="311332" y="279178"/>
                      <a:pt x="435840" y="495839"/>
                      <a:pt x="625213" y="623777"/>
                    </a:cubicBezTo>
                    <a:lnTo>
                      <a:pt x="711926" y="670843"/>
                    </a:lnTo>
                    <a:lnTo>
                      <a:pt x="677708" y="689416"/>
                    </a:lnTo>
                    <a:cubicBezTo>
                      <a:pt x="592534" y="725442"/>
                      <a:pt x="498891" y="745363"/>
                      <a:pt x="400594" y="745363"/>
                    </a:cubicBezTo>
                    <a:cubicBezTo>
                      <a:pt x="302298" y="745363"/>
                      <a:pt x="208654" y="725442"/>
                      <a:pt x="123480" y="689416"/>
                    </a:cubicBezTo>
                    <a:lnTo>
                      <a:pt x="3371" y="624223"/>
                    </a:lnTo>
                    <a:lnTo>
                      <a:pt x="0" y="590786"/>
                    </a:lnTo>
                    <a:cubicBezTo>
                      <a:pt x="0" y="345045"/>
                      <a:pt x="124508" y="128384"/>
                      <a:pt x="313881" y="446"/>
                    </a:cubicBezTo>
                    <a:lnTo>
                      <a:pt x="314703" y="0"/>
                    </a:lnTo>
                    <a:close/>
                  </a:path>
                </a:pathLst>
              </a:custGeom>
              <a:solidFill>
                <a:srgbClr val="87CCD9">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200" dirty="0" smtClean="0">
                    <a:solidFill>
                      <a:schemeClr val="tx1"/>
                    </a:solidFill>
                    <a:latin typeface="Cambria" panose="02040503050406030204" pitchFamily="18" charset="0"/>
                    <a:ea typeface="Cambria" panose="02040503050406030204" pitchFamily="18" charset="0"/>
                  </a:rPr>
                  <a:t>119</a:t>
                </a:r>
                <a:endParaRPr lang="en-GB" sz="1200" dirty="0">
                  <a:solidFill>
                    <a:schemeClr val="tx1"/>
                  </a:solidFill>
                  <a:latin typeface="Cambria" panose="02040503050406030204" pitchFamily="18" charset="0"/>
                  <a:ea typeface="Cambria" panose="02040503050406030204" pitchFamily="18" charset="0"/>
                </a:endParaRPr>
              </a:p>
            </p:txBody>
          </p:sp>
          <p:sp>
            <p:nvSpPr>
              <p:cNvPr id="64" name="Freeform 63"/>
              <p:cNvSpPr/>
              <p:nvPr/>
            </p:nvSpPr>
            <p:spPr>
              <a:xfrm>
                <a:off x="1666709" y="8473871"/>
                <a:ext cx="711926" cy="745363"/>
              </a:xfrm>
              <a:custGeom>
                <a:avLst/>
                <a:gdLst>
                  <a:gd name="connsiteX0" fmla="*/ 397223 w 711926"/>
                  <a:gd name="connsiteY0" fmla="*/ 0 h 745363"/>
                  <a:gd name="connsiteX1" fmla="*/ 398045 w 711926"/>
                  <a:gd name="connsiteY1" fmla="*/ 446 h 745363"/>
                  <a:gd name="connsiteX2" fmla="*/ 711926 w 711926"/>
                  <a:gd name="connsiteY2" fmla="*/ 590786 h 745363"/>
                  <a:gd name="connsiteX3" fmla="*/ 708555 w 711926"/>
                  <a:gd name="connsiteY3" fmla="*/ 624223 h 745363"/>
                  <a:gd name="connsiteX4" fmla="*/ 588446 w 711926"/>
                  <a:gd name="connsiteY4" fmla="*/ 689416 h 745363"/>
                  <a:gd name="connsiteX5" fmla="*/ 311332 w 711926"/>
                  <a:gd name="connsiteY5" fmla="*/ 745363 h 745363"/>
                  <a:gd name="connsiteX6" fmla="*/ 34218 w 711926"/>
                  <a:gd name="connsiteY6" fmla="*/ 689416 h 745363"/>
                  <a:gd name="connsiteX7" fmla="*/ 0 w 711926"/>
                  <a:gd name="connsiteY7" fmla="*/ 670843 h 745363"/>
                  <a:gd name="connsiteX8" fmla="*/ 86713 w 711926"/>
                  <a:gd name="connsiteY8" fmla="*/ 623777 h 745363"/>
                  <a:gd name="connsiteX9" fmla="*/ 400594 w 711926"/>
                  <a:gd name="connsiteY9" fmla="*/ 33437 h 745363"/>
                  <a:gd name="connsiteX10" fmla="*/ 397223 w 711926"/>
                  <a:gd name="connsiteY10" fmla="*/ 0 h 74536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711926" h="745363">
                    <a:moveTo>
                      <a:pt x="397223" y="0"/>
                    </a:moveTo>
                    <a:lnTo>
                      <a:pt x="398045" y="446"/>
                    </a:lnTo>
                    <a:cubicBezTo>
                      <a:pt x="587418" y="128384"/>
                      <a:pt x="711926" y="345045"/>
                      <a:pt x="711926" y="590786"/>
                    </a:cubicBezTo>
                    <a:lnTo>
                      <a:pt x="708555" y="624223"/>
                    </a:lnTo>
                    <a:lnTo>
                      <a:pt x="588446" y="689416"/>
                    </a:lnTo>
                    <a:cubicBezTo>
                      <a:pt x="503272" y="725442"/>
                      <a:pt x="409629" y="745363"/>
                      <a:pt x="311332" y="745363"/>
                    </a:cubicBezTo>
                    <a:cubicBezTo>
                      <a:pt x="213036" y="745363"/>
                      <a:pt x="119392" y="725442"/>
                      <a:pt x="34218" y="689416"/>
                    </a:cubicBezTo>
                    <a:lnTo>
                      <a:pt x="0" y="670843"/>
                    </a:lnTo>
                    <a:lnTo>
                      <a:pt x="86713" y="623777"/>
                    </a:lnTo>
                    <a:cubicBezTo>
                      <a:pt x="276086" y="495839"/>
                      <a:pt x="400594" y="279178"/>
                      <a:pt x="400594" y="33437"/>
                    </a:cubicBezTo>
                    <a:lnTo>
                      <a:pt x="397223" y="0"/>
                    </a:lnTo>
                    <a:close/>
                  </a:path>
                </a:pathLst>
              </a:custGeom>
              <a:solidFill>
                <a:srgbClr val="87CCD9">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r"/>
                <a:r>
                  <a:rPr lang="en-US" sz="1200" dirty="0" smtClean="0">
                    <a:solidFill>
                      <a:schemeClr val="tx1"/>
                    </a:solidFill>
                    <a:latin typeface="Cambria" panose="02040503050406030204" pitchFamily="18" charset="0"/>
                    <a:ea typeface="Cambria" panose="02040503050406030204" pitchFamily="18" charset="0"/>
                  </a:rPr>
                  <a:t>100</a:t>
                </a:r>
                <a:endParaRPr lang="en-GB" sz="1200" dirty="0">
                  <a:solidFill>
                    <a:schemeClr val="tx1"/>
                  </a:solidFill>
                  <a:latin typeface="Cambria" panose="02040503050406030204" pitchFamily="18" charset="0"/>
                  <a:ea typeface="Cambria" panose="02040503050406030204" pitchFamily="18" charset="0"/>
                </a:endParaRPr>
              </a:p>
            </p:txBody>
          </p:sp>
          <p:sp>
            <p:nvSpPr>
              <p:cNvPr id="65" name="Freeform 64"/>
              <p:cNvSpPr/>
              <p:nvPr/>
            </p:nvSpPr>
            <p:spPr>
              <a:xfrm>
                <a:off x="643451" y="7795382"/>
                <a:ext cx="1023258" cy="1302712"/>
              </a:xfrm>
              <a:custGeom>
                <a:avLst/>
                <a:gdLst>
                  <a:gd name="connsiteX0" fmla="*/ 711926 w 1023258"/>
                  <a:gd name="connsiteY0" fmla="*/ 0 h 1302712"/>
                  <a:gd name="connsiteX1" fmla="*/ 989040 w 1023258"/>
                  <a:gd name="connsiteY1" fmla="*/ 55947 h 1302712"/>
                  <a:gd name="connsiteX2" fmla="*/ 1023258 w 1023258"/>
                  <a:gd name="connsiteY2" fmla="*/ 74520 h 1302712"/>
                  <a:gd name="connsiteX3" fmla="*/ 936545 w 1023258"/>
                  <a:gd name="connsiteY3" fmla="*/ 121586 h 1302712"/>
                  <a:gd name="connsiteX4" fmla="*/ 637128 w 1023258"/>
                  <a:gd name="connsiteY4" fmla="*/ 568448 h 1302712"/>
                  <a:gd name="connsiteX5" fmla="*/ 626035 w 1023258"/>
                  <a:gd name="connsiteY5" fmla="*/ 678489 h 1302712"/>
                  <a:gd name="connsiteX6" fmla="*/ 625213 w 1023258"/>
                  <a:gd name="connsiteY6" fmla="*/ 678935 h 1302712"/>
                  <a:gd name="connsiteX7" fmla="*/ 311332 w 1023258"/>
                  <a:gd name="connsiteY7" fmla="*/ 1269275 h 1302712"/>
                  <a:gd name="connsiteX8" fmla="*/ 314703 w 1023258"/>
                  <a:gd name="connsiteY8" fmla="*/ 1302712 h 1302712"/>
                  <a:gd name="connsiteX9" fmla="*/ 313881 w 1023258"/>
                  <a:gd name="connsiteY9" fmla="*/ 1302266 h 1302712"/>
                  <a:gd name="connsiteX10" fmla="*/ 0 w 1023258"/>
                  <a:gd name="connsiteY10" fmla="*/ 711926 h 1302712"/>
                  <a:gd name="connsiteX11" fmla="*/ 711926 w 1023258"/>
                  <a:gd name="connsiteY11" fmla="*/ 0 h 13027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Lst>
                <a:rect l="l" t="t" r="r" b="b"/>
                <a:pathLst>
                  <a:path w="1023258" h="1302712">
                    <a:moveTo>
                      <a:pt x="711926" y="0"/>
                    </a:moveTo>
                    <a:cubicBezTo>
                      <a:pt x="810223" y="0"/>
                      <a:pt x="903866" y="19921"/>
                      <a:pt x="989040" y="55947"/>
                    </a:cubicBezTo>
                    <a:lnTo>
                      <a:pt x="1023258" y="74520"/>
                    </a:lnTo>
                    <a:lnTo>
                      <a:pt x="936545" y="121586"/>
                    </a:lnTo>
                    <a:cubicBezTo>
                      <a:pt x="785047" y="223936"/>
                      <a:pt x="675062" y="383069"/>
                      <a:pt x="637128" y="568448"/>
                    </a:cubicBezTo>
                    <a:lnTo>
                      <a:pt x="626035" y="678489"/>
                    </a:lnTo>
                    <a:lnTo>
                      <a:pt x="625213" y="678935"/>
                    </a:lnTo>
                    <a:cubicBezTo>
                      <a:pt x="435840" y="806873"/>
                      <a:pt x="311332" y="1023534"/>
                      <a:pt x="311332" y="1269275"/>
                    </a:cubicBezTo>
                    <a:lnTo>
                      <a:pt x="314703" y="1302712"/>
                    </a:lnTo>
                    <a:lnTo>
                      <a:pt x="313881" y="1302266"/>
                    </a:lnTo>
                    <a:cubicBezTo>
                      <a:pt x="124508" y="1174328"/>
                      <a:pt x="0" y="957667"/>
                      <a:pt x="0" y="711926"/>
                    </a:cubicBezTo>
                    <a:cubicBezTo>
                      <a:pt x="0" y="318740"/>
                      <a:pt x="318740" y="0"/>
                      <a:pt x="711926" y="0"/>
                    </a:cubicBezTo>
                    <a:close/>
                  </a:path>
                </a:pathLst>
              </a:custGeom>
              <a:solidFill>
                <a:srgbClr val="87CCD9">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200" dirty="0" smtClean="0">
                    <a:solidFill>
                      <a:schemeClr val="tx1"/>
                    </a:solidFill>
                    <a:latin typeface="Cambria" panose="02040503050406030204" pitchFamily="18" charset="0"/>
                    <a:ea typeface="Cambria" panose="02040503050406030204" pitchFamily="18" charset="0"/>
                  </a:rPr>
                  <a:t>71</a:t>
                </a:r>
              </a:p>
            </p:txBody>
          </p:sp>
          <p:sp>
            <p:nvSpPr>
              <p:cNvPr id="66" name="Freeform 65"/>
              <p:cNvSpPr/>
              <p:nvPr/>
            </p:nvSpPr>
            <p:spPr>
              <a:xfrm>
                <a:off x="1666709" y="7795382"/>
                <a:ext cx="1023258" cy="1302712"/>
              </a:xfrm>
              <a:custGeom>
                <a:avLst/>
                <a:gdLst>
                  <a:gd name="connsiteX0" fmla="*/ 311332 w 1023258"/>
                  <a:gd name="connsiteY0" fmla="*/ 0 h 1302712"/>
                  <a:gd name="connsiteX1" fmla="*/ 1023258 w 1023258"/>
                  <a:gd name="connsiteY1" fmla="*/ 711926 h 1302712"/>
                  <a:gd name="connsiteX2" fmla="*/ 709377 w 1023258"/>
                  <a:gd name="connsiteY2" fmla="*/ 1302266 h 1302712"/>
                  <a:gd name="connsiteX3" fmla="*/ 708555 w 1023258"/>
                  <a:gd name="connsiteY3" fmla="*/ 1302712 h 1302712"/>
                  <a:gd name="connsiteX4" fmla="*/ 711926 w 1023258"/>
                  <a:gd name="connsiteY4" fmla="*/ 1269275 h 1302712"/>
                  <a:gd name="connsiteX5" fmla="*/ 398045 w 1023258"/>
                  <a:gd name="connsiteY5" fmla="*/ 678935 h 1302712"/>
                  <a:gd name="connsiteX6" fmla="*/ 397223 w 1023258"/>
                  <a:gd name="connsiteY6" fmla="*/ 678489 h 1302712"/>
                  <a:gd name="connsiteX7" fmla="*/ 386130 w 1023258"/>
                  <a:gd name="connsiteY7" fmla="*/ 568448 h 1302712"/>
                  <a:gd name="connsiteX8" fmla="*/ 86713 w 1023258"/>
                  <a:gd name="connsiteY8" fmla="*/ 121586 h 1302712"/>
                  <a:gd name="connsiteX9" fmla="*/ 0 w 1023258"/>
                  <a:gd name="connsiteY9" fmla="*/ 74520 h 1302712"/>
                  <a:gd name="connsiteX10" fmla="*/ 34218 w 1023258"/>
                  <a:gd name="connsiteY10" fmla="*/ 55947 h 1302712"/>
                  <a:gd name="connsiteX11" fmla="*/ 311332 w 1023258"/>
                  <a:gd name="connsiteY11" fmla="*/ 0 h 130271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Lst>
                <a:rect l="l" t="t" r="r" b="b"/>
                <a:pathLst>
                  <a:path w="1023258" h="1302712">
                    <a:moveTo>
                      <a:pt x="311332" y="0"/>
                    </a:moveTo>
                    <a:cubicBezTo>
                      <a:pt x="704518" y="0"/>
                      <a:pt x="1023258" y="318740"/>
                      <a:pt x="1023258" y="711926"/>
                    </a:cubicBezTo>
                    <a:cubicBezTo>
                      <a:pt x="1023258" y="957667"/>
                      <a:pt x="898750" y="1174328"/>
                      <a:pt x="709377" y="1302266"/>
                    </a:cubicBezTo>
                    <a:lnTo>
                      <a:pt x="708555" y="1302712"/>
                    </a:lnTo>
                    <a:lnTo>
                      <a:pt x="711926" y="1269275"/>
                    </a:lnTo>
                    <a:cubicBezTo>
                      <a:pt x="711926" y="1023534"/>
                      <a:pt x="587418" y="806873"/>
                      <a:pt x="398045" y="678935"/>
                    </a:cubicBezTo>
                    <a:lnTo>
                      <a:pt x="397223" y="678489"/>
                    </a:lnTo>
                    <a:lnTo>
                      <a:pt x="386130" y="568448"/>
                    </a:lnTo>
                    <a:cubicBezTo>
                      <a:pt x="348196" y="383069"/>
                      <a:pt x="238212" y="223936"/>
                      <a:pt x="86713" y="121586"/>
                    </a:cubicBezTo>
                    <a:lnTo>
                      <a:pt x="0" y="74520"/>
                    </a:lnTo>
                    <a:lnTo>
                      <a:pt x="34218" y="55947"/>
                    </a:lnTo>
                    <a:cubicBezTo>
                      <a:pt x="119392" y="19921"/>
                      <a:pt x="213036" y="0"/>
                      <a:pt x="311332" y="0"/>
                    </a:cubicBezTo>
                    <a:close/>
                  </a:path>
                </a:pathLst>
              </a:custGeom>
              <a:solidFill>
                <a:srgbClr val="87CCD9">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r"/>
                <a:r>
                  <a:rPr lang="en-US" sz="1200" dirty="0" smtClean="0">
                    <a:solidFill>
                      <a:schemeClr val="tx1"/>
                    </a:solidFill>
                    <a:latin typeface="Cambria" panose="02040503050406030204" pitchFamily="18" charset="0"/>
                    <a:ea typeface="Cambria" panose="02040503050406030204" pitchFamily="18" charset="0"/>
                  </a:rPr>
                  <a:t>87</a:t>
                </a:r>
              </a:p>
            </p:txBody>
          </p:sp>
          <p:sp>
            <p:nvSpPr>
              <p:cNvPr id="67" name="Freeform 66"/>
              <p:cNvSpPr/>
              <p:nvPr/>
            </p:nvSpPr>
            <p:spPr>
              <a:xfrm>
                <a:off x="1266115" y="8352731"/>
                <a:ext cx="801188" cy="791983"/>
              </a:xfrm>
              <a:custGeom>
                <a:avLst/>
                <a:gdLst>
                  <a:gd name="connsiteX0" fmla="*/ 400594 w 801188"/>
                  <a:gd name="connsiteY0" fmla="*/ 0 h 791983"/>
                  <a:gd name="connsiteX1" fmla="*/ 677708 w 801188"/>
                  <a:gd name="connsiteY1" fmla="*/ 55947 h 791983"/>
                  <a:gd name="connsiteX2" fmla="*/ 797817 w 801188"/>
                  <a:gd name="connsiteY2" fmla="*/ 121140 h 791983"/>
                  <a:gd name="connsiteX3" fmla="*/ 801188 w 801188"/>
                  <a:gd name="connsiteY3" fmla="*/ 154577 h 791983"/>
                  <a:gd name="connsiteX4" fmla="*/ 487307 w 801188"/>
                  <a:gd name="connsiteY4" fmla="*/ 744917 h 791983"/>
                  <a:gd name="connsiteX5" fmla="*/ 400594 w 801188"/>
                  <a:gd name="connsiteY5" fmla="*/ 791983 h 791983"/>
                  <a:gd name="connsiteX6" fmla="*/ 313881 w 801188"/>
                  <a:gd name="connsiteY6" fmla="*/ 744917 h 791983"/>
                  <a:gd name="connsiteX7" fmla="*/ 0 w 801188"/>
                  <a:gd name="connsiteY7" fmla="*/ 154577 h 791983"/>
                  <a:gd name="connsiteX8" fmla="*/ 3371 w 801188"/>
                  <a:gd name="connsiteY8" fmla="*/ 121140 h 791983"/>
                  <a:gd name="connsiteX9" fmla="*/ 123480 w 801188"/>
                  <a:gd name="connsiteY9" fmla="*/ 55947 h 791983"/>
                  <a:gd name="connsiteX10" fmla="*/ 400594 w 801188"/>
                  <a:gd name="connsiteY10" fmla="*/ 0 h 79198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801188" h="791983">
                    <a:moveTo>
                      <a:pt x="400594" y="0"/>
                    </a:moveTo>
                    <a:cubicBezTo>
                      <a:pt x="498891" y="0"/>
                      <a:pt x="592534" y="19921"/>
                      <a:pt x="677708" y="55947"/>
                    </a:cubicBezTo>
                    <a:lnTo>
                      <a:pt x="797817" y="121140"/>
                    </a:lnTo>
                    <a:lnTo>
                      <a:pt x="801188" y="154577"/>
                    </a:lnTo>
                    <a:cubicBezTo>
                      <a:pt x="801188" y="400318"/>
                      <a:pt x="676680" y="616979"/>
                      <a:pt x="487307" y="744917"/>
                    </a:cubicBezTo>
                    <a:lnTo>
                      <a:pt x="400594" y="791983"/>
                    </a:lnTo>
                    <a:lnTo>
                      <a:pt x="313881" y="744917"/>
                    </a:lnTo>
                    <a:cubicBezTo>
                      <a:pt x="124508" y="616979"/>
                      <a:pt x="0" y="400318"/>
                      <a:pt x="0" y="154577"/>
                    </a:cubicBezTo>
                    <a:lnTo>
                      <a:pt x="3371" y="121140"/>
                    </a:lnTo>
                    <a:lnTo>
                      <a:pt x="123480" y="55947"/>
                    </a:lnTo>
                    <a:cubicBezTo>
                      <a:pt x="208654" y="19921"/>
                      <a:pt x="302298" y="0"/>
                      <a:pt x="400594" y="0"/>
                    </a:cubicBezTo>
                    <a:close/>
                  </a:path>
                </a:pathLst>
              </a:custGeom>
              <a:solidFill>
                <a:srgbClr val="87CCD9">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smtClean="0">
                    <a:solidFill>
                      <a:schemeClr val="tx1"/>
                    </a:solidFill>
                    <a:latin typeface="Cambria" panose="02040503050406030204" pitchFamily="18" charset="0"/>
                    <a:ea typeface="Cambria" panose="02040503050406030204" pitchFamily="18" charset="0"/>
                  </a:rPr>
                  <a:t>2,272</a:t>
                </a:r>
                <a:endParaRPr lang="en-GB" sz="1200" dirty="0">
                  <a:solidFill>
                    <a:schemeClr val="tx1"/>
                  </a:solidFill>
                  <a:latin typeface="Cambria" panose="02040503050406030204" pitchFamily="18" charset="0"/>
                  <a:ea typeface="Cambria" panose="02040503050406030204" pitchFamily="18" charset="0"/>
                </a:endParaRPr>
              </a:p>
            </p:txBody>
          </p:sp>
          <p:sp>
            <p:nvSpPr>
              <p:cNvPr id="68" name="Freeform 67"/>
              <p:cNvSpPr/>
              <p:nvPr/>
            </p:nvSpPr>
            <p:spPr>
              <a:xfrm>
                <a:off x="958154" y="9098094"/>
                <a:ext cx="1417110" cy="678489"/>
              </a:xfrm>
              <a:custGeom>
                <a:avLst/>
                <a:gdLst>
                  <a:gd name="connsiteX0" fmla="*/ 0 w 1417110"/>
                  <a:gd name="connsiteY0" fmla="*/ 0 h 678489"/>
                  <a:gd name="connsiteX1" fmla="*/ 120109 w 1417110"/>
                  <a:gd name="connsiteY1" fmla="*/ 65193 h 678489"/>
                  <a:gd name="connsiteX2" fmla="*/ 397223 w 1417110"/>
                  <a:gd name="connsiteY2" fmla="*/ 121140 h 678489"/>
                  <a:gd name="connsiteX3" fmla="*/ 674337 w 1417110"/>
                  <a:gd name="connsiteY3" fmla="*/ 65193 h 678489"/>
                  <a:gd name="connsiteX4" fmla="*/ 708555 w 1417110"/>
                  <a:gd name="connsiteY4" fmla="*/ 46620 h 678489"/>
                  <a:gd name="connsiteX5" fmla="*/ 742773 w 1417110"/>
                  <a:gd name="connsiteY5" fmla="*/ 65193 h 678489"/>
                  <a:gd name="connsiteX6" fmla="*/ 1019887 w 1417110"/>
                  <a:gd name="connsiteY6" fmla="*/ 121140 h 678489"/>
                  <a:gd name="connsiteX7" fmla="*/ 1297001 w 1417110"/>
                  <a:gd name="connsiteY7" fmla="*/ 65193 h 678489"/>
                  <a:gd name="connsiteX8" fmla="*/ 1417110 w 1417110"/>
                  <a:gd name="connsiteY8" fmla="*/ 0 h 678489"/>
                  <a:gd name="connsiteX9" fmla="*/ 1406017 w 1417110"/>
                  <a:gd name="connsiteY9" fmla="*/ 110041 h 678489"/>
                  <a:gd name="connsiteX10" fmla="*/ 708555 w 1417110"/>
                  <a:gd name="connsiteY10" fmla="*/ 678489 h 678489"/>
                  <a:gd name="connsiteX11" fmla="*/ 11093 w 1417110"/>
                  <a:gd name="connsiteY11" fmla="*/ 110041 h 678489"/>
                  <a:gd name="connsiteX12" fmla="*/ 0 w 1417110"/>
                  <a:gd name="connsiteY12" fmla="*/ 0 h 67848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Lst>
                <a:rect l="l" t="t" r="r" b="b"/>
                <a:pathLst>
                  <a:path w="1417110" h="678489">
                    <a:moveTo>
                      <a:pt x="0" y="0"/>
                    </a:moveTo>
                    <a:lnTo>
                      <a:pt x="120109" y="65193"/>
                    </a:lnTo>
                    <a:cubicBezTo>
                      <a:pt x="205283" y="101219"/>
                      <a:pt x="298927" y="121140"/>
                      <a:pt x="397223" y="121140"/>
                    </a:cubicBezTo>
                    <a:cubicBezTo>
                      <a:pt x="495520" y="121140"/>
                      <a:pt x="589163" y="101219"/>
                      <a:pt x="674337" y="65193"/>
                    </a:cubicBezTo>
                    <a:lnTo>
                      <a:pt x="708555" y="46620"/>
                    </a:lnTo>
                    <a:lnTo>
                      <a:pt x="742773" y="65193"/>
                    </a:lnTo>
                    <a:cubicBezTo>
                      <a:pt x="827947" y="101219"/>
                      <a:pt x="921591" y="121140"/>
                      <a:pt x="1019887" y="121140"/>
                    </a:cubicBezTo>
                    <a:cubicBezTo>
                      <a:pt x="1118184" y="121140"/>
                      <a:pt x="1211827" y="101219"/>
                      <a:pt x="1297001" y="65193"/>
                    </a:cubicBezTo>
                    <a:lnTo>
                      <a:pt x="1417110" y="0"/>
                    </a:lnTo>
                    <a:lnTo>
                      <a:pt x="1406017" y="110041"/>
                    </a:lnTo>
                    <a:cubicBezTo>
                      <a:pt x="1339633" y="434454"/>
                      <a:pt x="1052593" y="678489"/>
                      <a:pt x="708555" y="678489"/>
                    </a:cubicBezTo>
                    <a:cubicBezTo>
                      <a:pt x="364517" y="678489"/>
                      <a:pt x="77477" y="434454"/>
                      <a:pt x="11093" y="110041"/>
                    </a:cubicBezTo>
                    <a:lnTo>
                      <a:pt x="0" y="0"/>
                    </a:lnTo>
                    <a:close/>
                  </a:path>
                </a:pathLst>
              </a:custGeom>
              <a:solidFill>
                <a:srgbClr val="87CCD9">
                  <a:alpha val="50196"/>
                </a:srgbClr>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smtClean="0">
                    <a:solidFill>
                      <a:schemeClr val="tx1"/>
                    </a:solidFill>
                    <a:latin typeface="Cambria" panose="02040503050406030204" pitchFamily="18" charset="0"/>
                    <a:ea typeface="Cambria" panose="02040503050406030204" pitchFamily="18" charset="0"/>
                  </a:rPr>
                  <a:t>94</a:t>
                </a:r>
                <a:endParaRPr lang="en-GB" sz="1200" dirty="0">
                  <a:solidFill>
                    <a:schemeClr val="tx1"/>
                  </a:solidFill>
                  <a:latin typeface="Cambria" panose="02040503050406030204" pitchFamily="18" charset="0"/>
                  <a:ea typeface="Cambria" panose="02040503050406030204" pitchFamily="18" charset="0"/>
                </a:endParaRPr>
              </a:p>
            </p:txBody>
          </p:sp>
        </p:grpSp>
        <p:sp>
          <p:nvSpPr>
            <p:cNvPr id="76" name="TextBox 75"/>
            <p:cNvSpPr txBox="1"/>
            <p:nvPr/>
          </p:nvSpPr>
          <p:spPr>
            <a:xfrm>
              <a:off x="525723" y="656481"/>
              <a:ext cx="1570045" cy="461665"/>
            </a:xfrm>
            <a:prstGeom prst="rect">
              <a:avLst/>
            </a:prstGeom>
            <a:noFill/>
          </p:spPr>
          <p:txBody>
            <a:bodyPr wrap="none" rtlCol="0">
              <a:spAutoFit/>
            </a:bodyPr>
            <a:lstStyle/>
            <a:p>
              <a:pPr algn="ctr"/>
              <a:r>
                <a:rPr lang="en-US" sz="1200" dirty="0" smtClean="0">
                  <a:latin typeface="Cambria" panose="02040503050406030204" pitchFamily="18" charset="0"/>
                  <a:ea typeface="Cambria" panose="02040503050406030204" pitchFamily="18" charset="0"/>
                </a:rPr>
                <a:t>FAEVER 96well 0.0%</a:t>
              </a:r>
            </a:p>
            <a:p>
              <a:pPr algn="ctr"/>
              <a:r>
                <a:rPr lang="en-US" sz="1200" dirty="0" smtClean="0">
                  <a:latin typeface="Cambria" panose="02040503050406030204" pitchFamily="18" charset="0"/>
                  <a:ea typeface="Cambria" panose="02040503050406030204" pitchFamily="18" charset="0"/>
                </a:rPr>
                <a:t>N = 3,163</a:t>
              </a:r>
              <a:endParaRPr lang="en-GB" sz="1200" dirty="0">
                <a:latin typeface="Cambria" panose="02040503050406030204" pitchFamily="18" charset="0"/>
                <a:ea typeface="Cambria" panose="02040503050406030204" pitchFamily="18" charset="0"/>
              </a:endParaRPr>
            </a:p>
          </p:txBody>
        </p:sp>
        <p:sp>
          <p:nvSpPr>
            <p:cNvPr id="77" name="TextBox 76"/>
            <p:cNvSpPr txBox="1"/>
            <p:nvPr/>
          </p:nvSpPr>
          <p:spPr>
            <a:xfrm>
              <a:off x="2653232" y="653824"/>
              <a:ext cx="1570045" cy="461665"/>
            </a:xfrm>
            <a:prstGeom prst="rect">
              <a:avLst/>
            </a:prstGeom>
            <a:noFill/>
          </p:spPr>
          <p:txBody>
            <a:bodyPr wrap="none" rtlCol="0">
              <a:spAutoFit/>
            </a:bodyPr>
            <a:lstStyle/>
            <a:p>
              <a:pPr algn="ctr"/>
              <a:r>
                <a:rPr lang="en-US" sz="1200" dirty="0" smtClean="0">
                  <a:latin typeface="Cambria" panose="02040503050406030204" pitchFamily="18" charset="0"/>
                  <a:ea typeface="Cambria" panose="02040503050406030204" pitchFamily="18" charset="0"/>
                </a:rPr>
                <a:t>FAEVER 96well 0.1%</a:t>
              </a:r>
            </a:p>
            <a:p>
              <a:pPr algn="ctr"/>
              <a:r>
                <a:rPr lang="en-US" sz="1200" dirty="0" smtClean="0">
                  <a:latin typeface="Cambria" panose="02040503050406030204" pitchFamily="18" charset="0"/>
                  <a:ea typeface="Cambria" panose="02040503050406030204" pitchFamily="18" charset="0"/>
                </a:rPr>
                <a:t>N = 2,972</a:t>
              </a:r>
              <a:endParaRPr lang="en-GB" sz="1200" dirty="0">
                <a:latin typeface="Cambria" panose="02040503050406030204" pitchFamily="18" charset="0"/>
                <a:ea typeface="Cambria" panose="02040503050406030204" pitchFamily="18" charset="0"/>
              </a:endParaRPr>
            </a:p>
          </p:txBody>
        </p:sp>
        <p:sp>
          <p:nvSpPr>
            <p:cNvPr id="78" name="TextBox 77"/>
            <p:cNvSpPr txBox="1"/>
            <p:nvPr/>
          </p:nvSpPr>
          <p:spPr>
            <a:xfrm>
              <a:off x="4780741" y="656245"/>
              <a:ext cx="1570045" cy="461665"/>
            </a:xfrm>
            <a:prstGeom prst="rect">
              <a:avLst/>
            </a:prstGeom>
            <a:noFill/>
          </p:spPr>
          <p:txBody>
            <a:bodyPr wrap="none" rtlCol="0">
              <a:spAutoFit/>
            </a:bodyPr>
            <a:lstStyle/>
            <a:p>
              <a:pPr algn="ctr"/>
              <a:r>
                <a:rPr lang="en-US" sz="1200" dirty="0" smtClean="0">
                  <a:latin typeface="Cambria" panose="02040503050406030204" pitchFamily="18" charset="0"/>
                  <a:ea typeface="Cambria" panose="02040503050406030204" pitchFamily="18" charset="0"/>
                </a:rPr>
                <a:t>FAEVER 96well 0.5%</a:t>
              </a:r>
            </a:p>
            <a:p>
              <a:pPr algn="ctr"/>
              <a:r>
                <a:rPr lang="en-US" sz="1200" dirty="0" smtClean="0">
                  <a:latin typeface="Cambria" panose="02040503050406030204" pitchFamily="18" charset="0"/>
                  <a:ea typeface="Cambria" panose="02040503050406030204" pitchFamily="18" charset="0"/>
                </a:rPr>
                <a:t>N = 2,848</a:t>
              </a:r>
              <a:endParaRPr lang="en-GB" sz="1200" dirty="0">
                <a:latin typeface="Cambria" panose="02040503050406030204" pitchFamily="18" charset="0"/>
                <a:ea typeface="Cambria" panose="02040503050406030204" pitchFamily="18" charset="0"/>
              </a:endParaRPr>
            </a:p>
          </p:txBody>
        </p:sp>
        <p:sp>
          <p:nvSpPr>
            <p:cNvPr id="79" name="TextBox 78"/>
            <p:cNvSpPr txBox="1"/>
            <p:nvPr/>
          </p:nvSpPr>
          <p:spPr>
            <a:xfrm>
              <a:off x="525723" y="3338771"/>
              <a:ext cx="1570045" cy="461665"/>
            </a:xfrm>
            <a:prstGeom prst="rect">
              <a:avLst/>
            </a:prstGeom>
            <a:noFill/>
          </p:spPr>
          <p:txBody>
            <a:bodyPr wrap="none" rtlCol="0">
              <a:spAutoFit/>
            </a:bodyPr>
            <a:lstStyle/>
            <a:p>
              <a:pPr algn="ctr"/>
              <a:r>
                <a:rPr lang="en-US" sz="1200" dirty="0" smtClean="0">
                  <a:latin typeface="Cambria" panose="02040503050406030204" pitchFamily="18" charset="0"/>
                  <a:ea typeface="Cambria" panose="02040503050406030204" pitchFamily="18" charset="0"/>
                </a:rPr>
                <a:t>FAEVER 96well 1.0%</a:t>
              </a:r>
            </a:p>
            <a:p>
              <a:pPr algn="ctr"/>
              <a:r>
                <a:rPr lang="en-US" sz="1200" dirty="0" smtClean="0">
                  <a:latin typeface="Cambria" panose="02040503050406030204" pitchFamily="18" charset="0"/>
                  <a:ea typeface="Cambria" panose="02040503050406030204" pitchFamily="18" charset="0"/>
                </a:rPr>
                <a:t>N = 2,764</a:t>
              </a:r>
              <a:endParaRPr lang="en-GB" sz="1200" dirty="0">
                <a:latin typeface="Cambria" panose="02040503050406030204" pitchFamily="18" charset="0"/>
                <a:ea typeface="Cambria" panose="02040503050406030204" pitchFamily="18" charset="0"/>
              </a:endParaRPr>
            </a:p>
          </p:txBody>
        </p:sp>
        <p:sp>
          <p:nvSpPr>
            <p:cNvPr id="80" name="TextBox 79"/>
            <p:cNvSpPr txBox="1"/>
            <p:nvPr/>
          </p:nvSpPr>
          <p:spPr>
            <a:xfrm>
              <a:off x="2653232" y="3338770"/>
              <a:ext cx="1570045" cy="461665"/>
            </a:xfrm>
            <a:prstGeom prst="rect">
              <a:avLst/>
            </a:prstGeom>
            <a:noFill/>
          </p:spPr>
          <p:txBody>
            <a:bodyPr wrap="none" rtlCol="0">
              <a:spAutoFit/>
            </a:bodyPr>
            <a:lstStyle/>
            <a:p>
              <a:pPr algn="ctr"/>
              <a:r>
                <a:rPr lang="en-US" sz="1200" dirty="0" smtClean="0">
                  <a:latin typeface="Cambria" panose="02040503050406030204" pitchFamily="18" charset="0"/>
                  <a:ea typeface="Cambria" panose="02040503050406030204" pitchFamily="18" charset="0"/>
                </a:rPr>
                <a:t>FAEVER 96well 2.5%</a:t>
              </a:r>
            </a:p>
            <a:p>
              <a:pPr algn="ctr"/>
              <a:r>
                <a:rPr lang="en-US" sz="1200" dirty="0" smtClean="0">
                  <a:latin typeface="Cambria" panose="02040503050406030204" pitchFamily="18" charset="0"/>
                  <a:ea typeface="Cambria" panose="02040503050406030204" pitchFamily="18" charset="0"/>
                </a:rPr>
                <a:t>N = 2,819</a:t>
              </a:r>
              <a:endParaRPr lang="en-GB" sz="1200" dirty="0">
                <a:latin typeface="Cambria" panose="02040503050406030204" pitchFamily="18" charset="0"/>
                <a:ea typeface="Cambria" panose="02040503050406030204" pitchFamily="18" charset="0"/>
              </a:endParaRPr>
            </a:p>
          </p:txBody>
        </p:sp>
        <p:sp>
          <p:nvSpPr>
            <p:cNvPr id="81" name="TextBox 80"/>
            <p:cNvSpPr txBox="1"/>
            <p:nvPr/>
          </p:nvSpPr>
          <p:spPr>
            <a:xfrm>
              <a:off x="4780740" y="3332419"/>
              <a:ext cx="1570045" cy="461665"/>
            </a:xfrm>
            <a:prstGeom prst="rect">
              <a:avLst/>
            </a:prstGeom>
            <a:noFill/>
          </p:spPr>
          <p:txBody>
            <a:bodyPr wrap="none" rtlCol="0">
              <a:spAutoFit/>
            </a:bodyPr>
            <a:lstStyle/>
            <a:p>
              <a:pPr algn="ctr"/>
              <a:r>
                <a:rPr lang="en-US" sz="1200" dirty="0" smtClean="0">
                  <a:latin typeface="Cambria" panose="02040503050406030204" pitchFamily="18" charset="0"/>
                  <a:ea typeface="Cambria" panose="02040503050406030204" pitchFamily="18" charset="0"/>
                </a:rPr>
                <a:t>FAEVER 96well 5.0%</a:t>
              </a:r>
            </a:p>
            <a:p>
              <a:pPr algn="ctr"/>
              <a:r>
                <a:rPr lang="en-US" sz="1200" dirty="0" smtClean="0">
                  <a:latin typeface="Cambria" panose="02040503050406030204" pitchFamily="18" charset="0"/>
                  <a:ea typeface="Cambria" panose="02040503050406030204" pitchFamily="18" charset="0"/>
                </a:rPr>
                <a:t>N = 2,842</a:t>
              </a:r>
              <a:endParaRPr lang="en-GB" sz="1200" dirty="0">
                <a:latin typeface="Cambria" panose="02040503050406030204" pitchFamily="18" charset="0"/>
                <a:ea typeface="Cambria" panose="02040503050406030204" pitchFamily="18" charset="0"/>
              </a:endParaRPr>
            </a:p>
          </p:txBody>
        </p:sp>
        <p:sp>
          <p:nvSpPr>
            <p:cNvPr id="82" name="TextBox 81"/>
            <p:cNvSpPr txBox="1"/>
            <p:nvPr/>
          </p:nvSpPr>
          <p:spPr>
            <a:xfrm>
              <a:off x="598820" y="5928056"/>
              <a:ext cx="1445524" cy="461665"/>
            </a:xfrm>
            <a:prstGeom prst="rect">
              <a:avLst/>
            </a:prstGeom>
            <a:noFill/>
          </p:spPr>
          <p:txBody>
            <a:bodyPr wrap="none" rtlCol="0">
              <a:spAutoFit/>
            </a:bodyPr>
            <a:lstStyle/>
            <a:p>
              <a:pPr algn="ctr"/>
              <a:r>
                <a:rPr lang="en-US" sz="1200" dirty="0" smtClean="0">
                  <a:latin typeface="Cambria" panose="02040503050406030204" pitchFamily="18" charset="0"/>
                  <a:ea typeface="Cambria" panose="02040503050406030204" pitchFamily="18" charset="0"/>
                </a:rPr>
                <a:t>Ultracentrifugation</a:t>
              </a:r>
            </a:p>
            <a:p>
              <a:pPr algn="ctr"/>
              <a:r>
                <a:rPr lang="en-US" sz="1200" dirty="0" smtClean="0">
                  <a:latin typeface="Cambria" panose="02040503050406030204" pitchFamily="18" charset="0"/>
                  <a:ea typeface="Cambria" panose="02040503050406030204" pitchFamily="18" charset="0"/>
                </a:rPr>
                <a:t>N = 3,144</a:t>
              </a:r>
              <a:endParaRPr lang="en-GB" sz="1200" dirty="0">
                <a:latin typeface="Cambria" panose="02040503050406030204" pitchFamily="18" charset="0"/>
                <a:ea typeface="Cambria" panose="02040503050406030204" pitchFamily="18" charset="0"/>
              </a:endParaRPr>
            </a:p>
          </p:txBody>
        </p:sp>
      </p:grpSp>
      <p:graphicFrame>
        <p:nvGraphicFramePr>
          <p:cNvPr id="3" name="Table 2"/>
          <p:cNvGraphicFramePr>
            <a:graphicFrameLocks noGrp="1"/>
          </p:cNvGraphicFramePr>
          <p:nvPr>
            <p:extLst>
              <p:ext uri="{D42A27DB-BD31-4B8C-83A1-F6EECF244321}">
                <p14:modId xmlns:p14="http://schemas.microsoft.com/office/powerpoint/2010/main" val="3386445342"/>
              </p:ext>
            </p:extLst>
          </p:nvPr>
        </p:nvGraphicFramePr>
        <p:xfrm>
          <a:off x="3127105" y="7677393"/>
          <a:ext cx="3048000" cy="1487621"/>
        </p:xfrm>
        <a:graphic>
          <a:graphicData uri="http://schemas.openxmlformats.org/drawingml/2006/table">
            <a:tbl>
              <a:tblPr/>
              <a:tblGrid>
                <a:gridCol w="736600">
                  <a:extLst>
                    <a:ext uri="{9D8B030D-6E8A-4147-A177-3AD203B41FA5}">
                      <a16:colId xmlns:a16="http://schemas.microsoft.com/office/drawing/2014/main" val="1634407779"/>
                    </a:ext>
                  </a:extLst>
                </a:gridCol>
                <a:gridCol w="520700">
                  <a:extLst>
                    <a:ext uri="{9D8B030D-6E8A-4147-A177-3AD203B41FA5}">
                      <a16:colId xmlns:a16="http://schemas.microsoft.com/office/drawing/2014/main" val="3128605356"/>
                    </a:ext>
                  </a:extLst>
                </a:gridCol>
                <a:gridCol w="635000">
                  <a:extLst>
                    <a:ext uri="{9D8B030D-6E8A-4147-A177-3AD203B41FA5}">
                      <a16:colId xmlns:a16="http://schemas.microsoft.com/office/drawing/2014/main" val="262553550"/>
                    </a:ext>
                  </a:extLst>
                </a:gridCol>
                <a:gridCol w="635000">
                  <a:extLst>
                    <a:ext uri="{9D8B030D-6E8A-4147-A177-3AD203B41FA5}">
                      <a16:colId xmlns:a16="http://schemas.microsoft.com/office/drawing/2014/main" val="2883335237"/>
                    </a:ext>
                  </a:extLst>
                </a:gridCol>
                <a:gridCol w="520700">
                  <a:extLst>
                    <a:ext uri="{9D8B030D-6E8A-4147-A177-3AD203B41FA5}">
                      <a16:colId xmlns:a16="http://schemas.microsoft.com/office/drawing/2014/main" val="2616546559"/>
                    </a:ext>
                  </a:extLst>
                </a:gridCol>
              </a:tblGrid>
              <a:tr h="182880">
                <a:tc>
                  <a:txBody>
                    <a:bodyPr/>
                    <a:lstStyle/>
                    <a:p>
                      <a:pPr algn="l" fontAlgn="b"/>
                      <a:r>
                        <a:rPr lang="en-GB" sz="1100" b="1" i="0" u="none" strike="noStrike">
                          <a:solidFill>
                            <a:srgbClr val="000000"/>
                          </a:solidFill>
                          <a:effectLst/>
                          <a:latin typeface="Calibri" panose="020F0502020204030204" pitchFamily="34" charset="0"/>
                        </a:rPr>
                        <a:t>Enrichment</a:t>
                      </a:r>
                    </a:p>
                  </a:txBody>
                  <a:tcPr marL="7620" marR="7620" marT="7620" marB="0" anchor="b">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GB" sz="1100" b="1" i="0" u="none" strike="noStrike">
                          <a:solidFill>
                            <a:srgbClr val="000000"/>
                          </a:solidFill>
                          <a:effectLst/>
                          <a:latin typeface="Calibri" panose="020F0502020204030204" pitchFamily="34" charset="0"/>
                        </a:rPr>
                        <a:t>% TW20</a:t>
                      </a:r>
                    </a:p>
                  </a:txBody>
                  <a:tcPr marL="7620" marR="7620" marT="7620" marB="0" anchor="b">
                    <a:lnL>
                      <a:noFill/>
                    </a:lnL>
                    <a:lnR>
                      <a:noFill/>
                    </a:lnR>
                    <a:lnT w="12700" cap="flat" cmpd="sng" algn="ctr">
                      <a:solidFill>
                        <a:schemeClr val="tx1"/>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1" i="0" u="none" strike="noStrike">
                          <a:solidFill>
                            <a:srgbClr val="000000"/>
                          </a:solidFill>
                          <a:effectLst/>
                          <a:latin typeface="Calibri" panose="020F0502020204030204" pitchFamily="34" charset="0"/>
                        </a:rPr>
                        <a:t>3VV</a:t>
                      </a:r>
                    </a:p>
                  </a:txBody>
                  <a:tcPr marL="7620" marR="7620" marT="7620" marB="0" anchor="b">
                    <a:lnL>
                      <a:noFill/>
                    </a:lnL>
                    <a:lnR>
                      <a:noFill/>
                    </a:lnR>
                    <a:lnT w="12700" cap="flat" cmpd="sng" algn="ctr">
                      <a:solidFill>
                        <a:schemeClr val="tx1"/>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1" i="0" u="none" strike="noStrike">
                          <a:solidFill>
                            <a:srgbClr val="000000"/>
                          </a:solidFill>
                          <a:effectLst/>
                          <a:latin typeface="Calibri" panose="020F0502020204030204" pitchFamily="34" charset="0"/>
                        </a:rPr>
                        <a:t>Total IDs</a:t>
                      </a:r>
                    </a:p>
                  </a:txBody>
                  <a:tcPr marL="7620" marR="7620" marT="7620" marB="0" anchor="b">
                    <a:lnL>
                      <a:noFill/>
                    </a:lnL>
                    <a:lnR>
                      <a:noFill/>
                    </a:lnR>
                    <a:lnT w="12700" cap="flat" cmpd="sng" algn="ctr">
                      <a:solidFill>
                        <a:schemeClr val="tx1"/>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ctr" fontAlgn="b"/>
                      <a:r>
                        <a:rPr lang="en-GB" sz="1100" b="1" i="0" u="none" strike="noStrike">
                          <a:solidFill>
                            <a:srgbClr val="000000"/>
                          </a:solidFill>
                          <a:effectLst/>
                          <a:latin typeface="Calibri" panose="020F0502020204030204" pitchFamily="34" charset="0"/>
                        </a:rPr>
                        <a:t>Relative</a:t>
                      </a:r>
                    </a:p>
                  </a:txBody>
                  <a:tcPr marL="7620" marR="7620" marT="7620" marB="0" anchor="b">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67043828"/>
                  </a:ext>
                </a:extLst>
              </a:tr>
              <a:tr h="182880">
                <a:tc rowSpan="6">
                  <a:txBody>
                    <a:bodyPr/>
                    <a:lstStyle/>
                    <a:p>
                      <a:pPr algn="ctr" fontAlgn="ctr"/>
                      <a:r>
                        <a:rPr lang="en-GB" sz="1100" b="1" i="0" u="none" strike="noStrike" dirty="0">
                          <a:solidFill>
                            <a:srgbClr val="FFFFFF"/>
                          </a:solidFill>
                          <a:effectLst/>
                          <a:latin typeface="Calibri" panose="020F0502020204030204" pitchFamily="34" charset="0"/>
                        </a:rPr>
                        <a:t>FAEVER</a:t>
                      </a:r>
                    </a:p>
                  </a:txBody>
                  <a:tcPr marL="7620" marR="7620" marT="7620" marB="0" vert="vert27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66AAA7"/>
                    </a:solidFill>
                  </a:tcPr>
                </a:tc>
                <a:tc>
                  <a:txBody>
                    <a:bodyPr/>
                    <a:lstStyle/>
                    <a:p>
                      <a:pPr algn="r" fontAlgn="b"/>
                      <a:r>
                        <a:rPr lang="en-GB" sz="1100" b="1" i="0" u="none" strike="noStrike">
                          <a:solidFill>
                            <a:srgbClr val="FFFFFF"/>
                          </a:solidFill>
                          <a:effectLst/>
                          <a:latin typeface="Calibri" panose="020F0502020204030204" pitchFamily="34" charset="0"/>
                        </a:rPr>
                        <a:t>0.0%</a:t>
                      </a:r>
                    </a:p>
                  </a:txBody>
                  <a:tcPr marL="7620" marR="7620" marT="7620" marB="0" anchor="b">
                    <a:lnL w="12700" cap="flat" cmpd="sng" algn="ctr">
                      <a:solidFill>
                        <a:schemeClr val="tx1"/>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a:noFill/>
                    </a:lnB>
                    <a:solidFill>
                      <a:srgbClr val="66AAA7"/>
                    </a:solidFill>
                  </a:tcPr>
                </a:tc>
                <a:tc>
                  <a:txBody>
                    <a:bodyPr/>
                    <a:lstStyle/>
                    <a:p>
                      <a:pPr algn="ctr" fontAlgn="b"/>
                      <a:r>
                        <a:rPr lang="en-GB" sz="1100" b="0" i="0" u="none" strike="noStrike">
                          <a:solidFill>
                            <a:srgbClr val="000000"/>
                          </a:solidFill>
                          <a:effectLst/>
                          <a:latin typeface="Calibri" panose="020F0502020204030204" pitchFamily="34" charset="0"/>
                        </a:rPr>
                        <a:t>2697</a:t>
                      </a:r>
                    </a:p>
                  </a:txBody>
                  <a:tcPr marL="7620" marR="7620" marT="7620" marB="0" anchor="b">
                    <a:lnL>
                      <a:noFill/>
                    </a:lnL>
                    <a:lnR>
                      <a:noFill/>
                    </a:lnR>
                    <a:lnT w="6350" cap="flat" cmpd="sng" algn="ctr">
                      <a:solidFill>
                        <a:srgbClr val="000000"/>
                      </a:solidFill>
                      <a:prstDash val="solid"/>
                      <a:round/>
                      <a:headEnd type="none" w="med" len="med"/>
                      <a:tailEnd type="none" w="med" len="med"/>
                    </a:lnT>
                    <a:lnB>
                      <a:noFill/>
                    </a:lnB>
                    <a:solidFill>
                      <a:srgbClr val="66AAA7"/>
                    </a:solidFill>
                  </a:tcPr>
                </a:tc>
                <a:tc>
                  <a:txBody>
                    <a:bodyPr/>
                    <a:lstStyle/>
                    <a:p>
                      <a:pPr algn="ctr" fontAlgn="b"/>
                      <a:r>
                        <a:rPr lang="en-GB" sz="1100" b="0" i="0" u="none" strike="noStrike">
                          <a:solidFill>
                            <a:srgbClr val="000000"/>
                          </a:solidFill>
                          <a:effectLst/>
                          <a:latin typeface="Calibri" panose="020F0502020204030204" pitchFamily="34" charset="0"/>
                        </a:rPr>
                        <a:t>3163</a:t>
                      </a:r>
                    </a:p>
                  </a:txBody>
                  <a:tcPr marL="7620" marR="7620" marT="7620" marB="0" anchor="b">
                    <a:lnL>
                      <a:noFill/>
                    </a:lnL>
                    <a:lnR>
                      <a:noFill/>
                    </a:lnR>
                    <a:lnT w="6350" cap="flat" cmpd="sng" algn="ctr">
                      <a:solidFill>
                        <a:srgbClr val="000000"/>
                      </a:solidFill>
                      <a:prstDash val="solid"/>
                      <a:round/>
                      <a:headEnd type="none" w="med" len="med"/>
                      <a:tailEnd type="none" w="med" len="med"/>
                    </a:lnT>
                    <a:lnB>
                      <a:noFill/>
                    </a:lnB>
                    <a:solidFill>
                      <a:srgbClr val="66AAA7"/>
                    </a:solidFill>
                  </a:tcPr>
                </a:tc>
                <a:tc>
                  <a:txBody>
                    <a:bodyPr/>
                    <a:lstStyle/>
                    <a:p>
                      <a:pPr algn="ctr" fontAlgn="b"/>
                      <a:r>
                        <a:rPr lang="en-GB" sz="1100" b="0" i="0" u="none" strike="noStrike">
                          <a:solidFill>
                            <a:srgbClr val="000000"/>
                          </a:solidFill>
                          <a:effectLst/>
                          <a:latin typeface="Calibri" panose="020F0502020204030204" pitchFamily="34" charset="0"/>
                        </a:rPr>
                        <a:t>85.3%</a:t>
                      </a:r>
                    </a:p>
                  </a:txBody>
                  <a:tcPr marL="7620" marR="7620" marT="7620" marB="0" anchor="b">
                    <a:lnL>
                      <a:noFill/>
                    </a:lnL>
                    <a:lnR w="12700" cap="flat" cmpd="sng" algn="ctr">
                      <a:solidFill>
                        <a:schemeClr val="tx1"/>
                      </a:solidFill>
                      <a:prstDash val="solid"/>
                      <a:round/>
                      <a:headEnd type="none" w="med" len="med"/>
                      <a:tailEnd type="none" w="med" len="med"/>
                    </a:lnR>
                    <a:lnT w="6350" cap="flat" cmpd="sng" algn="ctr">
                      <a:solidFill>
                        <a:srgbClr val="000000"/>
                      </a:solidFill>
                      <a:prstDash val="solid"/>
                      <a:round/>
                      <a:headEnd type="none" w="med" len="med"/>
                      <a:tailEnd type="none" w="med" len="med"/>
                    </a:lnT>
                    <a:lnB>
                      <a:noFill/>
                    </a:lnB>
                    <a:solidFill>
                      <a:srgbClr val="66AAA7"/>
                    </a:solidFill>
                  </a:tcPr>
                </a:tc>
                <a:extLst>
                  <a:ext uri="{0D108BD9-81ED-4DB2-BD59-A6C34878D82A}">
                    <a16:rowId xmlns:a16="http://schemas.microsoft.com/office/drawing/2014/main" val="4032932985"/>
                  </a:ext>
                </a:extLst>
              </a:tr>
              <a:tr h="182880">
                <a:tc vMerge="1">
                  <a:txBody>
                    <a:bodyPr/>
                    <a:lstStyle/>
                    <a:p>
                      <a:endParaRPr lang="en-GB"/>
                    </a:p>
                  </a:txBody>
                  <a:tcPr/>
                </a:tc>
                <a:tc>
                  <a:txBody>
                    <a:bodyPr/>
                    <a:lstStyle/>
                    <a:p>
                      <a:pPr algn="r" fontAlgn="b"/>
                      <a:r>
                        <a:rPr lang="en-GB" sz="1100" b="1" i="0" u="none" strike="noStrike">
                          <a:solidFill>
                            <a:srgbClr val="000000"/>
                          </a:solidFill>
                          <a:effectLst/>
                          <a:latin typeface="Calibri" panose="020F0502020204030204" pitchFamily="34" charset="0"/>
                        </a:rPr>
                        <a:t>0.1%</a:t>
                      </a:r>
                    </a:p>
                  </a:txBody>
                  <a:tcPr marL="7620" marR="7620" marT="7620" marB="0" anchor="b">
                    <a:lnL w="12700" cap="flat" cmpd="sng" algn="ctr">
                      <a:solidFill>
                        <a:schemeClr val="tx1"/>
                      </a:solidFill>
                      <a:prstDash val="solid"/>
                      <a:round/>
                      <a:headEnd type="none" w="med" len="med"/>
                      <a:tailEnd type="none" w="med" len="med"/>
                    </a:lnL>
                    <a:lnR>
                      <a:noFill/>
                    </a:lnR>
                    <a:lnT>
                      <a:noFill/>
                    </a:lnT>
                    <a:lnB>
                      <a:noFill/>
                    </a:lnB>
                    <a:solidFill>
                      <a:srgbClr val="FFFFFF"/>
                    </a:solidFill>
                  </a:tcPr>
                </a:tc>
                <a:tc>
                  <a:txBody>
                    <a:bodyPr/>
                    <a:lstStyle/>
                    <a:p>
                      <a:pPr algn="ctr" fontAlgn="b"/>
                      <a:r>
                        <a:rPr lang="en-GB" sz="1100" b="0" i="0" u="none" strike="noStrike">
                          <a:solidFill>
                            <a:srgbClr val="000000"/>
                          </a:solidFill>
                          <a:effectLst/>
                          <a:latin typeface="Calibri" panose="020F0502020204030204" pitchFamily="34" charset="0"/>
                        </a:rPr>
                        <a:t>2346</a:t>
                      </a:r>
                    </a:p>
                  </a:txBody>
                  <a:tcPr marL="7620" marR="7620" marT="7620" marB="0" anchor="b">
                    <a:lnL>
                      <a:noFill/>
                    </a:lnL>
                    <a:lnR>
                      <a:noFill/>
                    </a:lnR>
                    <a:lnT>
                      <a:noFill/>
                    </a:lnT>
                    <a:lnB>
                      <a:noFill/>
                    </a:lnB>
                    <a:solidFill>
                      <a:srgbClr val="FFFFFF"/>
                    </a:solidFill>
                  </a:tcPr>
                </a:tc>
                <a:tc>
                  <a:txBody>
                    <a:bodyPr/>
                    <a:lstStyle/>
                    <a:p>
                      <a:pPr algn="ctr" fontAlgn="b"/>
                      <a:r>
                        <a:rPr lang="en-GB" sz="1100" b="0" i="0" u="none" strike="noStrike">
                          <a:solidFill>
                            <a:srgbClr val="000000"/>
                          </a:solidFill>
                          <a:effectLst/>
                          <a:latin typeface="Calibri" panose="020F0502020204030204" pitchFamily="34" charset="0"/>
                        </a:rPr>
                        <a:t>2972</a:t>
                      </a:r>
                    </a:p>
                  </a:txBody>
                  <a:tcPr marL="7620" marR="7620" marT="7620" marB="0" anchor="b">
                    <a:lnL>
                      <a:noFill/>
                    </a:lnL>
                    <a:lnR>
                      <a:noFill/>
                    </a:lnR>
                    <a:lnT>
                      <a:noFill/>
                    </a:lnT>
                    <a:lnB>
                      <a:noFill/>
                    </a:lnB>
                    <a:solidFill>
                      <a:srgbClr val="FFFFFF"/>
                    </a:solidFill>
                  </a:tcPr>
                </a:tc>
                <a:tc>
                  <a:txBody>
                    <a:bodyPr/>
                    <a:lstStyle/>
                    <a:p>
                      <a:pPr algn="ctr" fontAlgn="b"/>
                      <a:r>
                        <a:rPr lang="en-GB" sz="1100" b="0" i="0" u="none" strike="noStrike">
                          <a:solidFill>
                            <a:srgbClr val="000000"/>
                          </a:solidFill>
                          <a:effectLst/>
                          <a:latin typeface="Calibri" panose="020F0502020204030204" pitchFamily="34" charset="0"/>
                        </a:rPr>
                        <a:t>78.9%</a:t>
                      </a:r>
                    </a:p>
                  </a:txBody>
                  <a:tcPr marL="7620" marR="7620" marT="7620" marB="0" anchor="b">
                    <a:lnL>
                      <a:noFill/>
                    </a:lnL>
                    <a:lnR w="12700" cap="flat" cmpd="sng" algn="ctr">
                      <a:solidFill>
                        <a:schemeClr val="tx1"/>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2126707849"/>
                  </a:ext>
                </a:extLst>
              </a:tr>
              <a:tr h="182880">
                <a:tc vMerge="1">
                  <a:txBody>
                    <a:bodyPr/>
                    <a:lstStyle/>
                    <a:p>
                      <a:endParaRPr lang="en-GB"/>
                    </a:p>
                  </a:txBody>
                  <a:tcPr/>
                </a:tc>
                <a:tc>
                  <a:txBody>
                    <a:bodyPr/>
                    <a:lstStyle/>
                    <a:p>
                      <a:pPr algn="r" fontAlgn="b"/>
                      <a:r>
                        <a:rPr lang="en-GB" sz="1100" b="1" i="0" u="none" strike="noStrike">
                          <a:solidFill>
                            <a:srgbClr val="FFFFFF"/>
                          </a:solidFill>
                          <a:effectLst/>
                          <a:latin typeface="Calibri" panose="020F0502020204030204" pitchFamily="34" charset="0"/>
                        </a:rPr>
                        <a:t>0.5%</a:t>
                      </a:r>
                    </a:p>
                  </a:txBody>
                  <a:tcPr marL="7620" marR="7620" marT="7620" marB="0" anchor="b">
                    <a:lnL w="12700" cap="flat" cmpd="sng" algn="ctr">
                      <a:solidFill>
                        <a:schemeClr val="tx1"/>
                      </a:solidFill>
                      <a:prstDash val="solid"/>
                      <a:round/>
                      <a:headEnd type="none" w="med" len="med"/>
                      <a:tailEnd type="none" w="med" len="med"/>
                    </a:lnL>
                    <a:lnR>
                      <a:noFill/>
                    </a:lnR>
                    <a:lnT>
                      <a:noFill/>
                    </a:lnT>
                    <a:lnB>
                      <a:noFill/>
                    </a:lnB>
                    <a:solidFill>
                      <a:srgbClr val="66AAA7"/>
                    </a:solidFill>
                  </a:tcPr>
                </a:tc>
                <a:tc>
                  <a:txBody>
                    <a:bodyPr/>
                    <a:lstStyle/>
                    <a:p>
                      <a:pPr algn="ctr" fontAlgn="b"/>
                      <a:r>
                        <a:rPr lang="en-GB" sz="1100" b="0" i="0" u="none" strike="noStrike">
                          <a:solidFill>
                            <a:srgbClr val="000000"/>
                          </a:solidFill>
                          <a:effectLst/>
                          <a:latin typeface="Calibri" panose="020F0502020204030204" pitchFamily="34" charset="0"/>
                        </a:rPr>
                        <a:t>2102</a:t>
                      </a:r>
                    </a:p>
                  </a:txBody>
                  <a:tcPr marL="7620" marR="7620" marT="7620" marB="0" anchor="b">
                    <a:lnL>
                      <a:noFill/>
                    </a:lnL>
                    <a:lnR>
                      <a:noFill/>
                    </a:lnR>
                    <a:lnT>
                      <a:noFill/>
                    </a:lnT>
                    <a:lnB>
                      <a:noFill/>
                    </a:lnB>
                    <a:solidFill>
                      <a:srgbClr val="66AAA7"/>
                    </a:solidFill>
                  </a:tcPr>
                </a:tc>
                <a:tc>
                  <a:txBody>
                    <a:bodyPr/>
                    <a:lstStyle/>
                    <a:p>
                      <a:pPr algn="ctr" fontAlgn="b"/>
                      <a:r>
                        <a:rPr lang="en-GB" sz="1100" b="0" i="0" u="none" strike="noStrike">
                          <a:solidFill>
                            <a:srgbClr val="000000"/>
                          </a:solidFill>
                          <a:effectLst/>
                          <a:latin typeface="Calibri" panose="020F0502020204030204" pitchFamily="34" charset="0"/>
                        </a:rPr>
                        <a:t>2848</a:t>
                      </a:r>
                    </a:p>
                  </a:txBody>
                  <a:tcPr marL="7620" marR="7620" marT="7620" marB="0" anchor="b">
                    <a:lnL>
                      <a:noFill/>
                    </a:lnL>
                    <a:lnR>
                      <a:noFill/>
                    </a:lnR>
                    <a:lnT>
                      <a:noFill/>
                    </a:lnT>
                    <a:lnB>
                      <a:noFill/>
                    </a:lnB>
                    <a:solidFill>
                      <a:srgbClr val="66AAA7"/>
                    </a:solidFill>
                  </a:tcPr>
                </a:tc>
                <a:tc>
                  <a:txBody>
                    <a:bodyPr/>
                    <a:lstStyle/>
                    <a:p>
                      <a:pPr algn="ctr" fontAlgn="b"/>
                      <a:r>
                        <a:rPr lang="en-GB" sz="1100" b="0" i="0" u="none" strike="noStrike">
                          <a:solidFill>
                            <a:srgbClr val="000000"/>
                          </a:solidFill>
                          <a:effectLst/>
                          <a:latin typeface="Calibri" panose="020F0502020204030204" pitchFamily="34" charset="0"/>
                        </a:rPr>
                        <a:t>73.8%</a:t>
                      </a:r>
                    </a:p>
                  </a:txBody>
                  <a:tcPr marL="7620" marR="7620" marT="7620" marB="0" anchor="b">
                    <a:lnL>
                      <a:noFill/>
                    </a:lnL>
                    <a:lnR w="12700" cap="flat" cmpd="sng" algn="ctr">
                      <a:solidFill>
                        <a:schemeClr val="tx1"/>
                      </a:solidFill>
                      <a:prstDash val="solid"/>
                      <a:round/>
                      <a:headEnd type="none" w="med" len="med"/>
                      <a:tailEnd type="none" w="med" len="med"/>
                    </a:lnR>
                    <a:lnT>
                      <a:noFill/>
                    </a:lnT>
                    <a:lnB>
                      <a:noFill/>
                    </a:lnB>
                    <a:solidFill>
                      <a:srgbClr val="66AAA7"/>
                    </a:solidFill>
                  </a:tcPr>
                </a:tc>
                <a:extLst>
                  <a:ext uri="{0D108BD9-81ED-4DB2-BD59-A6C34878D82A}">
                    <a16:rowId xmlns:a16="http://schemas.microsoft.com/office/drawing/2014/main" val="2196740943"/>
                  </a:ext>
                </a:extLst>
              </a:tr>
              <a:tr h="182880">
                <a:tc vMerge="1">
                  <a:txBody>
                    <a:bodyPr/>
                    <a:lstStyle/>
                    <a:p>
                      <a:endParaRPr lang="en-GB"/>
                    </a:p>
                  </a:txBody>
                  <a:tcPr/>
                </a:tc>
                <a:tc>
                  <a:txBody>
                    <a:bodyPr/>
                    <a:lstStyle/>
                    <a:p>
                      <a:pPr algn="r" fontAlgn="b"/>
                      <a:r>
                        <a:rPr lang="en-GB" sz="1100" b="1" i="0" u="none" strike="noStrike">
                          <a:solidFill>
                            <a:srgbClr val="000000"/>
                          </a:solidFill>
                          <a:effectLst/>
                          <a:latin typeface="Calibri" panose="020F0502020204030204" pitchFamily="34" charset="0"/>
                        </a:rPr>
                        <a:t>1.0%</a:t>
                      </a:r>
                    </a:p>
                  </a:txBody>
                  <a:tcPr marL="7620" marR="7620" marT="7620" marB="0" anchor="b">
                    <a:lnL w="12700" cap="flat" cmpd="sng" algn="ctr">
                      <a:solidFill>
                        <a:schemeClr val="tx1"/>
                      </a:solidFill>
                      <a:prstDash val="solid"/>
                      <a:round/>
                      <a:headEnd type="none" w="med" len="med"/>
                      <a:tailEnd type="none" w="med" len="med"/>
                    </a:lnL>
                    <a:lnR>
                      <a:noFill/>
                    </a:lnR>
                    <a:lnT>
                      <a:noFill/>
                    </a:lnT>
                    <a:lnB>
                      <a:noFill/>
                    </a:lnB>
                    <a:solidFill>
                      <a:srgbClr val="FFFFFF"/>
                    </a:solidFill>
                  </a:tcPr>
                </a:tc>
                <a:tc>
                  <a:txBody>
                    <a:bodyPr/>
                    <a:lstStyle/>
                    <a:p>
                      <a:pPr algn="ctr" fontAlgn="b"/>
                      <a:r>
                        <a:rPr lang="en-GB" sz="1100" b="0" i="0" u="none" strike="noStrike">
                          <a:solidFill>
                            <a:srgbClr val="000000"/>
                          </a:solidFill>
                          <a:effectLst/>
                          <a:latin typeface="Calibri" panose="020F0502020204030204" pitchFamily="34" charset="0"/>
                        </a:rPr>
                        <a:t>2120</a:t>
                      </a:r>
                    </a:p>
                  </a:txBody>
                  <a:tcPr marL="7620" marR="7620" marT="7620" marB="0" anchor="b">
                    <a:lnL>
                      <a:noFill/>
                    </a:lnL>
                    <a:lnR>
                      <a:noFill/>
                    </a:lnR>
                    <a:lnT>
                      <a:noFill/>
                    </a:lnT>
                    <a:lnB>
                      <a:noFill/>
                    </a:lnB>
                    <a:solidFill>
                      <a:srgbClr val="FFFFFF"/>
                    </a:solidFill>
                  </a:tcPr>
                </a:tc>
                <a:tc>
                  <a:txBody>
                    <a:bodyPr/>
                    <a:lstStyle/>
                    <a:p>
                      <a:pPr algn="ctr" fontAlgn="b"/>
                      <a:r>
                        <a:rPr lang="en-GB" sz="1100" b="0" i="0" u="none" strike="noStrike">
                          <a:solidFill>
                            <a:srgbClr val="000000"/>
                          </a:solidFill>
                          <a:effectLst/>
                          <a:latin typeface="Calibri" panose="020F0502020204030204" pitchFamily="34" charset="0"/>
                        </a:rPr>
                        <a:t>2746</a:t>
                      </a:r>
                    </a:p>
                  </a:txBody>
                  <a:tcPr marL="7620" marR="7620" marT="7620" marB="0" anchor="b">
                    <a:lnL>
                      <a:noFill/>
                    </a:lnL>
                    <a:lnR>
                      <a:noFill/>
                    </a:lnR>
                    <a:lnT>
                      <a:noFill/>
                    </a:lnT>
                    <a:lnB>
                      <a:noFill/>
                    </a:lnB>
                    <a:solidFill>
                      <a:srgbClr val="FFFFFF"/>
                    </a:solidFill>
                  </a:tcPr>
                </a:tc>
                <a:tc>
                  <a:txBody>
                    <a:bodyPr/>
                    <a:lstStyle/>
                    <a:p>
                      <a:pPr algn="ctr" fontAlgn="b"/>
                      <a:r>
                        <a:rPr lang="en-GB" sz="1100" b="0" i="0" u="none" strike="noStrike">
                          <a:solidFill>
                            <a:srgbClr val="000000"/>
                          </a:solidFill>
                          <a:effectLst/>
                          <a:latin typeface="Calibri" panose="020F0502020204030204" pitchFamily="34" charset="0"/>
                        </a:rPr>
                        <a:t>77.2%</a:t>
                      </a:r>
                    </a:p>
                  </a:txBody>
                  <a:tcPr marL="7620" marR="7620" marT="7620" marB="0" anchor="b">
                    <a:lnL>
                      <a:noFill/>
                    </a:lnL>
                    <a:lnR w="12700" cap="flat" cmpd="sng" algn="ctr">
                      <a:solidFill>
                        <a:schemeClr val="tx1"/>
                      </a:solidFill>
                      <a:prstDash val="solid"/>
                      <a:round/>
                      <a:headEnd type="none" w="med" len="med"/>
                      <a:tailEnd type="none" w="med" len="med"/>
                    </a:lnR>
                    <a:lnT>
                      <a:noFill/>
                    </a:lnT>
                    <a:lnB>
                      <a:noFill/>
                    </a:lnB>
                    <a:solidFill>
                      <a:srgbClr val="FFFFFF"/>
                    </a:solidFill>
                  </a:tcPr>
                </a:tc>
                <a:extLst>
                  <a:ext uri="{0D108BD9-81ED-4DB2-BD59-A6C34878D82A}">
                    <a16:rowId xmlns:a16="http://schemas.microsoft.com/office/drawing/2014/main" val="151397485"/>
                  </a:ext>
                </a:extLst>
              </a:tr>
              <a:tr h="182880">
                <a:tc vMerge="1">
                  <a:txBody>
                    <a:bodyPr/>
                    <a:lstStyle/>
                    <a:p>
                      <a:endParaRPr lang="en-GB"/>
                    </a:p>
                  </a:txBody>
                  <a:tcPr/>
                </a:tc>
                <a:tc>
                  <a:txBody>
                    <a:bodyPr/>
                    <a:lstStyle/>
                    <a:p>
                      <a:pPr algn="r" fontAlgn="b"/>
                      <a:r>
                        <a:rPr lang="en-GB" sz="1100" b="1" i="0" u="none" strike="noStrike">
                          <a:solidFill>
                            <a:srgbClr val="FFFFFF"/>
                          </a:solidFill>
                          <a:effectLst/>
                          <a:latin typeface="Calibri" panose="020F0502020204030204" pitchFamily="34" charset="0"/>
                        </a:rPr>
                        <a:t>2.5%</a:t>
                      </a:r>
                    </a:p>
                  </a:txBody>
                  <a:tcPr marL="7620" marR="7620" marT="7620" marB="0" anchor="b">
                    <a:lnL w="12700" cap="flat" cmpd="sng" algn="ctr">
                      <a:solidFill>
                        <a:schemeClr val="tx1"/>
                      </a:solidFill>
                      <a:prstDash val="solid"/>
                      <a:round/>
                      <a:headEnd type="none" w="med" len="med"/>
                      <a:tailEnd type="none" w="med" len="med"/>
                    </a:lnL>
                    <a:lnR>
                      <a:noFill/>
                    </a:lnR>
                    <a:lnT>
                      <a:noFill/>
                    </a:lnT>
                    <a:lnB>
                      <a:noFill/>
                    </a:lnB>
                    <a:solidFill>
                      <a:srgbClr val="66AAA7"/>
                    </a:solidFill>
                  </a:tcPr>
                </a:tc>
                <a:tc>
                  <a:txBody>
                    <a:bodyPr/>
                    <a:lstStyle/>
                    <a:p>
                      <a:pPr algn="ctr" fontAlgn="b"/>
                      <a:r>
                        <a:rPr lang="en-GB" sz="1100" b="0" i="0" u="none" strike="noStrike">
                          <a:solidFill>
                            <a:srgbClr val="000000"/>
                          </a:solidFill>
                          <a:effectLst/>
                          <a:latin typeface="Calibri" panose="020F0502020204030204" pitchFamily="34" charset="0"/>
                        </a:rPr>
                        <a:t>2191</a:t>
                      </a:r>
                    </a:p>
                  </a:txBody>
                  <a:tcPr marL="7620" marR="7620" marT="7620" marB="0" anchor="b">
                    <a:lnL>
                      <a:noFill/>
                    </a:lnL>
                    <a:lnR>
                      <a:noFill/>
                    </a:lnR>
                    <a:lnT>
                      <a:noFill/>
                    </a:lnT>
                    <a:lnB>
                      <a:noFill/>
                    </a:lnB>
                    <a:solidFill>
                      <a:srgbClr val="66AAA7"/>
                    </a:solidFill>
                  </a:tcPr>
                </a:tc>
                <a:tc>
                  <a:txBody>
                    <a:bodyPr/>
                    <a:lstStyle/>
                    <a:p>
                      <a:pPr algn="ctr" fontAlgn="b"/>
                      <a:r>
                        <a:rPr lang="en-GB" sz="1100" b="0" i="0" u="none" strike="noStrike" dirty="0">
                          <a:solidFill>
                            <a:srgbClr val="000000"/>
                          </a:solidFill>
                          <a:effectLst/>
                          <a:latin typeface="Calibri" panose="020F0502020204030204" pitchFamily="34" charset="0"/>
                        </a:rPr>
                        <a:t>2819</a:t>
                      </a:r>
                    </a:p>
                  </a:txBody>
                  <a:tcPr marL="7620" marR="7620" marT="7620" marB="0" anchor="b">
                    <a:lnL>
                      <a:noFill/>
                    </a:lnL>
                    <a:lnR>
                      <a:noFill/>
                    </a:lnR>
                    <a:lnT>
                      <a:noFill/>
                    </a:lnT>
                    <a:lnB>
                      <a:noFill/>
                    </a:lnB>
                    <a:solidFill>
                      <a:srgbClr val="66AAA7"/>
                    </a:solidFill>
                  </a:tcPr>
                </a:tc>
                <a:tc>
                  <a:txBody>
                    <a:bodyPr/>
                    <a:lstStyle/>
                    <a:p>
                      <a:pPr algn="ctr" fontAlgn="b"/>
                      <a:r>
                        <a:rPr lang="en-GB" sz="1100" b="0" i="0" u="none" strike="noStrike">
                          <a:solidFill>
                            <a:srgbClr val="000000"/>
                          </a:solidFill>
                          <a:effectLst/>
                          <a:latin typeface="Calibri" panose="020F0502020204030204" pitchFamily="34" charset="0"/>
                        </a:rPr>
                        <a:t>77.7%</a:t>
                      </a:r>
                    </a:p>
                  </a:txBody>
                  <a:tcPr marL="7620" marR="7620" marT="7620" marB="0" anchor="b">
                    <a:lnL>
                      <a:noFill/>
                    </a:lnL>
                    <a:lnR w="12700" cap="flat" cmpd="sng" algn="ctr">
                      <a:solidFill>
                        <a:schemeClr val="tx1"/>
                      </a:solidFill>
                      <a:prstDash val="solid"/>
                      <a:round/>
                      <a:headEnd type="none" w="med" len="med"/>
                      <a:tailEnd type="none" w="med" len="med"/>
                    </a:lnR>
                    <a:lnT>
                      <a:noFill/>
                    </a:lnT>
                    <a:lnB>
                      <a:noFill/>
                    </a:lnB>
                    <a:solidFill>
                      <a:srgbClr val="66AAA7"/>
                    </a:solidFill>
                  </a:tcPr>
                </a:tc>
                <a:extLst>
                  <a:ext uri="{0D108BD9-81ED-4DB2-BD59-A6C34878D82A}">
                    <a16:rowId xmlns:a16="http://schemas.microsoft.com/office/drawing/2014/main" val="4025487027"/>
                  </a:ext>
                </a:extLst>
              </a:tr>
              <a:tr h="207461">
                <a:tc vMerge="1">
                  <a:txBody>
                    <a:bodyPr/>
                    <a:lstStyle/>
                    <a:p>
                      <a:endParaRPr lang="en-GB"/>
                    </a:p>
                  </a:txBody>
                  <a:tcPr/>
                </a:tc>
                <a:tc>
                  <a:txBody>
                    <a:bodyPr/>
                    <a:lstStyle/>
                    <a:p>
                      <a:pPr algn="r" fontAlgn="b"/>
                      <a:r>
                        <a:rPr lang="en-GB" sz="1100" b="1" i="0" u="none" strike="noStrike">
                          <a:solidFill>
                            <a:srgbClr val="000000"/>
                          </a:solidFill>
                          <a:effectLst/>
                          <a:latin typeface="Calibri" panose="020F0502020204030204" pitchFamily="34" charset="0"/>
                        </a:rPr>
                        <a:t>5.0%</a:t>
                      </a:r>
                    </a:p>
                  </a:txBody>
                  <a:tcPr marL="7620" marR="7620" marT="7620" marB="0" anchor="b">
                    <a:lnL w="12700" cap="flat" cmpd="sng" algn="ctr">
                      <a:solidFill>
                        <a:schemeClr val="tx1"/>
                      </a:solidFill>
                      <a:prstDash val="solid"/>
                      <a:round/>
                      <a:headEnd type="none" w="med" len="med"/>
                      <a:tailEnd type="none" w="med" len="med"/>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en-GB" sz="1100" b="0" i="0" u="none" strike="noStrike">
                          <a:solidFill>
                            <a:srgbClr val="000000"/>
                          </a:solidFill>
                          <a:effectLst/>
                          <a:latin typeface="Calibri" panose="020F0502020204030204" pitchFamily="34" charset="0"/>
                        </a:rPr>
                        <a:t>2272</a:t>
                      </a:r>
                    </a:p>
                  </a:txBody>
                  <a:tcPr marL="7620" marR="7620" marT="7620"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en-GB" sz="1100" b="0" i="0" u="none" strike="noStrike">
                          <a:solidFill>
                            <a:srgbClr val="000000"/>
                          </a:solidFill>
                          <a:effectLst/>
                          <a:latin typeface="Calibri" panose="020F0502020204030204" pitchFamily="34" charset="0"/>
                        </a:rPr>
                        <a:t>2842</a:t>
                      </a:r>
                    </a:p>
                  </a:txBody>
                  <a:tcPr marL="7620" marR="7620" marT="7620" marB="0" anchor="b">
                    <a:lnL>
                      <a:noFill/>
                    </a:lnL>
                    <a:lnR>
                      <a:noFill/>
                    </a:lnR>
                    <a:lnT>
                      <a:noFill/>
                    </a:lnT>
                    <a:lnB w="6350" cap="flat" cmpd="sng" algn="ctr">
                      <a:solidFill>
                        <a:srgbClr val="000000"/>
                      </a:solidFill>
                      <a:prstDash val="solid"/>
                      <a:round/>
                      <a:headEnd type="none" w="med" len="med"/>
                      <a:tailEnd type="none" w="med" len="med"/>
                    </a:lnB>
                    <a:solidFill>
                      <a:srgbClr val="FFFFFF"/>
                    </a:solidFill>
                  </a:tcPr>
                </a:tc>
                <a:tc>
                  <a:txBody>
                    <a:bodyPr/>
                    <a:lstStyle/>
                    <a:p>
                      <a:pPr algn="ctr" fontAlgn="b"/>
                      <a:r>
                        <a:rPr lang="en-GB" sz="1100" b="0" i="0" u="none" strike="noStrike">
                          <a:solidFill>
                            <a:srgbClr val="000000"/>
                          </a:solidFill>
                          <a:effectLst/>
                          <a:latin typeface="Calibri" panose="020F0502020204030204" pitchFamily="34" charset="0"/>
                        </a:rPr>
                        <a:t>79.9%</a:t>
                      </a:r>
                    </a:p>
                  </a:txBody>
                  <a:tcPr marL="7620" marR="7620" marT="7620" marB="0" anchor="b">
                    <a:lnL>
                      <a:noFill/>
                    </a:lnL>
                    <a:lnR w="12700" cap="flat" cmpd="sng" algn="ctr">
                      <a:solidFill>
                        <a:schemeClr val="tx1"/>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solidFill>
                      <a:srgbClr val="FFFFFF"/>
                    </a:solidFill>
                  </a:tcPr>
                </a:tc>
                <a:extLst>
                  <a:ext uri="{0D108BD9-81ED-4DB2-BD59-A6C34878D82A}">
                    <a16:rowId xmlns:a16="http://schemas.microsoft.com/office/drawing/2014/main" val="2721569417"/>
                  </a:ext>
                </a:extLst>
              </a:tr>
              <a:tr h="182880">
                <a:tc>
                  <a:txBody>
                    <a:bodyPr/>
                    <a:lstStyle/>
                    <a:p>
                      <a:pPr algn="ctr" fontAlgn="b"/>
                      <a:r>
                        <a:rPr lang="en-GB" sz="1100" b="1" i="0" u="none" strike="noStrike" dirty="0">
                          <a:solidFill>
                            <a:srgbClr val="FFFFFF"/>
                          </a:solidFill>
                          <a:effectLst/>
                          <a:latin typeface="Calibri" panose="020F0502020204030204" pitchFamily="34" charset="0"/>
                        </a:rPr>
                        <a:t>UC</a:t>
                      </a:r>
                    </a:p>
                  </a:txBody>
                  <a:tcPr marL="7620" marR="7620" marT="762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ED7D31"/>
                    </a:solidFill>
                  </a:tcPr>
                </a:tc>
                <a:tc>
                  <a:txBody>
                    <a:bodyPr/>
                    <a:lstStyle/>
                    <a:p>
                      <a:pPr algn="l" fontAlgn="b"/>
                      <a:r>
                        <a:rPr lang="en-GB" sz="1100" b="1" i="0" u="none" strike="noStrike">
                          <a:solidFill>
                            <a:srgbClr val="FFFFFF"/>
                          </a:solidFill>
                          <a:effectLst/>
                          <a:latin typeface="Calibri" panose="020F0502020204030204" pitchFamily="34" charset="0"/>
                        </a:rPr>
                        <a:t> </a:t>
                      </a:r>
                    </a:p>
                  </a:txBody>
                  <a:tcPr marL="7620" marR="7620" marT="7620" marB="0" anchor="b">
                    <a:lnL w="12700" cap="flat" cmpd="sng" algn="ctr">
                      <a:solidFill>
                        <a:schemeClr val="tx1"/>
                      </a:solidFill>
                      <a:prstDash val="solid"/>
                      <a:round/>
                      <a:headEnd type="none" w="med" len="med"/>
                      <a:tailEnd type="none" w="med" len="med"/>
                    </a:lnL>
                    <a:lnR>
                      <a:noFill/>
                    </a:lnR>
                    <a:lnT w="635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ED7D31"/>
                    </a:solidFill>
                  </a:tcPr>
                </a:tc>
                <a:tc>
                  <a:txBody>
                    <a:bodyPr/>
                    <a:lstStyle/>
                    <a:p>
                      <a:pPr algn="ctr" fontAlgn="b"/>
                      <a:r>
                        <a:rPr lang="en-GB" sz="1100" b="0" i="0" u="none" strike="noStrike">
                          <a:solidFill>
                            <a:srgbClr val="000000"/>
                          </a:solidFill>
                          <a:effectLst/>
                          <a:latin typeface="Calibri" panose="020F0502020204030204" pitchFamily="34" charset="0"/>
                        </a:rPr>
                        <a:t>2039</a:t>
                      </a:r>
                    </a:p>
                  </a:txBody>
                  <a:tcPr marL="7620" marR="7620" marT="7620" marB="0" anchor="b">
                    <a:lnL>
                      <a:noFill/>
                    </a:lnL>
                    <a:lnR>
                      <a:noFill/>
                    </a:lnR>
                    <a:lnT w="635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ED7D31"/>
                    </a:solidFill>
                  </a:tcPr>
                </a:tc>
                <a:tc>
                  <a:txBody>
                    <a:bodyPr/>
                    <a:lstStyle/>
                    <a:p>
                      <a:pPr algn="ctr" fontAlgn="b"/>
                      <a:r>
                        <a:rPr lang="en-GB" sz="1100" b="0" i="0" u="none" strike="noStrike">
                          <a:solidFill>
                            <a:srgbClr val="000000"/>
                          </a:solidFill>
                          <a:effectLst/>
                          <a:latin typeface="Calibri" panose="020F0502020204030204" pitchFamily="34" charset="0"/>
                        </a:rPr>
                        <a:t>3144</a:t>
                      </a:r>
                    </a:p>
                  </a:txBody>
                  <a:tcPr marL="7620" marR="7620" marT="7620" marB="0" anchor="b">
                    <a:lnL>
                      <a:noFill/>
                    </a:lnL>
                    <a:lnR>
                      <a:noFill/>
                    </a:lnR>
                    <a:lnT w="635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ED7D31"/>
                    </a:solidFill>
                  </a:tcPr>
                </a:tc>
                <a:tc>
                  <a:txBody>
                    <a:bodyPr/>
                    <a:lstStyle/>
                    <a:p>
                      <a:pPr algn="ctr" fontAlgn="b"/>
                      <a:r>
                        <a:rPr lang="en-GB" sz="1100" b="0" i="0" u="none" strike="noStrike" dirty="0">
                          <a:solidFill>
                            <a:srgbClr val="000000"/>
                          </a:solidFill>
                          <a:effectLst/>
                          <a:latin typeface="Calibri" panose="020F0502020204030204" pitchFamily="34" charset="0"/>
                        </a:rPr>
                        <a:t>64.9%</a:t>
                      </a:r>
                    </a:p>
                  </a:txBody>
                  <a:tcPr marL="7620" marR="7620" marT="7620" marB="0" anchor="b">
                    <a:lnL>
                      <a:noFill/>
                    </a:lnL>
                    <a:lnR w="12700" cap="flat" cmpd="sng" algn="ctr">
                      <a:solidFill>
                        <a:schemeClr val="tx1"/>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ED7D31"/>
                    </a:solidFill>
                  </a:tcPr>
                </a:tc>
                <a:extLst>
                  <a:ext uri="{0D108BD9-81ED-4DB2-BD59-A6C34878D82A}">
                    <a16:rowId xmlns:a16="http://schemas.microsoft.com/office/drawing/2014/main" val="1182356764"/>
                  </a:ext>
                </a:extLst>
              </a:tr>
            </a:tbl>
          </a:graphicData>
        </a:graphic>
      </p:graphicFrame>
      <p:sp>
        <p:nvSpPr>
          <p:cNvPr id="4" name="Rectangle 3"/>
          <p:cNvSpPr/>
          <p:nvPr/>
        </p:nvSpPr>
        <p:spPr>
          <a:xfrm>
            <a:off x="0" y="101427"/>
            <a:ext cx="6858000" cy="923330"/>
          </a:xfrm>
          <a:prstGeom prst="rect">
            <a:avLst/>
          </a:prstGeom>
        </p:spPr>
        <p:txBody>
          <a:bodyPr wrap="square">
            <a:spAutoFit/>
          </a:bodyPr>
          <a:lstStyle/>
          <a:p>
            <a:r>
              <a:rPr lang="en-US" b="1" dirty="0">
                <a:latin typeface="Cambria" panose="02040503050406030204" pitchFamily="18" charset="0"/>
                <a:ea typeface="Cambria" panose="02040503050406030204" pitchFamily="18" charset="0"/>
              </a:rPr>
              <a:t>Figure </a:t>
            </a:r>
            <a:r>
              <a:rPr lang="en-US" b="1" dirty="0" smtClean="0">
                <a:latin typeface="Cambria" panose="02040503050406030204" pitchFamily="18" charset="0"/>
                <a:ea typeface="Cambria" panose="02040503050406030204" pitchFamily="18" charset="0"/>
              </a:rPr>
              <a:t>S6a:</a:t>
            </a:r>
            <a:endParaRPr lang="en-US" b="1" dirty="0">
              <a:latin typeface="Cambria" panose="02040503050406030204" pitchFamily="18" charset="0"/>
              <a:ea typeface="Cambria" panose="02040503050406030204" pitchFamily="18" charset="0"/>
            </a:endParaRPr>
          </a:p>
          <a:p>
            <a:pPr algn="just"/>
            <a:r>
              <a:rPr lang="en-US" sz="1200" dirty="0" smtClean="0">
                <a:latin typeface="Cambria" panose="02040503050406030204" pitchFamily="18" charset="0"/>
                <a:ea typeface="Cambria" panose="02040503050406030204" pitchFamily="18" charset="0"/>
              </a:rPr>
              <a:t>Venn diagrams of the different replicates of each experimental setup </a:t>
            </a:r>
            <a:r>
              <a:rPr lang="en-US" sz="1200" dirty="0">
                <a:latin typeface="Cambria" panose="02040503050406030204" pitchFamily="18" charset="0"/>
                <a:ea typeface="Cambria" panose="02040503050406030204" pitchFamily="18" charset="0"/>
              </a:rPr>
              <a:t>depicting the number </a:t>
            </a:r>
            <a:r>
              <a:rPr lang="en-US" sz="1200" dirty="0" smtClean="0">
                <a:latin typeface="Cambria" panose="02040503050406030204" pitchFamily="18" charset="0"/>
                <a:ea typeface="Cambria" panose="02040503050406030204" pitchFamily="18" charset="0"/>
              </a:rPr>
              <a:t>of protein  identifications and the corresponding overlap. The table summarizes the data, including the percentage of proteins that were identified across all replicates (n = 3).</a:t>
            </a:r>
            <a:endParaRPr lang="en-GB" sz="1200" dirty="0">
              <a:latin typeface="Cambria" panose="02040503050406030204" pitchFamily="18" charset="0"/>
              <a:ea typeface="Cambria" panose="02040503050406030204" pitchFamily="18" charset="0"/>
            </a:endParaRPr>
          </a:p>
        </p:txBody>
      </p:sp>
    </p:spTree>
    <p:extLst>
      <p:ext uri="{BB962C8B-B14F-4D97-AF65-F5344CB8AC3E}">
        <p14:creationId xmlns:p14="http://schemas.microsoft.com/office/powerpoint/2010/main" val="270797388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0" y="101427"/>
            <a:ext cx="6858000" cy="923330"/>
          </a:xfrm>
          <a:prstGeom prst="rect">
            <a:avLst/>
          </a:prstGeom>
        </p:spPr>
        <p:txBody>
          <a:bodyPr wrap="square">
            <a:spAutoFit/>
          </a:bodyPr>
          <a:lstStyle/>
          <a:p>
            <a:r>
              <a:rPr lang="en-US" b="1" dirty="0">
                <a:latin typeface="Cambria" panose="02040503050406030204" pitchFamily="18" charset="0"/>
                <a:ea typeface="Cambria" panose="02040503050406030204" pitchFamily="18" charset="0"/>
              </a:rPr>
              <a:t>Figure </a:t>
            </a:r>
            <a:r>
              <a:rPr lang="en-US" b="1" dirty="0" smtClean="0">
                <a:latin typeface="Cambria" panose="02040503050406030204" pitchFamily="18" charset="0"/>
                <a:ea typeface="Cambria" panose="02040503050406030204" pitchFamily="18" charset="0"/>
              </a:rPr>
              <a:t>S6b:</a:t>
            </a:r>
            <a:endParaRPr lang="en-US" b="1" dirty="0">
              <a:latin typeface="Cambria" panose="02040503050406030204" pitchFamily="18" charset="0"/>
              <a:ea typeface="Cambria" panose="02040503050406030204" pitchFamily="18" charset="0"/>
            </a:endParaRPr>
          </a:p>
          <a:p>
            <a:pPr algn="just"/>
            <a:r>
              <a:rPr lang="en-US" sz="1200" b="1" dirty="0" smtClean="0">
                <a:latin typeface="Cambria" panose="02040503050406030204" pitchFamily="18" charset="0"/>
                <a:ea typeface="Cambria" panose="02040503050406030204" pitchFamily="18" charset="0"/>
              </a:rPr>
              <a:t>Overview of the number of bovine proteins identified across the different experiments. </a:t>
            </a:r>
            <a:r>
              <a:rPr lang="en-US" sz="1200" dirty="0" smtClean="0">
                <a:latin typeface="Cambria" panose="02040503050406030204" pitchFamily="18" charset="0"/>
                <a:ea typeface="Cambria" panose="02040503050406030204" pitchFamily="18" charset="0"/>
              </a:rPr>
              <a:t>In FAEVEr 96well, the number of bovine proteins decreases with an increasing percentage of TWEEN-20. However, only 36% is completely removed in the 5% TWEEN-20. </a:t>
            </a:r>
            <a:endParaRPr lang="en-GB" sz="1200" dirty="0">
              <a:latin typeface="Cambria" panose="02040503050406030204" pitchFamily="18" charset="0"/>
              <a:ea typeface="Cambria" panose="02040503050406030204" pitchFamily="18" charset="0"/>
            </a:endParaRPr>
          </a:p>
        </p:txBody>
      </p:sp>
      <p:graphicFrame>
        <p:nvGraphicFramePr>
          <p:cNvPr id="3" name="Object 2"/>
          <p:cNvGraphicFramePr>
            <a:graphicFrameLocks noChangeAspect="1"/>
          </p:cNvGraphicFramePr>
          <p:nvPr>
            <p:extLst>
              <p:ext uri="{D42A27DB-BD31-4B8C-83A1-F6EECF244321}">
                <p14:modId xmlns:p14="http://schemas.microsoft.com/office/powerpoint/2010/main" val="4124278122"/>
              </p:ext>
            </p:extLst>
          </p:nvPr>
        </p:nvGraphicFramePr>
        <p:xfrm>
          <a:off x="909535" y="1382510"/>
          <a:ext cx="5038929" cy="4715730"/>
        </p:xfrm>
        <a:graphic>
          <a:graphicData uri="http://schemas.openxmlformats.org/presentationml/2006/ole">
            <mc:AlternateContent xmlns:mc="http://schemas.openxmlformats.org/markup-compatibility/2006">
              <mc:Choice xmlns:v="urn:schemas-microsoft-com:vml" Requires="v">
                <p:oleObj spid="_x0000_s14342" name="Prism 10" r:id="rId3" imgW="2723054" imgH="2547808" progId="Prism10.Document">
                  <p:embed/>
                </p:oleObj>
              </mc:Choice>
              <mc:Fallback>
                <p:oleObj name="Prism 10" r:id="rId3" imgW="2723054" imgH="2547808" progId="Prism10.Document">
                  <p:embed/>
                  <p:pic>
                    <p:nvPicPr>
                      <p:cNvPr id="2" name="Object 1"/>
                      <p:cNvPicPr/>
                      <p:nvPr/>
                    </p:nvPicPr>
                    <p:blipFill>
                      <a:blip r:embed="rId4"/>
                      <a:stretch>
                        <a:fillRect/>
                      </a:stretch>
                    </p:blipFill>
                    <p:spPr>
                      <a:xfrm>
                        <a:off x="909535" y="1382510"/>
                        <a:ext cx="5038929" cy="4715730"/>
                      </a:xfrm>
                      <a:prstGeom prst="rect">
                        <a:avLst/>
                      </a:prstGeom>
                    </p:spPr>
                  </p:pic>
                </p:oleObj>
              </mc:Fallback>
            </mc:AlternateContent>
          </a:graphicData>
        </a:graphic>
      </p:graphicFrame>
    </p:spTree>
    <p:extLst>
      <p:ext uri="{BB962C8B-B14F-4D97-AF65-F5344CB8AC3E}">
        <p14:creationId xmlns:p14="http://schemas.microsoft.com/office/powerpoint/2010/main" val="35559356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2" cstate="print">
            <a:extLst>
              <a:ext uri="{28A0092B-C50C-407E-A947-70E740481C1C}">
                <a14:useLocalDpi xmlns:a14="http://schemas.microsoft.com/office/drawing/2010/main" val="0"/>
              </a:ext>
            </a:extLst>
          </a:blip>
          <a:srcRect l="17524" r="33333"/>
          <a:stretch/>
        </p:blipFill>
        <p:spPr>
          <a:xfrm>
            <a:off x="335279" y="1024757"/>
            <a:ext cx="6187441" cy="6247519"/>
          </a:xfrm>
          <a:prstGeom prst="rect">
            <a:avLst/>
          </a:prstGeom>
        </p:spPr>
      </p:pic>
      <p:sp>
        <p:nvSpPr>
          <p:cNvPr id="3" name="Rectangle 2"/>
          <p:cNvSpPr/>
          <p:nvPr/>
        </p:nvSpPr>
        <p:spPr>
          <a:xfrm>
            <a:off x="0" y="101427"/>
            <a:ext cx="6858000" cy="923330"/>
          </a:xfrm>
          <a:prstGeom prst="rect">
            <a:avLst/>
          </a:prstGeom>
        </p:spPr>
        <p:txBody>
          <a:bodyPr wrap="square">
            <a:spAutoFit/>
          </a:bodyPr>
          <a:lstStyle/>
          <a:p>
            <a:r>
              <a:rPr lang="en-US" b="1" dirty="0">
                <a:latin typeface="Cambria" panose="02040503050406030204" pitchFamily="18" charset="0"/>
                <a:ea typeface="Cambria" panose="02040503050406030204" pitchFamily="18" charset="0"/>
              </a:rPr>
              <a:t>Figure </a:t>
            </a:r>
            <a:r>
              <a:rPr lang="en-US" b="1" dirty="0" smtClean="0">
                <a:latin typeface="Cambria" panose="02040503050406030204" pitchFamily="18" charset="0"/>
                <a:ea typeface="Cambria" panose="02040503050406030204" pitchFamily="18" charset="0"/>
              </a:rPr>
              <a:t>S7a:</a:t>
            </a:r>
            <a:endParaRPr lang="en-US" b="1" dirty="0">
              <a:latin typeface="Cambria" panose="02040503050406030204" pitchFamily="18" charset="0"/>
              <a:ea typeface="Cambria" panose="02040503050406030204" pitchFamily="18" charset="0"/>
            </a:endParaRPr>
          </a:p>
          <a:p>
            <a:pPr algn="just"/>
            <a:r>
              <a:rPr lang="en-US" sz="1200" dirty="0" smtClean="0">
                <a:latin typeface="Cambria" panose="02040503050406030204" pitchFamily="18" charset="0"/>
                <a:ea typeface="Cambria" panose="02040503050406030204" pitchFamily="18" charset="0"/>
              </a:rPr>
              <a:t>String network of the 64 transmembrane proteins that were significantly higher abundant in ultracentrifugation compared to FAEVEr +5% TWEEN-20.  GO analysis revealed that 18 TM proteins are located in the ER (orange fill), whereas 34 are located in the Golgi apparatus (blue border).</a:t>
            </a:r>
            <a:endParaRPr lang="en-GB" sz="1200" dirty="0">
              <a:latin typeface="Cambria" panose="02040503050406030204" pitchFamily="18" charset="0"/>
              <a:ea typeface="Cambria" panose="02040503050406030204" pitchFamily="18" charset="0"/>
            </a:endParaRPr>
          </a:p>
        </p:txBody>
      </p:sp>
    </p:spTree>
    <p:extLst>
      <p:ext uri="{BB962C8B-B14F-4D97-AF65-F5344CB8AC3E}">
        <p14:creationId xmlns:p14="http://schemas.microsoft.com/office/powerpoint/2010/main" val="75168174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0" y="101427"/>
            <a:ext cx="6858000" cy="1107996"/>
          </a:xfrm>
          <a:prstGeom prst="rect">
            <a:avLst/>
          </a:prstGeom>
        </p:spPr>
        <p:txBody>
          <a:bodyPr wrap="square">
            <a:spAutoFit/>
          </a:bodyPr>
          <a:lstStyle/>
          <a:p>
            <a:r>
              <a:rPr lang="en-US" b="1" dirty="0">
                <a:latin typeface="Cambria" panose="02040503050406030204" pitchFamily="18" charset="0"/>
                <a:ea typeface="Cambria" panose="02040503050406030204" pitchFamily="18" charset="0"/>
              </a:rPr>
              <a:t>Figure </a:t>
            </a:r>
            <a:r>
              <a:rPr lang="en-US" b="1" dirty="0" smtClean="0">
                <a:latin typeface="Cambria" panose="02040503050406030204" pitchFamily="18" charset="0"/>
                <a:ea typeface="Cambria" panose="02040503050406030204" pitchFamily="18" charset="0"/>
              </a:rPr>
              <a:t>S7b:</a:t>
            </a:r>
            <a:endParaRPr lang="en-US" b="1" dirty="0">
              <a:latin typeface="Cambria" panose="02040503050406030204" pitchFamily="18" charset="0"/>
              <a:ea typeface="Cambria" panose="02040503050406030204" pitchFamily="18" charset="0"/>
            </a:endParaRPr>
          </a:p>
          <a:p>
            <a:pPr algn="just"/>
            <a:r>
              <a:rPr lang="en-US" sz="1200" dirty="0" smtClean="0">
                <a:latin typeface="Cambria" panose="02040503050406030204" pitchFamily="18" charset="0"/>
                <a:ea typeface="Cambria" panose="02040503050406030204" pitchFamily="18" charset="0"/>
              </a:rPr>
              <a:t>String network of the 125 transmembrane proteins that were significantly higher abundant </a:t>
            </a:r>
            <a:r>
              <a:rPr lang="en-US" sz="1200" dirty="0">
                <a:latin typeface="Cambria" panose="02040503050406030204" pitchFamily="18" charset="0"/>
                <a:ea typeface="Cambria" panose="02040503050406030204" pitchFamily="18" charset="0"/>
              </a:rPr>
              <a:t>in </a:t>
            </a:r>
            <a:r>
              <a:rPr lang="en-US" sz="1200" dirty="0" err="1">
                <a:latin typeface="Cambria" panose="02040503050406030204" pitchFamily="18" charset="0"/>
                <a:ea typeface="Cambria" panose="02040503050406030204" pitchFamily="18" charset="0"/>
              </a:rPr>
              <a:t>FAEVEr</a:t>
            </a:r>
            <a:r>
              <a:rPr lang="en-US" sz="1200" dirty="0">
                <a:latin typeface="Cambria" panose="02040503050406030204" pitchFamily="18" charset="0"/>
                <a:ea typeface="Cambria" panose="02040503050406030204" pitchFamily="18" charset="0"/>
              </a:rPr>
              <a:t> +5% </a:t>
            </a:r>
            <a:r>
              <a:rPr lang="en-US" sz="1200" dirty="0" smtClean="0">
                <a:latin typeface="Cambria" panose="02040503050406030204" pitchFamily="18" charset="0"/>
                <a:ea typeface="Cambria" panose="02040503050406030204" pitchFamily="18" charset="0"/>
              </a:rPr>
              <a:t>TWEEN-20 </a:t>
            </a:r>
            <a:r>
              <a:rPr lang="en-US" sz="1200" dirty="0">
                <a:latin typeface="Cambria" panose="02040503050406030204" pitchFamily="18" charset="0"/>
                <a:ea typeface="Cambria" panose="02040503050406030204" pitchFamily="18" charset="0"/>
              </a:rPr>
              <a:t>compared </a:t>
            </a:r>
            <a:r>
              <a:rPr lang="en-US" sz="1200" dirty="0" smtClean="0">
                <a:latin typeface="Cambria" panose="02040503050406030204" pitchFamily="18" charset="0"/>
                <a:ea typeface="Cambria" panose="02040503050406030204" pitchFamily="18" charset="0"/>
              </a:rPr>
              <a:t>to ultracentrifugation. GO analysis revealed that 33 TM proteins are associated with the establishment of anchoring junctions (green fill), whereas 31 are involved in TM transport (orange border) and 34 with cellular localization (diamonds).</a:t>
            </a:r>
            <a:endParaRPr lang="en-GB" sz="1200" dirty="0">
              <a:latin typeface="Cambria" panose="02040503050406030204" pitchFamily="18" charset="0"/>
              <a:ea typeface="Cambria" panose="02040503050406030204" pitchFamily="18" charset="0"/>
            </a:endParaRPr>
          </a:p>
        </p:txBody>
      </p:sp>
      <p:pic>
        <p:nvPicPr>
          <p:cNvPr id="5" name="Picture 4"/>
          <p:cNvPicPr>
            <a:picLocks noChangeAspect="1"/>
          </p:cNvPicPr>
          <p:nvPr/>
        </p:nvPicPr>
        <p:blipFill rotWithShape="1">
          <a:blip r:embed="rId2" cstate="print">
            <a:extLst>
              <a:ext uri="{28A0092B-C50C-407E-A947-70E740481C1C}">
                <a14:useLocalDpi xmlns:a14="http://schemas.microsoft.com/office/drawing/2010/main" val="0"/>
              </a:ext>
            </a:extLst>
          </a:blip>
          <a:srcRect l="26860" t="7144" r="32754"/>
          <a:stretch/>
        </p:blipFill>
        <p:spPr>
          <a:xfrm>
            <a:off x="79611" y="1444488"/>
            <a:ext cx="6778389" cy="6095999"/>
          </a:xfrm>
          <a:prstGeom prst="rect">
            <a:avLst/>
          </a:prstGeom>
        </p:spPr>
      </p:pic>
    </p:spTree>
    <p:extLst>
      <p:ext uri="{BB962C8B-B14F-4D97-AF65-F5344CB8AC3E}">
        <p14:creationId xmlns:p14="http://schemas.microsoft.com/office/powerpoint/2010/main" val="419519578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859</TotalTime>
  <Words>685</Words>
  <Application>Microsoft Office PowerPoint</Application>
  <PresentationFormat>A4 Paper (210x297 mm)</PresentationFormat>
  <Paragraphs>143</Paragraphs>
  <Slides>9</Slides>
  <Notes>0</Notes>
  <HiddenSlides>0</HiddenSlides>
  <MMClips>0</MMClips>
  <ScaleCrop>false</ScaleCrop>
  <HeadingPairs>
    <vt:vector size="8" baseType="variant">
      <vt:variant>
        <vt:lpstr>Fonts Used</vt:lpstr>
      </vt:variant>
      <vt:variant>
        <vt:i4>5</vt:i4>
      </vt:variant>
      <vt:variant>
        <vt:lpstr>Theme</vt:lpstr>
      </vt:variant>
      <vt:variant>
        <vt:i4>1</vt:i4>
      </vt:variant>
      <vt:variant>
        <vt:lpstr>Embedded OLE Servers</vt:lpstr>
      </vt:variant>
      <vt:variant>
        <vt:i4>1</vt:i4>
      </vt:variant>
      <vt:variant>
        <vt:lpstr>Slide Titles</vt:lpstr>
      </vt:variant>
      <vt:variant>
        <vt:i4>9</vt:i4>
      </vt:variant>
    </vt:vector>
  </HeadingPairs>
  <TitlesOfParts>
    <vt:vector size="16" baseType="lpstr">
      <vt:lpstr>Arial</vt:lpstr>
      <vt:lpstr>Bahnschrift</vt:lpstr>
      <vt:lpstr>Calibri</vt:lpstr>
      <vt:lpstr>Calibri Light</vt:lpstr>
      <vt:lpstr>Cambria</vt:lpstr>
      <vt:lpstr>Office Theme</vt:lpstr>
      <vt:lpstr>Prism 10</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arne</dc:creator>
  <cp:lastModifiedBy>jfrpauwe.pauwels@ugent.be</cp:lastModifiedBy>
  <cp:revision>72</cp:revision>
  <dcterms:created xsi:type="dcterms:W3CDTF">2024-11-19T08:33:31Z</dcterms:created>
  <dcterms:modified xsi:type="dcterms:W3CDTF">2025-01-17T16:54:05Z</dcterms:modified>
</cp:coreProperties>
</file>